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45" d="100"/>
          <a:sy n="45" d="100"/>
        </p:scale>
        <p:origin x="2220" y="4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D0F1C-6542-4FDB-BA3E-7BD07F548956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B4B26-FF87-4F8E-9D2A-3950D6D7A6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9346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D0F1C-6542-4FDB-BA3E-7BD07F548956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B4B26-FF87-4F8E-9D2A-3950D6D7A6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1953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D0F1C-6542-4FDB-BA3E-7BD07F548956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B4B26-FF87-4F8E-9D2A-3950D6D7A6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1763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D0F1C-6542-4FDB-BA3E-7BD07F548956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B4B26-FF87-4F8E-9D2A-3950D6D7A6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1558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D0F1C-6542-4FDB-BA3E-7BD07F548956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B4B26-FF87-4F8E-9D2A-3950D6D7A6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3032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D0F1C-6542-4FDB-BA3E-7BD07F548956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B4B26-FF87-4F8E-9D2A-3950D6D7A6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9157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D0F1C-6542-4FDB-BA3E-7BD07F548956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B4B26-FF87-4F8E-9D2A-3950D6D7A6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28375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D0F1C-6542-4FDB-BA3E-7BD07F548956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B4B26-FF87-4F8E-9D2A-3950D6D7A6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42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D0F1C-6542-4FDB-BA3E-7BD07F548956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B4B26-FF87-4F8E-9D2A-3950D6D7A6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1768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D0F1C-6542-4FDB-BA3E-7BD07F548956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B4B26-FF87-4F8E-9D2A-3950D6D7A6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688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BD0F1C-6542-4FDB-BA3E-7BD07F548956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2B4B26-FF87-4F8E-9D2A-3950D6D7A6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2842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BD0F1C-6542-4FDB-BA3E-7BD07F548956}" type="datetimeFigureOut">
              <a:rPr lang="zh-CN" altLang="en-US" smtClean="0"/>
              <a:t>2022/8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2B4B26-FF87-4F8E-9D2A-3950D6D7A6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3345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1C2E2A11-EB8A-6815-5CEC-2DF966FC647B}"/>
              </a:ext>
            </a:extLst>
          </p:cNvPr>
          <p:cNvGrpSpPr/>
          <p:nvPr/>
        </p:nvGrpSpPr>
        <p:grpSpPr>
          <a:xfrm>
            <a:off x="297186" y="641766"/>
            <a:ext cx="6162639" cy="5787736"/>
            <a:chOff x="297186" y="1339193"/>
            <a:chExt cx="6162639" cy="5787736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A42ECD94-55E4-648E-E37D-D2F7A3053829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567267" y="1453622"/>
              <a:ext cx="5514975" cy="5514975"/>
              <a:chOff x="0" y="937"/>
              <a:chExt cx="3474" cy="3474"/>
            </a:xfrm>
          </p:grpSpPr>
          <p:sp>
            <p:nvSpPr>
              <p:cNvPr id="21" name="AutoShape 3">
                <a:extLst>
                  <a:ext uri="{FF2B5EF4-FFF2-40B4-BE49-F238E27FC236}">
                    <a16:creationId xmlns:a16="http://schemas.microsoft.com/office/drawing/2014/main" id="{AB65012E-2EF0-DD72-D063-A2C1F23F690A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0" y="937"/>
                <a:ext cx="3474" cy="34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grpSp>
            <p:nvGrpSpPr>
              <p:cNvPr id="22" name="Group 205">
                <a:extLst>
                  <a:ext uri="{FF2B5EF4-FFF2-40B4-BE49-F238E27FC236}">
                    <a16:creationId xmlns:a16="http://schemas.microsoft.com/office/drawing/2014/main" id="{D9001AAD-9574-C0B1-3264-6C35F2303EDC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18" y="969"/>
                <a:ext cx="3095" cy="3314"/>
                <a:chOff x="318" y="969"/>
                <a:chExt cx="3095" cy="3314"/>
              </a:xfrm>
            </p:grpSpPr>
            <p:sp>
              <p:nvSpPr>
                <p:cNvPr id="271" name="Rectangle 5">
                  <a:extLst>
                    <a:ext uri="{FF2B5EF4-FFF2-40B4-BE49-F238E27FC236}">
                      <a16:creationId xmlns:a16="http://schemas.microsoft.com/office/drawing/2014/main" id="{FDE7636F-5E51-6D28-F507-14A97232217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18" y="1273"/>
                  <a:ext cx="3050" cy="2704"/>
                </a:xfrm>
                <a:prstGeom prst="rect">
                  <a:avLst/>
                </a:prstGeom>
                <a:solidFill>
                  <a:srgbClr val="FFFFFF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 dirty="0"/>
                </a:p>
              </p:txBody>
            </p:sp>
            <p:sp>
              <p:nvSpPr>
                <p:cNvPr id="272" name="Rectangle 6">
                  <a:extLst>
                    <a:ext uri="{FF2B5EF4-FFF2-40B4-BE49-F238E27FC236}">
                      <a16:creationId xmlns:a16="http://schemas.microsoft.com/office/drawing/2014/main" id="{F17D4276-98B6-68D9-F39E-9664731685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1547" y="1151"/>
                  <a:ext cx="35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2A220T41</a:t>
                  </a:r>
                </a:p>
              </p:txBody>
            </p:sp>
            <p:sp>
              <p:nvSpPr>
                <p:cNvPr id="273" name="Line 7">
                  <a:extLst>
                    <a:ext uri="{FF2B5EF4-FFF2-40B4-BE49-F238E27FC236}">
                      <a16:creationId xmlns:a16="http://schemas.microsoft.com/office/drawing/2014/main" id="{612392C3-CDFD-9B4A-81EE-6C398B6BD40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1723" y="1355"/>
                  <a:ext cx="1" cy="6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74" name="Rectangle 8">
                  <a:extLst>
                    <a:ext uri="{FF2B5EF4-FFF2-40B4-BE49-F238E27FC236}">
                      <a16:creationId xmlns:a16="http://schemas.microsoft.com/office/drawing/2014/main" id="{B7823633-A68D-4D6B-8091-813C55EDB96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380000">
                  <a:off x="1664" y="1168"/>
                  <a:ext cx="3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Lj2C220T9</a:t>
                  </a:r>
                </a:p>
              </p:txBody>
            </p:sp>
            <p:sp>
              <p:nvSpPr>
                <p:cNvPr id="275" name="Line 9">
                  <a:extLst>
                    <a:ext uri="{FF2B5EF4-FFF2-40B4-BE49-F238E27FC236}">
                      <a16:creationId xmlns:a16="http://schemas.microsoft.com/office/drawing/2014/main" id="{EDBB5A04-C40F-74FC-3F62-785DA789AE3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810" y="1354"/>
                  <a:ext cx="7" cy="6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76" name="Arc 10">
                  <a:extLst>
                    <a:ext uri="{FF2B5EF4-FFF2-40B4-BE49-F238E27FC236}">
                      <a16:creationId xmlns:a16="http://schemas.microsoft.com/office/drawing/2014/main" id="{9D7331FE-AAA5-0B7D-FD49-014649A6BC1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417"/>
                  <a:ext cx="45" cy="1299"/>
                </a:xfrm>
                <a:custGeom>
                  <a:avLst/>
                  <a:gdLst>
                    <a:gd name="G0" fmla="+- 0 0 0"/>
                    <a:gd name="G1" fmla="+- 21600 0 0"/>
                    <a:gd name="G2" fmla="+- 21600 0 0"/>
                    <a:gd name="T0" fmla="*/ 0 w 748"/>
                    <a:gd name="T1" fmla="*/ 0 h 21600"/>
                    <a:gd name="T2" fmla="*/ 748 w 748"/>
                    <a:gd name="T3" fmla="*/ 13 h 21600"/>
                    <a:gd name="T4" fmla="*/ 0 w 748"/>
                    <a:gd name="T5" fmla="*/ 21600 h 216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48" h="21600" fill="none" extrusionOk="0">
                      <a:moveTo>
                        <a:pt x="0" y="0"/>
                      </a:moveTo>
                      <a:cubicBezTo>
                        <a:pt x="249" y="0"/>
                        <a:pt x="498" y="4"/>
                        <a:pt x="748" y="12"/>
                      </a:cubicBezTo>
                    </a:path>
                    <a:path w="748" h="21600" stroke="0" extrusionOk="0">
                      <a:moveTo>
                        <a:pt x="0" y="0"/>
                      </a:moveTo>
                      <a:cubicBezTo>
                        <a:pt x="249" y="0"/>
                        <a:pt x="498" y="4"/>
                        <a:pt x="748" y="12"/>
                      </a:cubicBezTo>
                      <a:lnTo>
                        <a:pt x="0" y="2160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77" name="Arc 11">
                  <a:extLst>
                    <a:ext uri="{FF2B5EF4-FFF2-40B4-BE49-F238E27FC236}">
                      <a16:creationId xmlns:a16="http://schemas.microsoft.com/office/drawing/2014/main" id="{F3D56E93-6D71-BB43-9F39-1802EAC3C85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418"/>
                  <a:ext cx="86" cy="1298"/>
                </a:xfrm>
                <a:custGeom>
                  <a:avLst/>
                  <a:gdLst>
                    <a:gd name="G0" fmla="+- 0 0 0"/>
                    <a:gd name="G1" fmla="+- 21587 0 0"/>
                    <a:gd name="G2" fmla="+- 21600 0 0"/>
                    <a:gd name="T0" fmla="*/ 748 w 1432"/>
                    <a:gd name="T1" fmla="*/ 0 h 21587"/>
                    <a:gd name="T2" fmla="*/ 1432 w 1432"/>
                    <a:gd name="T3" fmla="*/ 35 h 21587"/>
                    <a:gd name="T4" fmla="*/ 0 w 1432"/>
                    <a:gd name="T5" fmla="*/ 21587 h 2158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32" h="21587" fill="none" extrusionOk="0">
                      <a:moveTo>
                        <a:pt x="748" y="-1"/>
                      </a:moveTo>
                      <a:cubicBezTo>
                        <a:pt x="976" y="7"/>
                        <a:pt x="1204" y="19"/>
                        <a:pt x="1432" y="34"/>
                      </a:cubicBezTo>
                    </a:path>
                    <a:path w="1432" h="21587" stroke="0" extrusionOk="0">
                      <a:moveTo>
                        <a:pt x="748" y="-1"/>
                      </a:moveTo>
                      <a:cubicBezTo>
                        <a:pt x="976" y="7"/>
                        <a:pt x="1204" y="19"/>
                        <a:pt x="1432" y="34"/>
                      </a:cubicBezTo>
                      <a:lnTo>
                        <a:pt x="0" y="21587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78" name="Line 12">
                  <a:extLst>
                    <a:ext uri="{FF2B5EF4-FFF2-40B4-BE49-F238E27FC236}">
                      <a16:creationId xmlns:a16="http://schemas.microsoft.com/office/drawing/2014/main" id="{B90AC548-7EFC-E2CD-4C2A-EA3B663DB75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760" y="1417"/>
                  <a:ext cx="5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79" name="Rectangle 13">
                  <a:extLst>
                    <a:ext uri="{FF2B5EF4-FFF2-40B4-BE49-F238E27FC236}">
                      <a16:creationId xmlns:a16="http://schemas.microsoft.com/office/drawing/2014/main" id="{132AC3DD-634E-AC71-6518-93BF07E5C3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620000">
                  <a:off x="1745" y="1165"/>
                  <a:ext cx="35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2A829T57</a:t>
                  </a:r>
                </a:p>
              </p:txBody>
            </p:sp>
            <p:sp>
              <p:nvSpPr>
                <p:cNvPr id="280" name="Line 14">
                  <a:extLst>
                    <a:ext uri="{FF2B5EF4-FFF2-40B4-BE49-F238E27FC236}">
                      <a16:creationId xmlns:a16="http://schemas.microsoft.com/office/drawing/2014/main" id="{09FD636E-6771-A73A-F0E2-5F09213B908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897" y="1368"/>
                  <a:ext cx="6" cy="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81" name="Rectangle 15">
                  <a:extLst>
                    <a:ext uri="{FF2B5EF4-FFF2-40B4-BE49-F238E27FC236}">
                      <a16:creationId xmlns:a16="http://schemas.microsoft.com/office/drawing/2014/main" id="{B88C0072-7D44-83C7-96DC-2824CF3EB28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860000">
                  <a:off x="1812" y="1148"/>
                  <a:ext cx="43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u124A27G15</a:t>
                  </a:r>
                </a:p>
              </p:txBody>
            </p:sp>
            <p:sp>
              <p:nvSpPr>
                <p:cNvPr id="282" name="Line 16">
                  <a:extLst>
                    <a:ext uri="{FF2B5EF4-FFF2-40B4-BE49-F238E27FC236}">
                      <a16:creationId xmlns:a16="http://schemas.microsoft.com/office/drawing/2014/main" id="{7B41C463-79A9-AD40-D370-9D76FEA42F0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984" y="1389"/>
                  <a:ext cx="6" cy="5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83" name="Arc 17">
                  <a:extLst>
                    <a:ext uri="{FF2B5EF4-FFF2-40B4-BE49-F238E27FC236}">
                      <a16:creationId xmlns:a16="http://schemas.microsoft.com/office/drawing/2014/main" id="{73D3F584-52BF-59A1-A16A-3D2262ED62E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429"/>
                  <a:ext cx="214" cy="1287"/>
                </a:xfrm>
                <a:custGeom>
                  <a:avLst/>
                  <a:gdLst>
                    <a:gd name="G0" fmla="+- 0 0 0"/>
                    <a:gd name="G1" fmla="+- 21407 0 0"/>
                    <a:gd name="G2" fmla="+- 21600 0 0"/>
                    <a:gd name="T0" fmla="*/ 2882 w 3559"/>
                    <a:gd name="T1" fmla="*/ 0 h 21407"/>
                    <a:gd name="T2" fmla="*/ 3559 w 3559"/>
                    <a:gd name="T3" fmla="*/ 102 h 21407"/>
                    <a:gd name="T4" fmla="*/ 0 w 3559"/>
                    <a:gd name="T5" fmla="*/ 21407 h 214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559" h="21407" fill="none" extrusionOk="0">
                      <a:moveTo>
                        <a:pt x="2881" y="0"/>
                      </a:moveTo>
                      <a:cubicBezTo>
                        <a:pt x="3108" y="30"/>
                        <a:pt x="3333" y="64"/>
                        <a:pt x="3558" y="102"/>
                      </a:cubicBezTo>
                    </a:path>
                    <a:path w="3559" h="21407" stroke="0" extrusionOk="0">
                      <a:moveTo>
                        <a:pt x="2881" y="0"/>
                      </a:moveTo>
                      <a:cubicBezTo>
                        <a:pt x="3108" y="30"/>
                        <a:pt x="3333" y="64"/>
                        <a:pt x="3558" y="102"/>
                      </a:cubicBezTo>
                      <a:lnTo>
                        <a:pt x="0" y="21407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84" name="Arc 18">
                  <a:extLst>
                    <a:ext uri="{FF2B5EF4-FFF2-40B4-BE49-F238E27FC236}">
                      <a16:creationId xmlns:a16="http://schemas.microsoft.com/office/drawing/2014/main" id="{5D8D0174-FACA-067A-A64E-6FC02F65D6F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435"/>
                  <a:ext cx="256" cy="1281"/>
                </a:xfrm>
                <a:custGeom>
                  <a:avLst/>
                  <a:gdLst>
                    <a:gd name="G0" fmla="+- 0 0 0"/>
                    <a:gd name="G1" fmla="+- 21305 0 0"/>
                    <a:gd name="G2" fmla="+- 21600 0 0"/>
                    <a:gd name="T0" fmla="*/ 3559 w 4262"/>
                    <a:gd name="T1" fmla="*/ 0 h 21305"/>
                    <a:gd name="T2" fmla="*/ 4262 w 4262"/>
                    <a:gd name="T3" fmla="*/ 130 h 21305"/>
                    <a:gd name="T4" fmla="*/ 0 w 4262"/>
                    <a:gd name="T5" fmla="*/ 21305 h 2130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262" h="21305" fill="none" extrusionOk="0">
                      <a:moveTo>
                        <a:pt x="3558" y="0"/>
                      </a:moveTo>
                      <a:cubicBezTo>
                        <a:pt x="3794" y="39"/>
                        <a:pt x="4028" y="82"/>
                        <a:pt x="4262" y="129"/>
                      </a:cubicBezTo>
                    </a:path>
                    <a:path w="4262" h="21305" stroke="0" extrusionOk="0">
                      <a:moveTo>
                        <a:pt x="3558" y="0"/>
                      </a:moveTo>
                      <a:cubicBezTo>
                        <a:pt x="3794" y="39"/>
                        <a:pt x="4028" y="82"/>
                        <a:pt x="4262" y="129"/>
                      </a:cubicBezTo>
                      <a:lnTo>
                        <a:pt x="0" y="21305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85" name="Line 19">
                  <a:extLst>
                    <a:ext uri="{FF2B5EF4-FFF2-40B4-BE49-F238E27FC236}">
                      <a16:creationId xmlns:a16="http://schemas.microsoft.com/office/drawing/2014/main" id="{9F60C2EE-1B4F-5E1F-3D11-B45E4BB9063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925" y="1435"/>
                  <a:ext cx="13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86" name="Arc 20">
                  <a:extLst>
                    <a:ext uri="{FF2B5EF4-FFF2-40B4-BE49-F238E27FC236}">
                      <a16:creationId xmlns:a16="http://schemas.microsoft.com/office/drawing/2014/main" id="{248CEBEB-E389-9619-2F81-327890DEE08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496"/>
                  <a:ext cx="123" cy="1220"/>
                </a:xfrm>
                <a:custGeom>
                  <a:avLst/>
                  <a:gdLst>
                    <a:gd name="G0" fmla="+- 0 0 0"/>
                    <a:gd name="G1" fmla="+- 21588 0 0"/>
                    <a:gd name="G2" fmla="+- 21600 0 0"/>
                    <a:gd name="T0" fmla="*/ 725 w 2172"/>
                    <a:gd name="T1" fmla="*/ 0 h 21588"/>
                    <a:gd name="T2" fmla="*/ 2172 w 2172"/>
                    <a:gd name="T3" fmla="*/ 97 h 21588"/>
                    <a:gd name="T4" fmla="*/ 0 w 2172"/>
                    <a:gd name="T5" fmla="*/ 21588 h 215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72" h="21588" fill="none" extrusionOk="0">
                      <a:moveTo>
                        <a:pt x="724" y="0"/>
                      </a:moveTo>
                      <a:cubicBezTo>
                        <a:pt x="1208" y="16"/>
                        <a:pt x="1690" y="48"/>
                        <a:pt x="2171" y="97"/>
                      </a:cubicBezTo>
                    </a:path>
                    <a:path w="2172" h="21588" stroke="0" extrusionOk="0">
                      <a:moveTo>
                        <a:pt x="724" y="0"/>
                      </a:moveTo>
                      <a:cubicBezTo>
                        <a:pt x="1208" y="16"/>
                        <a:pt x="1690" y="48"/>
                        <a:pt x="2171" y="97"/>
                      </a:cubicBezTo>
                      <a:lnTo>
                        <a:pt x="0" y="21588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87" name="Arc 21">
                  <a:extLst>
                    <a:ext uri="{FF2B5EF4-FFF2-40B4-BE49-F238E27FC236}">
                      <a16:creationId xmlns:a16="http://schemas.microsoft.com/office/drawing/2014/main" id="{9C01EDBB-99E5-304F-9BD0-D72093F61E0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502"/>
                  <a:ext cx="201" cy="1214"/>
                </a:xfrm>
                <a:custGeom>
                  <a:avLst/>
                  <a:gdLst>
                    <a:gd name="G0" fmla="+- 0 0 0"/>
                    <a:gd name="G1" fmla="+- 21491 0 0"/>
                    <a:gd name="G2" fmla="+- 21600 0 0"/>
                    <a:gd name="T0" fmla="*/ 2172 w 3560"/>
                    <a:gd name="T1" fmla="*/ 0 h 21491"/>
                    <a:gd name="T2" fmla="*/ 3560 w 3560"/>
                    <a:gd name="T3" fmla="*/ 186 h 21491"/>
                    <a:gd name="T4" fmla="*/ 0 w 3560"/>
                    <a:gd name="T5" fmla="*/ 21491 h 2149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560" h="21491" fill="none" extrusionOk="0">
                      <a:moveTo>
                        <a:pt x="2171" y="0"/>
                      </a:moveTo>
                      <a:cubicBezTo>
                        <a:pt x="2636" y="47"/>
                        <a:pt x="3099" y="109"/>
                        <a:pt x="3559" y="186"/>
                      </a:cubicBezTo>
                    </a:path>
                    <a:path w="3560" h="21491" stroke="0" extrusionOk="0">
                      <a:moveTo>
                        <a:pt x="2171" y="0"/>
                      </a:moveTo>
                      <a:cubicBezTo>
                        <a:pt x="2636" y="47"/>
                        <a:pt x="3099" y="109"/>
                        <a:pt x="3559" y="186"/>
                      </a:cubicBezTo>
                      <a:lnTo>
                        <a:pt x="0" y="21491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88" name="Line 22">
                  <a:extLst>
                    <a:ext uri="{FF2B5EF4-FFF2-40B4-BE49-F238E27FC236}">
                      <a16:creationId xmlns:a16="http://schemas.microsoft.com/office/drawing/2014/main" id="{5AF10CF7-459B-C742-EB9B-3A3C2DD6AF5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838" y="1499"/>
                  <a:ext cx="9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89" name="Rectangle 23">
                  <a:extLst>
                    <a:ext uri="{FF2B5EF4-FFF2-40B4-BE49-F238E27FC236}">
                      <a16:creationId xmlns:a16="http://schemas.microsoft.com/office/drawing/2014/main" id="{1EEAA86F-57F6-CB38-BC18-65740A71696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7100000">
                  <a:off x="1958" y="1214"/>
                  <a:ext cx="32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2C369G0</a:t>
                  </a:r>
                </a:p>
              </p:txBody>
            </p:sp>
            <p:sp>
              <p:nvSpPr>
                <p:cNvPr id="290" name="Line 24">
                  <a:extLst>
                    <a:ext uri="{FF2B5EF4-FFF2-40B4-BE49-F238E27FC236}">
                      <a16:creationId xmlns:a16="http://schemas.microsoft.com/office/drawing/2014/main" id="{D7531B9B-C7FF-105E-EE99-25D7FD178C7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048" y="1394"/>
                  <a:ext cx="37" cy="14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 dirty="0"/>
                </a:p>
              </p:txBody>
            </p:sp>
            <p:sp>
              <p:nvSpPr>
                <p:cNvPr id="291" name="Rectangle 25">
                  <a:extLst>
                    <a:ext uri="{FF2B5EF4-FFF2-40B4-BE49-F238E27FC236}">
                      <a16:creationId xmlns:a16="http://schemas.microsoft.com/office/drawing/2014/main" id="{D461E1D3-1E8B-81A7-F815-A08407415A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7340000">
                  <a:off x="2048" y="1245"/>
                  <a:ext cx="32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2C368G0</a:t>
                  </a:r>
                </a:p>
              </p:txBody>
            </p:sp>
            <p:sp>
              <p:nvSpPr>
                <p:cNvPr id="292" name="Line 26">
                  <a:extLst>
                    <a:ext uri="{FF2B5EF4-FFF2-40B4-BE49-F238E27FC236}">
                      <a16:creationId xmlns:a16="http://schemas.microsoft.com/office/drawing/2014/main" id="{A060B442-52BC-DB23-0C65-959743C2348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149" y="1434"/>
                  <a:ext cx="17" cy="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93" name="Rectangle 27">
                  <a:extLst>
                    <a:ext uri="{FF2B5EF4-FFF2-40B4-BE49-F238E27FC236}">
                      <a16:creationId xmlns:a16="http://schemas.microsoft.com/office/drawing/2014/main" id="{EAA2F981-6EB5-7990-BEEE-EFF58703827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7520000">
                  <a:off x="2146" y="1281"/>
                  <a:ext cx="32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2C368G2</a:t>
                  </a:r>
                </a:p>
              </p:txBody>
            </p:sp>
            <p:sp>
              <p:nvSpPr>
                <p:cNvPr id="294" name="Line 28">
                  <a:extLst>
                    <a:ext uri="{FF2B5EF4-FFF2-40B4-BE49-F238E27FC236}">
                      <a16:creationId xmlns:a16="http://schemas.microsoft.com/office/drawing/2014/main" id="{CC653FBC-F0D2-D74B-72BE-E2008119E40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231" y="1468"/>
                  <a:ext cx="25" cy="5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95" name="Arc 29">
                  <a:extLst>
                    <a:ext uri="{FF2B5EF4-FFF2-40B4-BE49-F238E27FC236}">
                      <a16:creationId xmlns:a16="http://schemas.microsoft.com/office/drawing/2014/main" id="{678EC58C-427C-BED2-A54F-66CA6562067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489"/>
                  <a:ext cx="466" cy="1227"/>
                </a:xfrm>
                <a:custGeom>
                  <a:avLst/>
                  <a:gdLst>
                    <a:gd name="G0" fmla="+- 0 0 0"/>
                    <a:gd name="G1" fmla="+- 20409 0 0"/>
                    <a:gd name="G2" fmla="+- 21600 0 0"/>
                    <a:gd name="T0" fmla="*/ 7075 w 7752"/>
                    <a:gd name="T1" fmla="*/ 0 h 20409"/>
                    <a:gd name="T2" fmla="*/ 7752 w 7752"/>
                    <a:gd name="T3" fmla="*/ 248 h 20409"/>
                    <a:gd name="T4" fmla="*/ 0 w 7752"/>
                    <a:gd name="T5" fmla="*/ 20409 h 2040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752" h="20409" fill="none" extrusionOk="0">
                      <a:moveTo>
                        <a:pt x="7074" y="0"/>
                      </a:moveTo>
                      <a:cubicBezTo>
                        <a:pt x="7301" y="79"/>
                        <a:pt x="7527" y="161"/>
                        <a:pt x="7752" y="247"/>
                      </a:cubicBezTo>
                    </a:path>
                    <a:path w="7752" h="20409" stroke="0" extrusionOk="0">
                      <a:moveTo>
                        <a:pt x="7074" y="0"/>
                      </a:moveTo>
                      <a:cubicBezTo>
                        <a:pt x="7301" y="79"/>
                        <a:pt x="7527" y="161"/>
                        <a:pt x="7752" y="247"/>
                      </a:cubicBezTo>
                      <a:lnTo>
                        <a:pt x="0" y="20409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96" name="Arc 30">
                  <a:extLst>
                    <a:ext uri="{FF2B5EF4-FFF2-40B4-BE49-F238E27FC236}">
                      <a16:creationId xmlns:a16="http://schemas.microsoft.com/office/drawing/2014/main" id="{4791BD4A-9F9F-94FC-C7B4-E83651BADD3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504"/>
                  <a:ext cx="506" cy="1212"/>
                </a:xfrm>
                <a:custGeom>
                  <a:avLst/>
                  <a:gdLst>
                    <a:gd name="G0" fmla="+- 0 0 0"/>
                    <a:gd name="G1" fmla="+- 20161 0 0"/>
                    <a:gd name="G2" fmla="+- 21600 0 0"/>
                    <a:gd name="T0" fmla="*/ 7752 w 8418"/>
                    <a:gd name="T1" fmla="*/ 0 h 20161"/>
                    <a:gd name="T2" fmla="*/ 8418 w 8418"/>
                    <a:gd name="T3" fmla="*/ 269 h 20161"/>
                    <a:gd name="T4" fmla="*/ 0 w 8418"/>
                    <a:gd name="T5" fmla="*/ 20161 h 201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418" h="20161" fill="none" extrusionOk="0">
                      <a:moveTo>
                        <a:pt x="7752" y="-1"/>
                      </a:moveTo>
                      <a:cubicBezTo>
                        <a:pt x="7975" y="85"/>
                        <a:pt x="8197" y="175"/>
                        <a:pt x="8418" y="268"/>
                      </a:cubicBezTo>
                    </a:path>
                    <a:path w="8418" h="20161" stroke="0" extrusionOk="0">
                      <a:moveTo>
                        <a:pt x="7752" y="-1"/>
                      </a:moveTo>
                      <a:cubicBezTo>
                        <a:pt x="7975" y="85"/>
                        <a:pt x="8197" y="175"/>
                        <a:pt x="8418" y="268"/>
                      </a:cubicBezTo>
                      <a:lnTo>
                        <a:pt x="0" y="20161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97" name="Line 31">
                  <a:extLst>
                    <a:ext uri="{FF2B5EF4-FFF2-40B4-BE49-F238E27FC236}">
                      <a16:creationId xmlns:a16="http://schemas.microsoft.com/office/drawing/2014/main" id="{04E4E33F-FD41-C596-707A-61C963A65F6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167" y="1504"/>
                  <a:ext cx="23" cy="6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98" name="Arc 32">
                  <a:extLst>
                    <a:ext uri="{FF2B5EF4-FFF2-40B4-BE49-F238E27FC236}">
                      <a16:creationId xmlns:a16="http://schemas.microsoft.com/office/drawing/2014/main" id="{A5B20886-6DCB-EC21-F5F5-A87CBF4F47D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538"/>
                  <a:ext cx="378" cy="1178"/>
                </a:xfrm>
                <a:custGeom>
                  <a:avLst/>
                  <a:gdLst>
                    <a:gd name="G0" fmla="+- 0 0 0"/>
                    <a:gd name="G1" fmla="+- 20847 0 0"/>
                    <a:gd name="G2" fmla="+- 21600 0 0"/>
                    <a:gd name="T0" fmla="*/ 5653 w 6698"/>
                    <a:gd name="T1" fmla="*/ 0 h 20847"/>
                    <a:gd name="T2" fmla="*/ 6698 w 6698"/>
                    <a:gd name="T3" fmla="*/ 312 h 20847"/>
                    <a:gd name="T4" fmla="*/ 0 w 6698"/>
                    <a:gd name="T5" fmla="*/ 20847 h 2084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698" h="20847" fill="none" extrusionOk="0">
                      <a:moveTo>
                        <a:pt x="5653" y="-1"/>
                      </a:moveTo>
                      <a:cubicBezTo>
                        <a:pt x="6003" y="95"/>
                        <a:pt x="6352" y="199"/>
                        <a:pt x="6698" y="311"/>
                      </a:cubicBezTo>
                    </a:path>
                    <a:path w="6698" h="20847" stroke="0" extrusionOk="0">
                      <a:moveTo>
                        <a:pt x="5653" y="-1"/>
                      </a:moveTo>
                      <a:cubicBezTo>
                        <a:pt x="6003" y="95"/>
                        <a:pt x="6352" y="199"/>
                        <a:pt x="6698" y="311"/>
                      </a:cubicBezTo>
                      <a:lnTo>
                        <a:pt x="0" y="20847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99" name="Arc 33">
                  <a:extLst>
                    <a:ext uri="{FF2B5EF4-FFF2-40B4-BE49-F238E27FC236}">
                      <a16:creationId xmlns:a16="http://schemas.microsoft.com/office/drawing/2014/main" id="{41BA999C-6022-1AA6-CB02-D7C8D305758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556"/>
                  <a:ext cx="438" cy="1160"/>
                </a:xfrm>
                <a:custGeom>
                  <a:avLst/>
                  <a:gdLst>
                    <a:gd name="G0" fmla="+- 0 0 0"/>
                    <a:gd name="G1" fmla="+- 20535 0 0"/>
                    <a:gd name="G2" fmla="+- 21600 0 0"/>
                    <a:gd name="T0" fmla="*/ 6698 w 7753"/>
                    <a:gd name="T1" fmla="*/ 0 h 20535"/>
                    <a:gd name="T2" fmla="*/ 7753 w 7753"/>
                    <a:gd name="T3" fmla="*/ 374 h 20535"/>
                    <a:gd name="T4" fmla="*/ 0 w 7753"/>
                    <a:gd name="T5" fmla="*/ 20535 h 205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753" h="20535" fill="none" extrusionOk="0">
                      <a:moveTo>
                        <a:pt x="6698" y="-1"/>
                      </a:moveTo>
                      <a:cubicBezTo>
                        <a:pt x="7052" y="115"/>
                        <a:pt x="7404" y="240"/>
                        <a:pt x="7752" y="374"/>
                      </a:cubicBezTo>
                    </a:path>
                    <a:path w="7753" h="20535" stroke="0" extrusionOk="0">
                      <a:moveTo>
                        <a:pt x="6698" y="-1"/>
                      </a:moveTo>
                      <a:cubicBezTo>
                        <a:pt x="7052" y="115"/>
                        <a:pt x="7404" y="240"/>
                        <a:pt x="7752" y="374"/>
                      </a:cubicBezTo>
                      <a:lnTo>
                        <a:pt x="0" y="20535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00" name="Line 34">
                  <a:extLst>
                    <a:ext uri="{FF2B5EF4-FFF2-40B4-BE49-F238E27FC236}">
                      <a16:creationId xmlns:a16="http://schemas.microsoft.com/office/drawing/2014/main" id="{54C3167C-07A8-F86F-7423-7BDF39E360F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080" y="1554"/>
                  <a:ext cx="23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01" name="Arc 35">
                  <a:extLst>
                    <a:ext uri="{FF2B5EF4-FFF2-40B4-BE49-F238E27FC236}">
                      <a16:creationId xmlns:a16="http://schemas.microsoft.com/office/drawing/2014/main" id="{5F0A7EA0-8D42-26B1-82E1-AEAD4C95D98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574"/>
                  <a:ext cx="237" cy="1142"/>
                </a:xfrm>
                <a:custGeom>
                  <a:avLst/>
                  <a:gdLst>
                    <a:gd name="G0" fmla="+- 0 0 0"/>
                    <a:gd name="G1" fmla="+- 21494 0 0"/>
                    <a:gd name="G2" fmla="+- 21600 0 0"/>
                    <a:gd name="T0" fmla="*/ 2142 w 4453"/>
                    <a:gd name="T1" fmla="*/ 0 h 21494"/>
                    <a:gd name="T2" fmla="*/ 4453 w 4453"/>
                    <a:gd name="T3" fmla="*/ 358 h 21494"/>
                    <a:gd name="T4" fmla="*/ 0 w 4453"/>
                    <a:gd name="T5" fmla="*/ 21494 h 2149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453" h="21494" fill="none" extrusionOk="0">
                      <a:moveTo>
                        <a:pt x="2141" y="0"/>
                      </a:moveTo>
                      <a:cubicBezTo>
                        <a:pt x="2918" y="77"/>
                        <a:pt x="3689" y="197"/>
                        <a:pt x="4453" y="357"/>
                      </a:cubicBezTo>
                    </a:path>
                    <a:path w="4453" h="21494" stroke="0" extrusionOk="0">
                      <a:moveTo>
                        <a:pt x="2141" y="0"/>
                      </a:moveTo>
                      <a:cubicBezTo>
                        <a:pt x="2918" y="77"/>
                        <a:pt x="3689" y="197"/>
                        <a:pt x="4453" y="357"/>
                      </a:cubicBezTo>
                      <a:lnTo>
                        <a:pt x="0" y="21494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02" name="Arc 36">
                  <a:extLst>
                    <a:ext uri="{FF2B5EF4-FFF2-40B4-BE49-F238E27FC236}">
                      <a16:creationId xmlns:a16="http://schemas.microsoft.com/office/drawing/2014/main" id="{ADF7D6D1-3FC5-A072-3627-0E6C1AE7537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593"/>
                  <a:ext cx="355" cy="1123"/>
                </a:xfrm>
                <a:custGeom>
                  <a:avLst/>
                  <a:gdLst>
                    <a:gd name="G0" fmla="+- 0 0 0"/>
                    <a:gd name="G1" fmla="+- 21136 0 0"/>
                    <a:gd name="G2" fmla="+- 21600 0 0"/>
                    <a:gd name="T0" fmla="*/ 4453 w 6689"/>
                    <a:gd name="T1" fmla="*/ 0 h 21136"/>
                    <a:gd name="T2" fmla="*/ 6689 w 6689"/>
                    <a:gd name="T3" fmla="*/ 598 h 21136"/>
                    <a:gd name="T4" fmla="*/ 0 w 6689"/>
                    <a:gd name="T5" fmla="*/ 21136 h 211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689" h="21136" fill="none" extrusionOk="0">
                      <a:moveTo>
                        <a:pt x="4453" y="-1"/>
                      </a:moveTo>
                      <a:cubicBezTo>
                        <a:pt x="5208" y="159"/>
                        <a:pt x="5954" y="358"/>
                        <a:pt x="6689" y="597"/>
                      </a:cubicBezTo>
                    </a:path>
                    <a:path w="6689" h="21136" stroke="0" extrusionOk="0">
                      <a:moveTo>
                        <a:pt x="4453" y="-1"/>
                      </a:moveTo>
                      <a:cubicBezTo>
                        <a:pt x="5208" y="159"/>
                        <a:pt x="5954" y="358"/>
                        <a:pt x="6689" y="597"/>
                      </a:cubicBezTo>
                      <a:lnTo>
                        <a:pt x="0" y="21136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03" name="Line 37">
                  <a:extLst>
                    <a:ext uri="{FF2B5EF4-FFF2-40B4-BE49-F238E27FC236}">
                      <a16:creationId xmlns:a16="http://schemas.microsoft.com/office/drawing/2014/main" id="{EF4863A6-D156-6DFE-FDEE-021DBDEE836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929" y="1591"/>
                  <a:ext cx="32" cy="14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04" name="Rectangle 38">
                  <a:extLst>
                    <a:ext uri="{FF2B5EF4-FFF2-40B4-BE49-F238E27FC236}">
                      <a16:creationId xmlns:a16="http://schemas.microsoft.com/office/drawing/2014/main" id="{4C905F89-94C5-60E2-7B9C-937AF6B7FC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7760000">
                  <a:off x="2271" y="1352"/>
                  <a:ext cx="224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2</a:t>
                  </a:r>
                </a:p>
              </p:txBody>
            </p:sp>
            <p:sp>
              <p:nvSpPr>
                <p:cNvPr id="305" name="Line 39">
                  <a:extLst>
                    <a:ext uri="{FF2B5EF4-FFF2-40B4-BE49-F238E27FC236}">
                      <a16:creationId xmlns:a16="http://schemas.microsoft.com/office/drawing/2014/main" id="{6BF63F7C-67D7-835F-5D6C-D3D19524283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309" y="1490"/>
                  <a:ext cx="32" cy="6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06" name="Rectangle 40">
                  <a:extLst>
                    <a:ext uri="{FF2B5EF4-FFF2-40B4-BE49-F238E27FC236}">
                      <a16:creationId xmlns:a16="http://schemas.microsoft.com/office/drawing/2014/main" id="{EFE15A2B-893A-12E4-D249-0AE87F97113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8000000">
                  <a:off x="2363" y="1402"/>
                  <a:ext cx="224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3</a:t>
                  </a:r>
                </a:p>
              </p:txBody>
            </p:sp>
            <p:sp>
              <p:nvSpPr>
                <p:cNvPr id="307" name="Line 41">
                  <a:extLst>
                    <a:ext uri="{FF2B5EF4-FFF2-40B4-BE49-F238E27FC236}">
                      <a16:creationId xmlns:a16="http://schemas.microsoft.com/office/drawing/2014/main" id="{E488DEB3-D92D-D70D-AFBF-26D755E59E2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382" y="1536"/>
                  <a:ext cx="41" cy="6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08" name="Arc 42">
                  <a:extLst>
                    <a:ext uri="{FF2B5EF4-FFF2-40B4-BE49-F238E27FC236}">
                      <a16:creationId xmlns:a16="http://schemas.microsoft.com/office/drawing/2014/main" id="{FFAFA666-73F7-C1AB-431A-9C8D94094D4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556"/>
                  <a:ext cx="622" cy="1160"/>
                </a:xfrm>
                <a:custGeom>
                  <a:avLst/>
                  <a:gdLst>
                    <a:gd name="G0" fmla="+- 0 0 0"/>
                    <a:gd name="G1" fmla="+- 19293 0 0"/>
                    <a:gd name="G2" fmla="+- 21600 0 0"/>
                    <a:gd name="T0" fmla="*/ 9713 w 10340"/>
                    <a:gd name="T1" fmla="*/ 0 h 19293"/>
                    <a:gd name="T2" fmla="*/ 10340 w 10340"/>
                    <a:gd name="T3" fmla="*/ 329 h 19293"/>
                    <a:gd name="T4" fmla="*/ 0 w 10340"/>
                    <a:gd name="T5" fmla="*/ 19293 h 1929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340" h="19293" fill="none" extrusionOk="0">
                      <a:moveTo>
                        <a:pt x="9712" y="0"/>
                      </a:moveTo>
                      <a:cubicBezTo>
                        <a:pt x="9923" y="106"/>
                        <a:pt x="10132" y="215"/>
                        <a:pt x="10340" y="328"/>
                      </a:cubicBezTo>
                    </a:path>
                    <a:path w="10340" h="19293" stroke="0" extrusionOk="0">
                      <a:moveTo>
                        <a:pt x="9712" y="0"/>
                      </a:moveTo>
                      <a:cubicBezTo>
                        <a:pt x="9923" y="106"/>
                        <a:pt x="10132" y="215"/>
                        <a:pt x="10340" y="328"/>
                      </a:cubicBezTo>
                      <a:lnTo>
                        <a:pt x="0" y="19293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09" name="Arc 43">
                  <a:extLst>
                    <a:ext uri="{FF2B5EF4-FFF2-40B4-BE49-F238E27FC236}">
                      <a16:creationId xmlns:a16="http://schemas.microsoft.com/office/drawing/2014/main" id="{EBA4F436-D34E-4064-701C-8A8D2DF8E3E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576"/>
                  <a:ext cx="657" cy="1140"/>
                </a:xfrm>
                <a:custGeom>
                  <a:avLst/>
                  <a:gdLst>
                    <a:gd name="G0" fmla="+- 0 0 0"/>
                    <a:gd name="G1" fmla="+- 18964 0 0"/>
                    <a:gd name="G2" fmla="+- 21600 0 0"/>
                    <a:gd name="T0" fmla="*/ 10340 w 10934"/>
                    <a:gd name="T1" fmla="*/ 0 h 18964"/>
                    <a:gd name="T2" fmla="*/ 10934 w 10934"/>
                    <a:gd name="T3" fmla="*/ 336 h 18964"/>
                    <a:gd name="T4" fmla="*/ 0 w 10934"/>
                    <a:gd name="T5" fmla="*/ 18964 h 189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934" h="18964" fill="none" extrusionOk="0">
                      <a:moveTo>
                        <a:pt x="10340" y="-1"/>
                      </a:moveTo>
                      <a:cubicBezTo>
                        <a:pt x="10539" y="108"/>
                        <a:pt x="10737" y="220"/>
                        <a:pt x="10934" y="335"/>
                      </a:cubicBezTo>
                    </a:path>
                    <a:path w="10934" h="18964" stroke="0" extrusionOk="0">
                      <a:moveTo>
                        <a:pt x="10340" y="-1"/>
                      </a:moveTo>
                      <a:cubicBezTo>
                        <a:pt x="10539" y="108"/>
                        <a:pt x="10737" y="220"/>
                        <a:pt x="10934" y="335"/>
                      </a:cubicBezTo>
                      <a:lnTo>
                        <a:pt x="0" y="18964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10" name="Line 44">
                  <a:extLst>
                    <a:ext uri="{FF2B5EF4-FFF2-40B4-BE49-F238E27FC236}">
                      <a16:creationId xmlns:a16="http://schemas.microsoft.com/office/drawing/2014/main" id="{B7366FD6-0E5C-1F57-20DB-F745A731ADF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240" y="1577"/>
                  <a:ext cx="105" cy="19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11" name="Rectangle 45">
                  <a:extLst>
                    <a:ext uri="{FF2B5EF4-FFF2-40B4-BE49-F238E27FC236}">
                      <a16:creationId xmlns:a16="http://schemas.microsoft.com/office/drawing/2014/main" id="{AFB39C55-4FD1-99E1-4A99-7E2A794081B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8240000">
                  <a:off x="2433" y="1442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10</a:t>
                  </a:r>
                </a:p>
              </p:txBody>
            </p:sp>
            <p:sp>
              <p:nvSpPr>
                <p:cNvPr id="312" name="Line 46">
                  <a:extLst>
                    <a:ext uri="{FF2B5EF4-FFF2-40B4-BE49-F238E27FC236}">
                      <a16:creationId xmlns:a16="http://schemas.microsoft.com/office/drawing/2014/main" id="{044EFD09-C577-A167-3415-7CB0C400BA7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368" y="1582"/>
                  <a:ext cx="128" cy="18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13" name="Rectangle 47">
                  <a:extLst>
                    <a:ext uri="{FF2B5EF4-FFF2-40B4-BE49-F238E27FC236}">
                      <a16:creationId xmlns:a16="http://schemas.microsoft.com/office/drawing/2014/main" id="{0D696DFF-C983-275A-1A4B-0C8AED15183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8480000">
                  <a:off x="2516" y="1498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24</a:t>
                  </a:r>
                </a:p>
              </p:txBody>
            </p:sp>
            <p:sp>
              <p:nvSpPr>
                <p:cNvPr id="314" name="Line 48">
                  <a:extLst>
                    <a:ext uri="{FF2B5EF4-FFF2-40B4-BE49-F238E27FC236}">
                      <a16:creationId xmlns:a16="http://schemas.microsoft.com/office/drawing/2014/main" id="{7CBDF1CB-A655-27C4-71F0-AE1D911587A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478" y="1636"/>
                  <a:ext cx="96" cy="1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15" name="Rectangle 49">
                  <a:extLst>
                    <a:ext uri="{FF2B5EF4-FFF2-40B4-BE49-F238E27FC236}">
                      <a16:creationId xmlns:a16="http://schemas.microsoft.com/office/drawing/2014/main" id="{51190E1E-4226-EFAF-F887-C09D4FC5962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8720000">
                  <a:off x="2593" y="1568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23</a:t>
                  </a:r>
                </a:p>
              </p:txBody>
            </p:sp>
            <p:sp>
              <p:nvSpPr>
                <p:cNvPr id="316" name="Line 50">
                  <a:extLst>
                    <a:ext uri="{FF2B5EF4-FFF2-40B4-BE49-F238E27FC236}">
                      <a16:creationId xmlns:a16="http://schemas.microsoft.com/office/drawing/2014/main" id="{2B68C39D-77ED-DCB3-C349-52C9CE76D50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592" y="1696"/>
                  <a:ext cx="50" cy="5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17" name="Rectangle 51">
                  <a:extLst>
                    <a:ext uri="{FF2B5EF4-FFF2-40B4-BE49-F238E27FC236}">
                      <a16:creationId xmlns:a16="http://schemas.microsoft.com/office/drawing/2014/main" id="{1CF27F41-253A-AE85-A33B-39E6955C56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8900000">
                  <a:off x="2660" y="1632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27</a:t>
                  </a:r>
                </a:p>
              </p:txBody>
            </p:sp>
            <p:sp>
              <p:nvSpPr>
                <p:cNvPr id="318" name="Line 52">
                  <a:extLst>
                    <a:ext uri="{FF2B5EF4-FFF2-40B4-BE49-F238E27FC236}">
                      <a16:creationId xmlns:a16="http://schemas.microsoft.com/office/drawing/2014/main" id="{896343B9-A761-78E9-EA39-C976FE7F9D4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652" y="1760"/>
                  <a:ext cx="54" cy="5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19" name="Arc 53">
                  <a:extLst>
                    <a:ext uri="{FF2B5EF4-FFF2-40B4-BE49-F238E27FC236}">
                      <a16:creationId xmlns:a16="http://schemas.microsoft.com/office/drawing/2014/main" id="{19C182FD-D71D-61BD-A2C6-E09BAA88421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751"/>
                  <a:ext cx="899" cy="965"/>
                </a:xfrm>
                <a:custGeom>
                  <a:avLst/>
                  <a:gdLst>
                    <a:gd name="G0" fmla="+- 0 0 0"/>
                    <a:gd name="G1" fmla="+- 16059 0 0"/>
                    <a:gd name="G2" fmla="+- 21600 0 0"/>
                    <a:gd name="T0" fmla="*/ 14445 w 14955"/>
                    <a:gd name="T1" fmla="*/ 0 h 16059"/>
                    <a:gd name="T2" fmla="*/ 14955 w 14955"/>
                    <a:gd name="T3" fmla="*/ 473 h 16059"/>
                    <a:gd name="T4" fmla="*/ 0 w 14955"/>
                    <a:gd name="T5" fmla="*/ 16059 h 1605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955" h="16059" fill="none" extrusionOk="0">
                      <a:moveTo>
                        <a:pt x="14445" y="-1"/>
                      </a:moveTo>
                      <a:cubicBezTo>
                        <a:pt x="14617" y="154"/>
                        <a:pt x="14787" y="312"/>
                        <a:pt x="14954" y="473"/>
                      </a:cubicBezTo>
                    </a:path>
                    <a:path w="14955" h="16059" stroke="0" extrusionOk="0">
                      <a:moveTo>
                        <a:pt x="14445" y="-1"/>
                      </a:moveTo>
                      <a:cubicBezTo>
                        <a:pt x="14617" y="154"/>
                        <a:pt x="14787" y="312"/>
                        <a:pt x="14954" y="473"/>
                      </a:cubicBezTo>
                      <a:lnTo>
                        <a:pt x="0" y="16059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20" name="Arc 54">
                  <a:extLst>
                    <a:ext uri="{FF2B5EF4-FFF2-40B4-BE49-F238E27FC236}">
                      <a16:creationId xmlns:a16="http://schemas.microsoft.com/office/drawing/2014/main" id="{0C533190-A8E9-BE1C-0315-81F01FD6AA7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779"/>
                  <a:ext cx="931" cy="937"/>
                </a:xfrm>
                <a:custGeom>
                  <a:avLst/>
                  <a:gdLst>
                    <a:gd name="G0" fmla="+- 0 0 0"/>
                    <a:gd name="G1" fmla="+- 15586 0 0"/>
                    <a:gd name="G2" fmla="+- 21600 0 0"/>
                    <a:gd name="T0" fmla="*/ 14955 w 15488"/>
                    <a:gd name="T1" fmla="*/ 0 h 15586"/>
                    <a:gd name="T2" fmla="*/ 15488 w 15488"/>
                    <a:gd name="T3" fmla="*/ 530 h 15586"/>
                    <a:gd name="T4" fmla="*/ 0 w 15488"/>
                    <a:gd name="T5" fmla="*/ 15586 h 155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488" h="15586" fill="none" extrusionOk="0">
                      <a:moveTo>
                        <a:pt x="14954" y="0"/>
                      </a:moveTo>
                      <a:cubicBezTo>
                        <a:pt x="15135" y="173"/>
                        <a:pt x="15313" y="350"/>
                        <a:pt x="15487" y="530"/>
                      </a:cubicBezTo>
                    </a:path>
                    <a:path w="15488" h="15586" stroke="0" extrusionOk="0">
                      <a:moveTo>
                        <a:pt x="14954" y="0"/>
                      </a:moveTo>
                      <a:cubicBezTo>
                        <a:pt x="15135" y="173"/>
                        <a:pt x="15313" y="350"/>
                        <a:pt x="15487" y="530"/>
                      </a:cubicBezTo>
                      <a:lnTo>
                        <a:pt x="0" y="15586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21" name="Line 55">
                  <a:extLst>
                    <a:ext uri="{FF2B5EF4-FFF2-40B4-BE49-F238E27FC236}">
                      <a16:creationId xmlns:a16="http://schemas.microsoft.com/office/drawing/2014/main" id="{9710EDD4-5BD9-A624-AA75-9B2C05BECC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569" y="1783"/>
                  <a:ext cx="55" cy="5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22" name="Arc 56">
                  <a:extLst>
                    <a:ext uri="{FF2B5EF4-FFF2-40B4-BE49-F238E27FC236}">
                      <a16:creationId xmlns:a16="http://schemas.microsoft.com/office/drawing/2014/main" id="{4D736722-C064-C8FF-4E55-F5EE15EE3B5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756"/>
                  <a:ext cx="801" cy="960"/>
                </a:xfrm>
                <a:custGeom>
                  <a:avLst/>
                  <a:gdLst>
                    <a:gd name="G0" fmla="+- 0 0 0"/>
                    <a:gd name="G1" fmla="+- 16994 0 0"/>
                    <a:gd name="G2" fmla="+- 21600 0 0"/>
                    <a:gd name="T0" fmla="*/ 13333 w 14173"/>
                    <a:gd name="T1" fmla="*/ 0 h 16994"/>
                    <a:gd name="T2" fmla="*/ 14173 w 14173"/>
                    <a:gd name="T3" fmla="*/ 695 h 16994"/>
                    <a:gd name="T4" fmla="*/ 0 w 14173"/>
                    <a:gd name="T5" fmla="*/ 16994 h 1699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173" h="16994" fill="none" extrusionOk="0">
                      <a:moveTo>
                        <a:pt x="13332" y="0"/>
                      </a:moveTo>
                      <a:cubicBezTo>
                        <a:pt x="13618" y="224"/>
                        <a:pt x="13899" y="455"/>
                        <a:pt x="14173" y="694"/>
                      </a:cubicBezTo>
                    </a:path>
                    <a:path w="14173" h="16994" stroke="0" extrusionOk="0">
                      <a:moveTo>
                        <a:pt x="13332" y="0"/>
                      </a:moveTo>
                      <a:cubicBezTo>
                        <a:pt x="13618" y="224"/>
                        <a:pt x="13899" y="455"/>
                        <a:pt x="14173" y="694"/>
                      </a:cubicBezTo>
                      <a:lnTo>
                        <a:pt x="0" y="16994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23" name="Arc 57">
                  <a:extLst>
                    <a:ext uri="{FF2B5EF4-FFF2-40B4-BE49-F238E27FC236}">
                      <a16:creationId xmlns:a16="http://schemas.microsoft.com/office/drawing/2014/main" id="{DA1F98EB-2888-0C56-0C65-77F7688AAF3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795"/>
                  <a:ext cx="846" cy="921"/>
                </a:xfrm>
                <a:custGeom>
                  <a:avLst/>
                  <a:gdLst>
                    <a:gd name="G0" fmla="+- 0 0 0"/>
                    <a:gd name="G1" fmla="+- 16299 0 0"/>
                    <a:gd name="G2" fmla="+- 21600 0 0"/>
                    <a:gd name="T0" fmla="*/ 14173 w 14978"/>
                    <a:gd name="T1" fmla="*/ 0 h 16299"/>
                    <a:gd name="T2" fmla="*/ 14978 w 14978"/>
                    <a:gd name="T3" fmla="*/ 736 h 16299"/>
                    <a:gd name="T4" fmla="*/ 0 w 14978"/>
                    <a:gd name="T5" fmla="*/ 16299 h 1629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978" h="16299" fill="none" extrusionOk="0">
                      <a:moveTo>
                        <a:pt x="14173" y="-1"/>
                      </a:moveTo>
                      <a:cubicBezTo>
                        <a:pt x="14447" y="238"/>
                        <a:pt x="14716" y="483"/>
                        <a:pt x="14978" y="735"/>
                      </a:cubicBezTo>
                    </a:path>
                    <a:path w="14978" h="16299" stroke="0" extrusionOk="0">
                      <a:moveTo>
                        <a:pt x="14173" y="-1"/>
                      </a:moveTo>
                      <a:cubicBezTo>
                        <a:pt x="14447" y="238"/>
                        <a:pt x="14716" y="483"/>
                        <a:pt x="14978" y="735"/>
                      </a:cubicBezTo>
                      <a:lnTo>
                        <a:pt x="0" y="16299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24" name="Line 58">
                  <a:extLst>
                    <a:ext uri="{FF2B5EF4-FFF2-40B4-BE49-F238E27FC236}">
                      <a16:creationId xmlns:a16="http://schemas.microsoft.com/office/drawing/2014/main" id="{DE0F71D9-CDC2-F4A7-2591-C103D920A86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478" y="1792"/>
                  <a:ext cx="50" cy="5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25" name="Arc 59">
                  <a:extLst>
                    <a:ext uri="{FF2B5EF4-FFF2-40B4-BE49-F238E27FC236}">
                      <a16:creationId xmlns:a16="http://schemas.microsoft.com/office/drawing/2014/main" id="{9A7B4609-6411-1CAB-07C6-B5A0D9D7905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769"/>
                  <a:ext cx="704" cy="947"/>
                </a:xfrm>
                <a:custGeom>
                  <a:avLst/>
                  <a:gdLst>
                    <a:gd name="G0" fmla="+- 0 0 0"/>
                    <a:gd name="G1" fmla="+- 17817 0 0"/>
                    <a:gd name="G2" fmla="+- 21600 0 0"/>
                    <a:gd name="T0" fmla="*/ 12211 w 13253"/>
                    <a:gd name="T1" fmla="*/ 0 h 17817"/>
                    <a:gd name="T2" fmla="*/ 13253 w 13253"/>
                    <a:gd name="T3" fmla="*/ 761 h 17817"/>
                    <a:gd name="T4" fmla="*/ 0 w 13253"/>
                    <a:gd name="T5" fmla="*/ 17817 h 1781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253" h="17817" fill="none" extrusionOk="0">
                      <a:moveTo>
                        <a:pt x="12211" y="-1"/>
                      </a:moveTo>
                      <a:cubicBezTo>
                        <a:pt x="12565" y="243"/>
                        <a:pt x="12913" y="496"/>
                        <a:pt x="13253" y="760"/>
                      </a:cubicBezTo>
                    </a:path>
                    <a:path w="13253" h="17817" stroke="0" extrusionOk="0">
                      <a:moveTo>
                        <a:pt x="12211" y="-1"/>
                      </a:moveTo>
                      <a:cubicBezTo>
                        <a:pt x="12565" y="243"/>
                        <a:pt x="12913" y="496"/>
                        <a:pt x="13253" y="760"/>
                      </a:cubicBezTo>
                      <a:lnTo>
                        <a:pt x="0" y="17817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26" name="Arc 60">
                  <a:extLst>
                    <a:ext uri="{FF2B5EF4-FFF2-40B4-BE49-F238E27FC236}">
                      <a16:creationId xmlns:a16="http://schemas.microsoft.com/office/drawing/2014/main" id="{6967E0EB-059C-B70F-11A3-C9462797EE2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810"/>
                  <a:ext cx="754" cy="906"/>
                </a:xfrm>
                <a:custGeom>
                  <a:avLst/>
                  <a:gdLst>
                    <a:gd name="G0" fmla="+- 0 0 0"/>
                    <a:gd name="G1" fmla="+- 17056 0 0"/>
                    <a:gd name="G2" fmla="+- 21600 0 0"/>
                    <a:gd name="T0" fmla="*/ 13253 w 14186"/>
                    <a:gd name="T1" fmla="*/ 0 h 17056"/>
                    <a:gd name="T2" fmla="*/ 14186 w 14186"/>
                    <a:gd name="T3" fmla="*/ 768 h 17056"/>
                    <a:gd name="T4" fmla="*/ 0 w 14186"/>
                    <a:gd name="T5" fmla="*/ 17056 h 170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186" h="17056" fill="none" extrusionOk="0">
                      <a:moveTo>
                        <a:pt x="13253" y="-1"/>
                      </a:moveTo>
                      <a:cubicBezTo>
                        <a:pt x="13571" y="247"/>
                        <a:pt x="13882" y="503"/>
                        <a:pt x="14186" y="767"/>
                      </a:cubicBezTo>
                    </a:path>
                    <a:path w="14186" h="17056" stroke="0" extrusionOk="0">
                      <a:moveTo>
                        <a:pt x="13253" y="-1"/>
                      </a:moveTo>
                      <a:cubicBezTo>
                        <a:pt x="13571" y="247"/>
                        <a:pt x="13882" y="503"/>
                        <a:pt x="14186" y="767"/>
                      </a:cubicBezTo>
                      <a:lnTo>
                        <a:pt x="0" y="17056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27" name="Line 61">
                  <a:extLst>
                    <a:ext uri="{FF2B5EF4-FFF2-40B4-BE49-F238E27FC236}">
                      <a16:creationId xmlns:a16="http://schemas.microsoft.com/office/drawing/2014/main" id="{96E67575-BE5A-A6D7-A708-196AA3A0A1C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382" y="1806"/>
                  <a:ext cx="46" cy="5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28" name="Arc 62">
                  <a:extLst>
                    <a:ext uri="{FF2B5EF4-FFF2-40B4-BE49-F238E27FC236}">
                      <a16:creationId xmlns:a16="http://schemas.microsoft.com/office/drawing/2014/main" id="{4FF7AA6C-FB78-F992-8304-44660B19EE3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773"/>
                  <a:ext cx="587" cy="943"/>
                </a:xfrm>
                <a:custGeom>
                  <a:avLst/>
                  <a:gdLst>
                    <a:gd name="G0" fmla="+- 0 0 0"/>
                    <a:gd name="G1" fmla="+- 18959 0 0"/>
                    <a:gd name="G2" fmla="+- 21600 0 0"/>
                    <a:gd name="T0" fmla="*/ 10349 w 11799"/>
                    <a:gd name="T1" fmla="*/ 0 h 18959"/>
                    <a:gd name="T2" fmla="*/ 11799 w 11799"/>
                    <a:gd name="T3" fmla="*/ 867 h 18959"/>
                    <a:gd name="T4" fmla="*/ 0 w 11799"/>
                    <a:gd name="T5" fmla="*/ 18959 h 1895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799" h="18959" fill="none" extrusionOk="0">
                      <a:moveTo>
                        <a:pt x="10349" y="-1"/>
                      </a:moveTo>
                      <a:cubicBezTo>
                        <a:pt x="10843" y="269"/>
                        <a:pt x="11327" y="558"/>
                        <a:pt x="11799" y="866"/>
                      </a:cubicBezTo>
                    </a:path>
                    <a:path w="11799" h="18959" stroke="0" extrusionOk="0">
                      <a:moveTo>
                        <a:pt x="10349" y="-1"/>
                      </a:moveTo>
                      <a:cubicBezTo>
                        <a:pt x="10843" y="269"/>
                        <a:pt x="11327" y="558"/>
                        <a:pt x="11799" y="866"/>
                      </a:cubicBezTo>
                      <a:lnTo>
                        <a:pt x="0" y="18959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29" name="Arc 63">
                  <a:extLst>
                    <a:ext uri="{FF2B5EF4-FFF2-40B4-BE49-F238E27FC236}">
                      <a16:creationId xmlns:a16="http://schemas.microsoft.com/office/drawing/2014/main" id="{93396CC9-AF6B-B2DA-8195-777111A988C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816"/>
                  <a:ext cx="657" cy="900"/>
                </a:xfrm>
                <a:custGeom>
                  <a:avLst/>
                  <a:gdLst>
                    <a:gd name="G0" fmla="+- 0 0 0"/>
                    <a:gd name="G1" fmla="+- 18092 0 0"/>
                    <a:gd name="G2" fmla="+- 21600 0 0"/>
                    <a:gd name="T0" fmla="*/ 11799 w 13212"/>
                    <a:gd name="T1" fmla="*/ 0 h 18092"/>
                    <a:gd name="T2" fmla="*/ 13212 w 13212"/>
                    <a:gd name="T3" fmla="*/ 1004 h 18092"/>
                    <a:gd name="T4" fmla="*/ 0 w 13212"/>
                    <a:gd name="T5" fmla="*/ 18092 h 1809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212" h="18092" fill="none" extrusionOk="0">
                      <a:moveTo>
                        <a:pt x="11799" y="-1"/>
                      </a:moveTo>
                      <a:cubicBezTo>
                        <a:pt x="12283" y="315"/>
                        <a:pt x="12754" y="650"/>
                        <a:pt x="13212" y="1003"/>
                      </a:cubicBezTo>
                    </a:path>
                    <a:path w="13212" h="18092" stroke="0" extrusionOk="0">
                      <a:moveTo>
                        <a:pt x="11799" y="-1"/>
                      </a:moveTo>
                      <a:cubicBezTo>
                        <a:pt x="12283" y="315"/>
                        <a:pt x="12754" y="650"/>
                        <a:pt x="13212" y="1003"/>
                      </a:cubicBezTo>
                      <a:lnTo>
                        <a:pt x="0" y="18092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30" name="Line 64">
                  <a:extLst>
                    <a:ext uri="{FF2B5EF4-FFF2-40B4-BE49-F238E27FC236}">
                      <a16:creationId xmlns:a16="http://schemas.microsoft.com/office/drawing/2014/main" id="{0EA291B0-3948-64FD-D453-75458983B75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272" y="1815"/>
                  <a:ext cx="41" cy="6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31" name="Arc 65">
                  <a:extLst>
                    <a:ext uri="{FF2B5EF4-FFF2-40B4-BE49-F238E27FC236}">
                      <a16:creationId xmlns:a16="http://schemas.microsoft.com/office/drawing/2014/main" id="{E102E035-F878-93C2-9291-94B7CCDCF8E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736"/>
                  <a:ext cx="384" cy="980"/>
                </a:xfrm>
                <a:custGeom>
                  <a:avLst/>
                  <a:gdLst>
                    <a:gd name="G0" fmla="+- 0 0 0"/>
                    <a:gd name="G1" fmla="+- 21141 0 0"/>
                    <a:gd name="G2" fmla="+- 21600 0 0"/>
                    <a:gd name="T0" fmla="*/ 4427 w 8289"/>
                    <a:gd name="T1" fmla="*/ 0 h 21141"/>
                    <a:gd name="T2" fmla="*/ 8289 w 8289"/>
                    <a:gd name="T3" fmla="*/ 1195 h 21141"/>
                    <a:gd name="T4" fmla="*/ 0 w 8289"/>
                    <a:gd name="T5" fmla="*/ 21141 h 2114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289" h="21141" fill="none" extrusionOk="0">
                      <a:moveTo>
                        <a:pt x="4427" y="-1"/>
                      </a:moveTo>
                      <a:cubicBezTo>
                        <a:pt x="5748" y="276"/>
                        <a:pt x="7041" y="676"/>
                        <a:pt x="8289" y="1194"/>
                      </a:cubicBezTo>
                    </a:path>
                    <a:path w="8289" h="21141" stroke="0" extrusionOk="0">
                      <a:moveTo>
                        <a:pt x="4427" y="-1"/>
                      </a:moveTo>
                      <a:cubicBezTo>
                        <a:pt x="5748" y="276"/>
                        <a:pt x="7041" y="676"/>
                        <a:pt x="8289" y="1194"/>
                      </a:cubicBezTo>
                      <a:lnTo>
                        <a:pt x="0" y="21141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32" name="Arc 66">
                  <a:extLst>
                    <a:ext uri="{FF2B5EF4-FFF2-40B4-BE49-F238E27FC236}">
                      <a16:creationId xmlns:a16="http://schemas.microsoft.com/office/drawing/2014/main" id="{6707064E-524E-4A84-0CC4-F4E5D6D819A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791"/>
                  <a:ext cx="549" cy="925"/>
                </a:xfrm>
                <a:custGeom>
                  <a:avLst/>
                  <a:gdLst>
                    <a:gd name="G0" fmla="+- 0 0 0"/>
                    <a:gd name="G1" fmla="+- 19946 0 0"/>
                    <a:gd name="G2" fmla="+- 21600 0 0"/>
                    <a:gd name="T0" fmla="*/ 8289 w 11832"/>
                    <a:gd name="T1" fmla="*/ 0 h 19946"/>
                    <a:gd name="T2" fmla="*/ 11832 w 11832"/>
                    <a:gd name="T3" fmla="*/ 1875 h 19946"/>
                    <a:gd name="T4" fmla="*/ 0 w 11832"/>
                    <a:gd name="T5" fmla="*/ 19946 h 199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832" h="19946" fill="none" extrusionOk="0">
                      <a:moveTo>
                        <a:pt x="8289" y="-1"/>
                      </a:moveTo>
                      <a:cubicBezTo>
                        <a:pt x="9525" y="513"/>
                        <a:pt x="10711" y="1141"/>
                        <a:pt x="11832" y="1874"/>
                      </a:cubicBezTo>
                    </a:path>
                    <a:path w="11832" h="19946" stroke="0" extrusionOk="0">
                      <a:moveTo>
                        <a:pt x="8289" y="-1"/>
                      </a:moveTo>
                      <a:cubicBezTo>
                        <a:pt x="9525" y="513"/>
                        <a:pt x="10711" y="1141"/>
                        <a:pt x="11832" y="1874"/>
                      </a:cubicBezTo>
                      <a:lnTo>
                        <a:pt x="0" y="19946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33" name="Line 67">
                  <a:extLst>
                    <a:ext uri="{FF2B5EF4-FFF2-40B4-BE49-F238E27FC236}">
                      <a16:creationId xmlns:a16="http://schemas.microsoft.com/office/drawing/2014/main" id="{737ADAB6-0874-B805-113C-554796FFB9E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080" y="1792"/>
                  <a:ext cx="28" cy="6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34" name="Rectangle 68">
                  <a:extLst>
                    <a:ext uri="{FF2B5EF4-FFF2-40B4-BE49-F238E27FC236}">
                      <a16:creationId xmlns:a16="http://schemas.microsoft.com/office/drawing/2014/main" id="{6B8DC985-FD79-5935-3359-F224067CB6F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9140000">
                  <a:off x="2712" y="1691"/>
                  <a:ext cx="35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1A749T13</a:t>
                  </a:r>
                </a:p>
              </p:txBody>
            </p:sp>
            <p:sp>
              <p:nvSpPr>
                <p:cNvPr id="335" name="Line 69">
                  <a:extLst>
                    <a:ext uri="{FF2B5EF4-FFF2-40B4-BE49-F238E27FC236}">
                      <a16:creationId xmlns:a16="http://schemas.microsoft.com/office/drawing/2014/main" id="{9F104C47-111B-ABBF-29D0-51EAC60433B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712" y="1842"/>
                  <a:ext cx="44" cy="3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36" name="Rectangle 70">
                  <a:extLst>
                    <a:ext uri="{FF2B5EF4-FFF2-40B4-BE49-F238E27FC236}">
                      <a16:creationId xmlns:a16="http://schemas.microsoft.com/office/drawing/2014/main" id="{5A4E2C27-2880-1C32-7CD6-5953FABFED2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9380000">
                  <a:off x="2771" y="1764"/>
                  <a:ext cx="35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1A751T11</a:t>
                  </a:r>
                </a:p>
              </p:txBody>
            </p:sp>
            <p:sp>
              <p:nvSpPr>
                <p:cNvPr id="337" name="Line 71">
                  <a:extLst>
                    <a:ext uri="{FF2B5EF4-FFF2-40B4-BE49-F238E27FC236}">
                      <a16:creationId xmlns:a16="http://schemas.microsoft.com/office/drawing/2014/main" id="{3D1551DB-5182-7775-B406-8CE0127CDFF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766" y="1909"/>
                  <a:ext cx="45" cy="3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38" name="Arc 72">
                  <a:extLst>
                    <a:ext uri="{FF2B5EF4-FFF2-40B4-BE49-F238E27FC236}">
                      <a16:creationId xmlns:a16="http://schemas.microsoft.com/office/drawing/2014/main" id="{D907CAB8-1DE5-8CE3-0069-58889C7824F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876"/>
                  <a:ext cx="1015" cy="840"/>
                </a:xfrm>
                <a:custGeom>
                  <a:avLst/>
                  <a:gdLst>
                    <a:gd name="G0" fmla="+- 0 0 0"/>
                    <a:gd name="G1" fmla="+- 13978 0 0"/>
                    <a:gd name="G2" fmla="+- 21600 0 0"/>
                    <a:gd name="T0" fmla="*/ 16468 w 16877"/>
                    <a:gd name="T1" fmla="*/ 0 h 13978"/>
                    <a:gd name="T2" fmla="*/ 16877 w 16877"/>
                    <a:gd name="T3" fmla="*/ 497 h 13978"/>
                    <a:gd name="T4" fmla="*/ 0 w 16877"/>
                    <a:gd name="T5" fmla="*/ 13978 h 1397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877" h="13978" fill="none" extrusionOk="0">
                      <a:moveTo>
                        <a:pt x="16467" y="0"/>
                      </a:moveTo>
                      <a:cubicBezTo>
                        <a:pt x="16606" y="163"/>
                        <a:pt x="16742" y="329"/>
                        <a:pt x="16876" y="497"/>
                      </a:cubicBezTo>
                    </a:path>
                    <a:path w="16877" h="13978" stroke="0" extrusionOk="0">
                      <a:moveTo>
                        <a:pt x="16467" y="0"/>
                      </a:moveTo>
                      <a:cubicBezTo>
                        <a:pt x="16606" y="163"/>
                        <a:pt x="16742" y="329"/>
                        <a:pt x="16876" y="497"/>
                      </a:cubicBezTo>
                      <a:lnTo>
                        <a:pt x="0" y="13978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39" name="Arc 73">
                  <a:extLst>
                    <a:ext uri="{FF2B5EF4-FFF2-40B4-BE49-F238E27FC236}">
                      <a16:creationId xmlns:a16="http://schemas.microsoft.com/office/drawing/2014/main" id="{0B21C132-A351-24AB-2603-630D41348E0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906"/>
                  <a:ext cx="1043" cy="810"/>
                </a:xfrm>
                <a:custGeom>
                  <a:avLst/>
                  <a:gdLst>
                    <a:gd name="G0" fmla="+- 0 0 0"/>
                    <a:gd name="G1" fmla="+- 13481 0 0"/>
                    <a:gd name="G2" fmla="+- 21600 0 0"/>
                    <a:gd name="T0" fmla="*/ 16877 w 17348"/>
                    <a:gd name="T1" fmla="*/ 0 h 13481"/>
                    <a:gd name="T2" fmla="*/ 17348 w 17348"/>
                    <a:gd name="T3" fmla="*/ 612 h 13481"/>
                    <a:gd name="T4" fmla="*/ 0 w 17348"/>
                    <a:gd name="T5" fmla="*/ 13481 h 1348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348" h="13481" fill="none" extrusionOk="0">
                      <a:moveTo>
                        <a:pt x="16876" y="0"/>
                      </a:moveTo>
                      <a:cubicBezTo>
                        <a:pt x="17037" y="201"/>
                        <a:pt x="17194" y="405"/>
                        <a:pt x="17347" y="612"/>
                      </a:cubicBezTo>
                    </a:path>
                    <a:path w="17348" h="13481" stroke="0" extrusionOk="0">
                      <a:moveTo>
                        <a:pt x="16876" y="0"/>
                      </a:moveTo>
                      <a:cubicBezTo>
                        <a:pt x="17037" y="201"/>
                        <a:pt x="17194" y="405"/>
                        <a:pt x="17347" y="612"/>
                      </a:cubicBezTo>
                      <a:lnTo>
                        <a:pt x="0" y="13481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40" name="Line 74">
                  <a:extLst>
                    <a:ext uri="{FF2B5EF4-FFF2-40B4-BE49-F238E27FC236}">
                      <a16:creationId xmlns:a16="http://schemas.microsoft.com/office/drawing/2014/main" id="{13FF357A-5AC9-5A3C-EBAA-235A0C1DC0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446" y="1911"/>
                  <a:ext cx="292" cy="23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41" name="Arc 75">
                  <a:extLst>
                    <a:ext uri="{FF2B5EF4-FFF2-40B4-BE49-F238E27FC236}">
                      <a16:creationId xmlns:a16="http://schemas.microsoft.com/office/drawing/2014/main" id="{13FCF6A3-48B7-ACE8-FAA3-25CE95D46DF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863"/>
                  <a:ext cx="557" cy="853"/>
                </a:xfrm>
                <a:custGeom>
                  <a:avLst/>
                  <a:gdLst>
                    <a:gd name="G0" fmla="+- 0 0 0"/>
                    <a:gd name="G1" fmla="+- 19960 0 0"/>
                    <a:gd name="G2" fmla="+- 21600 0 0"/>
                    <a:gd name="T0" fmla="*/ 8256 w 13024"/>
                    <a:gd name="T1" fmla="*/ 0 h 19960"/>
                    <a:gd name="T2" fmla="*/ 13024 w 13024"/>
                    <a:gd name="T3" fmla="*/ 2728 h 19960"/>
                    <a:gd name="T4" fmla="*/ 0 w 13024"/>
                    <a:gd name="T5" fmla="*/ 19960 h 199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024" h="19960" fill="none" extrusionOk="0">
                      <a:moveTo>
                        <a:pt x="8255" y="0"/>
                      </a:moveTo>
                      <a:cubicBezTo>
                        <a:pt x="9954" y="702"/>
                        <a:pt x="11557" y="1619"/>
                        <a:pt x="13023" y="2728"/>
                      </a:cubicBezTo>
                    </a:path>
                    <a:path w="13024" h="19960" stroke="0" extrusionOk="0">
                      <a:moveTo>
                        <a:pt x="8255" y="0"/>
                      </a:moveTo>
                      <a:cubicBezTo>
                        <a:pt x="9954" y="702"/>
                        <a:pt x="11557" y="1619"/>
                        <a:pt x="13023" y="2728"/>
                      </a:cubicBezTo>
                      <a:lnTo>
                        <a:pt x="0" y="1996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42" name="Arc 76">
                  <a:extLst>
                    <a:ext uri="{FF2B5EF4-FFF2-40B4-BE49-F238E27FC236}">
                      <a16:creationId xmlns:a16="http://schemas.microsoft.com/office/drawing/2014/main" id="{43B19509-4D40-3AB4-97AA-BA5C05A0E17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1979"/>
                  <a:ext cx="721" cy="737"/>
                </a:xfrm>
                <a:custGeom>
                  <a:avLst/>
                  <a:gdLst>
                    <a:gd name="G0" fmla="+- 0 0 0"/>
                    <a:gd name="G1" fmla="+- 17232 0 0"/>
                    <a:gd name="G2" fmla="+- 21600 0 0"/>
                    <a:gd name="T0" fmla="*/ 13024 w 16874"/>
                    <a:gd name="T1" fmla="*/ 0 h 17232"/>
                    <a:gd name="T2" fmla="*/ 16874 w 16874"/>
                    <a:gd name="T3" fmla="*/ 3747 h 17232"/>
                    <a:gd name="T4" fmla="*/ 0 w 16874"/>
                    <a:gd name="T5" fmla="*/ 17232 h 172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874" h="17232" fill="none" extrusionOk="0">
                      <a:moveTo>
                        <a:pt x="13023" y="0"/>
                      </a:moveTo>
                      <a:cubicBezTo>
                        <a:pt x="14458" y="1084"/>
                        <a:pt x="15751" y="2342"/>
                        <a:pt x="16873" y="3747"/>
                      </a:cubicBezTo>
                    </a:path>
                    <a:path w="16874" h="17232" stroke="0" extrusionOk="0">
                      <a:moveTo>
                        <a:pt x="13023" y="0"/>
                      </a:moveTo>
                      <a:cubicBezTo>
                        <a:pt x="14458" y="1084"/>
                        <a:pt x="15751" y="2342"/>
                        <a:pt x="16873" y="3747"/>
                      </a:cubicBezTo>
                      <a:lnTo>
                        <a:pt x="0" y="17232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43" name="Line 77">
                  <a:extLst>
                    <a:ext uri="{FF2B5EF4-FFF2-40B4-BE49-F238E27FC236}">
                      <a16:creationId xmlns:a16="http://schemas.microsoft.com/office/drawing/2014/main" id="{36A0906D-589A-D126-AB37-C76B54DED3A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236" y="1979"/>
                  <a:ext cx="45" cy="6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44" name="Rectangle 78">
                  <a:extLst>
                    <a:ext uri="{FF2B5EF4-FFF2-40B4-BE49-F238E27FC236}">
                      <a16:creationId xmlns:a16="http://schemas.microsoft.com/office/drawing/2014/main" id="{10EB02B6-B02E-1418-6432-6874B1597FC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9620000">
                  <a:off x="2823" y="1850"/>
                  <a:ext cx="354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solidFill>
                        <a:srgbClr val="0070C0"/>
                      </a:solidFill>
                      <a:effectLst/>
                      <a:latin typeface="Arial" panose="020B0604020202020204" pitchFamily="34" charset="0"/>
                    </a:rPr>
                    <a:t>Lj1C1221T6</a:t>
                  </a:r>
                </a:p>
              </p:txBody>
            </p:sp>
            <p:sp>
              <p:nvSpPr>
                <p:cNvPr id="345" name="Line 79">
                  <a:extLst>
                    <a:ext uri="{FF2B5EF4-FFF2-40B4-BE49-F238E27FC236}">
                      <a16:creationId xmlns:a16="http://schemas.microsoft.com/office/drawing/2014/main" id="{74127217-D2B2-0835-9EA9-E072C9BA04A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812" y="1984"/>
                  <a:ext cx="49" cy="3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46" name="Rectangle 80">
                  <a:extLst>
                    <a:ext uri="{FF2B5EF4-FFF2-40B4-BE49-F238E27FC236}">
                      <a16:creationId xmlns:a16="http://schemas.microsoft.com/office/drawing/2014/main" id="{A7D14FD2-5F55-A75E-96AA-E62ECA0C348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9860000">
                  <a:off x="2888" y="1943"/>
                  <a:ext cx="3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</a:rPr>
                    <a:t>Lj5C695T2</a:t>
                  </a:r>
                </a:p>
              </p:txBody>
            </p:sp>
            <p:sp>
              <p:nvSpPr>
                <p:cNvPr id="347" name="Line 81">
                  <a:extLst>
                    <a:ext uri="{FF2B5EF4-FFF2-40B4-BE49-F238E27FC236}">
                      <a16:creationId xmlns:a16="http://schemas.microsoft.com/office/drawing/2014/main" id="{1622B7AF-F76F-7B89-611A-E164CBC83BA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862" y="2059"/>
                  <a:ext cx="56" cy="2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48" name="Arc 82">
                  <a:extLst>
                    <a:ext uri="{FF2B5EF4-FFF2-40B4-BE49-F238E27FC236}">
                      <a16:creationId xmlns:a16="http://schemas.microsoft.com/office/drawing/2014/main" id="{B655105A-3F98-52E1-76DC-601212BBC3F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015"/>
                  <a:ext cx="1116" cy="701"/>
                </a:xfrm>
                <a:custGeom>
                  <a:avLst/>
                  <a:gdLst>
                    <a:gd name="G0" fmla="+- 0 0 0"/>
                    <a:gd name="G1" fmla="+- 11657 0 0"/>
                    <a:gd name="G2" fmla="+- 21600 0 0"/>
                    <a:gd name="T0" fmla="*/ 18185 w 18566"/>
                    <a:gd name="T1" fmla="*/ 0 h 11657"/>
                    <a:gd name="T2" fmla="*/ 18566 w 18566"/>
                    <a:gd name="T3" fmla="*/ 617 h 11657"/>
                    <a:gd name="T4" fmla="*/ 0 w 18566"/>
                    <a:gd name="T5" fmla="*/ 11657 h 116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566" h="11657" fill="none" extrusionOk="0">
                      <a:moveTo>
                        <a:pt x="18184" y="0"/>
                      </a:moveTo>
                      <a:cubicBezTo>
                        <a:pt x="18315" y="203"/>
                        <a:pt x="18442" y="409"/>
                        <a:pt x="18565" y="617"/>
                      </a:cubicBezTo>
                    </a:path>
                    <a:path w="18566" h="11657" stroke="0" extrusionOk="0">
                      <a:moveTo>
                        <a:pt x="18184" y="0"/>
                      </a:moveTo>
                      <a:cubicBezTo>
                        <a:pt x="18315" y="203"/>
                        <a:pt x="18442" y="409"/>
                        <a:pt x="18565" y="617"/>
                      </a:cubicBezTo>
                      <a:lnTo>
                        <a:pt x="0" y="11657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49" name="Arc 83">
                  <a:extLst>
                    <a:ext uri="{FF2B5EF4-FFF2-40B4-BE49-F238E27FC236}">
                      <a16:creationId xmlns:a16="http://schemas.microsoft.com/office/drawing/2014/main" id="{8AB9BD90-5050-7F3D-F7EE-6918984E645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052"/>
                  <a:ext cx="1137" cy="664"/>
                </a:xfrm>
                <a:custGeom>
                  <a:avLst/>
                  <a:gdLst>
                    <a:gd name="G0" fmla="+- 0 0 0"/>
                    <a:gd name="G1" fmla="+- 11040 0 0"/>
                    <a:gd name="G2" fmla="+- 21600 0 0"/>
                    <a:gd name="T0" fmla="*/ 18566 w 18919"/>
                    <a:gd name="T1" fmla="*/ 0 h 11040"/>
                    <a:gd name="T2" fmla="*/ 18919 w 18919"/>
                    <a:gd name="T3" fmla="*/ 617 h 11040"/>
                    <a:gd name="T4" fmla="*/ 0 w 18919"/>
                    <a:gd name="T5" fmla="*/ 11040 h 110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919" h="11040" fill="none" extrusionOk="0">
                      <a:moveTo>
                        <a:pt x="18565" y="0"/>
                      </a:moveTo>
                      <a:cubicBezTo>
                        <a:pt x="18686" y="203"/>
                        <a:pt x="18804" y="409"/>
                        <a:pt x="18918" y="617"/>
                      </a:cubicBezTo>
                    </a:path>
                    <a:path w="18919" h="11040" stroke="0" extrusionOk="0">
                      <a:moveTo>
                        <a:pt x="18565" y="0"/>
                      </a:moveTo>
                      <a:cubicBezTo>
                        <a:pt x="18686" y="203"/>
                        <a:pt x="18804" y="409"/>
                        <a:pt x="18918" y="617"/>
                      </a:cubicBezTo>
                      <a:lnTo>
                        <a:pt x="0" y="1104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50" name="Line 84">
                  <a:extLst>
                    <a:ext uri="{FF2B5EF4-FFF2-40B4-BE49-F238E27FC236}">
                      <a16:creationId xmlns:a16="http://schemas.microsoft.com/office/drawing/2014/main" id="{2E3E11DA-1B96-EE0C-7EE8-5D2534016E7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455" y="2053"/>
                  <a:ext cx="384" cy="22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51" name="Arc 85">
                  <a:extLst>
                    <a:ext uri="{FF2B5EF4-FFF2-40B4-BE49-F238E27FC236}">
                      <a16:creationId xmlns:a16="http://schemas.microsoft.com/office/drawing/2014/main" id="{99630A8A-6845-93C7-C686-F792CED08B6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038"/>
                  <a:ext cx="632" cy="678"/>
                </a:xfrm>
                <a:custGeom>
                  <a:avLst/>
                  <a:gdLst>
                    <a:gd name="G0" fmla="+- 0 0 0"/>
                    <a:gd name="G1" fmla="+- 17228 0 0"/>
                    <a:gd name="G2" fmla="+- 21600 0 0"/>
                    <a:gd name="T0" fmla="*/ 13029 w 16055"/>
                    <a:gd name="T1" fmla="*/ 0 h 17228"/>
                    <a:gd name="T2" fmla="*/ 16055 w 16055"/>
                    <a:gd name="T3" fmla="*/ 2778 h 17228"/>
                    <a:gd name="T4" fmla="*/ 0 w 16055"/>
                    <a:gd name="T5" fmla="*/ 17228 h 172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055" h="17228" fill="none" extrusionOk="0">
                      <a:moveTo>
                        <a:pt x="13029" y="-1"/>
                      </a:moveTo>
                      <a:cubicBezTo>
                        <a:pt x="14123" y="827"/>
                        <a:pt x="15136" y="1758"/>
                        <a:pt x="16054" y="2778"/>
                      </a:cubicBezTo>
                    </a:path>
                    <a:path w="16055" h="17228" stroke="0" extrusionOk="0">
                      <a:moveTo>
                        <a:pt x="13029" y="-1"/>
                      </a:moveTo>
                      <a:cubicBezTo>
                        <a:pt x="14123" y="827"/>
                        <a:pt x="15136" y="1758"/>
                        <a:pt x="16054" y="2778"/>
                      </a:cubicBezTo>
                      <a:lnTo>
                        <a:pt x="0" y="17228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52" name="Arc 86">
                  <a:extLst>
                    <a:ext uri="{FF2B5EF4-FFF2-40B4-BE49-F238E27FC236}">
                      <a16:creationId xmlns:a16="http://schemas.microsoft.com/office/drawing/2014/main" id="{8EBF2D01-EC49-031F-0E16-D16034CF33F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147"/>
                  <a:ext cx="731" cy="569"/>
                </a:xfrm>
                <a:custGeom>
                  <a:avLst/>
                  <a:gdLst>
                    <a:gd name="G0" fmla="+- 0 0 0"/>
                    <a:gd name="G1" fmla="+- 14450 0 0"/>
                    <a:gd name="G2" fmla="+- 21600 0 0"/>
                    <a:gd name="T0" fmla="*/ 16055 w 18562"/>
                    <a:gd name="T1" fmla="*/ 0 h 14450"/>
                    <a:gd name="T2" fmla="*/ 18562 w 18562"/>
                    <a:gd name="T3" fmla="*/ 3404 h 14450"/>
                    <a:gd name="T4" fmla="*/ 0 w 18562"/>
                    <a:gd name="T5" fmla="*/ 14450 h 144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562" h="14450" fill="none" extrusionOk="0">
                      <a:moveTo>
                        <a:pt x="16054" y="0"/>
                      </a:moveTo>
                      <a:cubicBezTo>
                        <a:pt x="16999" y="1050"/>
                        <a:pt x="17839" y="2190"/>
                        <a:pt x="18561" y="3404"/>
                      </a:cubicBezTo>
                    </a:path>
                    <a:path w="18562" h="14450" stroke="0" extrusionOk="0">
                      <a:moveTo>
                        <a:pt x="16054" y="0"/>
                      </a:moveTo>
                      <a:cubicBezTo>
                        <a:pt x="16999" y="1050"/>
                        <a:pt x="17839" y="2190"/>
                        <a:pt x="18561" y="3404"/>
                      </a:cubicBezTo>
                      <a:lnTo>
                        <a:pt x="0" y="1445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53" name="Line 87">
                  <a:extLst>
                    <a:ext uri="{FF2B5EF4-FFF2-40B4-BE49-F238E27FC236}">
                      <a16:creationId xmlns:a16="http://schemas.microsoft.com/office/drawing/2014/main" id="{EB7E466D-69EF-075B-92F7-30D54AEA16B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304" y="2149"/>
                  <a:ext cx="55" cy="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54" name="Rectangle 88">
                  <a:extLst>
                    <a:ext uri="{FF2B5EF4-FFF2-40B4-BE49-F238E27FC236}">
                      <a16:creationId xmlns:a16="http://schemas.microsoft.com/office/drawing/2014/main" id="{BAE0E531-CB79-0A75-29BD-137F291E36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0040000">
                  <a:off x="2946" y="2040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14</a:t>
                  </a:r>
                </a:p>
              </p:txBody>
            </p:sp>
            <p:sp>
              <p:nvSpPr>
                <p:cNvPr id="355" name="Line 89">
                  <a:extLst>
                    <a:ext uri="{FF2B5EF4-FFF2-40B4-BE49-F238E27FC236}">
                      <a16:creationId xmlns:a16="http://schemas.microsoft.com/office/drawing/2014/main" id="{5D9190EA-361D-2BC6-8F10-534A8F7BCBB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629" y="2135"/>
                  <a:ext cx="338" cy="15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56" name="Rectangle 90">
                  <a:extLst>
                    <a:ext uri="{FF2B5EF4-FFF2-40B4-BE49-F238E27FC236}">
                      <a16:creationId xmlns:a16="http://schemas.microsoft.com/office/drawing/2014/main" id="{1B8217D9-CF0B-FD06-C382-0C06BB7C88B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0280000">
                  <a:off x="2962" y="2113"/>
                  <a:ext cx="38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1A1220T16</a:t>
                  </a:r>
                </a:p>
              </p:txBody>
            </p:sp>
            <p:sp>
              <p:nvSpPr>
                <p:cNvPr id="357" name="Line 91">
                  <a:extLst>
                    <a:ext uri="{FF2B5EF4-FFF2-40B4-BE49-F238E27FC236}">
                      <a16:creationId xmlns:a16="http://schemas.microsoft.com/office/drawing/2014/main" id="{81312F93-AF14-C21F-FA28-DF6F7C67B97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725" y="2217"/>
                  <a:ext cx="279" cy="10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58" name="Rectangle 92">
                  <a:extLst>
                    <a:ext uri="{FF2B5EF4-FFF2-40B4-BE49-F238E27FC236}">
                      <a16:creationId xmlns:a16="http://schemas.microsoft.com/office/drawing/2014/main" id="{EFFE69A9-95E4-26C5-EA71-265FC15F4B6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0520000">
                  <a:off x="2995" y="2210"/>
                  <a:ext cx="38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1A1220T17</a:t>
                  </a:r>
                </a:p>
              </p:txBody>
            </p:sp>
            <p:sp>
              <p:nvSpPr>
                <p:cNvPr id="359" name="Line 93">
                  <a:extLst>
                    <a:ext uri="{FF2B5EF4-FFF2-40B4-BE49-F238E27FC236}">
                      <a16:creationId xmlns:a16="http://schemas.microsoft.com/office/drawing/2014/main" id="{19D96470-7A8B-3912-8A98-F39E5AEB31E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816" y="2304"/>
                  <a:ext cx="215" cy="6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60" name="Rectangle 94">
                  <a:extLst>
                    <a:ext uri="{FF2B5EF4-FFF2-40B4-BE49-F238E27FC236}">
                      <a16:creationId xmlns:a16="http://schemas.microsoft.com/office/drawing/2014/main" id="{4DF9D899-E3BB-EC7E-7EA9-5E153024D5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0760000">
                  <a:off x="3039" y="2319"/>
                  <a:ext cx="3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6C302T4</a:t>
                  </a:r>
                </a:p>
              </p:txBody>
            </p:sp>
            <p:sp>
              <p:nvSpPr>
                <p:cNvPr id="361" name="Line 95">
                  <a:extLst>
                    <a:ext uri="{FF2B5EF4-FFF2-40B4-BE49-F238E27FC236}">
                      <a16:creationId xmlns:a16="http://schemas.microsoft.com/office/drawing/2014/main" id="{9780348C-96DD-B03B-A106-A8C5095DA29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912" y="2391"/>
                  <a:ext cx="146" cy="3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62" name="Rectangle 96">
                  <a:extLst>
                    <a:ext uri="{FF2B5EF4-FFF2-40B4-BE49-F238E27FC236}">
                      <a16:creationId xmlns:a16="http://schemas.microsoft.com/office/drawing/2014/main" id="{61F87EE1-1F61-8ED1-3B6E-9D665C50E14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1000000">
                  <a:off x="3053" y="2413"/>
                  <a:ext cx="35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6A301T10</a:t>
                  </a:r>
                </a:p>
              </p:txBody>
            </p:sp>
            <p:sp>
              <p:nvSpPr>
                <p:cNvPr id="363" name="Line 97">
                  <a:extLst>
                    <a:ext uri="{FF2B5EF4-FFF2-40B4-BE49-F238E27FC236}">
                      <a16:creationId xmlns:a16="http://schemas.microsoft.com/office/drawing/2014/main" id="{CA3679B5-FD7E-0E12-A47E-7DEC6EDB50C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004" y="2482"/>
                  <a:ext cx="73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64" name="Rectangle 98">
                  <a:extLst>
                    <a:ext uri="{FF2B5EF4-FFF2-40B4-BE49-F238E27FC236}">
                      <a16:creationId xmlns:a16="http://schemas.microsoft.com/office/drawing/2014/main" id="{F00421AD-4C38-FBFA-724B-CCB9A2D1E9B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1240000">
                  <a:off x="3062" y="2518"/>
                  <a:ext cx="35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6A313T17</a:t>
                  </a:r>
                </a:p>
              </p:txBody>
            </p:sp>
            <p:sp>
              <p:nvSpPr>
                <p:cNvPr id="365" name="Line 99">
                  <a:extLst>
                    <a:ext uri="{FF2B5EF4-FFF2-40B4-BE49-F238E27FC236}">
                      <a16:creationId xmlns:a16="http://schemas.microsoft.com/office/drawing/2014/main" id="{B8DB7B13-7777-561B-6D2B-A7E15764C27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3013" y="2574"/>
                  <a:ext cx="73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66" name="Arc 100">
                  <a:extLst>
                    <a:ext uri="{FF2B5EF4-FFF2-40B4-BE49-F238E27FC236}">
                      <a16:creationId xmlns:a16="http://schemas.microsoft.com/office/drawing/2014/main" id="{78C01D3D-A821-5053-7DD8-E7D7C4C1BFD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496"/>
                  <a:ext cx="1286" cy="220"/>
                </a:xfrm>
                <a:custGeom>
                  <a:avLst/>
                  <a:gdLst>
                    <a:gd name="G0" fmla="+- 0 0 0"/>
                    <a:gd name="G1" fmla="+- 3659 0 0"/>
                    <a:gd name="G2" fmla="+- 21600 0 0"/>
                    <a:gd name="T0" fmla="*/ 21288 w 21393"/>
                    <a:gd name="T1" fmla="*/ 0 h 3659"/>
                    <a:gd name="T2" fmla="*/ 21393 w 21393"/>
                    <a:gd name="T3" fmla="*/ 677 h 3659"/>
                    <a:gd name="T4" fmla="*/ 0 w 21393"/>
                    <a:gd name="T5" fmla="*/ 3659 h 365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393" h="3659" fill="none" extrusionOk="0">
                      <a:moveTo>
                        <a:pt x="21287" y="0"/>
                      </a:moveTo>
                      <a:cubicBezTo>
                        <a:pt x="21326" y="225"/>
                        <a:pt x="21361" y="450"/>
                        <a:pt x="21393" y="676"/>
                      </a:cubicBezTo>
                    </a:path>
                    <a:path w="21393" h="3659" stroke="0" extrusionOk="0">
                      <a:moveTo>
                        <a:pt x="21287" y="0"/>
                      </a:moveTo>
                      <a:cubicBezTo>
                        <a:pt x="21326" y="225"/>
                        <a:pt x="21361" y="450"/>
                        <a:pt x="21393" y="676"/>
                      </a:cubicBezTo>
                      <a:lnTo>
                        <a:pt x="0" y="3659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67" name="Arc 101">
                  <a:extLst>
                    <a:ext uri="{FF2B5EF4-FFF2-40B4-BE49-F238E27FC236}">
                      <a16:creationId xmlns:a16="http://schemas.microsoft.com/office/drawing/2014/main" id="{FCFCF3B6-18DB-7ACE-E083-E61B56D69ED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537"/>
                  <a:ext cx="1292" cy="179"/>
                </a:xfrm>
                <a:custGeom>
                  <a:avLst/>
                  <a:gdLst>
                    <a:gd name="G0" fmla="+- 0 0 0"/>
                    <a:gd name="G1" fmla="+- 2982 0 0"/>
                    <a:gd name="G2" fmla="+- 21600 0 0"/>
                    <a:gd name="T0" fmla="*/ 21393 w 21486"/>
                    <a:gd name="T1" fmla="*/ 0 h 2982"/>
                    <a:gd name="T2" fmla="*/ 21486 w 21486"/>
                    <a:gd name="T3" fmla="*/ 765 h 2982"/>
                    <a:gd name="T4" fmla="*/ 0 w 21486"/>
                    <a:gd name="T5" fmla="*/ 2982 h 298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486" h="2982" fill="none" extrusionOk="0">
                      <a:moveTo>
                        <a:pt x="21393" y="-1"/>
                      </a:moveTo>
                      <a:cubicBezTo>
                        <a:pt x="21428" y="254"/>
                        <a:pt x="21459" y="509"/>
                        <a:pt x="21485" y="765"/>
                      </a:cubicBezTo>
                    </a:path>
                    <a:path w="21486" h="2982" stroke="0" extrusionOk="0">
                      <a:moveTo>
                        <a:pt x="21393" y="-1"/>
                      </a:moveTo>
                      <a:cubicBezTo>
                        <a:pt x="21428" y="254"/>
                        <a:pt x="21459" y="509"/>
                        <a:pt x="21485" y="765"/>
                      </a:cubicBezTo>
                      <a:lnTo>
                        <a:pt x="0" y="2982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68" name="Line 102">
                  <a:extLst>
                    <a:ext uri="{FF2B5EF4-FFF2-40B4-BE49-F238E27FC236}">
                      <a16:creationId xmlns:a16="http://schemas.microsoft.com/office/drawing/2014/main" id="{4D4A1479-788B-00F3-44B0-2F58A66F878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935" y="2537"/>
                  <a:ext cx="73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69" name="Arc 103">
                  <a:extLst>
                    <a:ext uri="{FF2B5EF4-FFF2-40B4-BE49-F238E27FC236}">
                      <a16:creationId xmlns:a16="http://schemas.microsoft.com/office/drawing/2014/main" id="{04271BF4-578F-4F62-88A3-F9A88110367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427"/>
                  <a:ext cx="1199" cy="289"/>
                </a:xfrm>
                <a:custGeom>
                  <a:avLst/>
                  <a:gdLst>
                    <a:gd name="G0" fmla="+- 0 0 0"/>
                    <a:gd name="G1" fmla="+- 5122 0 0"/>
                    <a:gd name="G2" fmla="+- 21600 0 0"/>
                    <a:gd name="T0" fmla="*/ 20984 w 21215"/>
                    <a:gd name="T1" fmla="*/ 0 h 5122"/>
                    <a:gd name="T2" fmla="*/ 21215 w 21215"/>
                    <a:gd name="T3" fmla="*/ 1063 h 5122"/>
                    <a:gd name="T4" fmla="*/ 0 w 21215"/>
                    <a:gd name="T5" fmla="*/ 5122 h 512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215" h="5122" fill="none" extrusionOk="0">
                      <a:moveTo>
                        <a:pt x="20983" y="0"/>
                      </a:moveTo>
                      <a:cubicBezTo>
                        <a:pt x="21069" y="352"/>
                        <a:pt x="21147" y="706"/>
                        <a:pt x="21215" y="1062"/>
                      </a:cubicBezTo>
                    </a:path>
                    <a:path w="21215" h="5122" stroke="0" extrusionOk="0">
                      <a:moveTo>
                        <a:pt x="20983" y="0"/>
                      </a:moveTo>
                      <a:cubicBezTo>
                        <a:pt x="21069" y="352"/>
                        <a:pt x="21147" y="706"/>
                        <a:pt x="21215" y="1062"/>
                      </a:cubicBezTo>
                      <a:lnTo>
                        <a:pt x="0" y="5122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70" name="Arc 104">
                  <a:extLst>
                    <a:ext uri="{FF2B5EF4-FFF2-40B4-BE49-F238E27FC236}">
                      <a16:creationId xmlns:a16="http://schemas.microsoft.com/office/drawing/2014/main" id="{3F6ED2E7-B8D5-1441-6573-CA58CFA3299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487"/>
                  <a:ext cx="1209" cy="229"/>
                </a:xfrm>
                <a:custGeom>
                  <a:avLst/>
                  <a:gdLst>
                    <a:gd name="G0" fmla="+- 0 0 0"/>
                    <a:gd name="G1" fmla="+- 4059 0 0"/>
                    <a:gd name="G2" fmla="+- 21600 0 0"/>
                    <a:gd name="T0" fmla="*/ 21215 w 21389"/>
                    <a:gd name="T1" fmla="*/ 0 h 4059"/>
                    <a:gd name="T2" fmla="*/ 21389 w 21389"/>
                    <a:gd name="T3" fmla="*/ 1044 h 4059"/>
                    <a:gd name="T4" fmla="*/ 0 w 21389"/>
                    <a:gd name="T5" fmla="*/ 4059 h 405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389" h="4059" fill="none" extrusionOk="0">
                      <a:moveTo>
                        <a:pt x="21215" y="-1"/>
                      </a:moveTo>
                      <a:cubicBezTo>
                        <a:pt x="21281" y="346"/>
                        <a:pt x="21339" y="694"/>
                        <a:pt x="21388" y="1044"/>
                      </a:cubicBezTo>
                    </a:path>
                    <a:path w="21389" h="4059" stroke="0" extrusionOk="0">
                      <a:moveTo>
                        <a:pt x="21215" y="-1"/>
                      </a:moveTo>
                      <a:cubicBezTo>
                        <a:pt x="21281" y="346"/>
                        <a:pt x="21339" y="694"/>
                        <a:pt x="21388" y="1044"/>
                      </a:cubicBezTo>
                      <a:lnTo>
                        <a:pt x="0" y="4059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71" name="Line 105">
                  <a:extLst>
                    <a:ext uri="{FF2B5EF4-FFF2-40B4-BE49-F238E27FC236}">
                      <a16:creationId xmlns:a16="http://schemas.microsoft.com/office/drawing/2014/main" id="{B89808F1-25D6-043A-BCEC-D92970D12DD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853" y="2487"/>
                  <a:ext cx="73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72" name="Arc 106">
                  <a:extLst>
                    <a:ext uri="{FF2B5EF4-FFF2-40B4-BE49-F238E27FC236}">
                      <a16:creationId xmlns:a16="http://schemas.microsoft.com/office/drawing/2014/main" id="{A29ABB74-2244-0A6E-000B-55ABB76F483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372"/>
                  <a:ext cx="1113" cy="344"/>
                </a:xfrm>
                <a:custGeom>
                  <a:avLst/>
                  <a:gdLst>
                    <a:gd name="G0" fmla="+- 0 0 0"/>
                    <a:gd name="G1" fmla="+- 6473 0 0"/>
                    <a:gd name="G2" fmla="+- 21600 0 0"/>
                    <a:gd name="T0" fmla="*/ 20607 w 20948"/>
                    <a:gd name="T1" fmla="*/ 0 h 6473"/>
                    <a:gd name="T2" fmla="*/ 20948 w 20948"/>
                    <a:gd name="T3" fmla="*/ 1208 h 6473"/>
                    <a:gd name="T4" fmla="*/ 0 w 20948"/>
                    <a:gd name="T5" fmla="*/ 6473 h 64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948" h="6473" fill="none" extrusionOk="0">
                      <a:moveTo>
                        <a:pt x="20607" y="-1"/>
                      </a:moveTo>
                      <a:cubicBezTo>
                        <a:pt x="20732" y="399"/>
                        <a:pt x="20846" y="802"/>
                        <a:pt x="20948" y="1207"/>
                      </a:cubicBezTo>
                    </a:path>
                    <a:path w="20948" h="6473" stroke="0" extrusionOk="0">
                      <a:moveTo>
                        <a:pt x="20607" y="-1"/>
                      </a:moveTo>
                      <a:cubicBezTo>
                        <a:pt x="20732" y="399"/>
                        <a:pt x="20846" y="802"/>
                        <a:pt x="20948" y="1207"/>
                      </a:cubicBezTo>
                      <a:lnTo>
                        <a:pt x="0" y="6473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73" name="Arc 107">
                  <a:extLst>
                    <a:ext uri="{FF2B5EF4-FFF2-40B4-BE49-F238E27FC236}">
                      <a16:creationId xmlns:a16="http://schemas.microsoft.com/office/drawing/2014/main" id="{29BC7F91-02F0-511C-D7A8-ACC0293FD7B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436"/>
                  <a:ext cx="1127" cy="280"/>
                </a:xfrm>
                <a:custGeom>
                  <a:avLst/>
                  <a:gdLst>
                    <a:gd name="G0" fmla="+- 0 0 0"/>
                    <a:gd name="G1" fmla="+- 5265 0 0"/>
                    <a:gd name="G2" fmla="+- 21600 0 0"/>
                    <a:gd name="T0" fmla="*/ 20948 w 21215"/>
                    <a:gd name="T1" fmla="*/ 0 h 5265"/>
                    <a:gd name="T2" fmla="*/ 21215 w 21215"/>
                    <a:gd name="T3" fmla="*/ 1207 h 5265"/>
                    <a:gd name="T4" fmla="*/ 0 w 21215"/>
                    <a:gd name="T5" fmla="*/ 5265 h 526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215" h="5265" fill="none" extrusionOk="0">
                      <a:moveTo>
                        <a:pt x="20948" y="-1"/>
                      </a:moveTo>
                      <a:cubicBezTo>
                        <a:pt x="21048" y="399"/>
                        <a:pt x="21137" y="802"/>
                        <a:pt x="21215" y="1206"/>
                      </a:cubicBezTo>
                    </a:path>
                    <a:path w="21215" h="5265" stroke="0" extrusionOk="0">
                      <a:moveTo>
                        <a:pt x="20948" y="-1"/>
                      </a:moveTo>
                      <a:cubicBezTo>
                        <a:pt x="21048" y="399"/>
                        <a:pt x="21137" y="802"/>
                        <a:pt x="21215" y="1206"/>
                      </a:cubicBezTo>
                      <a:lnTo>
                        <a:pt x="0" y="5265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74" name="Line 108">
                  <a:extLst>
                    <a:ext uri="{FF2B5EF4-FFF2-40B4-BE49-F238E27FC236}">
                      <a16:creationId xmlns:a16="http://schemas.microsoft.com/office/drawing/2014/main" id="{A77BBC0D-34C3-03F1-8B16-D2D498D2C15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766" y="2437"/>
                  <a:ext cx="73" cy="1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75" name="Arc 109">
                  <a:extLst>
                    <a:ext uri="{FF2B5EF4-FFF2-40B4-BE49-F238E27FC236}">
                      <a16:creationId xmlns:a16="http://schemas.microsoft.com/office/drawing/2014/main" id="{C514D6FF-B285-B506-ED1E-1D26F2C27F3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327"/>
                  <a:ext cx="1024" cy="389"/>
                </a:xfrm>
                <a:custGeom>
                  <a:avLst/>
                  <a:gdLst>
                    <a:gd name="G0" fmla="+- 0 0 0"/>
                    <a:gd name="G1" fmla="+- 7824 0 0"/>
                    <a:gd name="G2" fmla="+- 21600 0 0"/>
                    <a:gd name="T0" fmla="*/ 20133 w 20588"/>
                    <a:gd name="T1" fmla="*/ 0 h 7824"/>
                    <a:gd name="T2" fmla="*/ 20588 w 20588"/>
                    <a:gd name="T3" fmla="*/ 1290 h 7824"/>
                    <a:gd name="T4" fmla="*/ 0 w 20588"/>
                    <a:gd name="T5" fmla="*/ 7824 h 78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588" h="7824" fill="none" extrusionOk="0">
                      <a:moveTo>
                        <a:pt x="20133" y="-1"/>
                      </a:moveTo>
                      <a:cubicBezTo>
                        <a:pt x="20298" y="425"/>
                        <a:pt x="20450" y="855"/>
                        <a:pt x="20588" y="1289"/>
                      </a:cubicBezTo>
                    </a:path>
                    <a:path w="20588" h="7824" stroke="0" extrusionOk="0">
                      <a:moveTo>
                        <a:pt x="20133" y="-1"/>
                      </a:moveTo>
                      <a:cubicBezTo>
                        <a:pt x="20298" y="425"/>
                        <a:pt x="20450" y="855"/>
                        <a:pt x="20588" y="1289"/>
                      </a:cubicBezTo>
                      <a:lnTo>
                        <a:pt x="0" y="7824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76" name="Arc 110">
                  <a:extLst>
                    <a:ext uri="{FF2B5EF4-FFF2-40B4-BE49-F238E27FC236}">
                      <a16:creationId xmlns:a16="http://schemas.microsoft.com/office/drawing/2014/main" id="{78209FB5-A96C-18C1-7CD0-C3FF9DAE04F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391"/>
                  <a:ext cx="1042" cy="325"/>
                </a:xfrm>
                <a:custGeom>
                  <a:avLst/>
                  <a:gdLst>
                    <a:gd name="G0" fmla="+- 0 0 0"/>
                    <a:gd name="G1" fmla="+- 6534 0 0"/>
                    <a:gd name="G2" fmla="+- 21600 0 0"/>
                    <a:gd name="T0" fmla="*/ 20588 w 20947"/>
                    <a:gd name="T1" fmla="*/ 0 h 6534"/>
                    <a:gd name="T2" fmla="*/ 20947 w 20947"/>
                    <a:gd name="T3" fmla="*/ 1262 h 6534"/>
                    <a:gd name="T4" fmla="*/ 0 w 20947"/>
                    <a:gd name="T5" fmla="*/ 6534 h 653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947" h="6534" fill="none" extrusionOk="0">
                      <a:moveTo>
                        <a:pt x="20588" y="-1"/>
                      </a:moveTo>
                      <a:cubicBezTo>
                        <a:pt x="20720" y="416"/>
                        <a:pt x="20839" y="837"/>
                        <a:pt x="20946" y="1262"/>
                      </a:cubicBezTo>
                    </a:path>
                    <a:path w="20947" h="6534" stroke="0" extrusionOk="0">
                      <a:moveTo>
                        <a:pt x="20588" y="-1"/>
                      </a:moveTo>
                      <a:cubicBezTo>
                        <a:pt x="20720" y="416"/>
                        <a:pt x="20839" y="837"/>
                        <a:pt x="20946" y="1262"/>
                      </a:cubicBezTo>
                      <a:lnTo>
                        <a:pt x="0" y="6534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77" name="Line 111">
                  <a:extLst>
                    <a:ext uri="{FF2B5EF4-FFF2-40B4-BE49-F238E27FC236}">
                      <a16:creationId xmlns:a16="http://schemas.microsoft.com/office/drawing/2014/main" id="{5A819363-EC7E-F0C7-19BB-6721F019AA1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674" y="2391"/>
                  <a:ext cx="74" cy="2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78" name="Arc 112">
                  <a:extLst>
                    <a:ext uri="{FF2B5EF4-FFF2-40B4-BE49-F238E27FC236}">
                      <a16:creationId xmlns:a16="http://schemas.microsoft.com/office/drawing/2014/main" id="{BB6B71E0-B15C-F15D-45A3-FC7851A10C3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289"/>
                  <a:ext cx="932" cy="427"/>
                </a:xfrm>
                <a:custGeom>
                  <a:avLst/>
                  <a:gdLst>
                    <a:gd name="G0" fmla="+- 0 0 0"/>
                    <a:gd name="G1" fmla="+- 9199 0 0"/>
                    <a:gd name="G2" fmla="+- 21600 0 0"/>
                    <a:gd name="T0" fmla="*/ 19543 w 20105"/>
                    <a:gd name="T1" fmla="*/ 0 h 9199"/>
                    <a:gd name="T2" fmla="*/ 20105 w 20105"/>
                    <a:gd name="T3" fmla="*/ 1304 h 9199"/>
                    <a:gd name="T4" fmla="*/ 0 w 20105"/>
                    <a:gd name="T5" fmla="*/ 9199 h 919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105" h="9199" fill="none" extrusionOk="0">
                      <a:moveTo>
                        <a:pt x="19543" y="-1"/>
                      </a:moveTo>
                      <a:cubicBezTo>
                        <a:pt x="19744" y="428"/>
                        <a:pt x="19932" y="863"/>
                        <a:pt x="20105" y="1303"/>
                      </a:cubicBezTo>
                    </a:path>
                    <a:path w="20105" h="9199" stroke="0" extrusionOk="0">
                      <a:moveTo>
                        <a:pt x="19543" y="-1"/>
                      </a:moveTo>
                      <a:cubicBezTo>
                        <a:pt x="19744" y="428"/>
                        <a:pt x="19932" y="863"/>
                        <a:pt x="20105" y="1303"/>
                      </a:cubicBezTo>
                      <a:lnTo>
                        <a:pt x="0" y="9199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79" name="Arc 113">
                  <a:extLst>
                    <a:ext uri="{FF2B5EF4-FFF2-40B4-BE49-F238E27FC236}">
                      <a16:creationId xmlns:a16="http://schemas.microsoft.com/office/drawing/2014/main" id="{D535EF7D-8D69-FF0E-B10D-E8EF43AA6D0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350"/>
                  <a:ext cx="955" cy="366"/>
                </a:xfrm>
                <a:custGeom>
                  <a:avLst/>
                  <a:gdLst>
                    <a:gd name="G0" fmla="+- 0 0 0"/>
                    <a:gd name="G1" fmla="+- 7895 0 0"/>
                    <a:gd name="G2" fmla="+- 21600 0 0"/>
                    <a:gd name="T0" fmla="*/ 20105 w 20595"/>
                    <a:gd name="T1" fmla="*/ 0 h 7895"/>
                    <a:gd name="T2" fmla="*/ 20595 w 20595"/>
                    <a:gd name="T3" fmla="*/ 1382 h 7895"/>
                    <a:gd name="T4" fmla="*/ 0 w 20595"/>
                    <a:gd name="T5" fmla="*/ 7895 h 78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595" h="7895" fill="none" extrusionOk="0">
                      <a:moveTo>
                        <a:pt x="20105" y="-1"/>
                      </a:moveTo>
                      <a:cubicBezTo>
                        <a:pt x="20284" y="454"/>
                        <a:pt x="20447" y="915"/>
                        <a:pt x="20594" y="1382"/>
                      </a:cubicBezTo>
                    </a:path>
                    <a:path w="20595" h="7895" stroke="0" extrusionOk="0">
                      <a:moveTo>
                        <a:pt x="20105" y="-1"/>
                      </a:moveTo>
                      <a:cubicBezTo>
                        <a:pt x="20284" y="454"/>
                        <a:pt x="20447" y="915"/>
                        <a:pt x="20594" y="1382"/>
                      </a:cubicBezTo>
                      <a:lnTo>
                        <a:pt x="0" y="7895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80" name="Line 114">
                  <a:extLst>
                    <a:ext uri="{FF2B5EF4-FFF2-40B4-BE49-F238E27FC236}">
                      <a16:creationId xmlns:a16="http://schemas.microsoft.com/office/drawing/2014/main" id="{424A889B-AA80-E72A-6569-EE7FA7CC27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446" y="2350"/>
                  <a:ext cx="210" cy="7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81" name="Arc 115">
                  <a:extLst>
                    <a:ext uri="{FF2B5EF4-FFF2-40B4-BE49-F238E27FC236}">
                      <a16:creationId xmlns:a16="http://schemas.microsoft.com/office/drawing/2014/main" id="{B54470E3-F3E3-C9E7-5D90-C27B42431CC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199"/>
                  <a:ext cx="662" cy="517"/>
                </a:xfrm>
                <a:custGeom>
                  <a:avLst/>
                  <a:gdLst>
                    <a:gd name="G0" fmla="+- 0 0 0"/>
                    <a:gd name="G1" fmla="+- 14373 0 0"/>
                    <a:gd name="G2" fmla="+- 21600 0 0"/>
                    <a:gd name="T0" fmla="*/ 16124 w 18401"/>
                    <a:gd name="T1" fmla="*/ 0 h 14373"/>
                    <a:gd name="T2" fmla="*/ 18401 w 18401"/>
                    <a:gd name="T3" fmla="*/ 3060 h 14373"/>
                    <a:gd name="T4" fmla="*/ 0 w 18401"/>
                    <a:gd name="T5" fmla="*/ 14373 h 143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401" h="14373" fill="none" extrusionOk="0">
                      <a:moveTo>
                        <a:pt x="16123" y="0"/>
                      </a:moveTo>
                      <a:cubicBezTo>
                        <a:pt x="16971" y="951"/>
                        <a:pt x="17733" y="1975"/>
                        <a:pt x="18400" y="3060"/>
                      </a:cubicBezTo>
                    </a:path>
                    <a:path w="18401" h="14373" stroke="0" extrusionOk="0">
                      <a:moveTo>
                        <a:pt x="16123" y="0"/>
                      </a:moveTo>
                      <a:cubicBezTo>
                        <a:pt x="16971" y="951"/>
                        <a:pt x="17733" y="1975"/>
                        <a:pt x="18400" y="3060"/>
                      </a:cubicBezTo>
                      <a:lnTo>
                        <a:pt x="0" y="14373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82" name="Arc 116">
                  <a:extLst>
                    <a:ext uri="{FF2B5EF4-FFF2-40B4-BE49-F238E27FC236}">
                      <a16:creationId xmlns:a16="http://schemas.microsoft.com/office/drawing/2014/main" id="{C6AD5EC4-3E9D-F4F7-97EE-B446415B1CA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309"/>
                  <a:ext cx="724" cy="407"/>
                </a:xfrm>
                <a:custGeom>
                  <a:avLst/>
                  <a:gdLst>
                    <a:gd name="G0" fmla="+- 0 0 0"/>
                    <a:gd name="G1" fmla="+- 11313 0 0"/>
                    <a:gd name="G2" fmla="+- 21600 0 0"/>
                    <a:gd name="T0" fmla="*/ 18401 w 20101"/>
                    <a:gd name="T1" fmla="*/ 0 h 11313"/>
                    <a:gd name="T2" fmla="*/ 20101 w 20101"/>
                    <a:gd name="T3" fmla="*/ 3406 h 11313"/>
                    <a:gd name="T4" fmla="*/ 0 w 20101"/>
                    <a:gd name="T5" fmla="*/ 11313 h 1131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101" h="11313" fill="none" extrusionOk="0">
                      <a:moveTo>
                        <a:pt x="18400" y="0"/>
                      </a:moveTo>
                      <a:cubicBezTo>
                        <a:pt x="19066" y="1083"/>
                        <a:pt x="19635" y="2222"/>
                        <a:pt x="20100" y="3406"/>
                      </a:cubicBezTo>
                    </a:path>
                    <a:path w="20101" h="11313" stroke="0" extrusionOk="0">
                      <a:moveTo>
                        <a:pt x="18400" y="0"/>
                      </a:moveTo>
                      <a:cubicBezTo>
                        <a:pt x="19066" y="1083"/>
                        <a:pt x="19635" y="2222"/>
                        <a:pt x="20100" y="3406"/>
                      </a:cubicBezTo>
                      <a:lnTo>
                        <a:pt x="0" y="11313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83" name="Line 117">
                  <a:extLst>
                    <a:ext uri="{FF2B5EF4-FFF2-40B4-BE49-F238E27FC236}">
                      <a16:creationId xmlns:a16="http://schemas.microsoft.com/office/drawing/2014/main" id="{0360EAEA-9DF6-A34D-CEA2-F0EA219424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194" y="2309"/>
                  <a:ext cx="192" cy="11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84" name="Rectangle 118">
                  <a:extLst>
                    <a:ext uri="{FF2B5EF4-FFF2-40B4-BE49-F238E27FC236}">
                      <a16:creationId xmlns:a16="http://schemas.microsoft.com/office/drawing/2014/main" id="{9F0E76CC-59FF-B49A-76EF-9E7BA134524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1420000">
                  <a:off x="3086" y="2618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21</a:t>
                  </a:r>
                </a:p>
              </p:txBody>
            </p:sp>
            <p:sp>
              <p:nvSpPr>
                <p:cNvPr id="385" name="Line 119">
                  <a:extLst>
                    <a:ext uri="{FF2B5EF4-FFF2-40B4-BE49-F238E27FC236}">
                      <a16:creationId xmlns:a16="http://schemas.microsoft.com/office/drawing/2014/main" id="{B3AB650C-1EAC-C424-D717-9926B7051C3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350" y="2665"/>
                  <a:ext cx="745" cy="2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86" name="Rectangle 120">
                  <a:extLst>
                    <a:ext uri="{FF2B5EF4-FFF2-40B4-BE49-F238E27FC236}">
                      <a16:creationId xmlns:a16="http://schemas.microsoft.com/office/drawing/2014/main" id="{EAF5050A-89BB-F154-0E7F-6022E010153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60000">
                  <a:off x="3084" y="2717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17</a:t>
                  </a:r>
                </a:p>
              </p:txBody>
            </p:sp>
            <p:sp>
              <p:nvSpPr>
                <p:cNvPr id="387" name="Line 121">
                  <a:extLst>
                    <a:ext uri="{FF2B5EF4-FFF2-40B4-BE49-F238E27FC236}">
                      <a16:creationId xmlns:a16="http://schemas.microsoft.com/office/drawing/2014/main" id="{D3D65536-3BA8-AABB-8A2F-8179F713CE3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022" y="2757"/>
                  <a:ext cx="73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88" name="Rectangle 122">
                  <a:extLst>
                    <a:ext uri="{FF2B5EF4-FFF2-40B4-BE49-F238E27FC236}">
                      <a16:creationId xmlns:a16="http://schemas.microsoft.com/office/drawing/2014/main" id="{9798AF00-03C9-F53D-5CEB-1690E88F5CE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300000">
                  <a:off x="3081" y="2815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25</a:t>
                  </a:r>
                </a:p>
              </p:txBody>
            </p:sp>
            <p:sp>
              <p:nvSpPr>
                <p:cNvPr id="389" name="Line 123">
                  <a:extLst>
                    <a:ext uri="{FF2B5EF4-FFF2-40B4-BE49-F238E27FC236}">
                      <a16:creationId xmlns:a16="http://schemas.microsoft.com/office/drawing/2014/main" id="{15FBB20F-5569-7229-336D-4811FCC6853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017" y="2843"/>
                  <a:ext cx="73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90" name="Arc 124">
                  <a:extLst>
                    <a:ext uri="{FF2B5EF4-FFF2-40B4-BE49-F238E27FC236}">
                      <a16:creationId xmlns:a16="http://schemas.microsoft.com/office/drawing/2014/main" id="{20EA9DD5-6B8E-888E-D838-BEF1CF946DA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298" cy="82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1592 w 21592"/>
                    <a:gd name="T1" fmla="*/ 599 h 1367"/>
                    <a:gd name="T2" fmla="*/ 21557 w 21592"/>
                    <a:gd name="T3" fmla="*/ 1367 h 1367"/>
                    <a:gd name="T4" fmla="*/ 0 w 21592"/>
                    <a:gd name="T5" fmla="*/ 0 h 13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592" h="1367" fill="none" extrusionOk="0">
                      <a:moveTo>
                        <a:pt x="21591" y="598"/>
                      </a:moveTo>
                      <a:cubicBezTo>
                        <a:pt x="21584" y="855"/>
                        <a:pt x="21572" y="1111"/>
                        <a:pt x="21556" y="1366"/>
                      </a:cubicBezTo>
                    </a:path>
                    <a:path w="21592" h="1367" stroke="0" extrusionOk="0">
                      <a:moveTo>
                        <a:pt x="21591" y="598"/>
                      </a:moveTo>
                      <a:cubicBezTo>
                        <a:pt x="21584" y="855"/>
                        <a:pt x="21572" y="1111"/>
                        <a:pt x="21556" y="1366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91" name="Arc 125">
                  <a:extLst>
                    <a:ext uri="{FF2B5EF4-FFF2-40B4-BE49-F238E27FC236}">
                      <a16:creationId xmlns:a16="http://schemas.microsoft.com/office/drawing/2014/main" id="{CEA4DF8D-90A3-CE24-B54A-7CC9733E531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296" cy="123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1557 w 21557"/>
                    <a:gd name="T1" fmla="*/ 1367 h 2046"/>
                    <a:gd name="T2" fmla="*/ 21503 w 21557"/>
                    <a:gd name="T3" fmla="*/ 2046 h 2046"/>
                    <a:gd name="T4" fmla="*/ 0 w 21557"/>
                    <a:gd name="T5" fmla="*/ 0 h 20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557" h="2046" fill="none" extrusionOk="0">
                      <a:moveTo>
                        <a:pt x="21556" y="1366"/>
                      </a:moveTo>
                      <a:cubicBezTo>
                        <a:pt x="21542" y="1593"/>
                        <a:pt x="21524" y="1819"/>
                        <a:pt x="21502" y="2045"/>
                      </a:cubicBezTo>
                    </a:path>
                    <a:path w="21557" h="2046" stroke="0" extrusionOk="0">
                      <a:moveTo>
                        <a:pt x="21556" y="1366"/>
                      </a:moveTo>
                      <a:cubicBezTo>
                        <a:pt x="21542" y="1593"/>
                        <a:pt x="21524" y="1819"/>
                        <a:pt x="21502" y="2045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92" name="Line 126">
                  <a:extLst>
                    <a:ext uri="{FF2B5EF4-FFF2-40B4-BE49-F238E27FC236}">
                      <a16:creationId xmlns:a16="http://schemas.microsoft.com/office/drawing/2014/main" id="{9B21AE37-904C-9C56-94D7-768F30C93D5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44" y="2793"/>
                  <a:ext cx="73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93" name="Rectangle 127">
                  <a:extLst>
                    <a:ext uri="{FF2B5EF4-FFF2-40B4-BE49-F238E27FC236}">
                      <a16:creationId xmlns:a16="http://schemas.microsoft.com/office/drawing/2014/main" id="{8AAFC6E1-FA57-BBF7-908A-1873C58FE74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540000">
                  <a:off x="3066" y="2918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30</a:t>
                  </a:r>
                </a:p>
              </p:txBody>
            </p:sp>
            <p:sp>
              <p:nvSpPr>
                <p:cNvPr id="394" name="Line 128">
                  <a:extLst>
                    <a:ext uri="{FF2B5EF4-FFF2-40B4-BE49-F238E27FC236}">
                      <a16:creationId xmlns:a16="http://schemas.microsoft.com/office/drawing/2014/main" id="{B7B6CA74-475D-E870-A884-3E274B915DE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30" y="2917"/>
                  <a:ext cx="147" cy="2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95" name="Arc 129">
                  <a:extLst>
                    <a:ext uri="{FF2B5EF4-FFF2-40B4-BE49-F238E27FC236}">
                      <a16:creationId xmlns:a16="http://schemas.microsoft.com/office/drawing/2014/main" id="{5B2FF19C-C926-8DF0-1F5E-3AF942FB0C2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218" cy="137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1557 w 21557"/>
                    <a:gd name="T1" fmla="*/ 1365 h 2428"/>
                    <a:gd name="T2" fmla="*/ 21463 w 21557"/>
                    <a:gd name="T3" fmla="*/ 2428 h 2428"/>
                    <a:gd name="T4" fmla="*/ 0 w 21557"/>
                    <a:gd name="T5" fmla="*/ 0 h 24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557" h="2428" fill="none" extrusionOk="0">
                      <a:moveTo>
                        <a:pt x="21556" y="1364"/>
                      </a:moveTo>
                      <a:cubicBezTo>
                        <a:pt x="21534" y="1720"/>
                        <a:pt x="21503" y="2074"/>
                        <a:pt x="21463" y="2428"/>
                      </a:cubicBezTo>
                    </a:path>
                    <a:path w="21557" h="2428" stroke="0" extrusionOk="0">
                      <a:moveTo>
                        <a:pt x="21556" y="1364"/>
                      </a:moveTo>
                      <a:cubicBezTo>
                        <a:pt x="21534" y="1720"/>
                        <a:pt x="21503" y="2074"/>
                        <a:pt x="21463" y="2428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96" name="Arc 130">
                  <a:extLst>
                    <a:ext uri="{FF2B5EF4-FFF2-40B4-BE49-F238E27FC236}">
                      <a16:creationId xmlns:a16="http://schemas.microsoft.com/office/drawing/2014/main" id="{03809896-8AB2-CBD5-72AC-595C626CA81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213" cy="196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1463 w 21463"/>
                    <a:gd name="T1" fmla="*/ 2428 h 3476"/>
                    <a:gd name="T2" fmla="*/ 21318 w 21463"/>
                    <a:gd name="T3" fmla="*/ 3476 h 3476"/>
                    <a:gd name="T4" fmla="*/ 0 w 21463"/>
                    <a:gd name="T5" fmla="*/ 0 h 347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463" h="3476" fill="none" extrusionOk="0">
                      <a:moveTo>
                        <a:pt x="21463" y="2428"/>
                      </a:moveTo>
                      <a:cubicBezTo>
                        <a:pt x="21423" y="2778"/>
                        <a:pt x="21375" y="3127"/>
                        <a:pt x="21318" y="3476"/>
                      </a:cubicBezTo>
                    </a:path>
                    <a:path w="21463" h="3476" stroke="0" extrusionOk="0">
                      <a:moveTo>
                        <a:pt x="21463" y="2428"/>
                      </a:moveTo>
                      <a:cubicBezTo>
                        <a:pt x="21423" y="2778"/>
                        <a:pt x="21375" y="3127"/>
                        <a:pt x="21318" y="3476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97" name="Line 131">
                  <a:extLst>
                    <a:ext uri="{FF2B5EF4-FFF2-40B4-BE49-F238E27FC236}">
                      <a16:creationId xmlns:a16="http://schemas.microsoft.com/office/drawing/2014/main" id="{1340D52C-84E4-C197-683F-6DC8C65F2A7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66" y="2843"/>
                  <a:ext cx="74" cy="1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398" name="Rectangle 132">
                  <a:extLst>
                    <a:ext uri="{FF2B5EF4-FFF2-40B4-BE49-F238E27FC236}">
                      <a16:creationId xmlns:a16="http://schemas.microsoft.com/office/drawing/2014/main" id="{15A69696-372C-FC8A-BD49-A8030E48C4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780000">
                  <a:off x="3048" y="3012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22</a:t>
                  </a:r>
                </a:p>
              </p:txBody>
            </p:sp>
            <p:sp>
              <p:nvSpPr>
                <p:cNvPr id="399" name="Line 133">
                  <a:extLst>
                    <a:ext uri="{FF2B5EF4-FFF2-40B4-BE49-F238E27FC236}">
                      <a16:creationId xmlns:a16="http://schemas.microsoft.com/office/drawing/2014/main" id="{02B639BE-255B-494E-2BB8-9E19E4F3667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39" y="2976"/>
                  <a:ext cx="219" cy="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00" name="Arc 134">
                  <a:extLst>
                    <a:ext uri="{FF2B5EF4-FFF2-40B4-BE49-F238E27FC236}">
                      <a16:creationId xmlns:a16="http://schemas.microsoft.com/office/drawing/2014/main" id="{4ECDC7E4-2513-504F-7272-029976B1658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140" cy="196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1466 w 21466"/>
                    <a:gd name="T1" fmla="*/ 2406 h 3695"/>
                    <a:gd name="T2" fmla="*/ 21282 w 21466"/>
                    <a:gd name="T3" fmla="*/ 3695 h 3695"/>
                    <a:gd name="T4" fmla="*/ 0 w 21466"/>
                    <a:gd name="T5" fmla="*/ 0 h 36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466" h="3695" fill="none" extrusionOk="0">
                      <a:moveTo>
                        <a:pt x="21465" y="2405"/>
                      </a:moveTo>
                      <a:cubicBezTo>
                        <a:pt x="21417" y="2837"/>
                        <a:pt x="21355" y="3267"/>
                        <a:pt x="21281" y="3694"/>
                      </a:cubicBezTo>
                    </a:path>
                    <a:path w="21466" h="3695" stroke="0" extrusionOk="0">
                      <a:moveTo>
                        <a:pt x="21465" y="2405"/>
                      </a:moveTo>
                      <a:cubicBezTo>
                        <a:pt x="21417" y="2837"/>
                        <a:pt x="21355" y="3267"/>
                        <a:pt x="21281" y="3694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01" name="Arc 135">
                  <a:extLst>
                    <a:ext uri="{FF2B5EF4-FFF2-40B4-BE49-F238E27FC236}">
                      <a16:creationId xmlns:a16="http://schemas.microsoft.com/office/drawing/2014/main" id="{85CA35EB-9D51-2083-E491-5D8296BA04A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131" cy="261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1282 w 21282"/>
                    <a:gd name="T1" fmla="*/ 3695 h 4905"/>
                    <a:gd name="T2" fmla="*/ 21036 w 21282"/>
                    <a:gd name="T3" fmla="*/ 4905 h 4905"/>
                    <a:gd name="T4" fmla="*/ 0 w 21282"/>
                    <a:gd name="T5" fmla="*/ 0 h 490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282" h="4905" fill="none" extrusionOk="0">
                      <a:moveTo>
                        <a:pt x="21281" y="3694"/>
                      </a:moveTo>
                      <a:cubicBezTo>
                        <a:pt x="21211" y="4100"/>
                        <a:pt x="21129" y="4504"/>
                        <a:pt x="21035" y="4904"/>
                      </a:cubicBezTo>
                    </a:path>
                    <a:path w="21282" h="4905" stroke="0" extrusionOk="0">
                      <a:moveTo>
                        <a:pt x="21281" y="3694"/>
                      </a:moveTo>
                      <a:cubicBezTo>
                        <a:pt x="21211" y="4100"/>
                        <a:pt x="21129" y="4504"/>
                        <a:pt x="21035" y="4904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02" name="Line 136">
                  <a:extLst>
                    <a:ext uri="{FF2B5EF4-FFF2-40B4-BE49-F238E27FC236}">
                      <a16:creationId xmlns:a16="http://schemas.microsoft.com/office/drawing/2014/main" id="{9C70800F-976A-49B7-4A76-824B7F3386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84" y="2898"/>
                  <a:ext cx="73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03" name="Rectangle 137">
                  <a:extLst>
                    <a:ext uri="{FF2B5EF4-FFF2-40B4-BE49-F238E27FC236}">
                      <a16:creationId xmlns:a16="http://schemas.microsoft.com/office/drawing/2014/main" id="{D4DAFC59-943D-4859-302A-541BB5FB96A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20000">
                  <a:off x="3021" y="3114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29</a:t>
                  </a:r>
                </a:p>
              </p:txBody>
            </p:sp>
            <p:sp>
              <p:nvSpPr>
                <p:cNvPr id="404" name="Line 138">
                  <a:extLst>
                    <a:ext uri="{FF2B5EF4-FFF2-40B4-BE49-F238E27FC236}">
                      <a16:creationId xmlns:a16="http://schemas.microsoft.com/office/drawing/2014/main" id="{28163BD6-76D9-26AA-066B-E80F7FD497D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94" y="3077"/>
                  <a:ext cx="142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05" name="Rectangle 139">
                  <a:extLst>
                    <a:ext uri="{FF2B5EF4-FFF2-40B4-BE49-F238E27FC236}">
                      <a16:creationId xmlns:a16="http://schemas.microsoft.com/office/drawing/2014/main" id="{B8361AFD-1F19-D837-DBE5-0663F5605D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200000">
                  <a:off x="2986" y="3201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18</a:t>
                  </a:r>
                </a:p>
              </p:txBody>
            </p:sp>
            <p:sp>
              <p:nvSpPr>
                <p:cNvPr id="406" name="Line 140">
                  <a:extLst>
                    <a:ext uri="{FF2B5EF4-FFF2-40B4-BE49-F238E27FC236}">
                      <a16:creationId xmlns:a16="http://schemas.microsoft.com/office/drawing/2014/main" id="{068DFE30-B2AD-E0CC-319E-3E9CDCF8E59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35" y="3177"/>
                  <a:ext cx="69" cy="2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07" name="Rectangle 141">
                  <a:extLst>
                    <a:ext uri="{FF2B5EF4-FFF2-40B4-BE49-F238E27FC236}">
                      <a16:creationId xmlns:a16="http://schemas.microsoft.com/office/drawing/2014/main" id="{2C5BD347-FD05-61E7-984E-DB9500AF523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440000">
                  <a:off x="2949" y="3294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19</a:t>
                  </a:r>
                </a:p>
              </p:txBody>
            </p:sp>
            <p:sp>
              <p:nvSpPr>
                <p:cNvPr id="408" name="Line 142">
                  <a:extLst>
                    <a:ext uri="{FF2B5EF4-FFF2-40B4-BE49-F238E27FC236}">
                      <a16:creationId xmlns:a16="http://schemas.microsoft.com/office/drawing/2014/main" id="{7CFDC2EB-2ED4-9367-8A47-EBE084F008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903" y="3259"/>
                  <a:ext cx="69" cy="2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09" name="Arc 143">
                  <a:extLst>
                    <a:ext uri="{FF2B5EF4-FFF2-40B4-BE49-F238E27FC236}">
                      <a16:creationId xmlns:a16="http://schemas.microsoft.com/office/drawing/2014/main" id="{1802FE18-61FA-C262-4074-E894E75D26F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214" cy="502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0187 w 20187"/>
                    <a:gd name="T1" fmla="*/ 7685 h 8354"/>
                    <a:gd name="T2" fmla="*/ 19919 w 20187"/>
                    <a:gd name="T3" fmla="*/ 8354 h 8354"/>
                    <a:gd name="T4" fmla="*/ 0 w 20187"/>
                    <a:gd name="T5" fmla="*/ 0 h 83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187" h="8354" fill="none" extrusionOk="0">
                      <a:moveTo>
                        <a:pt x="20186" y="7684"/>
                      </a:moveTo>
                      <a:cubicBezTo>
                        <a:pt x="20101" y="7909"/>
                        <a:pt x="20012" y="8132"/>
                        <a:pt x="19919" y="8354"/>
                      </a:cubicBezTo>
                    </a:path>
                    <a:path w="20187" h="8354" stroke="0" extrusionOk="0">
                      <a:moveTo>
                        <a:pt x="20186" y="7684"/>
                      </a:moveTo>
                      <a:cubicBezTo>
                        <a:pt x="20101" y="7909"/>
                        <a:pt x="20012" y="8132"/>
                        <a:pt x="19919" y="8354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10" name="Arc 144">
                  <a:extLst>
                    <a:ext uri="{FF2B5EF4-FFF2-40B4-BE49-F238E27FC236}">
                      <a16:creationId xmlns:a16="http://schemas.microsoft.com/office/drawing/2014/main" id="{D33D8F62-049B-8674-EC10-629F86780BF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197" cy="540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9919 w 19919"/>
                    <a:gd name="T1" fmla="*/ 8354 h 8981"/>
                    <a:gd name="T2" fmla="*/ 19644 w 19919"/>
                    <a:gd name="T3" fmla="*/ 8981 h 8981"/>
                    <a:gd name="T4" fmla="*/ 0 w 19919"/>
                    <a:gd name="T5" fmla="*/ 0 h 898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919" h="8981" fill="none" extrusionOk="0">
                      <a:moveTo>
                        <a:pt x="19919" y="8354"/>
                      </a:moveTo>
                      <a:cubicBezTo>
                        <a:pt x="19830" y="8564"/>
                        <a:pt x="19739" y="8773"/>
                        <a:pt x="19644" y="8981"/>
                      </a:cubicBezTo>
                    </a:path>
                    <a:path w="19919" h="8981" stroke="0" extrusionOk="0">
                      <a:moveTo>
                        <a:pt x="19919" y="8354"/>
                      </a:moveTo>
                      <a:cubicBezTo>
                        <a:pt x="19830" y="8564"/>
                        <a:pt x="19739" y="8773"/>
                        <a:pt x="19644" y="8981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11" name="Line 145">
                  <a:extLst>
                    <a:ext uri="{FF2B5EF4-FFF2-40B4-BE49-F238E27FC236}">
                      <a16:creationId xmlns:a16="http://schemas.microsoft.com/office/drawing/2014/main" id="{ECF69FF0-A43B-2931-F308-B0864C50DEE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53" y="3186"/>
                  <a:ext cx="68" cy="2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12" name="Arc 146">
                  <a:extLst>
                    <a:ext uri="{FF2B5EF4-FFF2-40B4-BE49-F238E27FC236}">
                      <a16:creationId xmlns:a16="http://schemas.microsoft.com/office/drawing/2014/main" id="{57F67A9C-1AB9-8CD0-CA3C-7D19A732BBE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167" cy="412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0657 w 20657"/>
                    <a:gd name="T1" fmla="*/ 6312 h 7286"/>
                    <a:gd name="T2" fmla="*/ 20334 w 20657"/>
                    <a:gd name="T3" fmla="*/ 7286 h 7286"/>
                    <a:gd name="T4" fmla="*/ 0 w 20657"/>
                    <a:gd name="T5" fmla="*/ 0 h 72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657" h="7286" fill="none" extrusionOk="0">
                      <a:moveTo>
                        <a:pt x="20657" y="6312"/>
                      </a:moveTo>
                      <a:cubicBezTo>
                        <a:pt x="20557" y="6639"/>
                        <a:pt x="20449" y="6963"/>
                        <a:pt x="20334" y="7286"/>
                      </a:cubicBezTo>
                    </a:path>
                    <a:path w="20657" h="7286" stroke="0" extrusionOk="0">
                      <a:moveTo>
                        <a:pt x="20657" y="6312"/>
                      </a:moveTo>
                      <a:cubicBezTo>
                        <a:pt x="20557" y="6639"/>
                        <a:pt x="20449" y="6963"/>
                        <a:pt x="20334" y="7286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13" name="Arc 147">
                  <a:extLst>
                    <a:ext uri="{FF2B5EF4-FFF2-40B4-BE49-F238E27FC236}">
                      <a16:creationId xmlns:a16="http://schemas.microsoft.com/office/drawing/2014/main" id="{FC321A26-5626-0678-03A8-614AB50028C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149" cy="471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0334 w 20334"/>
                    <a:gd name="T1" fmla="*/ 7286 h 8333"/>
                    <a:gd name="T2" fmla="*/ 19928 w 20334"/>
                    <a:gd name="T3" fmla="*/ 8333 h 8333"/>
                    <a:gd name="T4" fmla="*/ 0 w 20334"/>
                    <a:gd name="T5" fmla="*/ 0 h 83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334" h="8333" fill="none" extrusionOk="0">
                      <a:moveTo>
                        <a:pt x="20334" y="7286"/>
                      </a:moveTo>
                      <a:cubicBezTo>
                        <a:pt x="20207" y="7638"/>
                        <a:pt x="20072" y="7987"/>
                        <a:pt x="19927" y="8332"/>
                      </a:cubicBezTo>
                    </a:path>
                    <a:path w="20334" h="8333" stroke="0" extrusionOk="0">
                      <a:moveTo>
                        <a:pt x="20334" y="7286"/>
                      </a:moveTo>
                      <a:cubicBezTo>
                        <a:pt x="20207" y="7638"/>
                        <a:pt x="20072" y="7987"/>
                        <a:pt x="19927" y="8332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14" name="Line 148">
                  <a:extLst>
                    <a:ext uri="{FF2B5EF4-FFF2-40B4-BE49-F238E27FC236}">
                      <a16:creationId xmlns:a16="http://schemas.microsoft.com/office/drawing/2014/main" id="{4DDF2353-4DAB-2348-8998-2E63D27491B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34" y="3081"/>
                  <a:ext cx="142" cy="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15" name="Arc 149">
                  <a:extLst>
                    <a:ext uri="{FF2B5EF4-FFF2-40B4-BE49-F238E27FC236}">
                      <a16:creationId xmlns:a16="http://schemas.microsoft.com/office/drawing/2014/main" id="{0086B154-6582-C41B-592E-A04E698547C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059" cy="275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1288 w 21288"/>
                    <a:gd name="T1" fmla="*/ 3655 h 5538"/>
                    <a:gd name="T2" fmla="*/ 20878 w 21288"/>
                    <a:gd name="T3" fmla="*/ 5538 h 5538"/>
                    <a:gd name="T4" fmla="*/ 0 w 21288"/>
                    <a:gd name="T5" fmla="*/ 0 h 55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288" h="5538" fill="none" extrusionOk="0">
                      <a:moveTo>
                        <a:pt x="21288" y="3655"/>
                      </a:moveTo>
                      <a:cubicBezTo>
                        <a:pt x="21179" y="4288"/>
                        <a:pt x="21042" y="4916"/>
                        <a:pt x="20877" y="5537"/>
                      </a:cubicBezTo>
                    </a:path>
                    <a:path w="21288" h="5538" stroke="0" extrusionOk="0">
                      <a:moveTo>
                        <a:pt x="21288" y="3655"/>
                      </a:moveTo>
                      <a:cubicBezTo>
                        <a:pt x="21179" y="4288"/>
                        <a:pt x="21042" y="4916"/>
                        <a:pt x="20877" y="5537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16" name="Arc 150">
                  <a:extLst>
                    <a:ext uri="{FF2B5EF4-FFF2-40B4-BE49-F238E27FC236}">
                      <a16:creationId xmlns:a16="http://schemas.microsoft.com/office/drawing/2014/main" id="{F5A251D7-EECF-F829-A6E6-769A5C7DFD9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039" cy="365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0878 w 20878"/>
                    <a:gd name="T1" fmla="*/ 5538 h 7341"/>
                    <a:gd name="T2" fmla="*/ 20314 w 20878"/>
                    <a:gd name="T3" fmla="*/ 7341 h 7341"/>
                    <a:gd name="T4" fmla="*/ 0 w 20878"/>
                    <a:gd name="T5" fmla="*/ 0 h 734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878" h="7341" fill="none" extrusionOk="0">
                      <a:moveTo>
                        <a:pt x="20877" y="5537"/>
                      </a:moveTo>
                      <a:cubicBezTo>
                        <a:pt x="20716" y="6146"/>
                        <a:pt x="20528" y="6748"/>
                        <a:pt x="20314" y="7341"/>
                      </a:cubicBezTo>
                    </a:path>
                    <a:path w="20878" h="7341" stroke="0" extrusionOk="0">
                      <a:moveTo>
                        <a:pt x="20877" y="5537"/>
                      </a:moveTo>
                      <a:cubicBezTo>
                        <a:pt x="20716" y="6146"/>
                        <a:pt x="20528" y="6748"/>
                        <a:pt x="20314" y="7341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17" name="Line 151">
                  <a:extLst>
                    <a:ext uri="{FF2B5EF4-FFF2-40B4-BE49-F238E27FC236}">
                      <a16:creationId xmlns:a16="http://schemas.microsoft.com/office/drawing/2014/main" id="{631EDD9F-3904-23B7-8206-F73C7130E0C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400" y="2894"/>
                  <a:ext cx="361" cy="9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18" name="Rectangle 152">
                  <a:extLst>
                    <a:ext uri="{FF2B5EF4-FFF2-40B4-BE49-F238E27FC236}">
                      <a16:creationId xmlns:a16="http://schemas.microsoft.com/office/drawing/2014/main" id="{63320439-B103-7671-0650-901BB251FF0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80000">
                  <a:off x="2914" y="3380"/>
                  <a:ext cx="224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6</a:t>
                  </a:r>
                </a:p>
              </p:txBody>
            </p:sp>
            <p:sp>
              <p:nvSpPr>
                <p:cNvPr id="419" name="Line 153">
                  <a:extLst>
                    <a:ext uri="{FF2B5EF4-FFF2-40B4-BE49-F238E27FC236}">
                      <a16:creationId xmlns:a16="http://schemas.microsoft.com/office/drawing/2014/main" id="{01F17E3A-3775-B81D-B61A-98373C798CB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66" y="3337"/>
                  <a:ext cx="64" cy="3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20" name="Rectangle 154">
                  <a:extLst>
                    <a:ext uri="{FF2B5EF4-FFF2-40B4-BE49-F238E27FC236}">
                      <a16:creationId xmlns:a16="http://schemas.microsoft.com/office/drawing/2014/main" id="{8CD0DC43-FB39-985A-61BA-F9D68F3A886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920000">
                  <a:off x="2857" y="3470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20</a:t>
                  </a:r>
                </a:p>
              </p:txBody>
            </p:sp>
            <p:sp>
              <p:nvSpPr>
                <p:cNvPr id="421" name="Line 155">
                  <a:extLst>
                    <a:ext uri="{FF2B5EF4-FFF2-40B4-BE49-F238E27FC236}">
                      <a16:creationId xmlns:a16="http://schemas.microsoft.com/office/drawing/2014/main" id="{8BDD27FE-8476-E836-2315-A7A14F90FD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821" y="3406"/>
                  <a:ext cx="64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22" name="Arc 156">
                  <a:extLst>
                    <a:ext uri="{FF2B5EF4-FFF2-40B4-BE49-F238E27FC236}">
                      <a16:creationId xmlns:a16="http://schemas.microsoft.com/office/drawing/2014/main" id="{F1041A65-7173-FE1F-95C5-D53BD7F20B9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142" cy="654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9004 w 19004"/>
                    <a:gd name="T1" fmla="*/ 10267 h 10879"/>
                    <a:gd name="T2" fmla="*/ 18660 w 19004"/>
                    <a:gd name="T3" fmla="*/ 10879 h 10879"/>
                    <a:gd name="T4" fmla="*/ 0 w 19004"/>
                    <a:gd name="T5" fmla="*/ 0 h 1087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004" h="10879" fill="none" extrusionOk="0">
                      <a:moveTo>
                        <a:pt x="19003" y="10266"/>
                      </a:moveTo>
                      <a:cubicBezTo>
                        <a:pt x="18892" y="10472"/>
                        <a:pt x="18778" y="10676"/>
                        <a:pt x="18660" y="10879"/>
                      </a:cubicBezTo>
                    </a:path>
                    <a:path w="19004" h="10879" stroke="0" extrusionOk="0">
                      <a:moveTo>
                        <a:pt x="19003" y="10266"/>
                      </a:moveTo>
                      <a:cubicBezTo>
                        <a:pt x="18892" y="10472"/>
                        <a:pt x="18778" y="10676"/>
                        <a:pt x="18660" y="10879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23" name="Arc 157">
                  <a:extLst>
                    <a:ext uri="{FF2B5EF4-FFF2-40B4-BE49-F238E27FC236}">
                      <a16:creationId xmlns:a16="http://schemas.microsoft.com/office/drawing/2014/main" id="{326598A9-008A-2ED1-5894-3B742CC852B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122" cy="694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8660 w 18660"/>
                    <a:gd name="T1" fmla="*/ 10879 h 11548"/>
                    <a:gd name="T2" fmla="*/ 18254 w 18660"/>
                    <a:gd name="T3" fmla="*/ 11548 h 11548"/>
                    <a:gd name="T4" fmla="*/ 0 w 18660"/>
                    <a:gd name="T5" fmla="*/ 0 h 115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660" h="11548" fill="none" extrusionOk="0">
                      <a:moveTo>
                        <a:pt x="18660" y="10879"/>
                      </a:moveTo>
                      <a:cubicBezTo>
                        <a:pt x="18528" y="11104"/>
                        <a:pt x="18393" y="11327"/>
                        <a:pt x="18253" y="11547"/>
                      </a:cubicBezTo>
                    </a:path>
                    <a:path w="18660" h="11548" stroke="0" extrusionOk="0">
                      <a:moveTo>
                        <a:pt x="18660" y="10879"/>
                      </a:moveTo>
                      <a:cubicBezTo>
                        <a:pt x="18528" y="11104"/>
                        <a:pt x="18393" y="11327"/>
                        <a:pt x="18253" y="11547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24" name="Line 158">
                  <a:extLst>
                    <a:ext uri="{FF2B5EF4-FFF2-40B4-BE49-F238E27FC236}">
                      <a16:creationId xmlns:a16="http://schemas.microsoft.com/office/drawing/2014/main" id="{98B2C1A4-EF66-47C8-1B7F-28B894D11A3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396" y="3104"/>
                  <a:ext cx="448" cy="26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25" name="Rectangle 159">
                  <a:extLst>
                    <a:ext uri="{FF2B5EF4-FFF2-40B4-BE49-F238E27FC236}">
                      <a16:creationId xmlns:a16="http://schemas.microsoft.com/office/drawing/2014/main" id="{920E55A0-94D9-9440-1645-31A3FD89A88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160000">
                  <a:off x="2796" y="3556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12</a:t>
                  </a:r>
                </a:p>
              </p:txBody>
            </p:sp>
            <p:sp>
              <p:nvSpPr>
                <p:cNvPr id="426" name="Line 160">
                  <a:extLst>
                    <a:ext uri="{FF2B5EF4-FFF2-40B4-BE49-F238E27FC236}">
                      <a16:creationId xmlns:a16="http://schemas.microsoft.com/office/drawing/2014/main" id="{DC8203F2-2071-86AD-B6B8-3A035CEF2FB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70" y="3479"/>
                  <a:ext cx="60" cy="4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27" name="Rectangle 161">
                  <a:extLst>
                    <a:ext uri="{FF2B5EF4-FFF2-40B4-BE49-F238E27FC236}">
                      <a16:creationId xmlns:a16="http://schemas.microsoft.com/office/drawing/2014/main" id="{E36BC060-BC40-E915-4094-85BD3460B8C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340000">
                  <a:off x="2742" y="3628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13</a:t>
                  </a:r>
                </a:p>
              </p:txBody>
            </p:sp>
            <p:sp>
              <p:nvSpPr>
                <p:cNvPr id="428" name="Line 162">
                  <a:extLst>
                    <a:ext uri="{FF2B5EF4-FFF2-40B4-BE49-F238E27FC236}">
                      <a16:creationId xmlns:a16="http://schemas.microsoft.com/office/drawing/2014/main" id="{FFF44212-CC76-2DF8-BE4D-77DCEEEFA0C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716" y="3543"/>
                  <a:ext cx="59" cy="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29" name="Arc 163">
                  <a:extLst>
                    <a:ext uri="{FF2B5EF4-FFF2-40B4-BE49-F238E27FC236}">
                      <a16:creationId xmlns:a16="http://schemas.microsoft.com/office/drawing/2014/main" id="{B08CA23C-4E85-9EAF-DDED-C91879594FF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051" cy="799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7479 w 17479"/>
                    <a:gd name="T1" fmla="*/ 12690 h 13288"/>
                    <a:gd name="T2" fmla="*/ 17029 w 17479"/>
                    <a:gd name="T3" fmla="*/ 13288 h 13288"/>
                    <a:gd name="T4" fmla="*/ 0 w 17479"/>
                    <a:gd name="T5" fmla="*/ 0 h 132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479" h="13288" fill="none" extrusionOk="0">
                      <a:moveTo>
                        <a:pt x="17479" y="12690"/>
                      </a:moveTo>
                      <a:cubicBezTo>
                        <a:pt x="17332" y="12892"/>
                        <a:pt x="17182" y="13091"/>
                        <a:pt x="17029" y="13288"/>
                      </a:cubicBezTo>
                    </a:path>
                    <a:path w="17479" h="13288" stroke="0" extrusionOk="0">
                      <a:moveTo>
                        <a:pt x="17479" y="12690"/>
                      </a:moveTo>
                      <a:cubicBezTo>
                        <a:pt x="17332" y="12892"/>
                        <a:pt x="17182" y="13091"/>
                        <a:pt x="17029" y="13288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30" name="Arc 164">
                  <a:extLst>
                    <a:ext uri="{FF2B5EF4-FFF2-40B4-BE49-F238E27FC236}">
                      <a16:creationId xmlns:a16="http://schemas.microsoft.com/office/drawing/2014/main" id="{826DC2EC-24F7-E3FB-20B0-95D1469AFD4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024" cy="832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7029 w 17029"/>
                    <a:gd name="T1" fmla="*/ 13288 h 13838"/>
                    <a:gd name="T2" fmla="*/ 16585 w 17029"/>
                    <a:gd name="T3" fmla="*/ 13838 h 13838"/>
                    <a:gd name="T4" fmla="*/ 0 w 17029"/>
                    <a:gd name="T5" fmla="*/ 0 h 138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029" h="13838" fill="none" extrusionOk="0">
                      <a:moveTo>
                        <a:pt x="17029" y="13288"/>
                      </a:moveTo>
                      <a:cubicBezTo>
                        <a:pt x="16884" y="13473"/>
                        <a:pt x="16736" y="13657"/>
                        <a:pt x="16585" y="13838"/>
                      </a:cubicBezTo>
                    </a:path>
                    <a:path w="17029" h="13838" stroke="0" extrusionOk="0">
                      <a:moveTo>
                        <a:pt x="17029" y="13288"/>
                      </a:moveTo>
                      <a:cubicBezTo>
                        <a:pt x="16884" y="13473"/>
                        <a:pt x="16736" y="13657"/>
                        <a:pt x="16585" y="13838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31" name="Line 165">
                  <a:extLst>
                    <a:ext uri="{FF2B5EF4-FFF2-40B4-BE49-F238E27FC236}">
                      <a16:creationId xmlns:a16="http://schemas.microsoft.com/office/drawing/2014/main" id="{CE8E4681-B033-BD0A-E741-C36E0401732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88" y="3470"/>
                  <a:ext cx="60" cy="4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32" name="Rectangle 166">
                  <a:extLst>
                    <a:ext uri="{FF2B5EF4-FFF2-40B4-BE49-F238E27FC236}">
                      <a16:creationId xmlns:a16="http://schemas.microsoft.com/office/drawing/2014/main" id="{0A6BF0C4-93BE-ABE5-2A3E-911A57B1EC5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580000">
                  <a:off x="2671" y="3706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11</a:t>
                  </a:r>
                </a:p>
              </p:txBody>
            </p:sp>
            <p:sp>
              <p:nvSpPr>
                <p:cNvPr id="433" name="Line 167">
                  <a:extLst>
                    <a:ext uri="{FF2B5EF4-FFF2-40B4-BE49-F238E27FC236}">
                      <a16:creationId xmlns:a16="http://schemas.microsoft.com/office/drawing/2014/main" id="{058B1BF7-E189-F063-7DE2-7C17C0410BC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06" y="3557"/>
                  <a:ext cx="110" cy="10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34" name="Arc 168">
                  <a:extLst>
                    <a:ext uri="{FF2B5EF4-FFF2-40B4-BE49-F238E27FC236}">
                      <a16:creationId xmlns:a16="http://schemas.microsoft.com/office/drawing/2014/main" id="{4ABD6ABE-510E-ACBC-8C96-D7907490DE3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962" cy="799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7030 w 17030"/>
                    <a:gd name="T1" fmla="*/ 13287 h 14137"/>
                    <a:gd name="T2" fmla="*/ 16331 w 17030"/>
                    <a:gd name="T3" fmla="*/ 14137 h 14137"/>
                    <a:gd name="T4" fmla="*/ 0 w 17030"/>
                    <a:gd name="T5" fmla="*/ 0 h 141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030" h="14137" fill="none" extrusionOk="0">
                      <a:moveTo>
                        <a:pt x="17029" y="13286"/>
                      </a:moveTo>
                      <a:cubicBezTo>
                        <a:pt x="16804" y="13576"/>
                        <a:pt x="16571" y="13859"/>
                        <a:pt x="16331" y="14137"/>
                      </a:cubicBezTo>
                    </a:path>
                    <a:path w="17030" h="14137" stroke="0" extrusionOk="0">
                      <a:moveTo>
                        <a:pt x="17029" y="13286"/>
                      </a:moveTo>
                      <a:cubicBezTo>
                        <a:pt x="16804" y="13576"/>
                        <a:pt x="16571" y="13859"/>
                        <a:pt x="16331" y="14137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35" name="Arc 169">
                  <a:extLst>
                    <a:ext uri="{FF2B5EF4-FFF2-40B4-BE49-F238E27FC236}">
                      <a16:creationId xmlns:a16="http://schemas.microsoft.com/office/drawing/2014/main" id="{C40B1BB0-8A66-FFD4-812E-39A8ED6640C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923" cy="842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6331 w 16331"/>
                    <a:gd name="T1" fmla="*/ 14137 h 14906"/>
                    <a:gd name="T2" fmla="*/ 15633 w 16331"/>
                    <a:gd name="T3" fmla="*/ 14906 h 14906"/>
                    <a:gd name="T4" fmla="*/ 0 w 16331"/>
                    <a:gd name="T5" fmla="*/ 0 h 1490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331" h="14906" fill="none" extrusionOk="0">
                      <a:moveTo>
                        <a:pt x="16331" y="14137"/>
                      </a:moveTo>
                      <a:cubicBezTo>
                        <a:pt x="16104" y="14398"/>
                        <a:pt x="15871" y="14655"/>
                        <a:pt x="15632" y="14905"/>
                      </a:cubicBezTo>
                    </a:path>
                    <a:path w="16331" h="14906" stroke="0" extrusionOk="0">
                      <a:moveTo>
                        <a:pt x="16331" y="14137"/>
                      </a:moveTo>
                      <a:cubicBezTo>
                        <a:pt x="16104" y="14398"/>
                        <a:pt x="15871" y="14655"/>
                        <a:pt x="15632" y="14905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36" name="Line 170">
                  <a:extLst>
                    <a:ext uri="{FF2B5EF4-FFF2-40B4-BE49-F238E27FC236}">
                      <a16:creationId xmlns:a16="http://schemas.microsoft.com/office/drawing/2014/main" id="{499541D0-ADFE-055F-D830-1615F15F2BF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588" y="3465"/>
                  <a:ext cx="59" cy="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37" name="Rectangle 171">
                  <a:extLst>
                    <a:ext uri="{FF2B5EF4-FFF2-40B4-BE49-F238E27FC236}">
                      <a16:creationId xmlns:a16="http://schemas.microsoft.com/office/drawing/2014/main" id="{6DE2FDEA-B449-5EC3-21A9-2557C9A125A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820000">
                  <a:off x="2614" y="3763"/>
                  <a:ext cx="224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5</a:t>
                  </a:r>
                </a:p>
              </p:txBody>
            </p:sp>
            <p:sp>
              <p:nvSpPr>
                <p:cNvPr id="438" name="Line 172">
                  <a:extLst>
                    <a:ext uri="{FF2B5EF4-FFF2-40B4-BE49-F238E27FC236}">
                      <a16:creationId xmlns:a16="http://schemas.microsoft.com/office/drawing/2014/main" id="{C3940E89-CF19-BA23-9FDA-9DB4B47C138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01" y="3671"/>
                  <a:ext cx="51" cy="5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39" name="Rectangle 173">
                  <a:extLst>
                    <a:ext uri="{FF2B5EF4-FFF2-40B4-BE49-F238E27FC236}">
                      <a16:creationId xmlns:a16="http://schemas.microsoft.com/office/drawing/2014/main" id="{A3DE52D2-E9C8-823D-30F1-9BAAD766B26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3060000">
                  <a:off x="2535" y="3830"/>
                  <a:ext cx="224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1</a:t>
                  </a:r>
                </a:p>
              </p:txBody>
            </p:sp>
            <p:sp>
              <p:nvSpPr>
                <p:cNvPr id="440" name="Line 174">
                  <a:extLst>
                    <a:ext uri="{FF2B5EF4-FFF2-40B4-BE49-F238E27FC236}">
                      <a16:creationId xmlns:a16="http://schemas.microsoft.com/office/drawing/2014/main" id="{3247213C-F6CC-9012-D592-B5EAB59124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528" y="3726"/>
                  <a:ext cx="50" cy="5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41" name="Arc 175">
                  <a:extLst>
                    <a:ext uri="{FF2B5EF4-FFF2-40B4-BE49-F238E27FC236}">
                      <a16:creationId xmlns:a16="http://schemas.microsoft.com/office/drawing/2014/main" id="{6A645E69-965D-ED75-AA72-9ED13A2651B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878" cy="986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4610 w 14610"/>
                    <a:gd name="T1" fmla="*/ 15909 h 16408"/>
                    <a:gd name="T2" fmla="*/ 14048 w 14610"/>
                    <a:gd name="T3" fmla="*/ 16408 h 16408"/>
                    <a:gd name="T4" fmla="*/ 0 w 14610"/>
                    <a:gd name="T5" fmla="*/ 0 h 1640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610" h="16408" fill="none" extrusionOk="0">
                      <a:moveTo>
                        <a:pt x="14610" y="15909"/>
                      </a:moveTo>
                      <a:cubicBezTo>
                        <a:pt x="14425" y="16078"/>
                        <a:pt x="14238" y="16244"/>
                        <a:pt x="14047" y="16407"/>
                      </a:cubicBezTo>
                    </a:path>
                    <a:path w="14610" h="16408" stroke="0" extrusionOk="0">
                      <a:moveTo>
                        <a:pt x="14610" y="15909"/>
                      </a:moveTo>
                      <a:cubicBezTo>
                        <a:pt x="14425" y="16078"/>
                        <a:pt x="14238" y="16244"/>
                        <a:pt x="14047" y="16407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42" name="Arc 176">
                  <a:extLst>
                    <a:ext uri="{FF2B5EF4-FFF2-40B4-BE49-F238E27FC236}">
                      <a16:creationId xmlns:a16="http://schemas.microsoft.com/office/drawing/2014/main" id="{DBD3708B-F106-A66C-7CF3-B85BAFE5465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845" cy="1015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4048 w 14048"/>
                    <a:gd name="T1" fmla="*/ 16408 h 16885"/>
                    <a:gd name="T2" fmla="*/ 13471 w 14048"/>
                    <a:gd name="T3" fmla="*/ 16885 h 16885"/>
                    <a:gd name="T4" fmla="*/ 0 w 14048"/>
                    <a:gd name="T5" fmla="*/ 0 h 1688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048" h="16885" fill="none" extrusionOk="0">
                      <a:moveTo>
                        <a:pt x="14047" y="16407"/>
                      </a:moveTo>
                      <a:cubicBezTo>
                        <a:pt x="13858" y="16570"/>
                        <a:pt x="13665" y="16729"/>
                        <a:pt x="13470" y="16884"/>
                      </a:cubicBezTo>
                    </a:path>
                    <a:path w="14048" h="16885" stroke="0" extrusionOk="0">
                      <a:moveTo>
                        <a:pt x="14047" y="16407"/>
                      </a:moveTo>
                      <a:cubicBezTo>
                        <a:pt x="13858" y="16570"/>
                        <a:pt x="13665" y="16729"/>
                        <a:pt x="13470" y="16884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43" name="Line 177">
                  <a:extLst>
                    <a:ext uri="{FF2B5EF4-FFF2-40B4-BE49-F238E27FC236}">
                      <a16:creationId xmlns:a16="http://schemas.microsoft.com/office/drawing/2014/main" id="{692A230A-2267-75E2-DE64-463E9590657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464" y="3589"/>
                  <a:ext cx="101" cy="1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44" name="Arc 178">
                  <a:extLst>
                    <a:ext uri="{FF2B5EF4-FFF2-40B4-BE49-F238E27FC236}">
                      <a16:creationId xmlns:a16="http://schemas.microsoft.com/office/drawing/2014/main" id="{7ADE1B8E-23AE-6C0D-5D7D-78904DB9920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869" cy="814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6353 w 16353"/>
                    <a:gd name="T1" fmla="*/ 14111 h 15321"/>
                    <a:gd name="T2" fmla="*/ 15226 w 16353"/>
                    <a:gd name="T3" fmla="*/ 15321 h 15321"/>
                    <a:gd name="T4" fmla="*/ 0 w 16353"/>
                    <a:gd name="T5" fmla="*/ 0 h 1532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353" h="15321" fill="none" extrusionOk="0">
                      <a:moveTo>
                        <a:pt x="16353" y="14111"/>
                      </a:moveTo>
                      <a:cubicBezTo>
                        <a:pt x="15993" y="14528"/>
                        <a:pt x="15617" y="14932"/>
                        <a:pt x="15225" y="15320"/>
                      </a:cubicBezTo>
                    </a:path>
                    <a:path w="16353" h="15321" stroke="0" extrusionOk="0">
                      <a:moveTo>
                        <a:pt x="16353" y="14111"/>
                      </a:moveTo>
                      <a:cubicBezTo>
                        <a:pt x="15993" y="14528"/>
                        <a:pt x="15617" y="14932"/>
                        <a:pt x="15225" y="15320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45" name="Arc 179">
                  <a:extLst>
                    <a:ext uri="{FF2B5EF4-FFF2-40B4-BE49-F238E27FC236}">
                      <a16:creationId xmlns:a16="http://schemas.microsoft.com/office/drawing/2014/main" id="{2500AA9D-8053-F48F-120A-B83C98A6766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809" cy="873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5226 w 15226"/>
                    <a:gd name="T1" fmla="*/ 15321 h 16430"/>
                    <a:gd name="T2" fmla="*/ 14021 w 15226"/>
                    <a:gd name="T3" fmla="*/ 16430 h 16430"/>
                    <a:gd name="T4" fmla="*/ 0 w 15226"/>
                    <a:gd name="T5" fmla="*/ 0 h 164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226" h="16430" fill="none" extrusionOk="0">
                      <a:moveTo>
                        <a:pt x="15225" y="15320"/>
                      </a:moveTo>
                      <a:cubicBezTo>
                        <a:pt x="14838" y="15705"/>
                        <a:pt x="14436" y="16075"/>
                        <a:pt x="14021" y="16430"/>
                      </a:cubicBezTo>
                    </a:path>
                    <a:path w="15226" h="16430" stroke="0" extrusionOk="0">
                      <a:moveTo>
                        <a:pt x="15225" y="15320"/>
                      </a:moveTo>
                      <a:cubicBezTo>
                        <a:pt x="14838" y="15705"/>
                        <a:pt x="14436" y="16075"/>
                        <a:pt x="14021" y="16430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46" name="Line 180">
                  <a:extLst>
                    <a:ext uri="{FF2B5EF4-FFF2-40B4-BE49-F238E27FC236}">
                      <a16:creationId xmlns:a16="http://schemas.microsoft.com/office/drawing/2014/main" id="{4F4C1869-5112-3503-D55D-822DC30E399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322" y="3319"/>
                  <a:ext cx="211" cy="21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47" name="Rectangle 181">
                  <a:extLst>
                    <a:ext uri="{FF2B5EF4-FFF2-40B4-BE49-F238E27FC236}">
                      <a16:creationId xmlns:a16="http://schemas.microsoft.com/office/drawing/2014/main" id="{E7440883-0BEF-D1C3-8018-643E92A7A77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3300000">
                  <a:off x="2445" y="3897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28</a:t>
                  </a:r>
                </a:p>
              </p:txBody>
            </p:sp>
            <p:sp>
              <p:nvSpPr>
                <p:cNvPr id="448" name="Line 182">
                  <a:extLst>
                    <a:ext uri="{FF2B5EF4-FFF2-40B4-BE49-F238E27FC236}">
                      <a16:creationId xmlns:a16="http://schemas.microsoft.com/office/drawing/2014/main" id="{EDF11A65-B7CE-FB9F-A440-47852164ED8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49" y="3474"/>
                  <a:ext cx="256" cy="36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49" name="Rectangle 183">
                  <a:extLst>
                    <a:ext uri="{FF2B5EF4-FFF2-40B4-BE49-F238E27FC236}">
                      <a16:creationId xmlns:a16="http://schemas.microsoft.com/office/drawing/2014/main" id="{A836E14A-5B82-8059-8C24-439C978F20D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3540000">
                  <a:off x="2365" y="3954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16</a:t>
                  </a:r>
                </a:p>
              </p:txBody>
            </p:sp>
            <p:sp>
              <p:nvSpPr>
                <p:cNvPr id="450" name="Line 184">
                  <a:extLst>
                    <a:ext uri="{FF2B5EF4-FFF2-40B4-BE49-F238E27FC236}">
                      <a16:creationId xmlns:a16="http://schemas.microsoft.com/office/drawing/2014/main" id="{F74E5C64-60EB-450C-69CD-FC13226094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40" y="3570"/>
                  <a:ext cx="192" cy="3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51" name="Rectangle 185">
                  <a:extLst>
                    <a:ext uri="{FF2B5EF4-FFF2-40B4-BE49-F238E27FC236}">
                      <a16:creationId xmlns:a16="http://schemas.microsoft.com/office/drawing/2014/main" id="{FC35DB73-0DBD-8B97-BD47-C4A2D99D125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3720000">
                  <a:off x="2289" y="3989"/>
                  <a:ext cx="224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8</a:t>
                  </a:r>
                </a:p>
              </p:txBody>
            </p:sp>
            <p:sp>
              <p:nvSpPr>
                <p:cNvPr id="452" name="Line 186">
                  <a:extLst>
                    <a:ext uri="{FF2B5EF4-FFF2-40B4-BE49-F238E27FC236}">
                      <a16:creationId xmlns:a16="http://schemas.microsoft.com/office/drawing/2014/main" id="{D7C64D40-12C3-7ADD-3984-17EB9B9AB2F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17" y="3671"/>
                  <a:ext cx="133" cy="26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53" name="Rectangle 187">
                  <a:extLst>
                    <a:ext uri="{FF2B5EF4-FFF2-40B4-BE49-F238E27FC236}">
                      <a16:creationId xmlns:a16="http://schemas.microsoft.com/office/drawing/2014/main" id="{C8202213-FF86-BBF1-CFAE-FA4A1E4A9FE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3960000">
                  <a:off x="2187" y="4044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15</a:t>
                  </a:r>
                </a:p>
              </p:txBody>
            </p:sp>
            <p:sp>
              <p:nvSpPr>
                <p:cNvPr id="454" name="Line 188">
                  <a:extLst>
                    <a:ext uri="{FF2B5EF4-FFF2-40B4-BE49-F238E27FC236}">
                      <a16:creationId xmlns:a16="http://schemas.microsoft.com/office/drawing/2014/main" id="{F5F90A71-7B24-FCFC-7E71-F6203C1ABFB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81" y="3767"/>
                  <a:ext cx="87" cy="20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55" name="Rectangle 189">
                  <a:extLst>
                    <a:ext uri="{FF2B5EF4-FFF2-40B4-BE49-F238E27FC236}">
                      <a16:creationId xmlns:a16="http://schemas.microsoft.com/office/drawing/2014/main" id="{48EE6128-628E-3554-56D4-FC24C2F493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4200000">
                  <a:off x="2107" y="4068"/>
                  <a:ext cx="224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9</a:t>
                  </a:r>
                </a:p>
              </p:txBody>
            </p:sp>
            <p:sp>
              <p:nvSpPr>
                <p:cNvPr id="456" name="Line 190">
                  <a:extLst>
                    <a:ext uri="{FF2B5EF4-FFF2-40B4-BE49-F238E27FC236}">
                      <a16:creationId xmlns:a16="http://schemas.microsoft.com/office/drawing/2014/main" id="{726D512A-C5B1-02FF-1947-C957A74477C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30" y="3867"/>
                  <a:ext cx="51" cy="14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57" name="Rectangle 191">
                  <a:extLst>
                    <a:ext uri="{FF2B5EF4-FFF2-40B4-BE49-F238E27FC236}">
                      <a16:creationId xmlns:a16="http://schemas.microsoft.com/office/drawing/2014/main" id="{2BB3AF67-2ED8-353B-8A1A-E9D51AC64F0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4440000">
                  <a:off x="1998" y="4114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26</a:t>
                  </a:r>
                </a:p>
              </p:txBody>
            </p:sp>
            <p:sp>
              <p:nvSpPr>
                <p:cNvPr id="458" name="Line 192">
                  <a:extLst>
                    <a:ext uri="{FF2B5EF4-FFF2-40B4-BE49-F238E27FC236}">
                      <a16:creationId xmlns:a16="http://schemas.microsoft.com/office/drawing/2014/main" id="{C595C1B2-10BE-67A8-C37F-5653B67AAC3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76" y="3963"/>
                  <a:ext cx="18" cy="7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59" name="Rectangle 193">
                  <a:extLst>
                    <a:ext uri="{FF2B5EF4-FFF2-40B4-BE49-F238E27FC236}">
                      <a16:creationId xmlns:a16="http://schemas.microsoft.com/office/drawing/2014/main" id="{44A0C12A-E4C4-27E2-4A5A-8363FCAECBD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4680000">
                  <a:off x="1921" y="4127"/>
                  <a:ext cx="224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7</a:t>
                  </a:r>
                </a:p>
              </p:txBody>
            </p:sp>
            <p:sp>
              <p:nvSpPr>
                <p:cNvPr id="460" name="Line 194">
                  <a:extLst>
                    <a:ext uri="{FF2B5EF4-FFF2-40B4-BE49-F238E27FC236}">
                      <a16:creationId xmlns:a16="http://schemas.microsoft.com/office/drawing/2014/main" id="{86E204CD-F4C6-40D9-4BCD-6CFE0995E5B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93" y="3986"/>
                  <a:ext cx="14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61" name="Arc 195">
                  <a:extLst>
                    <a:ext uri="{FF2B5EF4-FFF2-40B4-BE49-F238E27FC236}">
                      <a16:creationId xmlns:a16="http://schemas.microsoft.com/office/drawing/2014/main" id="{8F52A6E8-B090-AA91-6F87-6EC9D66437B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353" cy="1261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5868 w 5868"/>
                    <a:gd name="T1" fmla="*/ 20788 h 20975"/>
                    <a:gd name="T2" fmla="*/ 5157 w 5868"/>
                    <a:gd name="T3" fmla="*/ 20975 h 20975"/>
                    <a:gd name="T4" fmla="*/ 0 w 5868"/>
                    <a:gd name="T5" fmla="*/ 0 h 2097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868" h="20975" fill="none" extrusionOk="0">
                      <a:moveTo>
                        <a:pt x="5867" y="20787"/>
                      </a:moveTo>
                      <a:cubicBezTo>
                        <a:pt x="5632" y="20854"/>
                        <a:pt x="5395" y="20916"/>
                        <a:pt x="5157" y="20975"/>
                      </a:cubicBezTo>
                    </a:path>
                    <a:path w="5868" h="20975" stroke="0" extrusionOk="0">
                      <a:moveTo>
                        <a:pt x="5867" y="20787"/>
                      </a:moveTo>
                      <a:cubicBezTo>
                        <a:pt x="5632" y="20854"/>
                        <a:pt x="5395" y="20916"/>
                        <a:pt x="5157" y="20975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62" name="Arc 196">
                  <a:extLst>
                    <a:ext uri="{FF2B5EF4-FFF2-40B4-BE49-F238E27FC236}">
                      <a16:creationId xmlns:a16="http://schemas.microsoft.com/office/drawing/2014/main" id="{6E1D6B95-1955-2D51-E326-EB7E208DA64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310" cy="1270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5157 w 5157"/>
                    <a:gd name="T1" fmla="*/ 20975 h 21131"/>
                    <a:gd name="T2" fmla="*/ 4476 w 5157"/>
                    <a:gd name="T3" fmla="*/ 21131 h 21131"/>
                    <a:gd name="T4" fmla="*/ 0 w 5157"/>
                    <a:gd name="T5" fmla="*/ 0 h 211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157" h="21131" fill="none" extrusionOk="0">
                      <a:moveTo>
                        <a:pt x="5157" y="20975"/>
                      </a:moveTo>
                      <a:cubicBezTo>
                        <a:pt x="4930" y="21030"/>
                        <a:pt x="4703" y="21082"/>
                        <a:pt x="4476" y="21131"/>
                      </a:cubicBezTo>
                    </a:path>
                    <a:path w="5157" h="21131" stroke="0" extrusionOk="0">
                      <a:moveTo>
                        <a:pt x="5157" y="20975"/>
                      </a:moveTo>
                      <a:cubicBezTo>
                        <a:pt x="4930" y="21030"/>
                        <a:pt x="4703" y="21082"/>
                        <a:pt x="4476" y="21131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63" name="Line 197">
                  <a:extLst>
                    <a:ext uri="{FF2B5EF4-FFF2-40B4-BE49-F238E27FC236}">
                      <a16:creationId xmlns:a16="http://schemas.microsoft.com/office/drawing/2014/main" id="{DD94FF89-2256-CB62-CFEE-791035BD7FE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16" y="3904"/>
                  <a:ext cx="18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64" name="Arc 198">
                  <a:extLst>
                    <a:ext uri="{FF2B5EF4-FFF2-40B4-BE49-F238E27FC236}">
                      <a16:creationId xmlns:a16="http://schemas.microsoft.com/office/drawing/2014/main" id="{42668F55-D314-5C3E-F636-8FF46E7301E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406" cy="1169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7185 w 7185"/>
                    <a:gd name="T1" fmla="*/ 20370 h 20684"/>
                    <a:gd name="T2" fmla="*/ 6223 w 7185"/>
                    <a:gd name="T3" fmla="*/ 20684 h 20684"/>
                    <a:gd name="T4" fmla="*/ 0 w 7185"/>
                    <a:gd name="T5" fmla="*/ 0 h 206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185" h="20684" fill="none" extrusionOk="0">
                      <a:moveTo>
                        <a:pt x="7184" y="20369"/>
                      </a:moveTo>
                      <a:cubicBezTo>
                        <a:pt x="6866" y="20482"/>
                        <a:pt x="6546" y="20586"/>
                        <a:pt x="6223" y="20684"/>
                      </a:cubicBezTo>
                    </a:path>
                    <a:path w="7185" h="20684" stroke="0" extrusionOk="0">
                      <a:moveTo>
                        <a:pt x="7184" y="20369"/>
                      </a:moveTo>
                      <a:cubicBezTo>
                        <a:pt x="6866" y="20482"/>
                        <a:pt x="6546" y="20586"/>
                        <a:pt x="6223" y="20684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65" name="Arc 199">
                  <a:extLst>
                    <a:ext uri="{FF2B5EF4-FFF2-40B4-BE49-F238E27FC236}">
                      <a16:creationId xmlns:a16="http://schemas.microsoft.com/office/drawing/2014/main" id="{0FF4D453-7495-F543-E951-929A90C97B4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352" cy="1185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6223 w 6223"/>
                    <a:gd name="T1" fmla="*/ 20684 h 20971"/>
                    <a:gd name="T2" fmla="*/ 5176 w 6223"/>
                    <a:gd name="T3" fmla="*/ 20971 h 20971"/>
                    <a:gd name="T4" fmla="*/ 0 w 6223"/>
                    <a:gd name="T5" fmla="*/ 0 h 209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223" h="20971" fill="none" extrusionOk="0">
                      <a:moveTo>
                        <a:pt x="6223" y="20684"/>
                      </a:moveTo>
                      <a:cubicBezTo>
                        <a:pt x="5876" y="20788"/>
                        <a:pt x="5527" y="20883"/>
                        <a:pt x="5175" y="20970"/>
                      </a:cubicBezTo>
                    </a:path>
                    <a:path w="6223" h="20971" stroke="0" extrusionOk="0">
                      <a:moveTo>
                        <a:pt x="6223" y="20684"/>
                      </a:moveTo>
                      <a:cubicBezTo>
                        <a:pt x="5876" y="20788"/>
                        <a:pt x="5527" y="20883"/>
                        <a:pt x="5175" y="20970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66" name="Line 200">
                  <a:extLst>
                    <a:ext uri="{FF2B5EF4-FFF2-40B4-BE49-F238E27FC236}">
                      <a16:creationId xmlns:a16="http://schemas.microsoft.com/office/drawing/2014/main" id="{6D7F0E19-74A6-77C6-8582-C88DA74408D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57" y="3813"/>
                  <a:ext cx="19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67" name="Arc 201">
                  <a:extLst>
                    <a:ext uri="{FF2B5EF4-FFF2-40B4-BE49-F238E27FC236}">
                      <a16:creationId xmlns:a16="http://schemas.microsoft.com/office/drawing/2014/main" id="{1AF02CB6-570B-B746-55A4-98BEE6BCA04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455" cy="1078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8568 w 8568"/>
                    <a:gd name="T1" fmla="*/ 19828 h 20285"/>
                    <a:gd name="T2" fmla="*/ 7423 w 8568"/>
                    <a:gd name="T3" fmla="*/ 20285 h 20285"/>
                    <a:gd name="T4" fmla="*/ 0 w 8568"/>
                    <a:gd name="T5" fmla="*/ 0 h 2028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568" h="20285" fill="none" extrusionOk="0">
                      <a:moveTo>
                        <a:pt x="8567" y="19827"/>
                      </a:moveTo>
                      <a:cubicBezTo>
                        <a:pt x="8190" y="19991"/>
                        <a:pt x="7808" y="20143"/>
                        <a:pt x="7422" y="20284"/>
                      </a:cubicBezTo>
                    </a:path>
                    <a:path w="8568" h="20285" stroke="0" extrusionOk="0">
                      <a:moveTo>
                        <a:pt x="8567" y="19827"/>
                      </a:moveTo>
                      <a:cubicBezTo>
                        <a:pt x="8190" y="19991"/>
                        <a:pt x="7808" y="20143"/>
                        <a:pt x="7422" y="20284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68" name="Arc 202">
                  <a:extLst>
                    <a:ext uri="{FF2B5EF4-FFF2-40B4-BE49-F238E27FC236}">
                      <a16:creationId xmlns:a16="http://schemas.microsoft.com/office/drawing/2014/main" id="{4C411482-D980-A375-9ACB-3E5C26E80B7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394" cy="1099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7423 w 7423"/>
                    <a:gd name="T1" fmla="*/ 20285 h 20690"/>
                    <a:gd name="T2" fmla="*/ 6205 w 7423"/>
                    <a:gd name="T3" fmla="*/ 20690 h 20690"/>
                    <a:gd name="T4" fmla="*/ 0 w 7423"/>
                    <a:gd name="T5" fmla="*/ 0 h 2069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423" h="20690" fill="none" extrusionOk="0">
                      <a:moveTo>
                        <a:pt x="7422" y="20284"/>
                      </a:moveTo>
                      <a:cubicBezTo>
                        <a:pt x="7020" y="20431"/>
                        <a:pt x="6614" y="20566"/>
                        <a:pt x="6204" y="20689"/>
                      </a:cubicBezTo>
                    </a:path>
                    <a:path w="7423" h="20690" stroke="0" extrusionOk="0">
                      <a:moveTo>
                        <a:pt x="7422" y="20284"/>
                      </a:moveTo>
                      <a:cubicBezTo>
                        <a:pt x="7020" y="20431"/>
                        <a:pt x="6614" y="20566"/>
                        <a:pt x="6204" y="20689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69" name="Line 203">
                  <a:extLst>
                    <a:ext uri="{FF2B5EF4-FFF2-40B4-BE49-F238E27FC236}">
                      <a16:creationId xmlns:a16="http://schemas.microsoft.com/office/drawing/2014/main" id="{8D150A56-83A6-0CAB-B5C3-5328C5B2435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94" y="3726"/>
                  <a:ext cx="23" cy="6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470" name="Arc 204">
                  <a:extLst>
                    <a:ext uri="{FF2B5EF4-FFF2-40B4-BE49-F238E27FC236}">
                      <a16:creationId xmlns:a16="http://schemas.microsoft.com/office/drawing/2014/main" id="{B58D2F94-37CC-A2F0-20C0-858EDDC663A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492" cy="985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9886 w 9886"/>
                    <a:gd name="T1" fmla="*/ 19205 h 19794"/>
                    <a:gd name="T2" fmla="*/ 8647 w 9886"/>
                    <a:gd name="T3" fmla="*/ 19794 h 19794"/>
                    <a:gd name="T4" fmla="*/ 0 w 9886"/>
                    <a:gd name="T5" fmla="*/ 0 h 1979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886" h="19794" fill="none" extrusionOk="0">
                      <a:moveTo>
                        <a:pt x="9885" y="19204"/>
                      </a:moveTo>
                      <a:cubicBezTo>
                        <a:pt x="9479" y="19414"/>
                        <a:pt x="9066" y="19610"/>
                        <a:pt x="8646" y="19793"/>
                      </a:cubicBezTo>
                    </a:path>
                    <a:path w="9886" h="19794" stroke="0" extrusionOk="0">
                      <a:moveTo>
                        <a:pt x="9885" y="19204"/>
                      </a:moveTo>
                      <a:cubicBezTo>
                        <a:pt x="9479" y="19414"/>
                        <a:pt x="9066" y="19610"/>
                        <a:pt x="8646" y="19793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</p:grpSp>
          <p:grpSp>
            <p:nvGrpSpPr>
              <p:cNvPr id="23" name="Group 406">
                <a:extLst>
                  <a:ext uri="{FF2B5EF4-FFF2-40B4-BE49-F238E27FC236}">
                    <a16:creationId xmlns:a16="http://schemas.microsoft.com/office/drawing/2014/main" id="{50CFA758-2B57-E46B-934C-FE4619F95F2C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47" y="1362"/>
                <a:ext cx="2358" cy="3023"/>
                <a:chOff x="47" y="1362"/>
                <a:chExt cx="2358" cy="3023"/>
              </a:xfrm>
            </p:grpSpPr>
            <p:sp>
              <p:nvSpPr>
                <p:cNvPr id="71" name="Arc 206">
                  <a:extLst>
                    <a:ext uri="{FF2B5EF4-FFF2-40B4-BE49-F238E27FC236}">
                      <a16:creationId xmlns:a16="http://schemas.microsoft.com/office/drawing/2014/main" id="{449D7B6C-6F1A-46CD-2BA4-18FE226760A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430" cy="1010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8647 w 8647"/>
                    <a:gd name="T1" fmla="*/ 19794 h 20302"/>
                    <a:gd name="T2" fmla="*/ 7374 w 8647"/>
                    <a:gd name="T3" fmla="*/ 20302 h 20302"/>
                    <a:gd name="T4" fmla="*/ 0 w 8647"/>
                    <a:gd name="T5" fmla="*/ 0 h 2030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647" h="20302" fill="none" extrusionOk="0">
                      <a:moveTo>
                        <a:pt x="8646" y="19793"/>
                      </a:moveTo>
                      <a:cubicBezTo>
                        <a:pt x="8228" y="19976"/>
                        <a:pt x="7803" y="20146"/>
                        <a:pt x="7374" y="20302"/>
                      </a:cubicBezTo>
                    </a:path>
                    <a:path w="8647" h="20302" stroke="0" extrusionOk="0">
                      <a:moveTo>
                        <a:pt x="8646" y="19793"/>
                      </a:moveTo>
                      <a:cubicBezTo>
                        <a:pt x="8228" y="19976"/>
                        <a:pt x="7803" y="20146"/>
                        <a:pt x="7374" y="20302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72" name="Line 207">
                  <a:extLst>
                    <a:ext uri="{FF2B5EF4-FFF2-40B4-BE49-F238E27FC236}">
                      <a16:creationId xmlns:a16="http://schemas.microsoft.com/office/drawing/2014/main" id="{83689D7F-0076-41F1-AC4A-A1C4918C98C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26" y="3630"/>
                  <a:ext cx="27" cy="6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73" name="Arc 208">
                  <a:extLst>
                    <a:ext uri="{FF2B5EF4-FFF2-40B4-BE49-F238E27FC236}">
                      <a16:creationId xmlns:a16="http://schemas.microsoft.com/office/drawing/2014/main" id="{270839AE-DDCA-0D73-BAA3-5DA9FDBB19C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515" cy="891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1107 w 11107"/>
                    <a:gd name="T1" fmla="*/ 18526 h 19219"/>
                    <a:gd name="T2" fmla="*/ 9858 w 11107"/>
                    <a:gd name="T3" fmla="*/ 19219 h 19219"/>
                    <a:gd name="T4" fmla="*/ 0 w 11107"/>
                    <a:gd name="T5" fmla="*/ 0 h 192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107" h="19219" fill="none" extrusionOk="0">
                      <a:moveTo>
                        <a:pt x="11106" y="18525"/>
                      </a:moveTo>
                      <a:cubicBezTo>
                        <a:pt x="10698" y="18770"/>
                        <a:pt x="10281" y="19001"/>
                        <a:pt x="9858" y="19219"/>
                      </a:cubicBezTo>
                    </a:path>
                    <a:path w="11107" h="19219" stroke="0" extrusionOk="0">
                      <a:moveTo>
                        <a:pt x="11106" y="18525"/>
                      </a:moveTo>
                      <a:cubicBezTo>
                        <a:pt x="10698" y="18770"/>
                        <a:pt x="10281" y="19001"/>
                        <a:pt x="9858" y="19219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74" name="Arc 209">
                  <a:extLst>
                    <a:ext uri="{FF2B5EF4-FFF2-40B4-BE49-F238E27FC236}">
                      <a16:creationId xmlns:a16="http://schemas.microsoft.com/office/drawing/2014/main" id="{944655A7-835C-B2DA-8748-BECAF3F7A14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457" cy="917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9858 w 9858"/>
                    <a:gd name="T1" fmla="*/ 19219 h 19786"/>
                    <a:gd name="T2" fmla="*/ 8664 w 9858"/>
                    <a:gd name="T3" fmla="*/ 19786 h 19786"/>
                    <a:gd name="T4" fmla="*/ 0 w 9858"/>
                    <a:gd name="T5" fmla="*/ 0 h 197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858" h="19786" fill="none" extrusionOk="0">
                      <a:moveTo>
                        <a:pt x="9858" y="19219"/>
                      </a:moveTo>
                      <a:cubicBezTo>
                        <a:pt x="9465" y="19420"/>
                        <a:pt x="9067" y="19609"/>
                        <a:pt x="8664" y="19786"/>
                      </a:cubicBezTo>
                    </a:path>
                    <a:path w="9858" h="19786" stroke="0" extrusionOk="0">
                      <a:moveTo>
                        <a:pt x="9858" y="19219"/>
                      </a:moveTo>
                      <a:cubicBezTo>
                        <a:pt x="9465" y="19420"/>
                        <a:pt x="9067" y="19609"/>
                        <a:pt x="8664" y="19786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75" name="Line 210">
                  <a:extLst>
                    <a:ext uri="{FF2B5EF4-FFF2-40B4-BE49-F238E27FC236}">
                      <a16:creationId xmlns:a16="http://schemas.microsoft.com/office/drawing/2014/main" id="{6A25DDAA-8595-A36A-61BA-D503AD7C2AD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49" y="3534"/>
                  <a:ext cx="32" cy="6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76" name="Arc 211">
                  <a:extLst>
                    <a:ext uri="{FF2B5EF4-FFF2-40B4-BE49-F238E27FC236}">
                      <a16:creationId xmlns:a16="http://schemas.microsoft.com/office/drawing/2014/main" id="{F9A367A4-A20E-7AEE-65B6-6EF1C3C1C1B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528" cy="791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2343 w 12343"/>
                    <a:gd name="T1" fmla="*/ 17726 h 18512"/>
                    <a:gd name="T2" fmla="*/ 11130 w 12343"/>
                    <a:gd name="T3" fmla="*/ 18512 h 18512"/>
                    <a:gd name="T4" fmla="*/ 0 w 12343"/>
                    <a:gd name="T5" fmla="*/ 0 h 185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343" h="18512" fill="none" extrusionOk="0">
                      <a:moveTo>
                        <a:pt x="12342" y="17725"/>
                      </a:moveTo>
                      <a:cubicBezTo>
                        <a:pt x="11947" y="18001"/>
                        <a:pt x="11542" y="18263"/>
                        <a:pt x="11129" y="18511"/>
                      </a:cubicBezTo>
                    </a:path>
                    <a:path w="12343" h="18512" stroke="0" extrusionOk="0">
                      <a:moveTo>
                        <a:pt x="12342" y="17725"/>
                      </a:moveTo>
                      <a:cubicBezTo>
                        <a:pt x="11947" y="18001"/>
                        <a:pt x="11542" y="18263"/>
                        <a:pt x="11129" y="18511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77" name="Arc 212">
                  <a:extLst>
                    <a:ext uri="{FF2B5EF4-FFF2-40B4-BE49-F238E27FC236}">
                      <a16:creationId xmlns:a16="http://schemas.microsoft.com/office/drawing/2014/main" id="{154C582D-D647-3272-A0EC-ADAD1F1BDA6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476" cy="819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1130 w 11130"/>
                    <a:gd name="T1" fmla="*/ 18512 h 19167"/>
                    <a:gd name="T2" fmla="*/ 9959 w 11130"/>
                    <a:gd name="T3" fmla="*/ 19167 h 19167"/>
                    <a:gd name="T4" fmla="*/ 0 w 11130"/>
                    <a:gd name="T5" fmla="*/ 0 h 191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130" h="19167" fill="none" extrusionOk="0">
                      <a:moveTo>
                        <a:pt x="11129" y="18511"/>
                      </a:moveTo>
                      <a:cubicBezTo>
                        <a:pt x="10746" y="18742"/>
                        <a:pt x="10356" y="18960"/>
                        <a:pt x="9959" y="19167"/>
                      </a:cubicBezTo>
                    </a:path>
                    <a:path w="11130" h="19167" stroke="0" extrusionOk="0">
                      <a:moveTo>
                        <a:pt x="11129" y="18511"/>
                      </a:moveTo>
                      <a:cubicBezTo>
                        <a:pt x="10746" y="18742"/>
                        <a:pt x="10356" y="18960"/>
                        <a:pt x="9959" y="19167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78" name="Line 213">
                  <a:extLst>
                    <a:ext uri="{FF2B5EF4-FFF2-40B4-BE49-F238E27FC236}">
                      <a16:creationId xmlns:a16="http://schemas.microsoft.com/office/drawing/2014/main" id="{22B4E756-3593-4A65-A2C4-BB348AA36C9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58" y="3442"/>
                  <a:ext cx="41" cy="6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79" name="Arc 214">
                  <a:extLst>
                    <a:ext uri="{FF2B5EF4-FFF2-40B4-BE49-F238E27FC236}">
                      <a16:creationId xmlns:a16="http://schemas.microsoft.com/office/drawing/2014/main" id="{F4568DCA-8A17-74F8-0E8E-6CBFDBEED73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601" cy="672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5274 w 15274"/>
                    <a:gd name="T1" fmla="*/ 15274 h 17061"/>
                    <a:gd name="T2" fmla="*/ 13247 w 15274"/>
                    <a:gd name="T3" fmla="*/ 17061 h 17061"/>
                    <a:gd name="T4" fmla="*/ 0 w 15274"/>
                    <a:gd name="T5" fmla="*/ 0 h 170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274" h="17061" fill="none" extrusionOk="0">
                      <a:moveTo>
                        <a:pt x="15273" y="15273"/>
                      </a:moveTo>
                      <a:cubicBezTo>
                        <a:pt x="14635" y="15911"/>
                        <a:pt x="13959" y="16508"/>
                        <a:pt x="13246" y="17060"/>
                      </a:cubicBezTo>
                    </a:path>
                    <a:path w="15274" h="17061" stroke="0" extrusionOk="0">
                      <a:moveTo>
                        <a:pt x="15273" y="15273"/>
                      </a:moveTo>
                      <a:cubicBezTo>
                        <a:pt x="14635" y="15911"/>
                        <a:pt x="13959" y="16508"/>
                        <a:pt x="13246" y="17060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80" name="Arc 215">
                  <a:extLst>
                    <a:ext uri="{FF2B5EF4-FFF2-40B4-BE49-F238E27FC236}">
                      <a16:creationId xmlns:a16="http://schemas.microsoft.com/office/drawing/2014/main" id="{2A6FCB4B-D552-FDB6-08E1-9E5CCF94569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522" cy="728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3247 w 13247"/>
                    <a:gd name="T1" fmla="*/ 17061 h 18495"/>
                    <a:gd name="T2" fmla="*/ 11158 w 13247"/>
                    <a:gd name="T3" fmla="*/ 18495 h 18495"/>
                    <a:gd name="T4" fmla="*/ 0 w 13247"/>
                    <a:gd name="T5" fmla="*/ 0 h 184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247" h="18495" fill="none" extrusionOk="0">
                      <a:moveTo>
                        <a:pt x="13246" y="17060"/>
                      </a:moveTo>
                      <a:cubicBezTo>
                        <a:pt x="12579" y="17579"/>
                        <a:pt x="11881" y="18058"/>
                        <a:pt x="11157" y="18494"/>
                      </a:cubicBezTo>
                    </a:path>
                    <a:path w="13247" h="18495" stroke="0" extrusionOk="0">
                      <a:moveTo>
                        <a:pt x="13246" y="17060"/>
                      </a:moveTo>
                      <a:cubicBezTo>
                        <a:pt x="12579" y="17579"/>
                        <a:pt x="11881" y="18058"/>
                        <a:pt x="11157" y="18494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81" name="Line 216">
                  <a:extLst>
                    <a:ext uri="{FF2B5EF4-FFF2-40B4-BE49-F238E27FC236}">
                      <a16:creationId xmlns:a16="http://schemas.microsoft.com/office/drawing/2014/main" id="{23FA1C15-0460-3D3F-BAAE-CC6B8EA86EA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99" y="3328"/>
                  <a:ext cx="46" cy="5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82" name="Arc 217">
                  <a:extLst>
                    <a:ext uri="{FF2B5EF4-FFF2-40B4-BE49-F238E27FC236}">
                      <a16:creationId xmlns:a16="http://schemas.microsoft.com/office/drawing/2014/main" id="{B9CDFBD3-CF5E-3365-D2D7-1277BD7DD08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671" cy="511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8646 w 18646"/>
                    <a:gd name="T1" fmla="*/ 10904 h 14210"/>
                    <a:gd name="T2" fmla="*/ 16268 w 18646"/>
                    <a:gd name="T3" fmla="*/ 14210 h 14210"/>
                    <a:gd name="T4" fmla="*/ 0 w 18646"/>
                    <a:gd name="T5" fmla="*/ 0 h 142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646" h="14210" fill="none" extrusionOk="0">
                      <a:moveTo>
                        <a:pt x="18645" y="10903"/>
                      </a:moveTo>
                      <a:cubicBezTo>
                        <a:pt x="17959" y="12078"/>
                        <a:pt x="17162" y="13185"/>
                        <a:pt x="16267" y="14209"/>
                      </a:cubicBezTo>
                    </a:path>
                    <a:path w="18646" h="14210" stroke="0" extrusionOk="0">
                      <a:moveTo>
                        <a:pt x="18645" y="10903"/>
                      </a:moveTo>
                      <a:cubicBezTo>
                        <a:pt x="17959" y="12078"/>
                        <a:pt x="17162" y="13185"/>
                        <a:pt x="16267" y="14209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83" name="Arc 218">
                  <a:extLst>
                    <a:ext uri="{FF2B5EF4-FFF2-40B4-BE49-F238E27FC236}">
                      <a16:creationId xmlns:a16="http://schemas.microsoft.com/office/drawing/2014/main" id="{34CE3E19-AD80-3DFE-F58D-B2FB8ACFFC5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586" cy="612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6268 w 16268"/>
                    <a:gd name="T1" fmla="*/ 14210 h 16996"/>
                    <a:gd name="T2" fmla="*/ 13330 w 16268"/>
                    <a:gd name="T3" fmla="*/ 16996 h 16996"/>
                    <a:gd name="T4" fmla="*/ 0 w 16268"/>
                    <a:gd name="T5" fmla="*/ 0 h 1699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268" h="16996" fill="none" extrusionOk="0">
                      <a:moveTo>
                        <a:pt x="16267" y="14209"/>
                      </a:moveTo>
                      <a:cubicBezTo>
                        <a:pt x="15377" y="15228"/>
                        <a:pt x="14394" y="16161"/>
                        <a:pt x="13330" y="16996"/>
                      </a:cubicBezTo>
                    </a:path>
                    <a:path w="16268" h="16996" stroke="0" extrusionOk="0">
                      <a:moveTo>
                        <a:pt x="16267" y="14209"/>
                      </a:moveTo>
                      <a:cubicBezTo>
                        <a:pt x="15377" y="15228"/>
                        <a:pt x="14394" y="16161"/>
                        <a:pt x="13330" y="16996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84" name="Line 219">
                  <a:extLst>
                    <a:ext uri="{FF2B5EF4-FFF2-40B4-BE49-F238E27FC236}">
                      <a16:creationId xmlns:a16="http://schemas.microsoft.com/office/drawing/2014/main" id="{65C071E2-27B6-E389-4B89-C405FB0F888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54" y="3177"/>
                  <a:ext cx="55" cy="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85" name="Arc 220">
                  <a:extLst>
                    <a:ext uri="{FF2B5EF4-FFF2-40B4-BE49-F238E27FC236}">
                      <a16:creationId xmlns:a16="http://schemas.microsoft.com/office/drawing/2014/main" id="{DD809609-D781-95D0-93D8-160150A4291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5"/>
                  <a:ext cx="681" cy="331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0889 w 20889"/>
                    <a:gd name="T1" fmla="*/ 5495 h 10142"/>
                    <a:gd name="T2" fmla="*/ 19071 w 20889"/>
                    <a:gd name="T3" fmla="*/ 10142 h 10142"/>
                    <a:gd name="T4" fmla="*/ 0 w 20889"/>
                    <a:gd name="T5" fmla="*/ 0 h 101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889" h="10142" fill="none" extrusionOk="0">
                      <a:moveTo>
                        <a:pt x="20889" y="5495"/>
                      </a:moveTo>
                      <a:cubicBezTo>
                        <a:pt x="20464" y="7109"/>
                        <a:pt x="19854" y="8668"/>
                        <a:pt x="19070" y="10141"/>
                      </a:cubicBezTo>
                    </a:path>
                    <a:path w="20889" h="10142" stroke="0" extrusionOk="0">
                      <a:moveTo>
                        <a:pt x="20889" y="5495"/>
                      </a:moveTo>
                      <a:cubicBezTo>
                        <a:pt x="20464" y="7109"/>
                        <a:pt x="19854" y="8668"/>
                        <a:pt x="19070" y="10141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86" name="Arc 221">
                  <a:extLst>
                    <a:ext uri="{FF2B5EF4-FFF2-40B4-BE49-F238E27FC236}">
                      <a16:creationId xmlns:a16="http://schemas.microsoft.com/office/drawing/2014/main" id="{00902304-3D48-0B04-6870-2273456C4AC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5"/>
                  <a:ext cx="622" cy="463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9071 w 19071"/>
                    <a:gd name="T1" fmla="*/ 10142 h 14199"/>
                    <a:gd name="T2" fmla="*/ 16277 w 19071"/>
                    <a:gd name="T3" fmla="*/ 14199 h 14199"/>
                    <a:gd name="T4" fmla="*/ 0 w 19071"/>
                    <a:gd name="T5" fmla="*/ 0 h 1419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071" h="14199" fill="none" extrusionOk="0">
                      <a:moveTo>
                        <a:pt x="19070" y="10141"/>
                      </a:moveTo>
                      <a:cubicBezTo>
                        <a:pt x="18297" y="11596"/>
                        <a:pt x="17360" y="12957"/>
                        <a:pt x="16277" y="14199"/>
                      </a:cubicBezTo>
                    </a:path>
                    <a:path w="19071" h="14199" stroke="0" extrusionOk="0">
                      <a:moveTo>
                        <a:pt x="19070" y="10141"/>
                      </a:moveTo>
                      <a:cubicBezTo>
                        <a:pt x="18297" y="11596"/>
                        <a:pt x="17360" y="12957"/>
                        <a:pt x="16277" y="14199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87" name="Line 222">
                  <a:extLst>
                    <a:ext uri="{FF2B5EF4-FFF2-40B4-BE49-F238E27FC236}">
                      <a16:creationId xmlns:a16="http://schemas.microsoft.com/office/drawing/2014/main" id="{FBC15FF4-25DF-5CDC-2DF2-F612B62C2AC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81" y="3013"/>
                  <a:ext cx="64" cy="3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88" name="Arc 223">
                  <a:extLst>
                    <a:ext uri="{FF2B5EF4-FFF2-40B4-BE49-F238E27FC236}">
                      <a16:creationId xmlns:a16="http://schemas.microsoft.com/office/drawing/2014/main" id="{2646FF23-5E6E-D2FA-1FEF-C849D46BDC4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693"/>
                  <a:ext cx="627" cy="164"/>
                </a:xfrm>
                <a:custGeom>
                  <a:avLst/>
                  <a:gdLst>
                    <a:gd name="G0" fmla="+- 0 0 0"/>
                    <a:gd name="G1" fmla="+- 793 0 0"/>
                    <a:gd name="G2" fmla="+- 21600 0 0"/>
                    <a:gd name="T0" fmla="*/ 21585 w 21600"/>
                    <a:gd name="T1" fmla="*/ 0 h 5642"/>
                    <a:gd name="T2" fmla="*/ 21049 w 21600"/>
                    <a:gd name="T3" fmla="*/ 5642 h 5642"/>
                    <a:gd name="T4" fmla="*/ 0 w 21600"/>
                    <a:gd name="T5" fmla="*/ 793 h 56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600" h="5642" fill="none" extrusionOk="0">
                      <a:moveTo>
                        <a:pt x="21585" y="-1"/>
                      </a:moveTo>
                      <a:cubicBezTo>
                        <a:pt x="21595" y="264"/>
                        <a:pt x="21600" y="528"/>
                        <a:pt x="21600" y="793"/>
                      </a:cubicBezTo>
                      <a:cubicBezTo>
                        <a:pt x="21600" y="2424"/>
                        <a:pt x="21415" y="4051"/>
                        <a:pt x="21048" y="5641"/>
                      </a:cubicBezTo>
                    </a:path>
                    <a:path w="21600" h="5642" stroke="0" extrusionOk="0">
                      <a:moveTo>
                        <a:pt x="21585" y="-1"/>
                      </a:moveTo>
                      <a:cubicBezTo>
                        <a:pt x="21595" y="264"/>
                        <a:pt x="21600" y="528"/>
                        <a:pt x="21600" y="793"/>
                      </a:cubicBezTo>
                      <a:cubicBezTo>
                        <a:pt x="21600" y="2424"/>
                        <a:pt x="21415" y="4051"/>
                        <a:pt x="21048" y="5641"/>
                      </a:cubicBezTo>
                      <a:lnTo>
                        <a:pt x="0" y="793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89" name="Arc 224">
                  <a:extLst>
                    <a:ext uri="{FF2B5EF4-FFF2-40B4-BE49-F238E27FC236}">
                      <a16:creationId xmlns:a16="http://schemas.microsoft.com/office/drawing/2014/main" id="{CBCE660A-1C41-15C2-FD3B-931818DF44F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611" cy="293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1049 w 21049"/>
                    <a:gd name="T1" fmla="*/ 4849 h 10086"/>
                    <a:gd name="T2" fmla="*/ 19101 w 21049"/>
                    <a:gd name="T3" fmla="*/ 10086 h 10086"/>
                    <a:gd name="T4" fmla="*/ 0 w 21049"/>
                    <a:gd name="T5" fmla="*/ 0 h 100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049" h="10086" fill="none" extrusionOk="0">
                      <a:moveTo>
                        <a:pt x="21048" y="4848"/>
                      </a:moveTo>
                      <a:cubicBezTo>
                        <a:pt x="20628" y="6671"/>
                        <a:pt x="19974" y="8431"/>
                        <a:pt x="19100" y="10085"/>
                      </a:cubicBezTo>
                    </a:path>
                    <a:path w="21049" h="10086" stroke="0" extrusionOk="0">
                      <a:moveTo>
                        <a:pt x="21048" y="4848"/>
                      </a:moveTo>
                      <a:cubicBezTo>
                        <a:pt x="20628" y="6671"/>
                        <a:pt x="19974" y="8431"/>
                        <a:pt x="19100" y="10085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90" name="Line 225">
                  <a:extLst>
                    <a:ext uri="{FF2B5EF4-FFF2-40B4-BE49-F238E27FC236}">
                      <a16:creationId xmlns:a16="http://schemas.microsoft.com/office/drawing/2014/main" id="{C168522D-15C0-5A4E-5FBE-8742995CFC4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263" y="2843"/>
                  <a:ext cx="73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91" name="Arc 226">
                  <a:extLst>
                    <a:ext uri="{FF2B5EF4-FFF2-40B4-BE49-F238E27FC236}">
                      <a16:creationId xmlns:a16="http://schemas.microsoft.com/office/drawing/2014/main" id="{EC565F9E-F081-E4F3-AF67-972BC73B3EB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426"/>
                  <a:ext cx="546" cy="290"/>
                </a:xfrm>
                <a:custGeom>
                  <a:avLst/>
                  <a:gdLst>
                    <a:gd name="G0" fmla="+- 0 0 0"/>
                    <a:gd name="G1" fmla="+- 11314 0 0"/>
                    <a:gd name="G2" fmla="+- 21600 0 0"/>
                    <a:gd name="T0" fmla="*/ 18400 w 21324"/>
                    <a:gd name="T1" fmla="*/ 0 h 11314"/>
                    <a:gd name="T2" fmla="*/ 21324 w 21324"/>
                    <a:gd name="T3" fmla="*/ 7872 h 11314"/>
                    <a:gd name="T4" fmla="*/ 0 w 21324"/>
                    <a:gd name="T5" fmla="*/ 11314 h 1131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324" h="11314" fill="none" extrusionOk="0">
                      <a:moveTo>
                        <a:pt x="18399" y="0"/>
                      </a:moveTo>
                      <a:cubicBezTo>
                        <a:pt x="19880" y="2407"/>
                        <a:pt x="20873" y="5082"/>
                        <a:pt x="21323" y="7872"/>
                      </a:cubicBezTo>
                    </a:path>
                    <a:path w="21324" h="11314" stroke="0" extrusionOk="0">
                      <a:moveTo>
                        <a:pt x="18399" y="0"/>
                      </a:moveTo>
                      <a:cubicBezTo>
                        <a:pt x="19880" y="2407"/>
                        <a:pt x="20873" y="5082"/>
                        <a:pt x="21323" y="7872"/>
                      </a:cubicBezTo>
                      <a:lnTo>
                        <a:pt x="0" y="11314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92" name="Arc 227">
                  <a:extLst>
                    <a:ext uri="{FF2B5EF4-FFF2-40B4-BE49-F238E27FC236}">
                      <a16:creationId xmlns:a16="http://schemas.microsoft.com/office/drawing/2014/main" id="{C3AF207A-659D-B88B-25FF-CE91C498EFA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628"/>
                  <a:ext cx="554" cy="211"/>
                </a:xfrm>
                <a:custGeom>
                  <a:avLst/>
                  <a:gdLst>
                    <a:gd name="G0" fmla="+- 0 0 0"/>
                    <a:gd name="G1" fmla="+- 3442 0 0"/>
                    <a:gd name="G2" fmla="+- 21600 0 0"/>
                    <a:gd name="T0" fmla="*/ 21324 w 21600"/>
                    <a:gd name="T1" fmla="*/ 0 h 8248"/>
                    <a:gd name="T2" fmla="*/ 21059 w 21600"/>
                    <a:gd name="T3" fmla="*/ 8248 h 8248"/>
                    <a:gd name="T4" fmla="*/ 0 w 21600"/>
                    <a:gd name="T5" fmla="*/ 3442 h 82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600" h="8248" fill="none" extrusionOk="0">
                      <a:moveTo>
                        <a:pt x="21323" y="0"/>
                      </a:moveTo>
                      <a:cubicBezTo>
                        <a:pt x="21507" y="1138"/>
                        <a:pt x="21600" y="2289"/>
                        <a:pt x="21600" y="3442"/>
                      </a:cubicBezTo>
                      <a:cubicBezTo>
                        <a:pt x="21600" y="5059"/>
                        <a:pt x="21418" y="6671"/>
                        <a:pt x="21058" y="8247"/>
                      </a:cubicBezTo>
                    </a:path>
                    <a:path w="21600" h="8248" stroke="0" extrusionOk="0">
                      <a:moveTo>
                        <a:pt x="21323" y="0"/>
                      </a:moveTo>
                      <a:cubicBezTo>
                        <a:pt x="21507" y="1138"/>
                        <a:pt x="21600" y="2289"/>
                        <a:pt x="21600" y="3442"/>
                      </a:cubicBezTo>
                      <a:cubicBezTo>
                        <a:pt x="21600" y="5059"/>
                        <a:pt x="21418" y="6671"/>
                        <a:pt x="21058" y="8247"/>
                      </a:cubicBezTo>
                      <a:lnTo>
                        <a:pt x="0" y="3442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93" name="Line 228">
                  <a:extLst>
                    <a:ext uri="{FF2B5EF4-FFF2-40B4-BE49-F238E27FC236}">
                      <a16:creationId xmlns:a16="http://schemas.microsoft.com/office/drawing/2014/main" id="{D6A7B969-0E2C-8CD2-612D-A8E61B1BB78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2194" y="2624"/>
                  <a:ext cx="74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94" name="Rectangle 229">
                  <a:extLst>
                    <a:ext uri="{FF2B5EF4-FFF2-40B4-BE49-F238E27FC236}">
                      <a16:creationId xmlns:a16="http://schemas.microsoft.com/office/drawing/2014/main" id="{0451442F-E0CA-5B0D-2CE3-767C3E8D860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5660000">
                  <a:off x="1772" y="4174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AC05727</a:t>
                  </a:r>
                </a:p>
              </p:txBody>
            </p:sp>
            <p:sp>
              <p:nvSpPr>
                <p:cNvPr id="95" name="Line 230">
                  <a:extLst>
                    <a:ext uri="{FF2B5EF4-FFF2-40B4-BE49-F238E27FC236}">
                      <a16:creationId xmlns:a16="http://schemas.microsoft.com/office/drawing/2014/main" id="{9EFA15AA-2D2C-9E62-521A-F433E674A05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06" y="4000"/>
                  <a:ext cx="10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96" name="Rectangle 231">
                  <a:extLst>
                    <a:ext uri="{FF2B5EF4-FFF2-40B4-BE49-F238E27FC236}">
                      <a16:creationId xmlns:a16="http://schemas.microsoft.com/office/drawing/2014/main" id="{741D3409-62BB-EC0D-2997-2CA714A393D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5900000">
                  <a:off x="1676" y="4189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AC05728</a:t>
                  </a:r>
                </a:p>
              </p:txBody>
            </p:sp>
            <p:sp>
              <p:nvSpPr>
                <p:cNvPr id="97" name="Line 232">
                  <a:extLst>
                    <a:ext uri="{FF2B5EF4-FFF2-40B4-BE49-F238E27FC236}">
                      <a16:creationId xmlns:a16="http://schemas.microsoft.com/office/drawing/2014/main" id="{58F163BC-D450-45BC-E2B4-0D68E8EDB75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20" y="4009"/>
                  <a:ext cx="4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98" name="Arc 233">
                  <a:extLst>
                    <a:ext uri="{FF2B5EF4-FFF2-40B4-BE49-F238E27FC236}">
                      <a16:creationId xmlns:a16="http://schemas.microsoft.com/office/drawing/2014/main" id="{126B9BB5-0EE0-FF6E-9633-E1A8F898622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82" cy="1291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3031 w 3031"/>
                    <a:gd name="T1" fmla="*/ 21386 h 21472"/>
                    <a:gd name="T2" fmla="*/ 2349 w 3031"/>
                    <a:gd name="T3" fmla="*/ 21472 h 21472"/>
                    <a:gd name="T4" fmla="*/ 0 w 3031"/>
                    <a:gd name="T5" fmla="*/ 0 h 214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031" h="21472" fill="none" extrusionOk="0">
                      <a:moveTo>
                        <a:pt x="3031" y="21386"/>
                      </a:moveTo>
                      <a:cubicBezTo>
                        <a:pt x="2804" y="21418"/>
                        <a:pt x="2576" y="21446"/>
                        <a:pt x="2348" y="21471"/>
                      </a:cubicBezTo>
                    </a:path>
                    <a:path w="3031" h="21472" stroke="0" extrusionOk="0">
                      <a:moveTo>
                        <a:pt x="3031" y="21386"/>
                      </a:moveTo>
                      <a:cubicBezTo>
                        <a:pt x="2804" y="21418"/>
                        <a:pt x="2576" y="21446"/>
                        <a:pt x="2348" y="21471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99" name="Arc 234">
                  <a:extLst>
                    <a:ext uri="{FF2B5EF4-FFF2-40B4-BE49-F238E27FC236}">
                      <a16:creationId xmlns:a16="http://schemas.microsoft.com/office/drawing/2014/main" id="{FA628210-86F0-EDA0-3D12-BB479198A78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141" cy="1295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2349 w 2349"/>
                    <a:gd name="T1" fmla="*/ 21472 h 21541"/>
                    <a:gd name="T2" fmla="*/ 1599 w 2349"/>
                    <a:gd name="T3" fmla="*/ 21541 h 21541"/>
                    <a:gd name="T4" fmla="*/ 0 w 2349"/>
                    <a:gd name="T5" fmla="*/ 0 h 2154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349" h="21541" fill="none" extrusionOk="0">
                      <a:moveTo>
                        <a:pt x="2348" y="21471"/>
                      </a:moveTo>
                      <a:cubicBezTo>
                        <a:pt x="2099" y="21499"/>
                        <a:pt x="1849" y="21522"/>
                        <a:pt x="1598" y="21540"/>
                      </a:cubicBezTo>
                    </a:path>
                    <a:path w="2349" h="21541" stroke="0" extrusionOk="0">
                      <a:moveTo>
                        <a:pt x="2348" y="21471"/>
                      </a:moveTo>
                      <a:cubicBezTo>
                        <a:pt x="2099" y="21499"/>
                        <a:pt x="1849" y="21522"/>
                        <a:pt x="1598" y="21540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00" name="Line 235">
                  <a:extLst>
                    <a:ext uri="{FF2B5EF4-FFF2-40B4-BE49-F238E27FC236}">
                      <a16:creationId xmlns:a16="http://schemas.microsoft.com/office/drawing/2014/main" id="{E3F462AD-FDE7-25B8-9D1B-2B5279727F2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833" y="3707"/>
                  <a:ext cx="32" cy="29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01" name="Rectangle 236">
                  <a:extLst>
                    <a:ext uri="{FF2B5EF4-FFF2-40B4-BE49-F238E27FC236}">
                      <a16:creationId xmlns:a16="http://schemas.microsoft.com/office/drawing/2014/main" id="{F22E3C3C-AB19-6B83-B04F-1245C379384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140000">
                  <a:off x="1574" y="4188"/>
                  <a:ext cx="30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AF61455</a:t>
                  </a:r>
                </a:p>
              </p:txBody>
            </p:sp>
            <p:sp>
              <p:nvSpPr>
                <p:cNvPr id="102" name="Line 237">
                  <a:extLst>
                    <a:ext uri="{FF2B5EF4-FFF2-40B4-BE49-F238E27FC236}">
                      <a16:creationId xmlns:a16="http://schemas.microsoft.com/office/drawing/2014/main" id="{F7FFAB44-B6B9-8A36-9D4E-6BA8DEA7CEE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733" y="4014"/>
                  <a:ext cx="0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03" name="Rectangle 238">
                  <a:extLst>
                    <a:ext uri="{FF2B5EF4-FFF2-40B4-BE49-F238E27FC236}">
                      <a16:creationId xmlns:a16="http://schemas.microsoft.com/office/drawing/2014/main" id="{568C984D-EF9E-C2C1-E1F6-4082987BBBC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380000">
                  <a:off x="1471" y="4188"/>
                  <a:ext cx="312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AB70907</a:t>
                  </a:r>
                </a:p>
              </p:txBody>
            </p:sp>
            <p:sp>
              <p:nvSpPr>
                <p:cNvPr id="104" name="Line 239">
                  <a:extLst>
                    <a:ext uri="{FF2B5EF4-FFF2-40B4-BE49-F238E27FC236}">
                      <a16:creationId xmlns:a16="http://schemas.microsoft.com/office/drawing/2014/main" id="{7A63AE3A-EF38-2D92-EA04-1B25825DD4A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41" y="4009"/>
                  <a:ext cx="5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05" name="Arc 240">
                  <a:extLst>
                    <a:ext uri="{FF2B5EF4-FFF2-40B4-BE49-F238E27FC236}">
                      <a16:creationId xmlns:a16="http://schemas.microsoft.com/office/drawing/2014/main" id="{13A23E58-A55C-95D5-535F-BD5DC8E2D96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92" y="2716"/>
                  <a:ext cx="41" cy="1299"/>
                </a:xfrm>
                <a:custGeom>
                  <a:avLst/>
                  <a:gdLst>
                    <a:gd name="G0" fmla="+- 532 0 0"/>
                    <a:gd name="G1" fmla="+- 0 0 0"/>
                    <a:gd name="G2" fmla="+- 21600 0 0"/>
                    <a:gd name="T0" fmla="*/ 682 w 682"/>
                    <a:gd name="T1" fmla="*/ 21599 h 21600"/>
                    <a:gd name="T2" fmla="*/ 0 w 682"/>
                    <a:gd name="T3" fmla="*/ 21593 h 21600"/>
                    <a:gd name="T4" fmla="*/ 532 w 682"/>
                    <a:gd name="T5" fmla="*/ 0 h 216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82" h="21600" fill="none" extrusionOk="0">
                      <a:moveTo>
                        <a:pt x="682" y="21599"/>
                      </a:moveTo>
                      <a:cubicBezTo>
                        <a:pt x="632" y="21599"/>
                        <a:pt x="582" y="21599"/>
                        <a:pt x="532" y="21599"/>
                      </a:cubicBezTo>
                      <a:cubicBezTo>
                        <a:pt x="354" y="21599"/>
                        <a:pt x="177" y="21597"/>
                        <a:pt x="-1" y="21593"/>
                      </a:cubicBezTo>
                    </a:path>
                    <a:path w="682" h="21600" stroke="0" extrusionOk="0">
                      <a:moveTo>
                        <a:pt x="682" y="21599"/>
                      </a:moveTo>
                      <a:cubicBezTo>
                        <a:pt x="632" y="21599"/>
                        <a:pt x="582" y="21599"/>
                        <a:pt x="532" y="21599"/>
                      </a:cubicBezTo>
                      <a:cubicBezTo>
                        <a:pt x="354" y="21599"/>
                        <a:pt x="177" y="21597"/>
                        <a:pt x="-1" y="21593"/>
                      </a:cubicBezTo>
                      <a:lnTo>
                        <a:pt x="532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06" name="Arc 241">
                  <a:extLst>
                    <a:ext uri="{FF2B5EF4-FFF2-40B4-BE49-F238E27FC236}">
                      <a16:creationId xmlns:a16="http://schemas.microsoft.com/office/drawing/2014/main" id="{E9FA1B25-7223-99A1-546C-3B6EB274268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46" y="2716"/>
                  <a:ext cx="78" cy="1298"/>
                </a:xfrm>
                <a:custGeom>
                  <a:avLst/>
                  <a:gdLst>
                    <a:gd name="G0" fmla="+- 1296 0 0"/>
                    <a:gd name="G1" fmla="+- 0 0 0"/>
                    <a:gd name="G2" fmla="+- 21600 0 0"/>
                    <a:gd name="T0" fmla="*/ 764 w 1296"/>
                    <a:gd name="T1" fmla="*/ 21593 h 21593"/>
                    <a:gd name="T2" fmla="*/ 0 w 1296"/>
                    <a:gd name="T3" fmla="*/ 21561 h 21593"/>
                    <a:gd name="T4" fmla="*/ 1296 w 1296"/>
                    <a:gd name="T5" fmla="*/ 0 h 2159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96" h="21593" fill="none" extrusionOk="0">
                      <a:moveTo>
                        <a:pt x="763" y="21593"/>
                      </a:moveTo>
                      <a:cubicBezTo>
                        <a:pt x="509" y="21587"/>
                        <a:pt x="254" y="21576"/>
                        <a:pt x="-1" y="21561"/>
                      </a:cubicBezTo>
                    </a:path>
                    <a:path w="1296" h="21593" stroke="0" extrusionOk="0">
                      <a:moveTo>
                        <a:pt x="763" y="21593"/>
                      </a:moveTo>
                      <a:cubicBezTo>
                        <a:pt x="509" y="21587"/>
                        <a:pt x="254" y="21576"/>
                        <a:pt x="-1" y="21561"/>
                      </a:cubicBezTo>
                      <a:lnTo>
                        <a:pt x="1296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07" name="Line 242">
                  <a:extLst>
                    <a:ext uri="{FF2B5EF4-FFF2-40B4-BE49-F238E27FC236}">
                      <a16:creationId xmlns:a16="http://schemas.microsoft.com/office/drawing/2014/main" id="{3688ED9A-42BF-460D-6FA4-9A18532C9AF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692" y="3790"/>
                  <a:ext cx="4" cy="2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08" name="Rectangle 243">
                  <a:extLst>
                    <a:ext uri="{FF2B5EF4-FFF2-40B4-BE49-F238E27FC236}">
                      <a16:creationId xmlns:a16="http://schemas.microsoft.com/office/drawing/2014/main" id="{32AAA8A1-79F4-F5D2-41C5-A22E86FBC4E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620000">
                  <a:off x="1376" y="4180"/>
                  <a:ext cx="30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AF61453</a:t>
                  </a:r>
                </a:p>
              </p:txBody>
            </p:sp>
            <p:sp>
              <p:nvSpPr>
                <p:cNvPr id="109" name="Line 244">
                  <a:extLst>
                    <a:ext uri="{FF2B5EF4-FFF2-40B4-BE49-F238E27FC236}">
                      <a16:creationId xmlns:a16="http://schemas.microsoft.com/office/drawing/2014/main" id="{B4E48197-5520-9267-DECE-94963D6330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550" y="4005"/>
                  <a:ext cx="9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10" name="Rectangle 245">
                  <a:extLst>
                    <a:ext uri="{FF2B5EF4-FFF2-40B4-BE49-F238E27FC236}">
                      <a16:creationId xmlns:a16="http://schemas.microsoft.com/office/drawing/2014/main" id="{7507291D-FD1E-D336-2573-F9C3F2BAAC1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860000">
                  <a:off x="1277" y="4162"/>
                  <a:ext cx="312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AB71084</a:t>
                  </a:r>
                </a:p>
              </p:txBody>
            </p:sp>
            <p:sp>
              <p:nvSpPr>
                <p:cNvPr id="111" name="Line 246">
                  <a:extLst>
                    <a:ext uri="{FF2B5EF4-FFF2-40B4-BE49-F238E27FC236}">
                      <a16:creationId xmlns:a16="http://schemas.microsoft.com/office/drawing/2014/main" id="{F263EC80-0DEE-6F14-EA35-88395DF637E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463" y="3986"/>
                  <a:ext cx="14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12" name="Arc 247">
                  <a:extLst>
                    <a:ext uri="{FF2B5EF4-FFF2-40B4-BE49-F238E27FC236}">
                      <a16:creationId xmlns:a16="http://schemas.microsoft.com/office/drawing/2014/main" id="{D7847F64-B392-E702-CA39-788E507A072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518" y="2716"/>
                  <a:ext cx="206" cy="1288"/>
                </a:xfrm>
                <a:custGeom>
                  <a:avLst/>
                  <a:gdLst>
                    <a:gd name="G0" fmla="+- 3435 0 0"/>
                    <a:gd name="G1" fmla="+- 0 0 0"/>
                    <a:gd name="G2" fmla="+- 21600 0 0"/>
                    <a:gd name="T0" fmla="*/ 692 w 3435"/>
                    <a:gd name="T1" fmla="*/ 21425 h 21425"/>
                    <a:gd name="T2" fmla="*/ 0 w 3435"/>
                    <a:gd name="T3" fmla="*/ 21325 h 21425"/>
                    <a:gd name="T4" fmla="*/ 3435 w 3435"/>
                    <a:gd name="T5" fmla="*/ 0 h 214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435" h="21425" fill="none" extrusionOk="0">
                      <a:moveTo>
                        <a:pt x="691" y="21425"/>
                      </a:moveTo>
                      <a:cubicBezTo>
                        <a:pt x="460" y="21395"/>
                        <a:pt x="230" y="21362"/>
                        <a:pt x="-1" y="21325"/>
                      </a:cubicBezTo>
                    </a:path>
                    <a:path w="3435" h="21425" stroke="0" extrusionOk="0">
                      <a:moveTo>
                        <a:pt x="691" y="21425"/>
                      </a:moveTo>
                      <a:cubicBezTo>
                        <a:pt x="460" y="21395"/>
                        <a:pt x="230" y="21362"/>
                        <a:pt x="-1" y="21325"/>
                      </a:cubicBezTo>
                      <a:lnTo>
                        <a:pt x="3435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13" name="Arc 248">
                  <a:extLst>
                    <a:ext uri="{FF2B5EF4-FFF2-40B4-BE49-F238E27FC236}">
                      <a16:creationId xmlns:a16="http://schemas.microsoft.com/office/drawing/2014/main" id="{432EDFF9-9576-85DB-6BC6-CDF5C549F47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477" y="2716"/>
                  <a:ext cx="247" cy="1282"/>
                </a:xfrm>
                <a:custGeom>
                  <a:avLst/>
                  <a:gdLst>
                    <a:gd name="G0" fmla="+- 4108 0 0"/>
                    <a:gd name="G1" fmla="+- 0 0 0"/>
                    <a:gd name="G2" fmla="+- 21600 0 0"/>
                    <a:gd name="T0" fmla="*/ 673 w 4108"/>
                    <a:gd name="T1" fmla="*/ 21325 h 21325"/>
                    <a:gd name="T2" fmla="*/ 0 w 4108"/>
                    <a:gd name="T3" fmla="*/ 21206 h 21325"/>
                    <a:gd name="T4" fmla="*/ 4108 w 4108"/>
                    <a:gd name="T5" fmla="*/ 0 h 213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108" h="21325" fill="none" extrusionOk="0">
                      <a:moveTo>
                        <a:pt x="672" y="21325"/>
                      </a:moveTo>
                      <a:cubicBezTo>
                        <a:pt x="448" y="21288"/>
                        <a:pt x="223" y="21249"/>
                        <a:pt x="0" y="21205"/>
                      </a:cubicBezTo>
                    </a:path>
                    <a:path w="4108" h="21325" stroke="0" extrusionOk="0">
                      <a:moveTo>
                        <a:pt x="672" y="21325"/>
                      </a:moveTo>
                      <a:cubicBezTo>
                        <a:pt x="448" y="21288"/>
                        <a:pt x="223" y="21249"/>
                        <a:pt x="0" y="21205"/>
                      </a:cubicBezTo>
                      <a:lnTo>
                        <a:pt x="4108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14" name="Line 249">
                  <a:extLst>
                    <a:ext uri="{FF2B5EF4-FFF2-40B4-BE49-F238E27FC236}">
                      <a16:creationId xmlns:a16="http://schemas.microsoft.com/office/drawing/2014/main" id="{2372C964-8690-4E41-1D06-2A5611E2772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518" y="3849"/>
                  <a:ext cx="23" cy="14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15" name="Rectangle 250">
                  <a:extLst>
                    <a:ext uri="{FF2B5EF4-FFF2-40B4-BE49-F238E27FC236}">
                      <a16:creationId xmlns:a16="http://schemas.microsoft.com/office/drawing/2014/main" id="{37C9FC29-90AB-8765-7EB8-8046CC07E8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7040000">
                  <a:off x="1174" y="4135"/>
                  <a:ext cx="30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AF61454</a:t>
                  </a:r>
                </a:p>
              </p:txBody>
            </p:sp>
            <p:sp>
              <p:nvSpPr>
                <p:cNvPr id="116" name="Line 251">
                  <a:extLst>
                    <a:ext uri="{FF2B5EF4-FFF2-40B4-BE49-F238E27FC236}">
                      <a16:creationId xmlns:a16="http://schemas.microsoft.com/office/drawing/2014/main" id="{8A22A039-F045-83C3-B2D3-3AF74E5BBA0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371" y="3899"/>
                  <a:ext cx="37" cy="14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17" name="Rectangle 252">
                  <a:extLst>
                    <a:ext uri="{FF2B5EF4-FFF2-40B4-BE49-F238E27FC236}">
                      <a16:creationId xmlns:a16="http://schemas.microsoft.com/office/drawing/2014/main" id="{F1AAED11-CFDF-40CC-1B9A-96CE664EE4B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7280000">
                  <a:off x="1079" y="4106"/>
                  <a:ext cx="312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AB71085</a:t>
                  </a:r>
                </a:p>
              </p:txBody>
            </p:sp>
            <p:sp>
              <p:nvSpPr>
                <p:cNvPr id="118" name="Line 253">
                  <a:extLst>
                    <a:ext uri="{FF2B5EF4-FFF2-40B4-BE49-F238E27FC236}">
                      <a16:creationId xmlns:a16="http://schemas.microsoft.com/office/drawing/2014/main" id="{DA87C5A7-5048-21C0-53CB-D3346D6DA6F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85" y="3945"/>
                  <a:ext cx="22" cy="6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19" name="Rectangle 254">
                  <a:extLst>
                    <a:ext uri="{FF2B5EF4-FFF2-40B4-BE49-F238E27FC236}">
                      <a16:creationId xmlns:a16="http://schemas.microsoft.com/office/drawing/2014/main" id="{0FDFC523-E74D-2584-B67F-8F8189B411F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7520000">
                  <a:off x="982" y="4075"/>
                  <a:ext cx="312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AB70707</a:t>
                  </a:r>
                </a:p>
              </p:txBody>
            </p:sp>
            <p:sp>
              <p:nvSpPr>
                <p:cNvPr id="120" name="Line 255">
                  <a:extLst>
                    <a:ext uri="{FF2B5EF4-FFF2-40B4-BE49-F238E27FC236}">
                      <a16:creationId xmlns:a16="http://schemas.microsoft.com/office/drawing/2014/main" id="{DC0037D7-A93D-02DD-9EDF-392B59F31B6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198" y="3913"/>
                  <a:ext cx="27" cy="6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21" name="Arc 256">
                  <a:extLst>
                    <a:ext uri="{FF2B5EF4-FFF2-40B4-BE49-F238E27FC236}">
                      <a16:creationId xmlns:a16="http://schemas.microsoft.com/office/drawing/2014/main" id="{50CED420-961F-ADFF-3FDE-3FD03DF64DB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266" y="2716"/>
                  <a:ext cx="458" cy="1230"/>
                </a:xfrm>
                <a:custGeom>
                  <a:avLst/>
                  <a:gdLst>
                    <a:gd name="G0" fmla="+- 7619 0 0"/>
                    <a:gd name="G1" fmla="+- 0 0 0"/>
                    <a:gd name="G2" fmla="+- 21600 0 0"/>
                    <a:gd name="T0" fmla="*/ 679 w 7619"/>
                    <a:gd name="T1" fmla="*/ 20455 h 20455"/>
                    <a:gd name="T2" fmla="*/ 0 w 7619"/>
                    <a:gd name="T3" fmla="*/ 20212 h 20455"/>
                    <a:gd name="T4" fmla="*/ 7619 w 7619"/>
                    <a:gd name="T5" fmla="*/ 0 h 204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619" h="20455" fill="none" extrusionOk="0">
                      <a:moveTo>
                        <a:pt x="679" y="20454"/>
                      </a:moveTo>
                      <a:cubicBezTo>
                        <a:pt x="451" y="20377"/>
                        <a:pt x="225" y="20296"/>
                        <a:pt x="0" y="20211"/>
                      </a:cubicBezTo>
                    </a:path>
                    <a:path w="7619" h="20455" stroke="0" extrusionOk="0">
                      <a:moveTo>
                        <a:pt x="679" y="20454"/>
                      </a:moveTo>
                      <a:cubicBezTo>
                        <a:pt x="451" y="20377"/>
                        <a:pt x="225" y="20296"/>
                        <a:pt x="0" y="20211"/>
                      </a:cubicBezTo>
                      <a:lnTo>
                        <a:pt x="7619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22" name="Arc 257">
                  <a:extLst>
                    <a:ext uri="{FF2B5EF4-FFF2-40B4-BE49-F238E27FC236}">
                      <a16:creationId xmlns:a16="http://schemas.microsoft.com/office/drawing/2014/main" id="{5843B197-8323-7630-63B5-E1164986648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224" y="2716"/>
                  <a:ext cx="500" cy="1215"/>
                </a:xfrm>
                <a:custGeom>
                  <a:avLst/>
                  <a:gdLst>
                    <a:gd name="G0" fmla="+- 8311 0 0"/>
                    <a:gd name="G1" fmla="+- 0 0 0"/>
                    <a:gd name="G2" fmla="+- 21600 0 0"/>
                    <a:gd name="T0" fmla="*/ 692 w 8311"/>
                    <a:gd name="T1" fmla="*/ 20212 h 20212"/>
                    <a:gd name="T2" fmla="*/ 0 w 8311"/>
                    <a:gd name="T3" fmla="*/ 19937 h 20212"/>
                    <a:gd name="T4" fmla="*/ 8311 w 8311"/>
                    <a:gd name="T5" fmla="*/ 0 h 202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311" h="20212" fill="none" extrusionOk="0">
                      <a:moveTo>
                        <a:pt x="692" y="20211"/>
                      </a:moveTo>
                      <a:cubicBezTo>
                        <a:pt x="459" y="20124"/>
                        <a:pt x="229" y="20032"/>
                        <a:pt x="-1" y="19937"/>
                      </a:cubicBezTo>
                    </a:path>
                    <a:path w="8311" h="20212" stroke="0" extrusionOk="0">
                      <a:moveTo>
                        <a:pt x="692" y="20211"/>
                      </a:moveTo>
                      <a:cubicBezTo>
                        <a:pt x="459" y="20124"/>
                        <a:pt x="229" y="20032"/>
                        <a:pt x="-1" y="19937"/>
                      </a:cubicBezTo>
                      <a:lnTo>
                        <a:pt x="8311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23" name="Line 258">
                  <a:extLst>
                    <a:ext uri="{FF2B5EF4-FFF2-40B4-BE49-F238E27FC236}">
                      <a16:creationId xmlns:a16="http://schemas.microsoft.com/office/drawing/2014/main" id="{32B6987B-D02E-3F89-097F-36BFD83E70B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266" y="3863"/>
                  <a:ext cx="23" cy="6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24" name="Arc 259">
                  <a:extLst>
                    <a:ext uri="{FF2B5EF4-FFF2-40B4-BE49-F238E27FC236}">
                      <a16:creationId xmlns:a16="http://schemas.microsoft.com/office/drawing/2014/main" id="{92568903-0DF5-8DC9-7540-C53DCE8838E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352" y="2716"/>
                  <a:ext cx="372" cy="1180"/>
                </a:xfrm>
                <a:custGeom>
                  <a:avLst/>
                  <a:gdLst>
                    <a:gd name="G0" fmla="+- 6575 0 0"/>
                    <a:gd name="G1" fmla="+- 0 0 0"/>
                    <a:gd name="G2" fmla="+- 21600 0 0"/>
                    <a:gd name="T0" fmla="*/ 1066 w 6575"/>
                    <a:gd name="T1" fmla="*/ 20886 h 20886"/>
                    <a:gd name="T2" fmla="*/ 0 w 6575"/>
                    <a:gd name="T3" fmla="*/ 20575 h 20886"/>
                    <a:gd name="T4" fmla="*/ 6575 w 6575"/>
                    <a:gd name="T5" fmla="*/ 0 h 208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575" h="20886" fill="none" extrusionOk="0">
                      <a:moveTo>
                        <a:pt x="1066" y="20885"/>
                      </a:moveTo>
                      <a:cubicBezTo>
                        <a:pt x="708" y="20791"/>
                        <a:pt x="352" y="20687"/>
                        <a:pt x="0" y="20574"/>
                      </a:cubicBezTo>
                    </a:path>
                    <a:path w="6575" h="20886" stroke="0" extrusionOk="0">
                      <a:moveTo>
                        <a:pt x="1066" y="20885"/>
                      </a:moveTo>
                      <a:cubicBezTo>
                        <a:pt x="708" y="20791"/>
                        <a:pt x="352" y="20687"/>
                        <a:pt x="0" y="20574"/>
                      </a:cubicBezTo>
                      <a:lnTo>
                        <a:pt x="6575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25" name="Arc 260">
                  <a:extLst>
                    <a:ext uri="{FF2B5EF4-FFF2-40B4-BE49-F238E27FC236}">
                      <a16:creationId xmlns:a16="http://schemas.microsoft.com/office/drawing/2014/main" id="{9F853C7E-51D7-1509-18B1-FF9C17775E0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294" y="2716"/>
                  <a:ext cx="430" cy="1163"/>
                </a:xfrm>
                <a:custGeom>
                  <a:avLst/>
                  <a:gdLst>
                    <a:gd name="G0" fmla="+- 7611 0 0"/>
                    <a:gd name="G1" fmla="+- 0 0 0"/>
                    <a:gd name="G2" fmla="+- 21600 0 0"/>
                    <a:gd name="T0" fmla="*/ 1036 w 7611"/>
                    <a:gd name="T1" fmla="*/ 20575 h 20575"/>
                    <a:gd name="T2" fmla="*/ 0 w 7611"/>
                    <a:gd name="T3" fmla="*/ 20215 h 20575"/>
                    <a:gd name="T4" fmla="*/ 7611 w 7611"/>
                    <a:gd name="T5" fmla="*/ 0 h 2057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611" h="20575" fill="none" extrusionOk="0">
                      <a:moveTo>
                        <a:pt x="1036" y="20574"/>
                      </a:moveTo>
                      <a:cubicBezTo>
                        <a:pt x="687" y="20463"/>
                        <a:pt x="342" y="20343"/>
                        <a:pt x="0" y="20214"/>
                      </a:cubicBezTo>
                    </a:path>
                    <a:path w="7611" h="20575" stroke="0" extrusionOk="0">
                      <a:moveTo>
                        <a:pt x="1036" y="20574"/>
                      </a:moveTo>
                      <a:cubicBezTo>
                        <a:pt x="687" y="20463"/>
                        <a:pt x="342" y="20343"/>
                        <a:pt x="0" y="20214"/>
                      </a:cubicBezTo>
                      <a:lnTo>
                        <a:pt x="7611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26" name="Line 261">
                  <a:extLst>
                    <a:ext uri="{FF2B5EF4-FFF2-40B4-BE49-F238E27FC236}">
                      <a16:creationId xmlns:a16="http://schemas.microsoft.com/office/drawing/2014/main" id="{5CFD593E-BE9E-6988-E91C-9F2F3BA6D68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353" y="3808"/>
                  <a:ext cx="23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27" name="Arc 262">
                  <a:extLst>
                    <a:ext uri="{FF2B5EF4-FFF2-40B4-BE49-F238E27FC236}">
                      <a16:creationId xmlns:a16="http://schemas.microsoft.com/office/drawing/2014/main" id="{6FA69E98-2C62-40FB-7D71-AE6B3522126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458" y="2716"/>
                  <a:ext cx="266" cy="1133"/>
                </a:xfrm>
                <a:custGeom>
                  <a:avLst/>
                  <a:gdLst>
                    <a:gd name="G0" fmla="+- 5012 0 0"/>
                    <a:gd name="G1" fmla="+- 0 0 0"/>
                    <a:gd name="G2" fmla="+- 21600 0 0"/>
                    <a:gd name="T0" fmla="*/ 1568 w 5012"/>
                    <a:gd name="T1" fmla="*/ 21324 h 21324"/>
                    <a:gd name="T2" fmla="*/ 0 w 5012"/>
                    <a:gd name="T3" fmla="*/ 21010 h 21324"/>
                    <a:gd name="T4" fmla="*/ 5012 w 5012"/>
                    <a:gd name="T5" fmla="*/ 0 h 213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012" h="21324" fill="none" extrusionOk="0">
                      <a:moveTo>
                        <a:pt x="1568" y="21323"/>
                      </a:moveTo>
                      <a:cubicBezTo>
                        <a:pt x="1041" y="21238"/>
                        <a:pt x="518" y="21134"/>
                        <a:pt x="-1" y="21010"/>
                      </a:cubicBezTo>
                    </a:path>
                    <a:path w="5012" h="21324" stroke="0" extrusionOk="0">
                      <a:moveTo>
                        <a:pt x="1568" y="21323"/>
                      </a:moveTo>
                      <a:cubicBezTo>
                        <a:pt x="1041" y="21238"/>
                        <a:pt x="518" y="21134"/>
                        <a:pt x="-1" y="21010"/>
                      </a:cubicBezTo>
                      <a:lnTo>
                        <a:pt x="5012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28" name="Arc 263">
                  <a:extLst>
                    <a:ext uri="{FF2B5EF4-FFF2-40B4-BE49-F238E27FC236}">
                      <a16:creationId xmlns:a16="http://schemas.microsoft.com/office/drawing/2014/main" id="{3B72B75C-A673-F3B5-EDFB-06A1A39A05A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376" y="2716"/>
                  <a:ext cx="348" cy="1116"/>
                </a:xfrm>
                <a:custGeom>
                  <a:avLst/>
                  <a:gdLst>
                    <a:gd name="G0" fmla="+- 6559 0 0"/>
                    <a:gd name="G1" fmla="+- 0 0 0"/>
                    <a:gd name="G2" fmla="+- 21600 0 0"/>
                    <a:gd name="T0" fmla="*/ 1547 w 6559"/>
                    <a:gd name="T1" fmla="*/ 21010 h 21010"/>
                    <a:gd name="T2" fmla="*/ 0 w 6559"/>
                    <a:gd name="T3" fmla="*/ 20580 h 21010"/>
                    <a:gd name="T4" fmla="*/ 6559 w 6559"/>
                    <a:gd name="T5" fmla="*/ 0 h 210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559" h="21010" fill="none" extrusionOk="0">
                      <a:moveTo>
                        <a:pt x="1546" y="21010"/>
                      </a:moveTo>
                      <a:cubicBezTo>
                        <a:pt x="1026" y="20886"/>
                        <a:pt x="510" y="20742"/>
                        <a:pt x="-1" y="20580"/>
                      </a:cubicBezTo>
                    </a:path>
                    <a:path w="6559" h="21010" stroke="0" extrusionOk="0">
                      <a:moveTo>
                        <a:pt x="1546" y="21010"/>
                      </a:moveTo>
                      <a:cubicBezTo>
                        <a:pt x="1026" y="20886"/>
                        <a:pt x="510" y="20742"/>
                        <a:pt x="-1" y="20580"/>
                      </a:cubicBezTo>
                      <a:lnTo>
                        <a:pt x="6559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29" name="Line 264">
                  <a:extLst>
                    <a:ext uri="{FF2B5EF4-FFF2-40B4-BE49-F238E27FC236}">
                      <a16:creationId xmlns:a16="http://schemas.microsoft.com/office/drawing/2014/main" id="{9EA47EAD-B732-2789-84BF-AF15E373E56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458" y="3758"/>
                  <a:ext cx="19" cy="7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30" name="Arc 265">
                  <a:extLst>
                    <a:ext uri="{FF2B5EF4-FFF2-40B4-BE49-F238E27FC236}">
                      <a16:creationId xmlns:a16="http://schemas.microsoft.com/office/drawing/2014/main" id="{E1495AD8-53EE-B96D-7649-5D264535525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586" y="2716"/>
                  <a:ext cx="138" cy="1074"/>
                </a:xfrm>
                <a:custGeom>
                  <a:avLst/>
                  <a:gdLst>
                    <a:gd name="G0" fmla="+- 2776 0 0"/>
                    <a:gd name="G1" fmla="+- 0 0 0"/>
                    <a:gd name="G2" fmla="+- 21600 0 0"/>
                    <a:gd name="T0" fmla="*/ 2210 w 2776"/>
                    <a:gd name="T1" fmla="*/ 21593 h 21593"/>
                    <a:gd name="T2" fmla="*/ 0 w 2776"/>
                    <a:gd name="T3" fmla="*/ 21421 h 21593"/>
                    <a:gd name="T4" fmla="*/ 2776 w 2776"/>
                    <a:gd name="T5" fmla="*/ 0 h 2159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776" h="21593" fill="none" extrusionOk="0">
                      <a:moveTo>
                        <a:pt x="2210" y="21592"/>
                      </a:moveTo>
                      <a:cubicBezTo>
                        <a:pt x="1470" y="21573"/>
                        <a:pt x="733" y="21515"/>
                        <a:pt x="0" y="21420"/>
                      </a:cubicBezTo>
                    </a:path>
                    <a:path w="2776" h="21593" stroke="0" extrusionOk="0">
                      <a:moveTo>
                        <a:pt x="2210" y="21592"/>
                      </a:moveTo>
                      <a:cubicBezTo>
                        <a:pt x="1470" y="21573"/>
                        <a:pt x="733" y="21515"/>
                        <a:pt x="0" y="21420"/>
                      </a:cubicBezTo>
                      <a:lnTo>
                        <a:pt x="2776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31" name="Arc 266">
                  <a:extLst>
                    <a:ext uri="{FF2B5EF4-FFF2-40B4-BE49-F238E27FC236}">
                      <a16:creationId xmlns:a16="http://schemas.microsoft.com/office/drawing/2014/main" id="{8BC8A71C-B215-949C-23BF-EC1B9AFD771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477" y="2716"/>
                  <a:ext cx="247" cy="1066"/>
                </a:xfrm>
                <a:custGeom>
                  <a:avLst/>
                  <a:gdLst>
                    <a:gd name="G0" fmla="+- 4964 0 0"/>
                    <a:gd name="G1" fmla="+- 0 0 0"/>
                    <a:gd name="G2" fmla="+- 21600 0 0"/>
                    <a:gd name="T0" fmla="*/ 2188 w 4964"/>
                    <a:gd name="T1" fmla="*/ 21421 h 21421"/>
                    <a:gd name="T2" fmla="*/ 0 w 4964"/>
                    <a:gd name="T3" fmla="*/ 21022 h 21421"/>
                    <a:gd name="T4" fmla="*/ 4964 w 4964"/>
                    <a:gd name="T5" fmla="*/ 0 h 2142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964" h="21421" fill="none" extrusionOk="0">
                      <a:moveTo>
                        <a:pt x="2188" y="21420"/>
                      </a:moveTo>
                      <a:cubicBezTo>
                        <a:pt x="1452" y="21325"/>
                        <a:pt x="722" y="21192"/>
                        <a:pt x="0" y="21021"/>
                      </a:cubicBezTo>
                    </a:path>
                    <a:path w="4964" h="21421" stroke="0" extrusionOk="0">
                      <a:moveTo>
                        <a:pt x="2188" y="21420"/>
                      </a:moveTo>
                      <a:cubicBezTo>
                        <a:pt x="1452" y="21325"/>
                        <a:pt x="722" y="21192"/>
                        <a:pt x="0" y="21021"/>
                      </a:cubicBezTo>
                      <a:lnTo>
                        <a:pt x="4964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32" name="Line 267">
                  <a:extLst>
                    <a:ext uri="{FF2B5EF4-FFF2-40B4-BE49-F238E27FC236}">
                      <a16:creationId xmlns:a16="http://schemas.microsoft.com/office/drawing/2014/main" id="{BF5485A4-415B-6D5E-8C2C-348CBBEBDB6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586" y="3707"/>
                  <a:ext cx="9" cy="7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33" name="Arc 268">
                  <a:extLst>
                    <a:ext uri="{FF2B5EF4-FFF2-40B4-BE49-F238E27FC236}">
                      <a16:creationId xmlns:a16="http://schemas.microsoft.com/office/drawing/2014/main" id="{58CEC356-74E1-7ED8-0F7A-13A5F84F569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14" y="2716"/>
                  <a:ext cx="119" cy="1002"/>
                </a:xfrm>
                <a:custGeom>
                  <a:avLst/>
                  <a:gdLst>
                    <a:gd name="G0" fmla="+- 216 0 0"/>
                    <a:gd name="G1" fmla="+- 0 0 0"/>
                    <a:gd name="G2" fmla="+- 21600 0 0"/>
                    <a:gd name="T0" fmla="*/ 2566 w 2566"/>
                    <a:gd name="T1" fmla="*/ 21472 h 21600"/>
                    <a:gd name="T2" fmla="*/ 0 w 2566"/>
                    <a:gd name="T3" fmla="*/ 21599 h 21600"/>
                    <a:gd name="T4" fmla="*/ 216 w 2566"/>
                    <a:gd name="T5" fmla="*/ 0 h 216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566" h="21600" fill="none" extrusionOk="0">
                      <a:moveTo>
                        <a:pt x="2565" y="21471"/>
                      </a:moveTo>
                      <a:cubicBezTo>
                        <a:pt x="1785" y="21557"/>
                        <a:pt x="1001" y="21599"/>
                        <a:pt x="216" y="21599"/>
                      </a:cubicBezTo>
                      <a:cubicBezTo>
                        <a:pt x="143" y="21599"/>
                        <a:pt x="71" y="21599"/>
                        <a:pt x="0" y="21598"/>
                      </a:cubicBezTo>
                    </a:path>
                    <a:path w="2566" h="21600" stroke="0" extrusionOk="0">
                      <a:moveTo>
                        <a:pt x="2565" y="21471"/>
                      </a:moveTo>
                      <a:cubicBezTo>
                        <a:pt x="1785" y="21557"/>
                        <a:pt x="1001" y="21599"/>
                        <a:pt x="216" y="21599"/>
                      </a:cubicBezTo>
                      <a:cubicBezTo>
                        <a:pt x="143" y="21599"/>
                        <a:pt x="71" y="21599"/>
                        <a:pt x="0" y="21598"/>
                      </a:cubicBezTo>
                      <a:lnTo>
                        <a:pt x="216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34" name="Arc 269">
                  <a:extLst>
                    <a:ext uri="{FF2B5EF4-FFF2-40B4-BE49-F238E27FC236}">
                      <a16:creationId xmlns:a16="http://schemas.microsoft.com/office/drawing/2014/main" id="{E0DFC674-ED6C-64FA-2125-BEA19A5C6DD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595" y="2716"/>
                  <a:ext cx="129" cy="1001"/>
                </a:xfrm>
                <a:custGeom>
                  <a:avLst/>
                  <a:gdLst>
                    <a:gd name="G0" fmla="+- 2788 0 0"/>
                    <a:gd name="G1" fmla="+- 0 0 0"/>
                    <a:gd name="G2" fmla="+- 21600 0 0"/>
                    <a:gd name="T0" fmla="*/ 2572 w 2788"/>
                    <a:gd name="T1" fmla="*/ 21599 h 21599"/>
                    <a:gd name="T2" fmla="*/ 0 w 2788"/>
                    <a:gd name="T3" fmla="*/ 21419 h 21599"/>
                    <a:gd name="T4" fmla="*/ 2788 w 2788"/>
                    <a:gd name="T5" fmla="*/ 0 h 2159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788" h="21599" fill="none" extrusionOk="0">
                      <a:moveTo>
                        <a:pt x="2572" y="21598"/>
                      </a:moveTo>
                      <a:cubicBezTo>
                        <a:pt x="1711" y="21590"/>
                        <a:pt x="852" y="21530"/>
                        <a:pt x="-1" y="21419"/>
                      </a:cubicBezTo>
                    </a:path>
                    <a:path w="2788" h="21599" stroke="0" extrusionOk="0">
                      <a:moveTo>
                        <a:pt x="2572" y="21598"/>
                      </a:moveTo>
                      <a:cubicBezTo>
                        <a:pt x="1711" y="21590"/>
                        <a:pt x="852" y="21530"/>
                        <a:pt x="-1" y="21419"/>
                      </a:cubicBezTo>
                      <a:lnTo>
                        <a:pt x="2788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35" name="Line 270">
                  <a:extLst>
                    <a:ext uri="{FF2B5EF4-FFF2-40B4-BE49-F238E27FC236}">
                      <a16:creationId xmlns:a16="http://schemas.microsoft.com/office/drawing/2014/main" id="{D7563B72-6F40-49BB-D4E7-CB1B9430AAC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714" y="3195"/>
                  <a:ext cx="5" cy="52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36" name="Arc 271">
                  <a:extLst>
                    <a:ext uri="{FF2B5EF4-FFF2-40B4-BE49-F238E27FC236}">
                      <a16:creationId xmlns:a16="http://schemas.microsoft.com/office/drawing/2014/main" id="{9447AC63-9755-4F41-B107-F2AB585F19F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637"/>
                  <a:ext cx="481" cy="389"/>
                </a:xfrm>
                <a:custGeom>
                  <a:avLst/>
                  <a:gdLst>
                    <a:gd name="G0" fmla="+- 0 0 0"/>
                    <a:gd name="G1" fmla="+- 3496 0 0"/>
                    <a:gd name="G2" fmla="+- 21600 0 0"/>
                    <a:gd name="T0" fmla="*/ 21315 w 21600"/>
                    <a:gd name="T1" fmla="*/ 0 h 17513"/>
                    <a:gd name="T2" fmla="*/ 16434 w 21600"/>
                    <a:gd name="T3" fmla="*/ 17513 h 17513"/>
                    <a:gd name="T4" fmla="*/ 0 w 21600"/>
                    <a:gd name="T5" fmla="*/ 3496 h 1751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600" h="17513" fill="none" extrusionOk="0">
                      <a:moveTo>
                        <a:pt x="21315" y="-1"/>
                      </a:moveTo>
                      <a:cubicBezTo>
                        <a:pt x="21504" y="1155"/>
                        <a:pt x="21600" y="2324"/>
                        <a:pt x="21600" y="3496"/>
                      </a:cubicBezTo>
                      <a:cubicBezTo>
                        <a:pt x="21600" y="8634"/>
                        <a:pt x="19768" y="13603"/>
                        <a:pt x="16434" y="17513"/>
                      </a:cubicBezTo>
                    </a:path>
                    <a:path w="21600" h="17513" stroke="0" extrusionOk="0">
                      <a:moveTo>
                        <a:pt x="21315" y="-1"/>
                      </a:moveTo>
                      <a:cubicBezTo>
                        <a:pt x="21504" y="1155"/>
                        <a:pt x="21600" y="2324"/>
                        <a:pt x="21600" y="3496"/>
                      </a:cubicBezTo>
                      <a:cubicBezTo>
                        <a:pt x="21600" y="8634"/>
                        <a:pt x="19768" y="13603"/>
                        <a:pt x="16434" y="17513"/>
                      </a:cubicBezTo>
                      <a:lnTo>
                        <a:pt x="0" y="3496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37" name="Arc 272">
                  <a:extLst>
                    <a:ext uri="{FF2B5EF4-FFF2-40B4-BE49-F238E27FC236}">
                      <a16:creationId xmlns:a16="http://schemas.microsoft.com/office/drawing/2014/main" id="{D1F03E4C-6F1A-82CB-552B-472CE5B1FC7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19" y="2715"/>
                  <a:ext cx="371" cy="480"/>
                </a:xfrm>
                <a:custGeom>
                  <a:avLst/>
                  <a:gdLst>
                    <a:gd name="G0" fmla="+- 225 0 0"/>
                    <a:gd name="G1" fmla="+- 0 0 0"/>
                    <a:gd name="G2" fmla="+- 21600 0 0"/>
                    <a:gd name="T0" fmla="*/ 16659 w 16659"/>
                    <a:gd name="T1" fmla="*/ 14017 h 21600"/>
                    <a:gd name="T2" fmla="*/ 0 w 16659"/>
                    <a:gd name="T3" fmla="*/ 21599 h 21600"/>
                    <a:gd name="T4" fmla="*/ 225 w 16659"/>
                    <a:gd name="T5" fmla="*/ 0 h 216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659" h="21600" fill="none" extrusionOk="0">
                      <a:moveTo>
                        <a:pt x="16659" y="14017"/>
                      </a:moveTo>
                      <a:cubicBezTo>
                        <a:pt x="12555" y="18828"/>
                        <a:pt x="6548" y="21599"/>
                        <a:pt x="225" y="21599"/>
                      </a:cubicBezTo>
                      <a:cubicBezTo>
                        <a:pt x="149" y="21599"/>
                        <a:pt x="74" y="21599"/>
                        <a:pt x="0" y="21598"/>
                      </a:cubicBezTo>
                    </a:path>
                    <a:path w="16659" h="21600" stroke="0" extrusionOk="0">
                      <a:moveTo>
                        <a:pt x="16659" y="14017"/>
                      </a:moveTo>
                      <a:cubicBezTo>
                        <a:pt x="12555" y="18828"/>
                        <a:pt x="6548" y="21599"/>
                        <a:pt x="225" y="21599"/>
                      </a:cubicBezTo>
                      <a:cubicBezTo>
                        <a:pt x="149" y="21599"/>
                        <a:pt x="74" y="21599"/>
                        <a:pt x="0" y="21598"/>
                      </a:cubicBezTo>
                      <a:lnTo>
                        <a:pt x="225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38" name="Line 273">
                  <a:extLst>
                    <a:ext uri="{FF2B5EF4-FFF2-40B4-BE49-F238E27FC236}">
                      <a16:creationId xmlns:a16="http://schemas.microsoft.com/office/drawing/2014/main" id="{8CEE9686-C9B1-2C45-FE76-133E0A9FC14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25" y="2976"/>
                  <a:ext cx="60" cy="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39" name="Rectangle 274">
                  <a:extLst>
                    <a:ext uri="{FF2B5EF4-FFF2-40B4-BE49-F238E27FC236}">
                      <a16:creationId xmlns:a16="http://schemas.microsoft.com/office/drawing/2014/main" id="{39EE67FE-379A-216C-9589-6BEB618EBA8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7760000">
                  <a:off x="891" y="4034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AC24192</a:t>
                  </a:r>
                </a:p>
              </p:txBody>
            </p:sp>
            <p:sp>
              <p:nvSpPr>
                <p:cNvPr id="140" name="Line 275">
                  <a:extLst>
                    <a:ext uri="{FF2B5EF4-FFF2-40B4-BE49-F238E27FC236}">
                      <a16:creationId xmlns:a16="http://schemas.microsoft.com/office/drawing/2014/main" id="{2ABFE2B2-BB3E-BAB2-E17B-C73644F761C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115" y="3077"/>
                  <a:ext cx="426" cy="86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41" name="Arc 276">
                  <a:extLst>
                    <a:ext uri="{FF2B5EF4-FFF2-40B4-BE49-F238E27FC236}">
                      <a16:creationId xmlns:a16="http://schemas.microsoft.com/office/drawing/2014/main" id="{E6AB2301-91BF-5956-03AE-FE316DAC780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2716"/>
                  <a:ext cx="307" cy="394"/>
                </a:xfrm>
                <a:custGeom>
                  <a:avLst/>
                  <a:gdLst>
                    <a:gd name="G0" fmla="+- 0 0 0"/>
                    <a:gd name="G1" fmla="+- 0 0 0"/>
                    <a:gd name="G2" fmla="+- 21600 0 0"/>
                    <a:gd name="T0" fmla="*/ 16461 w 16461"/>
                    <a:gd name="T1" fmla="*/ 13986 h 21145"/>
                    <a:gd name="T2" fmla="*/ 4412 w 16461"/>
                    <a:gd name="T3" fmla="*/ 21145 h 21145"/>
                    <a:gd name="T4" fmla="*/ 0 w 16461"/>
                    <a:gd name="T5" fmla="*/ 0 h 2114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461" h="21145" fill="none" extrusionOk="0">
                      <a:moveTo>
                        <a:pt x="16460" y="13985"/>
                      </a:moveTo>
                      <a:cubicBezTo>
                        <a:pt x="13351" y="17644"/>
                        <a:pt x="9112" y="20163"/>
                        <a:pt x="4411" y="21144"/>
                      </a:cubicBezTo>
                    </a:path>
                    <a:path w="16461" h="21145" stroke="0" extrusionOk="0">
                      <a:moveTo>
                        <a:pt x="16460" y="13985"/>
                      </a:moveTo>
                      <a:cubicBezTo>
                        <a:pt x="13351" y="17644"/>
                        <a:pt x="9112" y="20163"/>
                        <a:pt x="4411" y="21144"/>
                      </a:cubicBez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42" name="Arc 277">
                  <a:extLst>
                    <a:ext uri="{FF2B5EF4-FFF2-40B4-BE49-F238E27FC236}">
                      <a16:creationId xmlns:a16="http://schemas.microsoft.com/office/drawing/2014/main" id="{BBF7177B-5A1E-1B88-E013-3392C0378BE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545" y="2716"/>
                  <a:ext cx="261" cy="403"/>
                </a:xfrm>
                <a:custGeom>
                  <a:avLst/>
                  <a:gdLst>
                    <a:gd name="G0" fmla="+- 9595 0 0"/>
                    <a:gd name="G1" fmla="+- 0 0 0"/>
                    <a:gd name="G2" fmla="+- 21600 0 0"/>
                    <a:gd name="T0" fmla="*/ 14007 w 14007"/>
                    <a:gd name="T1" fmla="*/ 21145 h 21600"/>
                    <a:gd name="T2" fmla="*/ 0 w 14007"/>
                    <a:gd name="T3" fmla="*/ 19352 h 21600"/>
                    <a:gd name="T4" fmla="*/ 9595 w 14007"/>
                    <a:gd name="T5" fmla="*/ 0 h 216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007" h="21600" fill="none" extrusionOk="0">
                      <a:moveTo>
                        <a:pt x="14006" y="21144"/>
                      </a:moveTo>
                      <a:cubicBezTo>
                        <a:pt x="12555" y="21447"/>
                        <a:pt x="11077" y="21599"/>
                        <a:pt x="9595" y="21599"/>
                      </a:cubicBezTo>
                      <a:cubicBezTo>
                        <a:pt x="6266" y="21599"/>
                        <a:pt x="2982" y="20830"/>
                        <a:pt x="0" y="19351"/>
                      </a:cubicBezTo>
                    </a:path>
                    <a:path w="14007" h="21600" stroke="0" extrusionOk="0">
                      <a:moveTo>
                        <a:pt x="14006" y="21144"/>
                      </a:moveTo>
                      <a:cubicBezTo>
                        <a:pt x="12555" y="21447"/>
                        <a:pt x="11077" y="21599"/>
                        <a:pt x="9595" y="21599"/>
                      </a:cubicBezTo>
                      <a:cubicBezTo>
                        <a:pt x="6266" y="21599"/>
                        <a:pt x="2982" y="20830"/>
                        <a:pt x="0" y="19351"/>
                      </a:cubicBezTo>
                      <a:lnTo>
                        <a:pt x="9595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43" name="Line 278">
                  <a:extLst>
                    <a:ext uri="{FF2B5EF4-FFF2-40B4-BE49-F238E27FC236}">
                      <a16:creationId xmlns:a16="http://schemas.microsoft.com/office/drawing/2014/main" id="{6EDCBD13-89A3-3D16-64FD-D2AE84F1B9D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783" y="2985"/>
                  <a:ext cx="23" cy="12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44" name="Rectangle 279">
                  <a:extLst>
                    <a:ext uri="{FF2B5EF4-FFF2-40B4-BE49-F238E27FC236}">
                      <a16:creationId xmlns:a16="http://schemas.microsoft.com/office/drawing/2014/main" id="{C48DC15B-E0E7-4FFB-624A-A3D37AA7A3A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8000000">
                  <a:off x="803" y="3990"/>
                  <a:ext cx="312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AB05407</a:t>
                  </a:r>
                </a:p>
              </p:txBody>
            </p:sp>
            <p:sp>
              <p:nvSpPr>
                <p:cNvPr id="145" name="Line 280">
                  <a:extLst>
                    <a:ext uri="{FF2B5EF4-FFF2-40B4-BE49-F238E27FC236}">
                      <a16:creationId xmlns:a16="http://schemas.microsoft.com/office/drawing/2014/main" id="{702B8456-CC39-C6E9-19B8-0914699A0F8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33" y="3195"/>
                  <a:ext cx="412" cy="70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46" name="Rectangle 281">
                  <a:extLst>
                    <a:ext uri="{FF2B5EF4-FFF2-40B4-BE49-F238E27FC236}">
                      <a16:creationId xmlns:a16="http://schemas.microsoft.com/office/drawing/2014/main" id="{A371450E-3EBF-8F7B-E544-776E87FFB8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8180000">
                  <a:off x="716" y="3934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412139</a:t>
                  </a:r>
                </a:p>
              </p:txBody>
            </p:sp>
            <p:sp>
              <p:nvSpPr>
                <p:cNvPr id="147" name="Line 282">
                  <a:extLst>
                    <a:ext uri="{FF2B5EF4-FFF2-40B4-BE49-F238E27FC236}">
                      <a16:creationId xmlns:a16="http://schemas.microsoft.com/office/drawing/2014/main" id="{B25D1121-1A84-9755-A33D-A3B332A5D13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60" y="3790"/>
                  <a:ext cx="46" cy="6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48" name="Rectangle 283">
                  <a:extLst>
                    <a:ext uri="{FF2B5EF4-FFF2-40B4-BE49-F238E27FC236}">
                      <a16:creationId xmlns:a16="http://schemas.microsoft.com/office/drawing/2014/main" id="{13BA5434-679F-266C-3B02-FCC7E05F3D1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8420000">
                  <a:off x="629" y="3873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439448</a:t>
                  </a:r>
                </a:p>
              </p:txBody>
            </p:sp>
            <p:sp>
              <p:nvSpPr>
                <p:cNvPr id="149" name="Line 284">
                  <a:extLst>
                    <a:ext uri="{FF2B5EF4-FFF2-40B4-BE49-F238E27FC236}">
                      <a16:creationId xmlns:a16="http://schemas.microsoft.com/office/drawing/2014/main" id="{D7E86EEE-80F9-031F-21E3-A1E41672B1F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882" y="3739"/>
                  <a:ext cx="46" cy="6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50" name="Arc 285">
                  <a:extLst>
                    <a:ext uri="{FF2B5EF4-FFF2-40B4-BE49-F238E27FC236}">
                      <a16:creationId xmlns:a16="http://schemas.microsoft.com/office/drawing/2014/main" id="{A1ACAC51-9121-C44C-A771-52AC0DC1370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64" y="2716"/>
                  <a:ext cx="760" cy="1077"/>
                </a:xfrm>
                <a:custGeom>
                  <a:avLst/>
                  <a:gdLst>
                    <a:gd name="G0" fmla="+- 12646 0 0"/>
                    <a:gd name="G1" fmla="+- 0 0 0"/>
                    <a:gd name="G2" fmla="+- 21600 0 0"/>
                    <a:gd name="T0" fmla="*/ 569 w 12646"/>
                    <a:gd name="T1" fmla="*/ 17908 h 17908"/>
                    <a:gd name="T2" fmla="*/ 0 w 12646"/>
                    <a:gd name="T3" fmla="*/ 17511 h 17908"/>
                    <a:gd name="T4" fmla="*/ 12646 w 12646"/>
                    <a:gd name="T5" fmla="*/ 0 h 1790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2646" h="17908" fill="none" extrusionOk="0">
                      <a:moveTo>
                        <a:pt x="568" y="17908"/>
                      </a:moveTo>
                      <a:cubicBezTo>
                        <a:pt x="377" y="17778"/>
                        <a:pt x="187" y="17646"/>
                        <a:pt x="-1" y="17511"/>
                      </a:cubicBezTo>
                    </a:path>
                    <a:path w="12646" h="17908" stroke="0" extrusionOk="0">
                      <a:moveTo>
                        <a:pt x="568" y="17908"/>
                      </a:moveTo>
                      <a:cubicBezTo>
                        <a:pt x="377" y="17778"/>
                        <a:pt x="187" y="17646"/>
                        <a:pt x="-1" y="17511"/>
                      </a:cubicBezTo>
                      <a:lnTo>
                        <a:pt x="12646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51" name="Arc 286">
                  <a:extLst>
                    <a:ext uri="{FF2B5EF4-FFF2-40B4-BE49-F238E27FC236}">
                      <a16:creationId xmlns:a16="http://schemas.microsoft.com/office/drawing/2014/main" id="{54B421CB-CFD5-0D11-1B07-AD57D93DF8A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29" y="2716"/>
                  <a:ext cx="795" cy="1053"/>
                </a:xfrm>
                <a:custGeom>
                  <a:avLst/>
                  <a:gdLst>
                    <a:gd name="G0" fmla="+- 13224 0 0"/>
                    <a:gd name="G1" fmla="+- 0 0 0"/>
                    <a:gd name="G2" fmla="+- 21600 0 0"/>
                    <a:gd name="T0" fmla="*/ 578 w 13224"/>
                    <a:gd name="T1" fmla="*/ 17511 h 17511"/>
                    <a:gd name="T2" fmla="*/ 0 w 13224"/>
                    <a:gd name="T3" fmla="*/ 17079 h 17511"/>
                    <a:gd name="T4" fmla="*/ 13224 w 13224"/>
                    <a:gd name="T5" fmla="*/ 0 h 175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224" h="17511" fill="none" extrusionOk="0">
                      <a:moveTo>
                        <a:pt x="577" y="17511"/>
                      </a:moveTo>
                      <a:cubicBezTo>
                        <a:pt x="382" y="17370"/>
                        <a:pt x="190" y="17226"/>
                        <a:pt x="0" y="17078"/>
                      </a:cubicBezTo>
                    </a:path>
                    <a:path w="13224" h="17511" stroke="0" extrusionOk="0">
                      <a:moveTo>
                        <a:pt x="577" y="17511"/>
                      </a:moveTo>
                      <a:cubicBezTo>
                        <a:pt x="382" y="17370"/>
                        <a:pt x="190" y="17226"/>
                        <a:pt x="0" y="17078"/>
                      </a:cubicBezTo>
                      <a:lnTo>
                        <a:pt x="13224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52" name="Line 287">
                  <a:extLst>
                    <a:ext uri="{FF2B5EF4-FFF2-40B4-BE49-F238E27FC236}">
                      <a16:creationId xmlns:a16="http://schemas.microsoft.com/office/drawing/2014/main" id="{08074CB3-09EB-1968-AC7F-3F8988C1A1B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65" y="3707"/>
                  <a:ext cx="45" cy="6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53" name="Rectangle 288">
                  <a:extLst>
                    <a:ext uri="{FF2B5EF4-FFF2-40B4-BE49-F238E27FC236}">
                      <a16:creationId xmlns:a16="http://schemas.microsoft.com/office/drawing/2014/main" id="{163D2090-87D7-036A-DA97-D359F4325A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8660000">
                  <a:off x="558" y="3807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407280</a:t>
                  </a:r>
                </a:p>
              </p:txBody>
            </p:sp>
            <p:sp>
              <p:nvSpPr>
                <p:cNvPr id="154" name="Line 289">
                  <a:extLst>
                    <a:ext uri="{FF2B5EF4-FFF2-40B4-BE49-F238E27FC236}">
                      <a16:creationId xmlns:a16="http://schemas.microsoft.com/office/drawing/2014/main" id="{4BE42BD9-F48B-CB60-84A5-76E354905E3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814" y="3625"/>
                  <a:ext cx="100" cy="1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55" name="Arc 290">
                  <a:extLst>
                    <a:ext uri="{FF2B5EF4-FFF2-40B4-BE49-F238E27FC236}">
                      <a16:creationId xmlns:a16="http://schemas.microsoft.com/office/drawing/2014/main" id="{582542C5-EDDE-05CB-5248-5D26F02DEB3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59" y="2716"/>
                  <a:ext cx="765" cy="990"/>
                </a:xfrm>
                <a:custGeom>
                  <a:avLst/>
                  <a:gdLst>
                    <a:gd name="G0" fmla="+- 13537 0 0"/>
                    <a:gd name="G1" fmla="+- 0 0 0"/>
                    <a:gd name="G2" fmla="+- 21600 0 0"/>
                    <a:gd name="T0" fmla="*/ 910 w 13537"/>
                    <a:gd name="T1" fmla="*/ 17525 h 17525"/>
                    <a:gd name="T2" fmla="*/ 0 w 13537"/>
                    <a:gd name="T3" fmla="*/ 16832 h 17525"/>
                    <a:gd name="T4" fmla="*/ 13537 w 13537"/>
                    <a:gd name="T5" fmla="*/ 0 h 175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537" h="17525" fill="none" extrusionOk="0">
                      <a:moveTo>
                        <a:pt x="910" y="17524"/>
                      </a:moveTo>
                      <a:cubicBezTo>
                        <a:pt x="600" y="17301"/>
                        <a:pt x="297" y="17070"/>
                        <a:pt x="0" y="16831"/>
                      </a:cubicBezTo>
                    </a:path>
                    <a:path w="13537" h="17525" stroke="0" extrusionOk="0">
                      <a:moveTo>
                        <a:pt x="910" y="17524"/>
                      </a:moveTo>
                      <a:cubicBezTo>
                        <a:pt x="600" y="17301"/>
                        <a:pt x="297" y="17070"/>
                        <a:pt x="0" y="16831"/>
                      </a:cubicBezTo>
                      <a:lnTo>
                        <a:pt x="13537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56" name="Arc 291">
                  <a:extLst>
                    <a:ext uri="{FF2B5EF4-FFF2-40B4-BE49-F238E27FC236}">
                      <a16:creationId xmlns:a16="http://schemas.microsoft.com/office/drawing/2014/main" id="{240B80EB-C76E-767E-9B5C-1F9DF609ABD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15" y="2716"/>
                  <a:ext cx="809" cy="951"/>
                </a:xfrm>
                <a:custGeom>
                  <a:avLst/>
                  <a:gdLst>
                    <a:gd name="G0" fmla="+- 14326 0 0"/>
                    <a:gd name="G1" fmla="+- 0 0 0"/>
                    <a:gd name="G2" fmla="+- 21600 0 0"/>
                    <a:gd name="T0" fmla="*/ 789 w 14326"/>
                    <a:gd name="T1" fmla="*/ 16832 h 16832"/>
                    <a:gd name="T2" fmla="*/ 0 w 14326"/>
                    <a:gd name="T3" fmla="*/ 16165 h 16832"/>
                    <a:gd name="T4" fmla="*/ 14326 w 14326"/>
                    <a:gd name="T5" fmla="*/ 0 h 168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326" h="16832" fill="none" extrusionOk="0">
                      <a:moveTo>
                        <a:pt x="789" y="16831"/>
                      </a:moveTo>
                      <a:cubicBezTo>
                        <a:pt x="520" y="16616"/>
                        <a:pt x="257" y="16393"/>
                        <a:pt x="-1" y="16165"/>
                      </a:cubicBezTo>
                    </a:path>
                    <a:path w="14326" h="16832" stroke="0" extrusionOk="0">
                      <a:moveTo>
                        <a:pt x="789" y="16831"/>
                      </a:moveTo>
                      <a:cubicBezTo>
                        <a:pt x="520" y="16616"/>
                        <a:pt x="257" y="16393"/>
                        <a:pt x="-1" y="16165"/>
                      </a:cubicBezTo>
                      <a:lnTo>
                        <a:pt x="14326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57" name="Line 292">
                  <a:extLst>
                    <a:ext uri="{FF2B5EF4-FFF2-40B4-BE49-F238E27FC236}">
                      <a16:creationId xmlns:a16="http://schemas.microsoft.com/office/drawing/2014/main" id="{0F8710A5-3DD8-4621-1909-C04B7770C27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60" y="3611"/>
                  <a:ext cx="50" cy="6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58" name="Rectangle 293">
                  <a:extLst>
                    <a:ext uri="{FF2B5EF4-FFF2-40B4-BE49-F238E27FC236}">
                      <a16:creationId xmlns:a16="http://schemas.microsoft.com/office/drawing/2014/main" id="{89FA52A8-0EC6-819B-2C4B-5AFC15DF3C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8900000">
                  <a:off x="479" y="3745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402349</a:t>
                  </a:r>
                </a:p>
              </p:txBody>
            </p:sp>
            <p:sp>
              <p:nvSpPr>
                <p:cNvPr id="159" name="Line 294">
                  <a:extLst>
                    <a:ext uri="{FF2B5EF4-FFF2-40B4-BE49-F238E27FC236}">
                      <a16:creationId xmlns:a16="http://schemas.microsoft.com/office/drawing/2014/main" id="{BAC91050-17E9-4B51-F830-D77EED24E94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745" y="3520"/>
                  <a:ext cx="160" cy="16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60" name="Arc 295">
                  <a:extLst>
                    <a:ext uri="{FF2B5EF4-FFF2-40B4-BE49-F238E27FC236}">
                      <a16:creationId xmlns:a16="http://schemas.microsoft.com/office/drawing/2014/main" id="{0FD58C85-8BA3-D534-E250-B6EE491DF20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54" y="2716"/>
                  <a:ext cx="770" cy="895"/>
                </a:xfrm>
                <a:custGeom>
                  <a:avLst/>
                  <a:gdLst>
                    <a:gd name="G0" fmla="+- 14491 0 0"/>
                    <a:gd name="G1" fmla="+- 0 0 0"/>
                    <a:gd name="G2" fmla="+- 21600 0 0"/>
                    <a:gd name="T0" fmla="*/ 975 w 14491"/>
                    <a:gd name="T1" fmla="*/ 16848 h 16848"/>
                    <a:gd name="T2" fmla="*/ 0 w 14491"/>
                    <a:gd name="T3" fmla="*/ 16018 h 16848"/>
                    <a:gd name="T4" fmla="*/ 14491 w 14491"/>
                    <a:gd name="T5" fmla="*/ 0 h 168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4491" h="16848" fill="none" extrusionOk="0">
                      <a:moveTo>
                        <a:pt x="974" y="16848"/>
                      </a:moveTo>
                      <a:cubicBezTo>
                        <a:pt x="641" y="16581"/>
                        <a:pt x="316" y="16304"/>
                        <a:pt x="0" y="16017"/>
                      </a:cubicBezTo>
                    </a:path>
                    <a:path w="14491" h="16848" stroke="0" extrusionOk="0">
                      <a:moveTo>
                        <a:pt x="974" y="16848"/>
                      </a:moveTo>
                      <a:cubicBezTo>
                        <a:pt x="641" y="16581"/>
                        <a:pt x="316" y="16304"/>
                        <a:pt x="0" y="16017"/>
                      </a:cubicBezTo>
                      <a:lnTo>
                        <a:pt x="14491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61" name="Arc 296">
                  <a:extLst>
                    <a:ext uri="{FF2B5EF4-FFF2-40B4-BE49-F238E27FC236}">
                      <a16:creationId xmlns:a16="http://schemas.microsoft.com/office/drawing/2014/main" id="{545F31EA-BAA0-2109-53AC-324D078E290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05" y="2716"/>
                  <a:ext cx="819" cy="851"/>
                </a:xfrm>
                <a:custGeom>
                  <a:avLst/>
                  <a:gdLst>
                    <a:gd name="G0" fmla="+- 15414 0 0"/>
                    <a:gd name="G1" fmla="+- 0 0 0"/>
                    <a:gd name="G2" fmla="+- 21600 0 0"/>
                    <a:gd name="T0" fmla="*/ 923 w 15414"/>
                    <a:gd name="T1" fmla="*/ 16018 h 16018"/>
                    <a:gd name="T2" fmla="*/ 0 w 15414"/>
                    <a:gd name="T3" fmla="*/ 15132 h 16018"/>
                    <a:gd name="T4" fmla="*/ 15414 w 15414"/>
                    <a:gd name="T5" fmla="*/ 0 h 160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414" h="16018" fill="none" extrusionOk="0">
                      <a:moveTo>
                        <a:pt x="923" y="16017"/>
                      </a:moveTo>
                      <a:cubicBezTo>
                        <a:pt x="606" y="15731"/>
                        <a:pt x="298" y="15436"/>
                        <a:pt x="0" y="15131"/>
                      </a:cubicBezTo>
                    </a:path>
                    <a:path w="15414" h="16018" stroke="0" extrusionOk="0">
                      <a:moveTo>
                        <a:pt x="923" y="16017"/>
                      </a:moveTo>
                      <a:cubicBezTo>
                        <a:pt x="606" y="15731"/>
                        <a:pt x="298" y="15436"/>
                        <a:pt x="0" y="15131"/>
                      </a:cubicBezTo>
                      <a:lnTo>
                        <a:pt x="15414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62" name="Line 297">
                  <a:extLst>
                    <a:ext uri="{FF2B5EF4-FFF2-40B4-BE49-F238E27FC236}">
                      <a16:creationId xmlns:a16="http://schemas.microsoft.com/office/drawing/2014/main" id="{C9592A6F-06F8-8D84-DF04-EC0E2638299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55" y="3515"/>
                  <a:ext cx="51" cy="5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63" name="Rectangle 298">
                  <a:extLst>
                    <a:ext uri="{FF2B5EF4-FFF2-40B4-BE49-F238E27FC236}">
                      <a16:creationId xmlns:a16="http://schemas.microsoft.com/office/drawing/2014/main" id="{EF6494F1-163B-4FAD-94C5-1472D38A8B2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9140000">
                  <a:off x="411" y="3671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418910</a:t>
                  </a:r>
                </a:p>
              </p:txBody>
            </p:sp>
            <p:sp>
              <p:nvSpPr>
                <p:cNvPr id="164" name="Line 299">
                  <a:extLst>
                    <a:ext uri="{FF2B5EF4-FFF2-40B4-BE49-F238E27FC236}">
                      <a16:creationId xmlns:a16="http://schemas.microsoft.com/office/drawing/2014/main" id="{E9627B1B-C8BF-64F2-8315-6F7805D12A0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686" y="3415"/>
                  <a:ext cx="228" cy="19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65" name="Arc 300">
                  <a:extLst>
                    <a:ext uri="{FF2B5EF4-FFF2-40B4-BE49-F238E27FC236}">
                      <a16:creationId xmlns:a16="http://schemas.microsoft.com/office/drawing/2014/main" id="{122C68B5-1A2D-3886-2952-C8801A00C58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54" y="2716"/>
                  <a:ext cx="770" cy="797"/>
                </a:xfrm>
                <a:custGeom>
                  <a:avLst/>
                  <a:gdLst>
                    <a:gd name="G0" fmla="+- 15473 0 0"/>
                    <a:gd name="G1" fmla="+- 0 0 0"/>
                    <a:gd name="G2" fmla="+- 21600 0 0"/>
                    <a:gd name="T0" fmla="*/ 996 w 15473"/>
                    <a:gd name="T1" fmla="*/ 16030 h 16030"/>
                    <a:gd name="T2" fmla="*/ 0 w 15473"/>
                    <a:gd name="T3" fmla="*/ 15071 h 16030"/>
                    <a:gd name="T4" fmla="*/ 15473 w 15473"/>
                    <a:gd name="T5" fmla="*/ 0 h 160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473" h="16030" fill="none" extrusionOk="0">
                      <a:moveTo>
                        <a:pt x="995" y="16030"/>
                      </a:moveTo>
                      <a:cubicBezTo>
                        <a:pt x="653" y="15721"/>
                        <a:pt x="321" y="15401"/>
                        <a:pt x="-1" y="15071"/>
                      </a:cubicBezTo>
                    </a:path>
                    <a:path w="15473" h="16030" stroke="0" extrusionOk="0">
                      <a:moveTo>
                        <a:pt x="995" y="16030"/>
                      </a:moveTo>
                      <a:cubicBezTo>
                        <a:pt x="653" y="15721"/>
                        <a:pt x="321" y="15401"/>
                        <a:pt x="-1" y="15071"/>
                      </a:cubicBezTo>
                      <a:lnTo>
                        <a:pt x="15473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66" name="Arc 301">
                  <a:extLst>
                    <a:ext uri="{FF2B5EF4-FFF2-40B4-BE49-F238E27FC236}">
                      <a16:creationId xmlns:a16="http://schemas.microsoft.com/office/drawing/2014/main" id="{A66D76D5-C5C8-E765-0241-8837945131A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11" y="2716"/>
                  <a:ext cx="813" cy="750"/>
                </a:xfrm>
                <a:custGeom>
                  <a:avLst/>
                  <a:gdLst>
                    <a:gd name="G0" fmla="+- 16347 0 0"/>
                    <a:gd name="G1" fmla="+- 0 0 0"/>
                    <a:gd name="G2" fmla="+- 21600 0 0"/>
                    <a:gd name="T0" fmla="*/ 874 w 16347"/>
                    <a:gd name="T1" fmla="*/ 15071 h 15071"/>
                    <a:gd name="T2" fmla="*/ 0 w 16347"/>
                    <a:gd name="T3" fmla="*/ 14118 h 15071"/>
                    <a:gd name="T4" fmla="*/ 16347 w 16347"/>
                    <a:gd name="T5" fmla="*/ 0 h 150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347" h="15071" fill="none" extrusionOk="0">
                      <a:moveTo>
                        <a:pt x="873" y="15071"/>
                      </a:moveTo>
                      <a:cubicBezTo>
                        <a:pt x="572" y="14762"/>
                        <a:pt x="281" y="14444"/>
                        <a:pt x="-1" y="14118"/>
                      </a:cubicBezTo>
                    </a:path>
                    <a:path w="16347" h="15071" stroke="0" extrusionOk="0">
                      <a:moveTo>
                        <a:pt x="873" y="15071"/>
                      </a:moveTo>
                      <a:cubicBezTo>
                        <a:pt x="572" y="14762"/>
                        <a:pt x="281" y="14444"/>
                        <a:pt x="-1" y="14118"/>
                      </a:cubicBezTo>
                      <a:lnTo>
                        <a:pt x="16347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67" name="Line 302">
                  <a:extLst>
                    <a:ext uri="{FF2B5EF4-FFF2-40B4-BE49-F238E27FC236}">
                      <a16:creationId xmlns:a16="http://schemas.microsoft.com/office/drawing/2014/main" id="{D09A2F2D-966D-8554-1F3D-153C2033703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55" y="3410"/>
                  <a:ext cx="55" cy="5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68" name="Rectangle 303">
                  <a:extLst>
                    <a:ext uri="{FF2B5EF4-FFF2-40B4-BE49-F238E27FC236}">
                      <a16:creationId xmlns:a16="http://schemas.microsoft.com/office/drawing/2014/main" id="{71B8E461-9F73-A08C-F99D-0CC24D199E4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9380000">
                  <a:off x="350" y="3587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402351</a:t>
                  </a:r>
                </a:p>
              </p:txBody>
            </p:sp>
            <p:sp>
              <p:nvSpPr>
                <p:cNvPr id="169" name="Line 304">
                  <a:extLst>
                    <a:ext uri="{FF2B5EF4-FFF2-40B4-BE49-F238E27FC236}">
                      <a16:creationId xmlns:a16="http://schemas.microsoft.com/office/drawing/2014/main" id="{E25A5A7D-8685-7BCF-3D08-0B38F9C660C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626" y="3314"/>
                  <a:ext cx="297" cy="2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70" name="Arc 305">
                  <a:extLst>
                    <a:ext uri="{FF2B5EF4-FFF2-40B4-BE49-F238E27FC236}">
                      <a16:creationId xmlns:a16="http://schemas.microsoft.com/office/drawing/2014/main" id="{65CB29A0-6C0C-555A-5A7E-FE3840C7782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65" y="2716"/>
                  <a:ext cx="759" cy="699"/>
                </a:xfrm>
                <a:custGeom>
                  <a:avLst/>
                  <a:gdLst>
                    <a:gd name="G0" fmla="+- 16380 0 0"/>
                    <a:gd name="G1" fmla="+- 0 0 0"/>
                    <a:gd name="G2" fmla="+- 21600 0 0"/>
                    <a:gd name="T0" fmla="*/ 903 w 16380"/>
                    <a:gd name="T1" fmla="*/ 15067 h 15067"/>
                    <a:gd name="T2" fmla="*/ 0 w 16380"/>
                    <a:gd name="T3" fmla="*/ 14080 h 15067"/>
                    <a:gd name="T4" fmla="*/ 16380 w 16380"/>
                    <a:gd name="T5" fmla="*/ 0 h 150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380" h="15067" fill="none" extrusionOk="0">
                      <a:moveTo>
                        <a:pt x="902" y="15067"/>
                      </a:moveTo>
                      <a:cubicBezTo>
                        <a:pt x="591" y="14747"/>
                        <a:pt x="290" y="14418"/>
                        <a:pt x="-1" y="14080"/>
                      </a:cubicBezTo>
                    </a:path>
                    <a:path w="16380" h="15067" stroke="0" extrusionOk="0">
                      <a:moveTo>
                        <a:pt x="902" y="15067"/>
                      </a:moveTo>
                      <a:cubicBezTo>
                        <a:pt x="591" y="14747"/>
                        <a:pt x="290" y="14418"/>
                        <a:pt x="-1" y="14080"/>
                      </a:cubicBezTo>
                      <a:lnTo>
                        <a:pt x="16380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71" name="Arc 306">
                  <a:extLst>
                    <a:ext uri="{FF2B5EF4-FFF2-40B4-BE49-F238E27FC236}">
                      <a16:creationId xmlns:a16="http://schemas.microsoft.com/office/drawing/2014/main" id="{3BC95D36-FC6C-1CDE-5508-6E075D5C50D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24" y="2716"/>
                  <a:ext cx="800" cy="653"/>
                </a:xfrm>
                <a:custGeom>
                  <a:avLst/>
                  <a:gdLst>
                    <a:gd name="G0" fmla="+- 17257 0 0"/>
                    <a:gd name="G1" fmla="+- 0 0 0"/>
                    <a:gd name="G2" fmla="+- 21600 0 0"/>
                    <a:gd name="T0" fmla="*/ 877 w 17257"/>
                    <a:gd name="T1" fmla="*/ 14080 h 14080"/>
                    <a:gd name="T2" fmla="*/ 0 w 17257"/>
                    <a:gd name="T3" fmla="*/ 12991 h 14080"/>
                    <a:gd name="T4" fmla="*/ 17257 w 17257"/>
                    <a:gd name="T5" fmla="*/ 0 h 1408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257" h="14080" fill="none" extrusionOk="0">
                      <a:moveTo>
                        <a:pt x="876" y="14080"/>
                      </a:moveTo>
                      <a:cubicBezTo>
                        <a:pt x="572" y="13726"/>
                        <a:pt x="280" y="13363"/>
                        <a:pt x="0" y="12990"/>
                      </a:cubicBezTo>
                    </a:path>
                    <a:path w="17257" h="14080" stroke="0" extrusionOk="0">
                      <a:moveTo>
                        <a:pt x="876" y="14080"/>
                      </a:moveTo>
                      <a:cubicBezTo>
                        <a:pt x="572" y="13726"/>
                        <a:pt x="280" y="13363"/>
                        <a:pt x="0" y="12990"/>
                      </a:cubicBezTo>
                      <a:lnTo>
                        <a:pt x="17257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72" name="Line 307">
                  <a:extLst>
                    <a:ext uri="{FF2B5EF4-FFF2-40B4-BE49-F238E27FC236}">
                      <a16:creationId xmlns:a16="http://schemas.microsoft.com/office/drawing/2014/main" id="{62F8006E-6EE7-8BE7-4092-857B03ACB91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65" y="3314"/>
                  <a:ext cx="59" cy="5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73" name="Rectangle 308">
                  <a:extLst>
                    <a:ext uri="{FF2B5EF4-FFF2-40B4-BE49-F238E27FC236}">
                      <a16:creationId xmlns:a16="http://schemas.microsoft.com/office/drawing/2014/main" id="{8FDBD95E-8F6C-A09D-6B4D-6400781A33F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9560000">
                  <a:off x="294" y="3502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124329</a:t>
                  </a:r>
                </a:p>
              </p:txBody>
            </p:sp>
            <p:sp>
              <p:nvSpPr>
                <p:cNvPr id="174" name="Line 309">
                  <a:extLst>
                    <a:ext uri="{FF2B5EF4-FFF2-40B4-BE49-F238E27FC236}">
                      <a16:creationId xmlns:a16="http://schemas.microsoft.com/office/drawing/2014/main" id="{FD97DDB6-B351-6CF5-3A09-7C5388BB95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76" y="3218"/>
                  <a:ext cx="375" cy="24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75" name="Arc 310">
                  <a:extLst>
                    <a:ext uri="{FF2B5EF4-FFF2-40B4-BE49-F238E27FC236}">
                      <a16:creationId xmlns:a16="http://schemas.microsoft.com/office/drawing/2014/main" id="{F2F1FC9D-F61B-C2F2-53AC-39CFBBD2915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85" y="2716"/>
                  <a:ext cx="739" cy="602"/>
                </a:xfrm>
                <a:custGeom>
                  <a:avLst/>
                  <a:gdLst>
                    <a:gd name="G0" fmla="+- 17277 0 0"/>
                    <a:gd name="G1" fmla="+- 0 0 0"/>
                    <a:gd name="G2" fmla="+- 21600 0 0"/>
                    <a:gd name="T0" fmla="*/ 904 w 17277"/>
                    <a:gd name="T1" fmla="*/ 14088 h 14088"/>
                    <a:gd name="T2" fmla="*/ 0 w 17277"/>
                    <a:gd name="T3" fmla="*/ 12964 h 14088"/>
                    <a:gd name="T4" fmla="*/ 17277 w 17277"/>
                    <a:gd name="T5" fmla="*/ 0 h 1408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277" h="14088" fill="none" extrusionOk="0">
                      <a:moveTo>
                        <a:pt x="903" y="14088"/>
                      </a:moveTo>
                      <a:cubicBezTo>
                        <a:pt x="590" y="13723"/>
                        <a:pt x="288" y="13348"/>
                        <a:pt x="0" y="12963"/>
                      </a:cubicBezTo>
                    </a:path>
                    <a:path w="17277" h="14088" stroke="0" extrusionOk="0">
                      <a:moveTo>
                        <a:pt x="903" y="14088"/>
                      </a:moveTo>
                      <a:cubicBezTo>
                        <a:pt x="590" y="13723"/>
                        <a:pt x="288" y="13348"/>
                        <a:pt x="0" y="12963"/>
                      </a:cubicBezTo>
                      <a:lnTo>
                        <a:pt x="17277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76" name="Arc 311">
                  <a:extLst>
                    <a:ext uri="{FF2B5EF4-FFF2-40B4-BE49-F238E27FC236}">
                      <a16:creationId xmlns:a16="http://schemas.microsoft.com/office/drawing/2014/main" id="{E2E352BE-CFD5-701D-CFDA-A56B281323F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49" y="2716"/>
                  <a:ext cx="775" cy="554"/>
                </a:xfrm>
                <a:custGeom>
                  <a:avLst/>
                  <a:gdLst>
                    <a:gd name="G0" fmla="+- 18115 0 0"/>
                    <a:gd name="G1" fmla="+- 0 0 0"/>
                    <a:gd name="G2" fmla="+- 21600 0 0"/>
                    <a:gd name="T0" fmla="*/ 838 w 18115"/>
                    <a:gd name="T1" fmla="*/ 12964 h 12964"/>
                    <a:gd name="T2" fmla="*/ 0 w 18115"/>
                    <a:gd name="T3" fmla="*/ 11764 h 12964"/>
                    <a:gd name="T4" fmla="*/ 18115 w 18115"/>
                    <a:gd name="T5" fmla="*/ 0 h 129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115" h="12964" fill="none" extrusionOk="0">
                      <a:moveTo>
                        <a:pt x="838" y="12963"/>
                      </a:moveTo>
                      <a:cubicBezTo>
                        <a:pt x="545" y="12573"/>
                        <a:pt x="265" y="12173"/>
                        <a:pt x="-1" y="11764"/>
                      </a:cubicBezTo>
                    </a:path>
                    <a:path w="18115" h="12964" stroke="0" extrusionOk="0">
                      <a:moveTo>
                        <a:pt x="838" y="12963"/>
                      </a:moveTo>
                      <a:cubicBezTo>
                        <a:pt x="545" y="12573"/>
                        <a:pt x="265" y="12173"/>
                        <a:pt x="-1" y="11764"/>
                      </a:cubicBezTo>
                      <a:lnTo>
                        <a:pt x="18115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77" name="Line 312">
                  <a:extLst>
                    <a:ext uri="{FF2B5EF4-FFF2-40B4-BE49-F238E27FC236}">
                      <a16:creationId xmlns:a16="http://schemas.microsoft.com/office/drawing/2014/main" id="{4557BD10-3E13-0E6E-F9D5-108CC64937F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983" y="3227"/>
                  <a:ext cx="59" cy="4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78" name="Rectangle 313">
                  <a:extLst>
                    <a:ext uri="{FF2B5EF4-FFF2-40B4-BE49-F238E27FC236}">
                      <a16:creationId xmlns:a16="http://schemas.microsoft.com/office/drawing/2014/main" id="{EA8E2885-6F20-155C-358B-E25D7E47054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9800000">
                  <a:off x="236" y="3419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112927</a:t>
                  </a:r>
                </a:p>
              </p:txBody>
            </p:sp>
            <p:sp>
              <p:nvSpPr>
                <p:cNvPr id="179" name="Line 314">
                  <a:extLst>
                    <a:ext uri="{FF2B5EF4-FFF2-40B4-BE49-F238E27FC236}">
                      <a16:creationId xmlns:a16="http://schemas.microsoft.com/office/drawing/2014/main" id="{C16A486A-960A-6139-4D17-DCFEC4B168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26" y="3136"/>
                  <a:ext cx="452" cy="25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80" name="Arc 315">
                  <a:extLst>
                    <a:ext uri="{FF2B5EF4-FFF2-40B4-BE49-F238E27FC236}">
                      <a16:creationId xmlns:a16="http://schemas.microsoft.com/office/drawing/2014/main" id="{4DE388F1-E982-9537-BFD7-1F11FD8C008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012" y="2716"/>
                  <a:ext cx="712" cy="510"/>
                </a:xfrm>
                <a:custGeom>
                  <a:avLst/>
                  <a:gdLst>
                    <a:gd name="G0" fmla="+- 18088 0 0"/>
                    <a:gd name="G1" fmla="+- 0 0 0"/>
                    <a:gd name="G2" fmla="+- 21600 0 0"/>
                    <a:gd name="T0" fmla="*/ 802 w 18088"/>
                    <a:gd name="T1" fmla="*/ 12952 h 12952"/>
                    <a:gd name="T2" fmla="*/ 0 w 18088"/>
                    <a:gd name="T3" fmla="*/ 11806 h 12952"/>
                    <a:gd name="T4" fmla="*/ 18088 w 18088"/>
                    <a:gd name="T5" fmla="*/ 0 h 1295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088" h="12952" fill="none" extrusionOk="0">
                      <a:moveTo>
                        <a:pt x="802" y="12951"/>
                      </a:moveTo>
                      <a:cubicBezTo>
                        <a:pt x="522" y="12578"/>
                        <a:pt x="254" y="12196"/>
                        <a:pt x="-1" y="11806"/>
                      </a:cubicBezTo>
                    </a:path>
                    <a:path w="18088" h="12952" stroke="0" extrusionOk="0">
                      <a:moveTo>
                        <a:pt x="802" y="12951"/>
                      </a:moveTo>
                      <a:cubicBezTo>
                        <a:pt x="522" y="12578"/>
                        <a:pt x="254" y="12196"/>
                        <a:pt x="-1" y="11806"/>
                      </a:cubicBezTo>
                      <a:lnTo>
                        <a:pt x="18088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81" name="Arc 316">
                  <a:extLst>
                    <a:ext uri="{FF2B5EF4-FFF2-40B4-BE49-F238E27FC236}">
                      <a16:creationId xmlns:a16="http://schemas.microsoft.com/office/drawing/2014/main" id="{B2638F85-BE7A-D4B5-EC38-485FEDD7C94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82" y="2716"/>
                  <a:ext cx="742" cy="465"/>
                </a:xfrm>
                <a:custGeom>
                  <a:avLst/>
                  <a:gdLst>
                    <a:gd name="G0" fmla="+- 18846 0 0"/>
                    <a:gd name="G1" fmla="+- 0 0 0"/>
                    <a:gd name="G2" fmla="+- 21600 0 0"/>
                    <a:gd name="T0" fmla="*/ 758 w 18846"/>
                    <a:gd name="T1" fmla="*/ 11806 h 11806"/>
                    <a:gd name="T2" fmla="*/ 0 w 18846"/>
                    <a:gd name="T3" fmla="*/ 10555 h 11806"/>
                    <a:gd name="T4" fmla="*/ 18846 w 18846"/>
                    <a:gd name="T5" fmla="*/ 0 h 1180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846" h="11806" fill="none" extrusionOk="0">
                      <a:moveTo>
                        <a:pt x="757" y="11806"/>
                      </a:moveTo>
                      <a:cubicBezTo>
                        <a:pt x="491" y="11397"/>
                        <a:pt x="238" y="10980"/>
                        <a:pt x="0" y="10554"/>
                      </a:cubicBezTo>
                    </a:path>
                    <a:path w="18846" h="11806" stroke="0" extrusionOk="0">
                      <a:moveTo>
                        <a:pt x="757" y="11806"/>
                      </a:moveTo>
                      <a:cubicBezTo>
                        <a:pt x="491" y="11397"/>
                        <a:pt x="238" y="10980"/>
                        <a:pt x="0" y="10554"/>
                      </a:cubicBezTo>
                      <a:lnTo>
                        <a:pt x="18846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82" name="Line 317">
                  <a:extLst>
                    <a:ext uri="{FF2B5EF4-FFF2-40B4-BE49-F238E27FC236}">
                      <a16:creationId xmlns:a16="http://schemas.microsoft.com/office/drawing/2014/main" id="{411A7CE0-F81F-2013-E7EE-A094B0A20E1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1010" y="3058"/>
                  <a:ext cx="188" cy="1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83" name="Rectangle 318">
                  <a:extLst>
                    <a:ext uri="{FF2B5EF4-FFF2-40B4-BE49-F238E27FC236}">
                      <a16:creationId xmlns:a16="http://schemas.microsoft.com/office/drawing/2014/main" id="{E2C9ACF8-7B18-35F6-D478-DF68A8A5F7A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0040000">
                  <a:off x="223" y="3317"/>
                  <a:ext cx="27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86551</a:t>
                  </a:r>
                </a:p>
              </p:txBody>
            </p:sp>
            <p:sp>
              <p:nvSpPr>
                <p:cNvPr id="184" name="Line 319">
                  <a:extLst>
                    <a:ext uri="{FF2B5EF4-FFF2-40B4-BE49-F238E27FC236}">
                      <a16:creationId xmlns:a16="http://schemas.microsoft.com/office/drawing/2014/main" id="{FE173BB7-9B01-207E-4753-59DE5A41F46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85" y="3273"/>
                  <a:ext cx="68" cy="3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85" name="Rectangle 320">
                  <a:extLst>
                    <a:ext uri="{FF2B5EF4-FFF2-40B4-BE49-F238E27FC236}">
                      <a16:creationId xmlns:a16="http://schemas.microsoft.com/office/drawing/2014/main" id="{A5C66FC4-D876-52A4-4563-6ADA3B70DA5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0280000">
                  <a:off x="153" y="3234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163980</a:t>
                  </a:r>
                </a:p>
              </p:txBody>
            </p:sp>
            <p:sp>
              <p:nvSpPr>
                <p:cNvPr id="186" name="Line 321">
                  <a:extLst>
                    <a:ext uri="{FF2B5EF4-FFF2-40B4-BE49-F238E27FC236}">
                      <a16:creationId xmlns:a16="http://schemas.microsoft.com/office/drawing/2014/main" id="{48B52E6A-D4AC-3CAB-D2AE-C88215775AD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48" y="3195"/>
                  <a:ext cx="69" cy="2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87" name="Arc 322">
                  <a:extLst>
                    <a:ext uri="{FF2B5EF4-FFF2-40B4-BE49-F238E27FC236}">
                      <a16:creationId xmlns:a16="http://schemas.microsoft.com/office/drawing/2014/main" id="{E5ECCE79-0059-551B-0403-63C8ADBC0B7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5" y="2716"/>
                  <a:ext cx="1189" cy="558"/>
                </a:xfrm>
                <a:custGeom>
                  <a:avLst/>
                  <a:gdLst>
                    <a:gd name="G0" fmla="+- 19784 0 0"/>
                    <a:gd name="G1" fmla="+- 0 0 0"/>
                    <a:gd name="G2" fmla="+- 21600 0 0"/>
                    <a:gd name="T0" fmla="*/ 278 w 19784"/>
                    <a:gd name="T1" fmla="*/ 9278 h 9278"/>
                    <a:gd name="T2" fmla="*/ 0 w 19784"/>
                    <a:gd name="T3" fmla="*/ 8669 h 9278"/>
                    <a:gd name="T4" fmla="*/ 19784 w 19784"/>
                    <a:gd name="T5" fmla="*/ 0 h 927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784" h="9278" fill="none" extrusionOk="0">
                      <a:moveTo>
                        <a:pt x="278" y="9277"/>
                      </a:moveTo>
                      <a:cubicBezTo>
                        <a:pt x="182" y="9076"/>
                        <a:pt x="89" y="8873"/>
                        <a:pt x="-1" y="8669"/>
                      </a:cubicBezTo>
                    </a:path>
                    <a:path w="19784" h="9278" stroke="0" extrusionOk="0">
                      <a:moveTo>
                        <a:pt x="278" y="9277"/>
                      </a:moveTo>
                      <a:cubicBezTo>
                        <a:pt x="182" y="9076"/>
                        <a:pt x="89" y="8873"/>
                        <a:pt x="-1" y="8669"/>
                      </a:cubicBezTo>
                      <a:lnTo>
                        <a:pt x="19784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88" name="Arc 323">
                  <a:extLst>
                    <a:ext uri="{FF2B5EF4-FFF2-40B4-BE49-F238E27FC236}">
                      <a16:creationId xmlns:a16="http://schemas.microsoft.com/office/drawing/2014/main" id="{46879E22-4F42-EF73-ED2C-4EBE320AEBE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17" y="2716"/>
                  <a:ext cx="1207" cy="521"/>
                </a:xfrm>
                <a:custGeom>
                  <a:avLst/>
                  <a:gdLst>
                    <a:gd name="G0" fmla="+- 20077 0 0"/>
                    <a:gd name="G1" fmla="+- 0 0 0"/>
                    <a:gd name="G2" fmla="+- 21600 0 0"/>
                    <a:gd name="T0" fmla="*/ 293 w 20077"/>
                    <a:gd name="T1" fmla="*/ 8669 h 8669"/>
                    <a:gd name="T2" fmla="*/ 0 w 20077"/>
                    <a:gd name="T3" fmla="*/ 7968 h 8669"/>
                    <a:gd name="T4" fmla="*/ 20077 w 20077"/>
                    <a:gd name="T5" fmla="*/ 0 h 866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077" h="8669" fill="none" extrusionOk="0">
                      <a:moveTo>
                        <a:pt x="292" y="8669"/>
                      </a:moveTo>
                      <a:cubicBezTo>
                        <a:pt x="191" y="8437"/>
                        <a:pt x="93" y="8203"/>
                        <a:pt x="0" y="7967"/>
                      </a:cubicBezTo>
                    </a:path>
                    <a:path w="20077" h="8669" stroke="0" extrusionOk="0">
                      <a:moveTo>
                        <a:pt x="292" y="8669"/>
                      </a:moveTo>
                      <a:cubicBezTo>
                        <a:pt x="191" y="8437"/>
                        <a:pt x="93" y="8203"/>
                        <a:pt x="0" y="7967"/>
                      </a:cubicBezTo>
                      <a:lnTo>
                        <a:pt x="20077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89" name="Line 324">
                  <a:extLst>
                    <a:ext uri="{FF2B5EF4-FFF2-40B4-BE49-F238E27FC236}">
                      <a16:creationId xmlns:a16="http://schemas.microsoft.com/office/drawing/2014/main" id="{B6E409EB-8552-8F4A-68F6-FB6973DB054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35" y="3209"/>
                  <a:ext cx="68" cy="2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90" name="Rectangle 325">
                  <a:extLst>
                    <a:ext uri="{FF2B5EF4-FFF2-40B4-BE49-F238E27FC236}">
                      <a16:creationId xmlns:a16="http://schemas.microsoft.com/office/drawing/2014/main" id="{503DF79F-FAA1-D989-BDA2-40060263857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0520000">
                  <a:off x="147" y="3132"/>
                  <a:ext cx="27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76432</a:t>
                  </a:r>
                </a:p>
              </p:txBody>
            </p:sp>
            <p:sp>
              <p:nvSpPr>
                <p:cNvPr id="191" name="Line 326">
                  <a:extLst>
                    <a:ext uri="{FF2B5EF4-FFF2-40B4-BE49-F238E27FC236}">
                      <a16:creationId xmlns:a16="http://schemas.microsoft.com/office/drawing/2014/main" id="{76D81C9A-AC1D-445B-4CD4-87AC13FE358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16" y="3090"/>
                  <a:ext cx="142" cy="4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92" name="Arc 327">
                  <a:extLst>
                    <a:ext uri="{FF2B5EF4-FFF2-40B4-BE49-F238E27FC236}">
                      <a16:creationId xmlns:a16="http://schemas.microsoft.com/office/drawing/2014/main" id="{85010085-DFD3-7693-5F2D-C5BF628DD50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83" y="2716"/>
                  <a:ext cx="1141" cy="488"/>
                </a:xfrm>
                <a:custGeom>
                  <a:avLst/>
                  <a:gdLst>
                    <a:gd name="G0" fmla="+- 20193 0 0"/>
                    <a:gd name="G1" fmla="+- 0 0 0"/>
                    <a:gd name="G2" fmla="+- 21600 0 0"/>
                    <a:gd name="T0" fmla="*/ 395 w 20193"/>
                    <a:gd name="T1" fmla="*/ 8636 h 8636"/>
                    <a:gd name="T2" fmla="*/ 0 w 20193"/>
                    <a:gd name="T3" fmla="*/ 7667 h 8636"/>
                    <a:gd name="T4" fmla="*/ 20193 w 20193"/>
                    <a:gd name="T5" fmla="*/ 0 h 86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193" h="8636" fill="none" extrusionOk="0">
                      <a:moveTo>
                        <a:pt x="394" y="8636"/>
                      </a:moveTo>
                      <a:cubicBezTo>
                        <a:pt x="255" y="8316"/>
                        <a:pt x="123" y="7993"/>
                        <a:pt x="-1" y="7667"/>
                      </a:cubicBezTo>
                    </a:path>
                    <a:path w="20193" h="8636" stroke="0" extrusionOk="0">
                      <a:moveTo>
                        <a:pt x="394" y="8636"/>
                      </a:moveTo>
                      <a:cubicBezTo>
                        <a:pt x="255" y="8316"/>
                        <a:pt x="123" y="7993"/>
                        <a:pt x="-1" y="7667"/>
                      </a:cubicBezTo>
                      <a:lnTo>
                        <a:pt x="20193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93" name="Arc 328">
                  <a:extLst>
                    <a:ext uri="{FF2B5EF4-FFF2-40B4-BE49-F238E27FC236}">
                      <a16:creationId xmlns:a16="http://schemas.microsoft.com/office/drawing/2014/main" id="{192B9AF0-A060-19FC-F3DC-0F2D2B3DA0B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62" y="2716"/>
                  <a:ext cx="1162" cy="433"/>
                </a:xfrm>
                <a:custGeom>
                  <a:avLst/>
                  <a:gdLst>
                    <a:gd name="G0" fmla="+- 20561 0 0"/>
                    <a:gd name="G1" fmla="+- 0 0 0"/>
                    <a:gd name="G2" fmla="+- 21600 0 0"/>
                    <a:gd name="T0" fmla="*/ 368 w 20561"/>
                    <a:gd name="T1" fmla="*/ 7667 h 7667"/>
                    <a:gd name="T2" fmla="*/ 0 w 20561"/>
                    <a:gd name="T3" fmla="*/ 6618 h 7667"/>
                    <a:gd name="T4" fmla="*/ 20561 w 20561"/>
                    <a:gd name="T5" fmla="*/ 0 h 766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561" h="7667" fill="none" extrusionOk="0">
                      <a:moveTo>
                        <a:pt x="367" y="7667"/>
                      </a:moveTo>
                      <a:cubicBezTo>
                        <a:pt x="236" y="7320"/>
                        <a:pt x="113" y="6970"/>
                        <a:pt x="-1" y="6618"/>
                      </a:cubicBezTo>
                    </a:path>
                    <a:path w="20561" h="7667" stroke="0" extrusionOk="0">
                      <a:moveTo>
                        <a:pt x="367" y="7667"/>
                      </a:moveTo>
                      <a:cubicBezTo>
                        <a:pt x="236" y="7320"/>
                        <a:pt x="113" y="6970"/>
                        <a:pt x="-1" y="6618"/>
                      </a:cubicBezTo>
                      <a:lnTo>
                        <a:pt x="20561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94" name="Line 329">
                  <a:extLst>
                    <a:ext uri="{FF2B5EF4-FFF2-40B4-BE49-F238E27FC236}">
                      <a16:creationId xmlns:a16="http://schemas.microsoft.com/office/drawing/2014/main" id="{443C87CD-5508-B971-2A99-DD93C1BAEC8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81" y="3127"/>
                  <a:ext cx="68" cy="2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95" name="Rectangle 330">
                  <a:extLst>
                    <a:ext uri="{FF2B5EF4-FFF2-40B4-BE49-F238E27FC236}">
                      <a16:creationId xmlns:a16="http://schemas.microsoft.com/office/drawing/2014/main" id="{93E7ECD1-D158-6D87-022A-AB17788EE11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0760000">
                  <a:off x="136" y="3037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31</a:t>
                  </a:r>
                </a:p>
              </p:txBody>
            </p:sp>
            <p:sp>
              <p:nvSpPr>
                <p:cNvPr id="196" name="Line 331">
                  <a:extLst>
                    <a:ext uri="{FF2B5EF4-FFF2-40B4-BE49-F238E27FC236}">
                      <a16:creationId xmlns:a16="http://schemas.microsoft.com/office/drawing/2014/main" id="{5DD01896-1E26-699A-E5E6-EC6F5AE729C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3" y="2994"/>
                  <a:ext cx="215" cy="5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97" name="Arc 332">
                  <a:extLst>
                    <a:ext uri="{FF2B5EF4-FFF2-40B4-BE49-F238E27FC236}">
                      <a16:creationId xmlns:a16="http://schemas.microsoft.com/office/drawing/2014/main" id="{371E8DDC-721B-F24D-C4A6-A9DA23AE77A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29" y="2716"/>
                  <a:ext cx="1095" cy="407"/>
                </a:xfrm>
                <a:custGeom>
                  <a:avLst/>
                  <a:gdLst>
                    <a:gd name="G0" fmla="+- 20614 0 0"/>
                    <a:gd name="G1" fmla="+- 0 0 0"/>
                    <a:gd name="G2" fmla="+- 21600 0 0"/>
                    <a:gd name="T0" fmla="*/ 419 w 20614"/>
                    <a:gd name="T1" fmla="*/ 7663 h 7663"/>
                    <a:gd name="T2" fmla="*/ 0 w 20614"/>
                    <a:gd name="T3" fmla="*/ 6450 h 7663"/>
                    <a:gd name="T4" fmla="*/ 20614 w 20614"/>
                    <a:gd name="T5" fmla="*/ 0 h 766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614" h="7663" fill="none" extrusionOk="0">
                      <a:moveTo>
                        <a:pt x="418" y="7663"/>
                      </a:moveTo>
                      <a:cubicBezTo>
                        <a:pt x="267" y="7262"/>
                        <a:pt x="127" y="6858"/>
                        <a:pt x="-1" y="6450"/>
                      </a:cubicBezTo>
                    </a:path>
                    <a:path w="20614" h="7663" stroke="0" extrusionOk="0">
                      <a:moveTo>
                        <a:pt x="418" y="7663"/>
                      </a:moveTo>
                      <a:cubicBezTo>
                        <a:pt x="267" y="7262"/>
                        <a:pt x="127" y="6858"/>
                        <a:pt x="-1" y="6450"/>
                      </a:cubicBezTo>
                      <a:lnTo>
                        <a:pt x="20614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98" name="Arc 333">
                  <a:extLst>
                    <a:ext uri="{FF2B5EF4-FFF2-40B4-BE49-F238E27FC236}">
                      <a16:creationId xmlns:a16="http://schemas.microsoft.com/office/drawing/2014/main" id="{0A9CEA55-D905-7D8C-E191-7EECD4F5DB2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11" y="2716"/>
                  <a:ext cx="1113" cy="343"/>
                </a:xfrm>
                <a:custGeom>
                  <a:avLst/>
                  <a:gdLst>
                    <a:gd name="G0" fmla="+- 20954 0 0"/>
                    <a:gd name="G1" fmla="+- 0 0 0"/>
                    <a:gd name="G2" fmla="+- 21600 0 0"/>
                    <a:gd name="T0" fmla="*/ 340 w 20954"/>
                    <a:gd name="T1" fmla="*/ 6450 h 6450"/>
                    <a:gd name="T2" fmla="*/ 0 w 20954"/>
                    <a:gd name="T3" fmla="*/ 5243 h 6450"/>
                    <a:gd name="T4" fmla="*/ 20954 w 20954"/>
                    <a:gd name="T5" fmla="*/ 0 h 645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954" h="6450" fill="none" extrusionOk="0">
                      <a:moveTo>
                        <a:pt x="339" y="6450"/>
                      </a:moveTo>
                      <a:cubicBezTo>
                        <a:pt x="214" y="6051"/>
                        <a:pt x="101" y="5648"/>
                        <a:pt x="-1" y="5243"/>
                      </a:cubicBezTo>
                    </a:path>
                    <a:path w="20954" h="6450" stroke="0" extrusionOk="0">
                      <a:moveTo>
                        <a:pt x="339" y="6450"/>
                      </a:moveTo>
                      <a:cubicBezTo>
                        <a:pt x="214" y="6051"/>
                        <a:pt x="101" y="5648"/>
                        <a:pt x="-1" y="5243"/>
                      </a:cubicBezTo>
                      <a:lnTo>
                        <a:pt x="20954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199" name="Line 334">
                  <a:extLst>
                    <a:ext uri="{FF2B5EF4-FFF2-40B4-BE49-F238E27FC236}">
                      <a16:creationId xmlns:a16="http://schemas.microsoft.com/office/drawing/2014/main" id="{348BD2C0-EA4B-12C3-D494-77AC43290ED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626" y="2926"/>
                  <a:ext cx="425" cy="13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00" name="Rectangle 335">
                  <a:extLst>
                    <a:ext uri="{FF2B5EF4-FFF2-40B4-BE49-F238E27FC236}">
                      <a16:creationId xmlns:a16="http://schemas.microsoft.com/office/drawing/2014/main" id="{F0FE4CE4-7EC5-FDC0-F62E-4E304BBE9CB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0940000">
                  <a:off x="72" y="2943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403761</a:t>
                  </a:r>
                </a:p>
              </p:txBody>
            </p:sp>
            <p:sp>
              <p:nvSpPr>
                <p:cNvPr id="201" name="Line 336">
                  <a:extLst>
                    <a:ext uri="{FF2B5EF4-FFF2-40B4-BE49-F238E27FC236}">
                      <a16:creationId xmlns:a16="http://schemas.microsoft.com/office/drawing/2014/main" id="{91CF7E59-92AA-D773-CD15-378A335CC3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75" y="2944"/>
                  <a:ext cx="73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02" name="Rectangle 337">
                  <a:extLst>
                    <a:ext uri="{FF2B5EF4-FFF2-40B4-BE49-F238E27FC236}">
                      <a16:creationId xmlns:a16="http://schemas.microsoft.com/office/drawing/2014/main" id="{E54B28B2-D737-5067-9927-7B6C3581EC4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1180000">
                  <a:off x="53" y="2838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406214</a:t>
                  </a:r>
                </a:p>
              </p:txBody>
            </p:sp>
            <p:sp>
              <p:nvSpPr>
                <p:cNvPr id="203" name="Line 338">
                  <a:extLst>
                    <a:ext uri="{FF2B5EF4-FFF2-40B4-BE49-F238E27FC236}">
                      <a16:creationId xmlns:a16="http://schemas.microsoft.com/office/drawing/2014/main" id="{17E1C282-72A3-452C-F089-3F13EB1BFF0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61" y="2857"/>
                  <a:ext cx="73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04" name="Arc 339">
                  <a:extLst>
                    <a:ext uri="{FF2B5EF4-FFF2-40B4-BE49-F238E27FC236}">
                      <a16:creationId xmlns:a16="http://schemas.microsoft.com/office/drawing/2014/main" id="{C7087CA8-9AE0-C553-0701-9860C7F51EC2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9" y="2716"/>
                  <a:ext cx="1285" cy="233"/>
                </a:xfrm>
                <a:custGeom>
                  <a:avLst/>
                  <a:gdLst>
                    <a:gd name="G0" fmla="+- 21375 0 0"/>
                    <a:gd name="G1" fmla="+- 0 0 0"/>
                    <a:gd name="G2" fmla="+- 21600 0 0"/>
                    <a:gd name="T0" fmla="*/ 126 w 21375"/>
                    <a:gd name="T1" fmla="*/ 3880 h 3880"/>
                    <a:gd name="T2" fmla="*/ 0 w 21375"/>
                    <a:gd name="T3" fmla="*/ 3111 h 3880"/>
                    <a:gd name="T4" fmla="*/ 21375 w 21375"/>
                    <a:gd name="T5" fmla="*/ 0 h 388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375" h="3880" fill="none" extrusionOk="0">
                      <a:moveTo>
                        <a:pt x="126" y="3879"/>
                      </a:moveTo>
                      <a:cubicBezTo>
                        <a:pt x="79" y="3624"/>
                        <a:pt x="37" y="3368"/>
                        <a:pt x="0" y="3110"/>
                      </a:cubicBezTo>
                    </a:path>
                    <a:path w="21375" h="3880" stroke="0" extrusionOk="0">
                      <a:moveTo>
                        <a:pt x="126" y="3879"/>
                      </a:moveTo>
                      <a:cubicBezTo>
                        <a:pt x="79" y="3624"/>
                        <a:pt x="37" y="3368"/>
                        <a:pt x="0" y="3110"/>
                      </a:cubicBezTo>
                      <a:lnTo>
                        <a:pt x="21375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05" name="Arc 340">
                  <a:extLst>
                    <a:ext uri="{FF2B5EF4-FFF2-40B4-BE49-F238E27FC236}">
                      <a16:creationId xmlns:a16="http://schemas.microsoft.com/office/drawing/2014/main" id="{D0D9E507-F546-FE97-B46C-3AC66B2C56E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34" y="2716"/>
                  <a:ext cx="1290" cy="187"/>
                </a:xfrm>
                <a:custGeom>
                  <a:avLst/>
                  <a:gdLst>
                    <a:gd name="G0" fmla="+- 21463 0 0"/>
                    <a:gd name="G1" fmla="+- 0 0 0"/>
                    <a:gd name="G2" fmla="+- 21600 0 0"/>
                    <a:gd name="T0" fmla="*/ 88 w 21463"/>
                    <a:gd name="T1" fmla="*/ 3111 h 3111"/>
                    <a:gd name="T2" fmla="*/ 0 w 21463"/>
                    <a:gd name="T3" fmla="*/ 2429 h 3111"/>
                    <a:gd name="T4" fmla="*/ 21463 w 21463"/>
                    <a:gd name="T5" fmla="*/ 0 h 31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463" h="3111" fill="none" extrusionOk="0">
                      <a:moveTo>
                        <a:pt x="88" y="3110"/>
                      </a:moveTo>
                      <a:cubicBezTo>
                        <a:pt x="55" y="2884"/>
                        <a:pt x="25" y="2656"/>
                        <a:pt x="0" y="2428"/>
                      </a:cubicBezTo>
                    </a:path>
                    <a:path w="21463" h="3111" stroke="0" extrusionOk="0">
                      <a:moveTo>
                        <a:pt x="88" y="3110"/>
                      </a:moveTo>
                      <a:cubicBezTo>
                        <a:pt x="55" y="2884"/>
                        <a:pt x="25" y="2656"/>
                        <a:pt x="0" y="2428"/>
                      </a:cubicBezTo>
                      <a:lnTo>
                        <a:pt x="21463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06" name="Line 341">
                  <a:extLst>
                    <a:ext uri="{FF2B5EF4-FFF2-40B4-BE49-F238E27FC236}">
                      <a16:creationId xmlns:a16="http://schemas.microsoft.com/office/drawing/2014/main" id="{DFF66FC4-F26B-B18D-3ADD-16619B432B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9" y="2894"/>
                  <a:ext cx="73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07" name="Rectangle 342">
                  <a:extLst>
                    <a:ext uri="{FF2B5EF4-FFF2-40B4-BE49-F238E27FC236}">
                      <a16:creationId xmlns:a16="http://schemas.microsoft.com/office/drawing/2014/main" id="{E9614848-45DD-321B-0949-C92AFFCF171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1420000">
                  <a:off x="47" y="2741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Sm403764</a:t>
                  </a:r>
                </a:p>
              </p:txBody>
            </p:sp>
            <p:sp>
              <p:nvSpPr>
                <p:cNvPr id="208" name="Line 343">
                  <a:extLst>
                    <a:ext uri="{FF2B5EF4-FFF2-40B4-BE49-F238E27FC236}">
                      <a16:creationId xmlns:a16="http://schemas.microsoft.com/office/drawing/2014/main" id="{02313791-D8A2-69CB-1082-1EFCF7E21E4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52" y="2775"/>
                  <a:ext cx="151" cy="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09" name="Arc 344">
                  <a:extLst>
                    <a:ext uri="{FF2B5EF4-FFF2-40B4-BE49-F238E27FC236}">
                      <a16:creationId xmlns:a16="http://schemas.microsoft.com/office/drawing/2014/main" id="{993C0CDC-CE8F-A579-6AD0-36AB38B50DC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09" y="2716"/>
                  <a:ext cx="1215" cy="178"/>
                </a:xfrm>
                <a:custGeom>
                  <a:avLst/>
                  <a:gdLst>
                    <a:gd name="G0" fmla="+- 21506 0 0"/>
                    <a:gd name="G1" fmla="+- 0 0 0"/>
                    <a:gd name="G2" fmla="+- 21600 0 0"/>
                    <a:gd name="T0" fmla="*/ 137 w 21506"/>
                    <a:gd name="T1" fmla="*/ 3151 h 3151"/>
                    <a:gd name="T2" fmla="*/ 0 w 21506"/>
                    <a:gd name="T3" fmla="*/ 2015 h 3151"/>
                    <a:gd name="T4" fmla="*/ 21506 w 21506"/>
                    <a:gd name="T5" fmla="*/ 0 h 31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506" h="3151" fill="none" extrusionOk="0">
                      <a:moveTo>
                        <a:pt x="137" y="3150"/>
                      </a:moveTo>
                      <a:cubicBezTo>
                        <a:pt x="81" y="2773"/>
                        <a:pt x="35" y="2394"/>
                        <a:pt x="0" y="2014"/>
                      </a:cubicBezTo>
                    </a:path>
                    <a:path w="21506" h="3151" stroke="0" extrusionOk="0">
                      <a:moveTo>
                        <a:pt x="137" y="3150"/>
                      </a:moveTo>
                      <a:cubicBezTo>
                        <a:pt x="81" y="2773"/>
                        <a:pt x="35" y="2394"/>
                        <a:pt x="0" y="2014"/>
                      </a:cubicBezTo>
                      <a:lnTo>
                        <a:pt x="21506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10" name="Arc 345">
                  <a:extLst>
                    <a:ext uri="{FF2B5EF4-FFF2-40B4-BE49-F238E27FC236}">
                      <a16:creationId xmlns:a16="http://schemas.microsoft.com/office/drawing/2014/main" id="{3318AC16-9888-AB85-6C7B-7F1AF5230D4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05" y="2716"/>
                  <a:ext cx="1219" cy="114"/>
                </a:xfrm>
                <a:custGeom>
                  <a:avLst/>
                  <a:gdLst>
                    <a:gd name="G0" fmla="+- 21579 0 0"/>
                    <a:gd name="G1" fmla="+- 0 0 0"/>
                    <a:gd name="G2" fmla="+- 21600 0 0"/>
                    <a:gd name="T0" fmla="*/ 73 w 21579"/>
                    <a:gd name="T1" fmla="*/ 2015 h 2015"/>
                    <a:gd name="T2" fmla="*/ 0 w 21579"/>
                    <a:gd name="T3" fmla="*/ 954 h 2015"/>
                    <a:gd name="T4" fmla="*/ 21579 w 21579"/>
                    <a:gd name="T5" fmla="*/ 0 h 201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579" h="2015" fill="none" extrusionOk="0">
                      <a:moveTo>
                        <a:pt x="73" y="2014"/>
                      </a:moveTo>
                      <a:cubicBezTo>
                        <a:pt x="40" y="1661"/>
                        <a:pt x="15" y="1308"/>
                        <a:pt x="0" y="953"/>
                      </a:cubicBezTo>
                    </a:path>
                    <a:path w="21579" h="2015" stroke="0" extrusionOk="0">
                      <a:moveTo>
                        <a:pt x="73" y="2014"/>
                      </a:moveTo>
                      <a:cubicBezTo>
                        <a:pt x="40" y="1661"/>
                        <a:pt x="15" y="1308"/>
                        <a:pt x="0" y="953"/>
                      </a:cubicBezTo>
                      <a:lnTo>
                        <a:pt x="21579" y="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11" name="Line 346">
                  <a:extLst>
                    <a:ext uri="{FF2B5EF4-FFF2-40B4-BE49-F238E27FC236}">
                      <a16:creationId xmlns:a16="http://schemas.microsoft.com/office/drawing/2014/main" id="{08A0FF8F-1D2B-0401-F68F-89F72707A5F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507" y="2789"/>
                  <a:ext cx="444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12" name="Rectangle 347">
                  <a:extLst>
                    <a:ext uri="{FF2B5EF4-FFF2-40B4-BE49-F238E27FC236}">
                      <a16:creationId xmlns:a16="http://schemas.microsoft.com/office/drawing/2014/main" id="{7945F798-4D02-8D85-197E-C683FCE4526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60000">
                  <a:off x="127" y="2643"/>
                  <a:ext cx="224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4</a:t>
                  </a:r>
                </a:p>
              </p:txBody>
            </p:sp>
            <p:sp>
              <p:nvSpPr>
                <p:cNvPr id="213" name="Line 348">
                  <a:extLst>
                    <a:ext uri="{FF2B5EF4-FFF2-40B4-BE49-F238E27FC236}">
                      <a16:creationId xmlns:a16="http://schemas.microsoft.com/office/drawing/2014/main" id="{6B01715C-54CE-3A16-38C8-AF3BFC658DE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52" y="2688"/>
                  <a:ext cx="73" cy="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14" name="Rectangle 349">
                  <a:extLst>
                    <a:ext uri="{FF2B5EF4-FFF2-40B4-BE49-F238E27FC236}">
                      <a16:creationId xmlns:a16="http://schemas.microsoft.com/office/drawing/2014/main" id="{90FCD547-6B2F-60F4-1207-F789E1F68B1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300000">
                  <a:off x="47" y="2543"/>
                  <a:ext cx="3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2C284T5</a:t>
                  </a:r>
                </a:p>
              </p:txBody>
            </p:sp>
            <p:sp>
              <p:nvSpPr>
                <p:cNvPr id="215" name="Line 350">
                  <a:extLst>
                    <a:ext uri="{FF2B5EF4-FFF2-40B4-BE49-F238E27FC236}">
                      <a16:creationId xmlns:a16="http://schemas.microsoft.com/office/drawing/2014/main" id="{3B25B85C-4EB6-E72E-5FF6-291CC149362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357" y="2597"/>
                  <a:ext cx="73" cy="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16" name="Arc 351">
                  <a:extLst>
                    <a:ext uri="{FF2B5EF4-FFF2-40B4-BE49-F238E27FC236}">
                      <a16:creationId xmlns:a16="http://schemas.microsoft.com/office/drawing/2014/main" id="{CF4B6A4E-E364-92CA-8874-21ED7005E04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26" y="2647"/>
                  <a:ext cx="1298" cy="69"/>
                </a:xfrm>
                <a:custGeom>
                  <a:avLst/>
                  <a:gdLst>
                    <a:gd name="G0" fmla="+- 21595 0 0"/>
                    <a:gd name="G1" fmla="+- 1146 0 0"/>
                    <a:gd name="G2" fmla="+- 21600 0 0"/>
                    <a:gd name="T0" fmla="*/ 0 w 21595"/>
                    <a:gd name="T1" fmla="*/ 681 h 1146"/>
                    <a:gd name="T2" fmla="*/ 25 w 21595"/>
                    <a:gd name="T3" fmla="*/ 0 h 1146"/>
                    <a:gd name="T4" fmla="*/ 21595 w 21595"/>
                    <a:gd name="T5" fmla="*/ 1146 h 11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595" h="1146" fill="none" extrusionOk="0">
                      <a:moveTo>
                        <a:pt x="0" y="681"/>
                      </a:moveTo>
                      <a:cubicBezTo>
                        <a:pt x="4" y="453"/>
                        <a:pt x="13" y="226"/>
                        <a:pt x="25" y="0"/>
                      </a:cubicBezTo>
                    </a:path>
                    <a:path w="21595" h="1146" stroke="0" extrusionOk="0">
                      <a:moveTo>
                        <a:pt x="0" y="681"/>
                      </a:moveTo>
                      <a:cubicBezTo>
                        <a:pt x="4" y="453"/>
                        <a:pt x="13" y="226"/>
                        <a:pt x="25" y="0"/>
                      </a:cubicBezTo>
                      <a:lnTo>
                        <a:pt x="21595" y="1146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17" name="Arc 352">
                  <a:extLst>
                    <a:ext uri="{FF2B5EF4-FFF2-40B4-BE49-F238E27FC236}">
                      <a16:creationId xmlns:a16="http://schemas.microsoft.com/office/drawing/2014/main" id="{91B519A6-FBCE-BD94-B651-810537D73BA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27" y="2601"/>
                  <a:ext cx="1297" cy="115"/>
                </a:xfrm>
                <a:custGeom>
                  <a:avLst/>
                  <a:gdLst>
                    <a:gd name="G0" fmla="+- 21570 0 0"/>
                    <a:gd name="G1" fmla="+- 1912 0 0"/>
                    <a:gd name="G2" fmla="+- 21600 0 0"/>
                    <a:gd name="T0" fmla="*/ 0 w 21570"/>
                    <a:gd name="T1" fmla="*/ 766 h 1912"/>
                    <a:gd name="T2" fmla="*/ 55 w 21570"/>
                    <a:gd name="T3" fmla="*/ 0 h 1912"/>
                    <a:gd name="T4" fmla="*/ 21570 w 21570"/>
                    <a:gd name="T5" fmla="*/ 1912 h 19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570" h="1912" fill="none" extrusionOk="0">
                      <a:moveTo>
                        <a:pt x="0" y="766"/>
                      </a:moveTo>
                      <a:cubicBezTo>
                        <a:pt x="14" y="510"/>
                        <a:pt x="32" y="254"/>
                        <a:pt x="54" y="-1"/>
                      </a:cubicBezTo>
                    </a:path>
                    <a:path w="21570" h="1912" stroke="0" extrusionOk="0">
                      <a:moveTo>
                        <a:pt x="0" y="766"/>
                      </a:moveTo>
                      <a:cubicBezTo>
                        <a:pt x="14" y="510"/>
                        <a:pt x="32" y="254"/>
                        <a:pt x="54" y="-1"/>
                      </a:cubicBezTo>
                      <a:lnTo>
                        <a:pt x="21570" y="1912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18" name="Line 353">
                  <a:extLst>
                    <a:ext uri="{FF2B5EF4-FFF2-40B4-BE49-F238E27FC236}">
                      <a16:creationId xmlns:a16="http://schemas.microsoft.com/office/drawing/2014/main" id="{A3D8E29D-9F2C-D286-9814-EEC1EBEA77B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430" y="2642"/>
                  <a:ext cx="443" cy="2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19" name="Rectangle 354">
                  <a:extLst>
                    <a:ext uri="{FF2B5EF4-FFF2-40B4-BE49-F238E27FC236}">
                      <a16:creationId xmlns:a16="http://schemas.microsoft.com/office/drawing/2014/main" id="{CE479B0E-4BC4-A2C3-85A4-54CEC8F3DD4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480000">
                  <a:off x="63" y="2434"/>
                  <a:ext cx="3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2C688T6</a:t>
                  </a:r>
                </a:p>
              </p:txBody>
            </p:sp>
            <p:sp>
              <p:nvSpPr>
                <p:cNvPr id="220" name="Line 355">
                  <a:extLst>
                    <a:ext uri="{FF2B5EF4-FFF2-40B4-BE49-F238E27FC236}">
                      <a16:creationId xmlns:a16="http://schemas.microsoft.com/office/drawing/2014/main" id="{FFC642D5-A124-DFB8-C861-E52040FD1F7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370" y="2505"/>
                  <a:ext cx="73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21" name="Rectangle 356">
                  <a:extLst>
                    <a:ext uri="{FF2B5EF4-FFF2-40B4-BE49-F238E27FC236}">
                      <a16:creationId xmlns:a16="http://schemas.microsoft.com/office/drawing/2014/main" id="{91106EFA-7B46-6CD7-D3E4-868B200287C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720000">
                  <a:off x="66" y="2334"/>
                  <a:ext cx="32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2C680G7</a:t>
                  </a:r>
                </a:p>
              </p:txBody>
            </p:sp>
            <p:sp>
              <p:nvSpPr>
                <p:cNvPr id="222" name="Line 357">
                  <a:extLst>
                    <a:ext uri="{FF2B5EF4-FFF2-40B4-BE49-F238E27FC236}">
                      <a16:creationId xmlns:a16="http://schemas.microsoft.com/office/drawing/2014/main" id="{D92998F1-EEB4-D0E7-5624-AA0775B82DA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384" y="2414"/>
                  <a:ext cx="73" cy="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23" name="Arc 358">
                  <a:extLst>
                    <a:ext uri="{FF2B5EF4-FFF2-40B4-BE49-F238E27FC236}">
                      <a16:creationId xmlns:a16="http://schemas.microsoft.com/office/drawing/2014/main" id="{EDA643F9-95E1-CB61-1F79-C6391C65E73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41" y="2473"/>
                  <a:ext cx="1283" cy="243"/>
                </a:xfrm>
                <a:custGeom>
                  <a:avLst/>
                  <a:gdLst>
                    <a:gd name="G0" fmla="+- 21338 0 0"/>
                    <a:gd name="G1" fmla="+- 4041 0 0"/>
                    <a:gd name="G2" fmla="+- 21600 0 0"/>
                    <a:gd name="T0" fmla="*/ 0 w 21338"/>
                    <a:gd name="T1" fmla="*/ 687 h 4041"/>
                    <a:gd name="T2" fmla="*/ 119 w 21338"/>
                    <a:gd name="T3" fmla="*/ 0 h 4041"/>
                    <a:gd name="T4" fmla="*/ 21338 w 21338"/>
                    <a:gd name="T5" fmla="*/ 4041 h 404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338" h="4041" fill="none" extrusionOk="0">
                      <a:moveTo>
                        <a:pt x="-1" y="686"/>
                      </a:moveTo>
                      <a:cubicBezTo>
                        <a:pt x="36" y="457"/>
                        <a:pt x="75" y="228"/>
                        <a:pt x="119" y="0"/>
                      </a:cubicBezTo>
                    </a:path>
                    <a:path w="21338" h="4041" stroke="0" extrusionOk="0">
                      <a:moveTo>
                        <a:pt x="-1" y="686"/>
                      </a:moveTo>
                      <a:cubicBezTo>
                        <a:pt x="36" y="457"/>
                        <a:pt x="75" y="228"/>
                        <a:pt x="119" y="0"/>
                      </a:cubicBezTo>
                      <a:lnTo>
                        <a:pt x="21338" y="4041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24" name="Arc 359">
                  <a:extLst>
                    <a:ext uri="{FF2B5EF4-FFF2-40B4-BE49-F238E27FC236}">
                      <a16:creationId xmlns:a16="http://schemas.microsoft.com/office/drawing/2014/main" id="{3C7BFF9C-BEE8-F296-E21D-6CAD7D915E5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48" y="2432"/>
                  <a:ext cx="1276" cy="284"/>
                </a:xfrm>
                <a:custGeom>
                  <a:avLst/>
                  <a:gdLst>
                    <a:gd name="G0" fmla="+- 21219 0 0"/>
                    <a:gd name="G1" fmla="+- 4724 0 0"/>
                    <a:gd name="G2" fmla="+- 21600 0 0"/>
                    <a:gd name="T0" fmla="*/ 0 w 21219"/>
                    <a:gd name="T1" fmla="*/ 683 h 4724"/>
                    <a:gd name="T2" fmla="*/ 142 w 21219"/>
                    <a:gd name="T3" fmla="*/ 0 h 4724"/>
                    <a:gd name="T4" fmla="*/ 21219 w 21219"/>
                    <a:gd name="T5" fmla="*/ 4724 h 47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219" h="4724" fill="none" extrusionOk="0">
                      <a:moveTo>
                        <a:pt x="0" y="683"/>
                      </a:moveTo>
                      <a:cubicBezTo>
                        <a:pt x="43" y="454"/>
                        <a:pt x="91" y="226"/>
                        <a:pt x="141" y="-1"/>
                      </a:cubicBezTo>
                    </a:path>
                    <a:path w="21219" h="4724" stroke="0" extrusionOk="0">
                      <a:moveTo>
                        <a:pt x="0" y="683"/>
                      </a:moveTo>
                      <a:cubicBezTo>
                        <a:pt x="43" y="454"/>
                        <a:pt x="91" y="226"/>
                        <a:pt x="141" y="-1"/>
                      </a:cubicBezTo>
                      <a:lnTo>
                        <a:pt x="21219" y="4724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25" name="Line 360">
                  <a:extLst>
                    <a:ext uri="{FF2B5EF4-FFF2-40B4-BE49-F238E27FC236}">
                      <a16:creationId xmlns:a16="http://schemas.microsoft.com/office/drawing/2014/main" id="{8533D82F-B0BE-CB80-DE2C-3AA9BA142B6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448" y="2473"/>
                  <a:ext cx="73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26" name="Rectangle 361">
                  <a:extLst>
                    <a:ext uri="{FF2B5EF4-FFF2-40B4-BE49-F238E27FC236}">
                      <a16:creationId xmlns:a16="http://schemas.microsoft.com/office/drawing/2014/main" id="{75C4FAC3-FB00-AE3D-26ED-B9965A362E2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960000">
                  <a:off x="101" y="2240"/>
                  <a:ext cx="31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2A10T42</a:t>
                  </a:r>
                </a:p>
              </p:txBody>
            </p:sp>
            <p:sp>
              <p:nvSpPr>
                <p:cNvPr id="227" name="Line 362">
                  <a:extLst>
                    <a:ext uri="{FF2B5EF4-FFF2-40B4-BE49-F238E27FC236}">
                      <a16:creationId xmlns:a16="http://schemas.microsoft.com/office/drawing/2014/main" id="{7339914B-79AA-2DD0-DD7F-C9A186891AC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407" y="2327"/>
                  <a:ext cx="142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28" name="Arc 363">
                  <a:extLst>
                    <a:ext uri="{FF2B5EF4-FFF2-40B4-BE49-F238E27FC236}">
                      <a16:creationId xmlns:a16="http://schemas.microsoft.com/office/drawing/2014/main" id="{3AD7A139-D79D-3B79-90CF-896D9E3B944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25" y="2427"/>
                  <a:ext cx="1199" cy="289"/>
                </a:xfrm>
                <a:custGeom>
                  <a:avLst/>
                  <a:gdLst>
                    <a:gd name="G0" fmla="+- 21216 0 0"/>
                    <a:gd name="G1" fmla="+- 5118 0 0"/>
                    <a:gd name="G2" fmla="+- 21600 0 0"/>
                    <a:gd name="T0" fmla="*/ 0 w 21216"/>
                    <a:gd name="T1" fmla="*/ 1063 h 5118"/>
                    <a:gd name="T2" fmla="*/ 231 w 21216"/>
                    <a:gd name="T3" fmla="*/ 0 h 5118"/>
                    <a:gd name="T4" fmla="*/ 21216 w 21216"/>
                    <a:gd name="T5" fmla="*/ 5118 h 51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216" h="5118" fill="none" extrusionOk="0">
                      <a:moveTo>
                        <a:pt x="0" y="1063"/>
                      </a:moveTo>
                      <a:cubicBezTo>
                        <a:pt x="68" y="706"/>
                        <a:pt x="145" y="352"/>
                        <a:pt x="231" y="0"/>
                      </a:cubicBezTo>
                    </a:path>
                    <a:path w="21216" h="5118" stroke="0" extrusionOk="0">
                      <a:moveTo>
                        <a:pt x="0" y="1063"/>
                      </a:moveTo>
                      <a:cubicBezTo>
                        <a:pt x="68" y="706"/>
                        <a:pt x="145" y="352"/>
                        <a:pt x="231" y="0"/>
                      </a:cubicBezTo>
                      <a:lnTo>
                        <a:pt x="21216" y="5118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29" name="Arc 364">
                  <a:extLst>
                    <a:ext uri="{FF2B5EF4-FFF2-40B4-BE49-F238E27FC236}">
                      <a16:creationId xmlns:a16="http://schemas.microsoft.com/office/drawing/2014/main" id="{80900220-A4A5-624A-9BE5-AD55320794D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38" y="2368"/>
                  <a:ext cx="1186" cy="348"/>
                </a:xfrm>
                <a:custGeom>
                  <a:avLst/>
                  <a:gdLst>
                    <a:gd name="G0" fmla="+- 20985 0 0"/>
                    <a:gd name="G1" fmla="+- 6153 0 0"/>
                    <a:gd name="G2" fmla="+- 21600 0 0"/>
                    <a:gd name="T0" fmla="*/ 0 w 20985"/>
                    <a:gd name="T1" fmla="*/ 1035 h 6153"/>
                    <a:gd name="T2" fmla="*/ 280 w 20985"/>
                    <a:gd name="T3" fmla="*/ 0 h 6153"/>
                    <a:gd name="T4" fmla="*/ 20985 w 20985"/>
                    <a:gd name="T5" fmla="*/ 6153 h 615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985" h="6153" fill="none" extrusionOk="0">
                      <a:moveTo>
                        <a:pt x="0" y="1035"/>
                      </a:moveTo>
                      <a:cubicBezTo>
                        <a:pt x="84" y="687"/>
                        <a:pt x="178" y="342"/>
                        <a:pt x="279" y="-1"/>
                      </a:cubicBezTo>
                    </a:path>
                    <a:path w="20985" h="6153" stroke="0" extrusionOk="0">
                      <a:moveTo>
                        <a:pt x="0" y="1035"/>
                      </a:moveTo>
                      <a:cubicBezTo>
                        <a:pt x="84" y="687"/>
                        <a:pt x="178" y="342"/>
                        <a:pt x="279" y="-1"/>
                      </a:cubicBezTo>
                      <a:lnTo>
                        <a:pt x="20985" y="6153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30" name="Line 365">
                  <a:extLst>
                    <a:ext uri="{FF2B5EF4-FFF2-40B4-BE49-F238E27FC236}">
                      <a16:creationId xmlns:a16="http://schemas.microsoft.com/office/drawing/2014/main" id="{52EDAD5D-45E0-B5DB-03FC-78EA5A04B5E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535" y="2427"/>
                  <a:ext cx="73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31" name="Rectangle 366">
                  <a:extLst>
                    <a:ext uri="{FF2B5EF4-FFF2-40B4-BE49-F238E27FC236}">
                      <a16:creationId xmlns:a16="http://schemas.microsoft.com/office/drawing/2014/main" id="{ECC613F2-46A1-59C9-DF80-BB8BA27F458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200000">
                  <a:off x="171" y="2156"/>
                  <a:ext cx="282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2C11T1</a:t>
                  </a:r>
                </a:p>
              </p:txBody>
            </p:sp>
            <p:sp>
              <p:nvSpPr>
                <p:cNvPr id="232" name="Line 367">
                  <a:extLst>
                    <a:ext uri="{FF2B5EF4-FFF2-40B4-BE49-F238E27FC236}">
                      <a16:creationId xmlns:a16="http://schemas.microsoft.com/office/drawing/2014/main" id="{9D4AB939-E1D5-9E71-6728-0A2243C567A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439" y="2240"/>
                  <a:ext cx="210" cy="7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33" name="Arc 368">
                  <a:extLst>
                    <a:ext uri="{FF2B5EF4-FFF2-40B4-BE49-F238E27FC236}">
                      <a16:creationId xmlns:a16="http://schemas.microsoft.com/office/drawing/2014/main" id="{CFD524C8-C919-B317-3E55-E5DBE464D05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09" y="2382"/>
                  <a:ext cx="1115" cy="334"/>
                </a:xfrm>
                <a:custGeom>
                  <a:avLst/>
                  <a:gdLst>
                    <a:gd name="G0" fmla="+- 20994 0 0"/>
                    <a:gd name="G1" fmla="+- 6286 0 0"/>
                    <a:gd name="G2" fmla="+- 21600 0 0"/>
                    <a:gd name="T0" fmla="*/ 0 w 20994"/>
                    <a:gd name="T1" fmla="*/ 1207 h 6286"/>
                    <a:gd name="T2" fmla="*/ 329 w 20994"/>
                    <a:gd name="T3" fmla="*/ 0 h 6286"/>
                    <a:gd name="T4" fmla="*/ 20994 w 20994"/>
                    <a:gd name="T5" fmla="*/ 6286 h 62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994" h="6286" fill="none" extrusionOk="0">
                      <a:moveTo>
                        <a:pt x="-1" y="1206"/>
                      </a:moveTo>
                      <a:cubicBezTo>
                        <a:pt x="97" y="801"/>
                        <a:pt x="207" y="399"/>
                        <a:pt x="328" y="-1"/>
                      </a:cubicBezTo>
                    </a:path>
                    <a:path w="20994" h="6286" stroke="0" extrusionOk="0">
                      <a:moveTo>
                        <a:pt x="-1" y="1206"/>
                      </a:moveTo>
                      <a:cubicBezTo>
                        <a:pt x="97" y="801"/>
                        <a:pt x="207" y="399"/>
                        <a:pt x="328" y="-1"/>
                      </a:cubicBezTo>
                      <a:lnTo>
                        <a:pt x="20994" y="6286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34" name="Arc 369">
                  <a:extLst>
                    <a:ext uri="{FF2B5EF4-FFF2-40B4-BE49-F238E27FC236}">
                      <a16:creationId xmlns:a16="http://schemas.microsoft.com/office/drawing/2014/main" id="{51BE7C43-B8E4-C94C-0344-DED98666DA0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26" y="2318"/>
                  <a:ext cx="1098" cy="398"/>
                </a:xfrm>
                <a:custGeom>
                  <a:avLst/>
                  <a:gdLst>
                    <a:gd name="G0" fmla="+- 20665 0 0"/>
                    <a:gd name="G1" fmla="+- 7500 0 0"/>
                    <a:gd name="G2" fmla="+- 21600 0 0"/>
                    <a:gd name="T0" fmla="*/ 0 w 20665"/>
                    <a:gd name="T1" fmla="*/ 1214 h 7500"/>
                    <a:gd name="T2" fmla="*/ 409 w 20665"/>
                    <a:gd name="T3" fmla="*/ 0 h 7500"/>
                    <a:gd name="T4" fmla="*/ 20665 w 20665"/>
                    <a:gd name="T5" fmla="*/ 7500 h 750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665" h="7500" fill="none" extrusionOk="0">
                      <a:moveTo>
                        <a:pt x="-1" y="1213"/>
                      </a:moveTo>
                      <a:cubicBezTo>
                        <a:pt x="124" y="805"/>
                        <a:pt x="260" y="400"/>
                        <a:pt x="408" y="-1"/>
                      </a:cubicBezTo>
                    </a:path>
                    <a:path w="20665" h="7500" stroke="0" extrusionOk="0">
                      <a:moveTo>
                        <a:pt x="-1" y="1213"/>
                      </a:moveTo>
                      <a:cubicBezTo>
                        <a:pt x="124" y="805"/>
                        <a:pt x="260" y="400"/>
                        <a:pt x="408" y="-1"/>
                      </a:cubicBezTo>
                      <a:lnTo>
                        <a:pt x="20665" y="750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35" name="Line 370">
                  <a:extLst>
                    <a:ext uri="{FF2B5EF4-FFF2-40B4-BE49-F238E27FC236}">
                      <a16:creationId xmlns:a16="http://schemas.microsoft.com/office/drawing/2014/main" id="{893A7613-298D-C527-0C1D-459369F5D08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626" y="2382"/>
                  <a:ext cx="73" cy="1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36" name="Rectangle 371">
                  <a:extLst>
                    <a:ext uri="{FF2B5EF4-FFF2-40B4-BE49-F238E27FC236}">
                      <a16:creationId xmlns:a16="http://schemas.microsoft.com/office/drawing/2014/main" id="{9B67C28A-C623-E3FE-156E-12DA6FAC668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440000">
                  <a:off x="139" y="2043"/>
                  <a:ext cx="363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1A273G19</a:t>
                  </a:r>
                </a:p>
              </p:txBody>
            </p:sp>
            <p:sp>
              <p:nvSpPr>
                <p:cNvPr id="237" name="Line 372">
                  <a:extLst>
                    <a:ext uri="{FF2B5EF4-FFF2-40B4-BE49-F238E27FC236}">
                      <a16:creationId xmlns:a16="http://schemas.microsoft.com/office/drawing/2014/main" id="{535D3752-718C-9E75-8FFE-C61DF77DCD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471" y="2153"/>
                  <a:ext cx="137" cy="6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38" name="Rectangle 373">
                  <a:extLst>
                    <a:ext uri="{FF2B5EF4-FFF2-40B4-BE49-F238E27FC236}">
                      <a16:creationId xmlns:a16="http://schemas.microsoft.com/office/drawing/2014/main" id="{3EC5E497-ABB0-E325-FAC4-7E211BD6CC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80000">
                  <a:off x="215" y="1957"/>
                  <a:ext cx="32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1C274G2</a:t>
                  </a:r>
                </a:p>
              </p:txBody>
            </p:sp>
            <p:sp>
              <p:nvSpPr>
                <p:cNvPr id="239" name="Line 374">
                  <a:extLst>
                    <a:ext uri="{FF2B5EF4-FFF2-40B4-BE49-F238E27FC236}">
                      <a16:creationId xmlns:a16="http://schemas.microsoft.com/office/drawing/2014/main" id="{BDE7E6E3-C8A3-191F-97A5-5227B5B502F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512" y="2071"/>
                  <a:ext cx="64" cy="3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40" name="Rectangle 375">
                  <a:extLst>
                    <a:ext uri="{FF2B5EF4-FFF2-40B4-BE49-F238E27FC236}">
                      <a16:creationId xmlns:a16="http://schemas.microsoft.com/office/drawing/2014/main" id="{81A11D8C-5C0A-6A24-8A15-5D2DBFC0F46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860000">
                  <a:off x="273" y="1869"/>
                  <a:ext cx="3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1C252T4</a:t>
                  </a:r>
                </a:p>
              </p:txBody>
            </p:sp>
            <p:sp>
              <p:nvSpPr>
                <p:cNvPr id="241" name="Line 376">
                  <a:extLst>
                    <a:ext uri="{FF2B5EF4-FFF2-40B4-BE49-F238E27FC236}">
                      <a16:creationId xmlns:a16="http://schemas.microsoft.com/office/drawing/2014/main" id="{0BF5B036-CCF6-0B04-F565-E8844A21F76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558" y="1993"/>
                  <a:ext cx="64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42" name="Arc 377">
                  <a:extLst>
                    <a:ext uri="{FF2B5EF4-FFF2-40B4-BE49-F238E27FC236}">
                      <a16:creationId xmlns:a16="http://schemas.microsoft.com/office/drawing/2014/main" id="{E90A24FA-C507-9243-BAA7-F7E9A5A2543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77" y="2070"/>
                  <a:ext cx="1147" cy="646"/>
                </a:xfrm>
                <a:custGeom>
                  <a:avLst/>
                  <a:gdLst>
                    <a:gd name="G0" fmla="+- 19081 0 0"/>
                    <a:gd name="G1" fmla="+- 10743 0 0"/>
                    <a:gd name="G2" fmla="+- 21600 0 0"/>
                    <a:gd name="T0" fmla="*/ 0 w 19081"/>
                    <a:gd name="T1" fmla="*/ 621 h 10743"/>
                    <a:gd name="T2" fmla="*/ 342 w 19081"/>
                    <a:gd name="T3" fmla="*/ 0 h 10743"/>
                    <a:gd name="T4" fmla="*/ 19081 w 19081"/>
                    <a:gd name="T5" fmla="*/ 10743 h 1074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081" h="10743" fill="none" extrusionOk="0">
                      <a:moveTo>
                        <a:pt x="-1" y="620"/>
                      </a:moveTo>
                      <a:cubicBezTo>
                        <a:pt x="110" y="412"/>
                        <a:pt x="224" y="205"/>
                        <a:pt x="342" y="0"/>
                      </a:cubicBezTo>
                    </a:path>
                    <a:path w="19081" h="10743" stroke="0" extrusionOk="0">
                      <a:moveTo>
                        <a:pt x="-1" y="620"/>
                      </a:moveTo>
                      <a:cubicBezTo>
                        <a:pt x="110" y="412"/>
                        <a:pt x="224" y="205"/>
                        <a:pt x="342" y="0"/>
                      </a:cubicBezTo>
                      <a:lnTo>
                        <a:pt x="19081" y="10743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43" name="Arc 378">
                  <a:extLst>
                    <a:ext uri="{FF2B5EF4-FFF2-40B4-BE49-F238E27FC236}">
                      <a16:creationId xmlns:a16="http://schemas.microsoft.com/office/drawing/2014/main" id="{C866487C-9796-9248-A417-DECB52CF4A8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597" y="2030"/>
                  <a:ext cx="1127" cy="686"/>
                </a:xfrm>
                <a:custGeom>
                  <a:avLst/>
                  <a:gdLst>
                    <a:gd name="G0" fmla="+- 18739 0 0"/>
                    <a:gd name="G1" fmla="+- 11415 0 0"/>
                    <a:gd name="G2" fmla="+- 21600 0 0"/>
                    <a:gd name="T0" fmla="*/ 0 w 18739"/>
                    <a:gd name="T1" fmla="*/ 672 h 11415"/>
                    <a:gd name="T2" fmla="*/ 402 w 18739"/>
                    <a:gd name="T3" fmla="*/ 0 h 11415"/>
                    <a:gd name="T4" fmla="*/ 18739 w 18739"/>
                    <a:gd name="T5" fmla="*/ 11415 h 1141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739" h="11415" fill="none" extrusionOk="0">
                      <a:moveTo>
                        <a:pt x="0" y="672"/>
                      </a:moveTo>
                      <a:cubicBezTo>
                        <a:pt x="129" y="445"/>
                        <a:pt x="263" y="221"/>
                        <a:pt x="401" y="-1"/>
                      </a:cubicBezTo>
                    </a:path>
                    <a:path w="18739" h="11415" stroke="0" extrusionOk="0">
                      <a:moveTo>
                        <a:pt x="0" y="672"/>
                      </a:moveTo>
                      <a:cubicBezTo>
                        <a:pt x="129" y="445"/>
                        <a:pt x="263" y="221"/>
                        <a:pt x="401" y="-1"/>
                      </a:cubicBezTo>
                      <a:lnTo>
                        <a:pt x="18739" y="11415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44" name="Line 379">
                  <a:extLst>
                    <a:ext uri="{FF2B5EF4-FFF2-40B4-BE49-F238E27FC236}">
                      <a16:creationId xmlns:a16="http://schemas.microsoft.com/office/drawing/2014/main" id="{1EE552E0-53F6-F087-B417-921B2922A97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599" y="2071"/>
                  <a:ext cx="64" cy="3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45" name="Arc 380">
                  <a:extLst>
                    <a:ext uri="{FF2B5EF4-FFF2-40B4-BE49-F238E27FC236}">
                      <a16:creationId xmlns:a16="http://schemas.microsoft.com/office/drawing/2014/main" id="{68324D1B-C675-B9D5-0D4B-9BCC9FEE18B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10" y="2163"/>
                  <a:ext cx="1114" cy="553"/>
                </a:xfrm>
                <a:custGeom>
                  <a:avLst/>
                  <a:gdLst>
                    <a:gd name="G0" fmla="+- 19719 0 0"/>
                    <a:gd name="G1" fmla="+- 9794 0 0"/>
                    <a:gd name="G2" fmla="+- 21600 0 0"/>
                    <a:gd name="T0" fmla="*/ 0 w 19719"/>
                    <a:gd name="T1" fmla="*/ 977 h 9794"/>
                    <a:gd name="T2" fmla="*/ 467 w 19719"/>
                    <a:gd name="T3" fmla="*/ 0 h 9794"/>
                    <a:gd name="T4" fmla="*/ 19719 w 19719"/>
                    <a:gd name="T5" fmla="*/ 9794 h 979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719" h="9794" fill="none" extrusionOk="0">
                      <a:moveTo>
                        <a:pt x="0" y="977"/>
                      </a:moveTo>
                      <a:cubicBezTo>
                        <a:pt x="147" y="647"/>
                        <a:pt x="303" y="321"/>
                        <a:pt x="467" y="0"/>
                      </a:cubicBezTo>
                    </a:path>
                    <a:path w="19719" h="9794" stroke="0" extrusionOk="0">
                      <a:moveTo>
                        <a:pt x="0" y="977"/>
                      </a:moveTo>
                      <a:cubicBezTo>
                        <a:pt x="147" y="647"/>
                        <a:pt x="303" y="321"/>
                        <a:pt x="467" y="0"/>
                      </a:cubicBezTo>
                      <a:lnTo>
                        <a:pt x="19719" y="9794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46" name="Arc 381">
                  <a:extLst>
                    <a:ext uri="{FF2B5EF4-FFF2-40B4-BE49-F238E27FC236}">
                      <a16:creationId xmlns:a16="http://schemas.microsoft.com/office/drawing/2014/main" id="{AF167CBE-7F25-AEAE-9DA4-F454391120E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36" y="2108"/>
                  <a:ext cx="1088" cy="608"/>
                </a:xfrm>
                <a:custGeom>
                  <a:avLst/>
                  <a:gdLst>
                    <a:gd name="G0" fmla="+- 19252 0 0"/>
                    <a:gd name="G1" fmla="+- 10753 0 0"/>
                    <a:gd name="G2" fmla="+- 21600 0 0"/>
                    <a:gd name="T0" fmla="*/ 0 w 19252"/>
                    <a:gd name="T1" fmla="*/ 959 h 10753"/>
                    <a:gd name="T2" fmla="*/ 519 w 19252"/>
                    <a:gd name="T3" fmla="*/ 0 h 10753"/>
                    <a:gd name="T4" fmla="*/ 19252 w 19252"/>
                    <a:gd name="T5" fmla="*/ 10753 h 1075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252" h="10753" fill="none" extrusionOk="0">
                      <a:moveTo>
                        <a:pt x="0" y="959"/>
                      </a:moveTo>
                      <a:cubicBezTo>
                        <a:pt x="164" y="635"/>
                        <a:pt x="337" y="315"/>
                        <a:pt x="518" y="-1"/>
                      </a:cubicBezTo>
                    </a:path>
                    <a:path w="19252" h="10753" stroke="0" extrusionOk="0">
                      <a:moveTo>
                        <a:pt x="0" y="959"/>
                      </a:moveTo>
                      <a:cubicBezTo>
                        <a:pt x="164" y="635"/>
                        <a:pt x="337" y="315"/>
                        <a:pt x="518" y="-1"/>
                      </a:cubicBezTo>
                      <a:lnTo>
                        <a:pt x="19252" y="10753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47" name="Line 382">
                  <a:extLst>
                    <a:ext uri="{FF2B5EF4-FFF2-40B4-BE49-F238E27FC236}">
                      <a16:creationId xmlns:a16="http://schemas.microsoft.com/office/drawing/2014/main" id="{109D1A28-1925-5BCF-6218-A5218C771BF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635" y="2158"/>
                  <a:ext cx="133" cy="6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48" name="Arc 383">
                  <a:extLst>
                    <a:ext uri="{FF2B5EF4-FFF2-40B4-BE49-F238E27FC236}">
                      <a16:creationId xmlns:a16="http://schemas.microsoft.com/office/drawing/2014/main" id="{80B2E3D0-3A15-C9F9-5FB7-F1E49341815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697" y="2313"/>
                  <a:ext cx="1027" cy="403"/>
                </a:xfrm>
                <a:custGeom>
                  <a:avLst/>
                  <a:gdLst>
                    <a:gd name="G0" fmla="+- 20648 0 0"/>
                    <a:gd name="G1" fmla="+- 8095 0 0"/>
                    <a:gd name="G2" fmla="+- 21600 0 0"/>
                    <a:gd name="T0" fmla="*/ 0 w 20648"/>
                    <a:gd name="T1" fmla="*/ 1754 h 8095"/>
                    <a:gd name="T2" fmla="*/ 622 w 20648"/>
                    <a:gd name="T3" fmla="*/ 0 h 8095"/>
                    <a:gd name="T4" fmla="*/ 20648 w 20648"/>
                    <a:gd name="T5" fmla="*/ 8095 h 80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648" h="8095" fill="none" extrusionOk="0">
                      <a:moveTo>
                        <a:pt x="-1" y="1753"/>
                      </a:moveTo>
                      <a:cubicBezTo>
                        <a:pt x="181" y="1160"/>
                        <a:pt x="389" y="575"/>
                        <a:pt x="622" y="0"/>
                      </a:cubicBezTo>
                    </a:path>
                    <a:path w="20648" h="8095" stroke="0" extrusionOk="0">
                      <a:moveTo>
                        <a:pt x="-1" y="1753"/>
                      </a:moveTo>
                      <a:cubicBezTo>
                        <a:pt x="181" y="1160"/>
                        <a:pt x="389" y="575"/>
                        <a:pt x="622" y="0"/>
                      </a:cubicBezTo>
                      <a:lnTo>
                        <a:pt x="20648" y="8095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49" name="Arc 384">
                  <a:extLst>
                    <a:ext uri="{FF2B5EF4-FFF2-40B4-BE49-F238E27FC236}">
                      <a16:creationId xmlns:a16="http://schemas.microsoft.com/office/drawing/2014/main" id="{7E74FBF2-A362-48A5-CDA3-A79F4ABB61B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28" y="2226"/>
                  <a:ext cx="996" cy="490"/>
                </a:xfrm>
                <a:custGeom>
                  <a:avLst/>
                  <a:gdLst>
                    <a:gd name="G0" fmla="+- 20026 0 0"/>
                    <a:gd name="G1" fmla="+- 9852 0 0"/>
                    <a:gd name="G2" fmla="+- 21600 0 0"/>
                    <a:gd name="T0" fmla="*/ 0 w 20026"/>
                    <a:gd name="T1" fmla="*/ 1757 h 9852"/>
                    <a:gd name="T2" fmla="*/ 804 w 20026"/>
                    <a:gd name="T3" fmla="*/ 0 h 9852"/>
                    <a:gd name="T4" fmla="*/ 20026 w 20026"/>
                    <a:gd name="T5" fmla="*/ 9852 h 985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026" h="9852" fill="none" extrusionOk="0">
                      <a:moveTo>
                        <a:pt x="0" y="1757"/>
                      </a:moveTo>
                      <a:cubicBezTo>
                        <a:pt x="241" y="1159"/>
                        <a:pt x="509" y="573"/>
                        <a:pt x="803" y="-1"/>
                      </a:cubicBezTo>
                    </a:path>
                    <a:path w="20026" h="9852" stroke="0" extrusionOk="0">
                      <a:moveTo>
                        <a:pt x="0" y="1757"/>
                      </a:moveTo>
                      <a:cubicBezTo>
                        <a:pt x="241" y="1159"/>
                        <a:pt x="509" y="573"/>
                        <a:pt x="803" y="-1"/>
                      </a:cubicBezTo>
                      <a:lnTo>
                        <a:pt x="20026" y="9852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50" name="Line 385">
                  <a:extLst>
                    <a:ext uri="{FF2B5EF4-FFF2-40B4-BE49-F238E27FC236}">
                      <a16:creationId xmlns:a16="http://schemas.microsoft.com/office/drawing/2014/main" id="{F56165F0-DE06-3EE6-2A3F-ADDBA4ED0C7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727" y="2313"/>
                  <a:ext cx="68" cy="2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51" name="Rectangle 386">
                  <a:extLst>
                    <a:ext uri="{FF2B5EF4-FFF2-40B4-BE49-F238E27FC236}">
                      <a16:creationId xmlns:a16="http://schemas.microsoft.com/office/drawing/2014/main" id="{42643E59-82D5-6F65-900E-613C8249DB8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100000">
                  <a:off x="379" y="1799"/>
                  <a:ext cx="26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AtTPS32</a:t>
                  </a:r>
                </a:p>
              </p:txBody>
            </p:sp>
            <p:sp>
              <p:nvSpPr>
                <p:cNvPr id="252" name="Line 387">
                  <a:extLst>
                    <a:ext uri="{FF2B5EF4-FFF2-40B4-BE49-F238E27FC236}">
                      <a16:creationId xmlns:a16="http://schemas.microsoft.com/office/drawing/2014/main" id="{BF06A89C-601E-B4C6-90F4-557C0B169FC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608" y="1915"/>
                  <a:ext cx="302" cy="22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53" name="Arc 388">
                  <a:extLst>
                    <a:ext uri="{FF2B5EF4-FFF2-40B4-BE49-F238E27FC236}">
                      <a16:creationId xmlns:a16="http://schemas.microsoft.com/office/drawing/2014/main" id="{5D2CE8B3-6489-4F0C-233C-43A09B769EA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95" y="2232"/>
                  <a:ext cx="929" cy="484"/>
                </a:xfrm>
                <a:custGeom>
                  <a:avLst/>
                  <a:gdLst>
                    <a:gd name="G0" fmla="+- 20030 0 0"/>
                    <a:gd name="G1" fmla="+- 10444 0 0"/>
                    <a:gd name="G2" fmla="+- 21600 0 0"/>
                    <a:gd name="T0" fmla="*/ 0 w 20030"/>
                    <a:gd name="T1" fmla="*/ 2359 h 10444"/>
                    <a:gd name="T2" fmla="*/ 1123 w 20030"/>
                    <a:gd name="T3" fmla="*/ 0 h 10444"/>
                    <a:gd name="T4" fmla="*/ 20030 w 20030"/>
                    <a:gd name="T5" fmla="*/ 10444 h 104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030" h="10444" fill="none" extrusionOk="0">
                      <a:moveTo>
                        <a:pt x="0" y="2359"/>
                      </a:moveTo>
                      <a:cubicBezTo>
                        <a:pt x="326" y="1550"/>
                        <a:pt x="701" y="762"/>
                        <a:pt x="1122" y="-1"/>
                      </a:cubicBezTo>
                    </a:path>
                    <a:path w="20030" h="10444" stroke="0" extrusionOk="0">
                      <a:moveTo>
                        <a:pt x="0" y="2359"/>
                      </a:moveTo>
                      <a:cubicBezTo>
                        <a:pt x="326" y="1550"/>
                        <a:pt x="701" y="762"/>
                        <a:pt x="1122" y="-1"/>
                      </a:cubicBezTo>
                      <a:lnTo>
                        <a:pt x="20030" y="10444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54" name="Arc 389">
                  <a:extLst>
                    <a:ext uri="{FF2B5EF4-FFF2-40B4-BE49-F238E27FC236}">
                      <a16:creationId xmlns:a16="http://schemas.microsoft.com/office/drawing/2014/main" id="{A1983175-9405-A159-9AE8-AE13DE94103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47" y="2132"/>
                  <a:ext cx="877" cy="584"/>
                </a:xfrm>
                <a:custGeom>
                  <a:avLst/>
                  <a:gdLst>
                    <a:gd name="G0" fmla="+- 18907 0 0"/>
                    <a:gd name="G1" fmla="+- 12590 0 0"/>
                    <a:gd name="G2" fmla="+- 21600 0 0"/>
                    <a:gd name="T0" fmla="*/ 0 w 18907"/>
                    <a:gd name="T1" fmla="*/ 2146 h 12590"/>
                    <a:gd name="T2" fmla="*/ 1355 w 18907"/>
                    <a:gd name="T3" fmla="*/ 0 h 12590"/>
                    <a:gd name="T4" fmla="*/ 18907 w 18907"/>
                    <a:gd name="T5" fmla="*/ 12590 h 1259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8907" h="12590" fill="none" extrusionOk="0">
                      <a:moveTo>
                        <a:pt x="-1" y="2145"/>
                      </a:moveTo>
                      <a:cubicBezTo>
                        <a:pt x="409" y="1404"/>
                        <a:pt x="861" y="688"/>
                        <a:pt x="1355" y="0"/>
                      </a:cubicBezTo>
                    </a:path>
                    <a:path w="18907" h="12590" stroke="0" extrusionOk="0">
                      <a:moveTo>
                        <a:pt x="-1" y="2145"/>
                      </a:moveTo>
                      <a:cubicBezTo>
                        <a:pt x="409" y="1404"/>
                        <a:pt x="861" y="688"/>
                        <a:pt x="1355" y="0"/>
                      </a:cubicBezTo>
                      <a:lnTo>
                        <a:pt x="18907" y="1259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55" name="Line 390">
                  <a:extLst>
                    <a:ext uri="{FF2B5EF4-FFF2-40B4-BE49-F238E27FC236}">
                      <a16:creationId xmlns:a16="http://schemas.microsoft.com/office/drawing/2014/main" id="{B7EC2BC4-D184-3EDF-23B0-A997B394469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846" y="2235"/>
                  <a:ext cx="64" cy="3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56" name="Rectangle 391">
                  <a:extLst>
                    <a:ext uri="{FF2B5EF4-FFF2-40B4-BE49-F238E27FC236}">
                      <a16:creationId xmlns:a16="http://schemas.microsoft.com/office/drawing/2014/main" id="{4526E8A7-7254-7914-4D3B-3FF693DFEEF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340000">
                  <a:off x="359" y="1696"/>
                  <a:ext cx="35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3A466T18</a:t>
                  </a:r>
                </a:p>
              </p:txBody>
            </p:sp>
            <p:sp>
              <p:nvSpPr>
                <p:cNvPr id="257" name="Line 392">
                  <a:extLst>
                    <a:ext uri="{FF2B5EF4-FFF2-40B4-BE49-F238E27FC236}">
                      <a16:creationId xmlns:a16="http://schemas.microsoft.com/office/drawing/2014/main" id="{A18F9E78-DA9F-26D6-FCE9-FE886B4C7E4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663" y="1842"/>
                  <a:ext cx="59" cy="5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58" name="Rectangle 393">
                  <a:extLst>
                    <a:ext uri="{FF2B5EF4-FFF2-40B4-BE49-F238E27FC236}">
                      <a16:creationId xmlns:a16="http://schemas.microsoft.com/office/drawing/2014/main" id="{867291DA-EC55-395F-249C-353F7CA17EC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580000">
                  <a:off x="433" y="1620"/>
                  <a:ext cx="35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 dirty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3A496T11</a:t>
                  </a:r>
                </a:p>
              </p:txBody>
            </p:sp>
            <p:sp>
              <p:nvSpPr>
                <p:cNvPr id="259" name="Line 394">
                  <a:extLst>
                    <a:ext uri="{FF2B5EF4-FFF2-40B4-BE49-F238E27FC236}">
                      <a16:creationId xmlns:a16="http://schemas.microsoft.com/office/drawing/2014/main" id="{1AFA9DAB-8E56-25DF-392D-0BC3533FF94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727" y="1774"/>
                  <a:ext cx="55" cy="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60" name="Arc 395">
                  <a:extLst>
                    <a:ext uri="{FF2B5EF4-FFF2-40B4-BE49-F238E27FC236}">
                      <a16:creationId xmlns:a16="http://schemas.microsoft.com/office/drawing/2014/main" id="{297AE119-525A-9D28-C38E-4347836EB2C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21" y="1857"/>
                  <a:ext cx="1003" cy="859"/>
                </a:xfrm>
                <a:custGeom>
                  <a:avLst/>
                  <a:gdLst>
                    <a:gd name="G0" fmla="+- 16691 0 0"/>
                    <a:gd name="G1" fmla="+- 14297 0 0"/>
                    <a:gd name="G2" fmla="+- 21600 0 0"/>
                    <a:gd name="T0" fmla="*/ 0 w 16691"/>
                    <a:gd name="T1" fmla="*/ 587 h 14297"/>
                    <a:gd name="T2" fmla="*/ 499 w 16691"/>
                    <a:gd name="T3" fmla="*/ 0 h 14297"/>
                    <a:gd name="T4" fmla="*/ 16691 w 16691"/>
                    <a:gd name="T5" fmla="*/ 14297 h 1429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691" h="14297" fill="none" extrusionOk="0">
                      <a:moveTo>
                        <a:pt x="-1" y="586"/>
                      </a:moveTo>
                      <a:cubicBezTo>
                        <a:pt x="162" y="388"/>
                        <a:pt x="329" y="192"/>
                        <a:pt x="499" y="0"/>
                      </a:cubicBezTo>
                    </a:path>
                    <a:path w="16691" h="14297" stroke="0" extrusionOk="0">
                      <a:moveTo>
                        <a:pt x="-1" y="586"/>
                      </a:moveTo>
                      <a:cubicBezTo>
                        <a:pt x="162" y="388"/>
                        <a:pt x="329" y="192"/>
                        <a:pt x="499" y="0"/>
                      </a:cubicBezTo>
                      <a:lnTo>
                        <a:pt x="16691" y="14297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61" name="Arc 396">
                  <a:extLst>
                    <a:ext uri="{FF2B5EF4-FFF2-40B4-BE49-F238E27FC236}">
                      <a16:creationId xmlns:a16="http://schemas.microsoft.com/office/drawing/2014/main" id="{BAB049A9-B530-6C7F-AB1C-395943CA96C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51" y="1826"/>
                  <a:ext cx="973" cy="890"/>
                </a:xfrm>
                <a:custGeom>
                  <a:avLst/>
                  <a:gdLst>
                    <a:gd name="G0" fmla="+- 16192 0 0"/>
                    <a:gd name="G1" fmla="+- 14810 0 0"/>
                    <a:gd name="G2" fmla="+- 21600 0 0"/>
                    <a:gd name="T0" fmla="*/ 0 w 16192"/>
                    <a:gd name="T1" fmla="*/ 513 h 14810"/>
                    <a:gd name="T2" fmla="*/ 469 w 16192"/>
                    <a:gd name="T3" fmla="*/ 0 h 14810"/>
                    <a:gd name="T4" fmla="*/ 16192 w 16192"/>
                    <a:gd name="T5" fmla="*/ 14810 h 1481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192" h="14810" fill="none" extrusionOk="0">
                      <a:moveTo>
                        <a:pt x="0" y="513"/>
                      </a:moveTo>
                      <a:cubicBezTo>
                        <a:pt x="153" y="339"/>
                        <a:pt x="309" y="168"/>
                        <a:pt x="468" y="-1"/>
                      </a:cubicBezTo>
                    </a:path>
                    <a:path w="16192" h="14810" stroke="0" extrusionOk="0">
                      <a:moveTo>
                        <a:pt x="0" y="513"/>
                      </a:moveTo>
                      <a:cubicBezTo>
                        <a:pt x="153" y="339"/>
                        <a:pt x="309" y="168"/>
                        <a:pt x="468" y="-1"/>
                      </a:cubicBezTo>
                      <a:lnTo>
                        <a:pt x="16192" y="14810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62" name="Line 397">
                  <a:extLst>
                    <a:ext uri="{FF2B5EF4-FFF2-40B4-BE49-F238E27FC236}">
                      <a16:creationId xmlns:a16="http://schemas.microsoft.com/office/drawing/2014/main" id="{79D017C3-8995-6353-AD9D-34A58AB54D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750" y="1861"/>
                  <a:ext cx="55" cy="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63" name="Rectangle 398">
                  <a:extLst>
                    <a:ext uri="{FF2B5EF4-FFF2-40B4-BE49-F238E27FC236}">
                      <a16:creationId xmlns:a16="http://schemas.microsoft.com/office/drawing/2014/main" id="{AA2D0906-31A1-C53D-CC14-9642D2A5E6D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2820000">
                  <a:off x="528" y="1562"/>
                  <a:ext cx="3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3C497T1</a:t>
                  </a:r>
                </a:p>
              </p:txBody>
            </p:sp>
            <p:sp>
              <p:nvSpPr>
                <p:cNvPr id="264" name="Line 399">
                  <a:extLst>
                    <a:ext uri="{FF2B5EF4-FFF2-40B4-BE49-F238E27FC236}">
                      <a16:creationId xmlns:a16="http://schemas.microsoft.com/office/drawing/2014/main" id="{C9CDEB26-8456-0131-929F-8DE24078BB9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791" y="1710"/>
                  <a:ext cx="100" cy="10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65" name="Arc 400">
                  <a:extLst>
                    <a:ext uri="{FF2B5EF4-FFF2-40B4-BE49-F238E27FC236}">
                      <a16:creationId xmlns:a16="http://schemas.microsoft.com/office/drawing/2014/main" id="{BE11588A-4910-9D7A-DF2A-11B32B2C5AF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08" y="1865"/>
                  <a:ext cx="916" cy="851"/>
                </a:xfrm>
                <a:custGeom>
                  <a:avLst/>
                  <a:gdLst>
                    <a:gd name="G0" fmla="+- 16217 0 0"/>
                    <a:gd name="G1" fmla="+- 15069 0 0"/>
                    <a:gd name="G2" fmla="+- 21600 0 0"/>
                    <a:gd name="T0" fmla="*/ 0 w 16217"/>
                    <a:gd name="T1" fmla="*/ 801 h 15069"/>
                    <a:gd name="T2" fmla="*/ 741 w 16217"/>
                    <a:gd name="T3" fmla="*/ 0 h 15069"/>
                    <a:gd name="T4" fmla="*/ 16217 w 16217"/>
                    <a:gd name="T5" fmla="*/ 15069 h 1506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217" h="15069" fill="none" extrusionOk="0">
                      <a:moveTo>
                        <a:pt x="0" y="801"/>
                      </a:moveTo>
                      <a:cubicBezTo>
                        <a:pt x="240" y="527"/>
                        <a:pt x="487" y="260"/>
                        <a:pt x="741" y="0"/>
                      </a:cubicBezTo>
                    </a:path>
                    <a:path w="16217" h="15069" stroke="0" extrusionOk="0">
                      <a:moveTo>
                        <a:pt x="0" y="801"/>
                      </a:moveTo>
                      <a:cubicBezTo>
                        <a:pt x="240" y="527"/>
                        <a:pt x="487" y="260"/>
                        <a:pt x="741" y="0"/>
                      </a:cubicBezTo>
                      <a:lnTo>
                        <a:pt x="16217" y="15069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66" name="Arc 401">
                  <a:extLst>
                    <a:ext uri="{FF2B5EF4-FFF2-40B4-BE49-F238E27FC236}">
                      <a16:creationId xmlns:a16="http://schemas.microsoft.com/office/drawing/2014/main" id="{48D20285-CC7B-D2EC-95A6-80A59B05B6E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850" y="1824"/>
                  <a:ext cx="874" cy="892"/>
                </a:xfrm>
                <a:custGeom>
                  <a:avLst/>
                  <a:gdLst>
                    <a:gd name="G0" fmla="+- 15476 0 0"/>
                    <a:gd name="G1" fmla="+- 15787 0 0"/>
                    <a:gd name="G2" fmla="+- 21600 0 0"/>
                    <a:gd name="T0" fmla="*/ 0 w 15476"/>
                    <a:gd name="T1" fmla="*/ 718 h 15787"/>
                    <a:gd name="T2" fmla="*/ 734 w 15476"/>
                    <a:gd name="T3" fmla="*/ 0 h 15787"/>
                    <a:gd name="T4" fmla="*/ 15476 w 15476"/>
                    <a:gd name="T5" fmla="*/ 15787 h 1578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476" h="15787" fill="none" extrusionOk="0">
                      <a:moveTo>
                        <a:pt x="0" y="718"/>
                      </a:moveTo>
                      <a:cubicBezTo>
                        <a:pt x="239" y="473"/>
                        <a:pt x="483" y="233"/>
                        <a:pt x="733" y="-1"/>
                      </a:cubicBezTo>
                    </a:path>
                    <a:path w="15476" h="15787" stroke="0" extrusionOk="0">
                      <a:moveTo>
                        <a:pt x="0" y="718"/>
                      </a:moveTo>
                      <a:cubicBezTo>
                        <a:pt x="239" y="473"/>
                        <a:pt x="483" y="233"/>
                        <a:pt x="733" y="-1"/>
                      </a:cubicBezTo>
                      <a:lnTo>
                        <a:pt x="15476" y="15787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67" name="Line 402">
                  <a:extLst>
                    <a:ext uri="{FF2B5EF4-FFF2-40B4-BE49-F238E27FC236}">
                      <a16:creationId xmlns:a16="http://schemas.microsoft.com/office/drawing/2014/main" id="{8D4220DE-BAC0-5A20-85C9-E5F844EF087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846" y="1861"/>
                  <a:ext cx="55" cy="5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68" name="Rectangle 403">
                  <a:extLst>
                    <a:ext uri="{FF2B5EF4-FFF2-40B4-BE49-F238E27FC236}">
                      <a16:creationId xmlns:a16="http://schemas.microsoft.com/office/drawing/2014/main" id="{6ED127A8-8E3B-42D4-F1A9-1B1CC41BEE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3000000">
                  <a:off x="602" y="1488"/>
                  <a:ext cx="32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effectLst/>
                      <a:latin typeface="Arial" panose="020B0604020202020204" pitchFamily="34" charset="0"/>
                    </a:rPr>
                    <a:t>Lj1C516G0</a:t>
                  </a:r>
                </a:p>
              </p:txBody>
            </p:sp>
            <p:sp>
              <p:nvSpPr>
                <p:cNvPr id="269" name="Line 404">
                  <a:extLst>
                    <a:ext uri="{FF2B5EF4-FFF2-40B4-BE49-F238E27FC236}">
                      <a16:creationId xmlns:a16="http://schemas.microsoft.com/office/drawing/2014/main" id="{6F78519B-C158-5438-CB65-57198DC978A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 flipV="1">
                  <a:off x="859" y="1650"/>
                  <a:ext cx="142" cy="17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  <p:sp>
              <p:nvSpPr>
                <p:cNvPr id="270" name="Arc 405">
                  <a:extLst>
                    <a:ext uri="{FF2B5EF4-FFF2-40B4-BE49-F238E27FC236}">
                      <a16:creationId xmlns:a16="http://schemas.microsoft.com/office/drawing/2014/main" id="{F0126C5E-305C-869B-651E-3226F918E0D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02" y="1869"/>
                  <a:ext cx="822" cy="847"/>
                </a:xfrm>
                <a:custGeom>
                  <a:avLst/>
                  <a:gdLst>
                    <a:gd name="G0" fmla="+- 15479 0 0"/>
                    <a:gd name="G1" fmla="+- 15946 0 0"/>
                    <a:gd name="G2" fmla="+- 21600 0 0"/>
                    <a:gd name="T0" fmla="*/ 0 w 15479"/>
                    <a:gd name="T1" fmla="*/ 881 h 15946"/>
                    <a:gd name="T2" fmla="*/ 909 w 15479"/>
                    <a:gd name="T3" fmla="*/ 0 h 15946"/>
                    <a:gd name="T4" fmla="*/ 15479 w 15479"/>
                    <a:gd name="T5" fmla="*/ 15946 h 159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479" h="15946" fill="none" extrusionOk="0">
                      <a:moveTo>
                        <a:pt x="-1" y="880"/>
                      </a:moveTo>
                      <a:cubicBezTo>
                        <a:pt x="294" y="578"/>
                        <a:pt x="597" y="284"/>
                        <a:pt x="908" y="-1"/>
                      </a:cubicBezTo>
                    </a:path>
                    <a:path w="15479" h="15946" stroke="0" extrusionOk="0">
                      <a:moveTo>
                        <a:pt x="-1" y="880"/>
                      </a:moveTo>
                      <a:cubicBezTo>
                        <a:pt x="294" y="578"/>
                        <a:pt x="597" y="284"/>
                        <a:pt x="908" y="-1"/>
                      </a:cubicBezTo>
                      <a:lnTo>
                        <a:pt x="15479" y="15946"/>
                      </a:lnTo>
                      <a:close/>
                    </a:path>
                  </a:pathLst>
                </a:custGeom>
                <a:noFill/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800"/>
                </a:p>
              </p:txBody>
            </p:sp>
          </p:grpSp>
          <p:sp>
            <p:nvSpPr>
              <p:cNvPr id="24" name="Arc 407">
                <a:extLst>
                  <a:ext uri="{FF2B5EF4-FFF2-40B4-BE49-F238E27FC236}">
                    <a16:creationId xmlns:a16="http://schemas.microsoft.com/office/drawing/2014/main" id="{51F14F18-2834-A4CF-A1DC-13E086FC2EB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50" y="1825"/>
                <a:ext cx="774" cy="891"/>
              </a:xfrm>
              <a:custGeom>
                <a:avLst/>
                <a:gdLst>
                  <a:gd name="G0" fmla="+- 14570 0 0"/>
                  <a:gd name="G1" fmla="+- 16780 0 0"/>
                  <a:gd name="G2" fmla="+- 21600 0 0"/>
                  <a:gd name="T0" fmla="*/ 0 w 14570"/>
                  <a:gd name="T1" fmla="*/ 834 h 16780"/>
                  <a:gd name="T2" fmla="*/ 969 w 14570"/>
                  <a:gd name="T3" fmla="*/ 0 h 16780"/>
                  <a:gd name="T4" fmla="*/ 14570 w 14570"/>
                  <a:gd name="T5" fmla="*/ 16780 h 167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570" h="16780" fill="none" extrusionOk="0">
                    <a:moveTo>
                      <a:pt x="-1" y="833"/>
                    </a:moveTo>
                    <a:cubicBezTo>
                      <a:pt x="314" y="546"/>
                      <a:pt x="637" y="268"/>
                      <a:pt x="968" y="-1"/>
                    </a:cubicBezTo>
                  </a:path>
                  <a:path w="14570" h="16780" stroke="0" extrusionOk="0">
                    <a:moveTo>
                      <a:pt x="-1" y="833"/>
                    </a:moveTo>
                    <a:cubicBezTo>
                      <a:pt x="314" y="546"/>
                      <a:pt x="637" y="268"/>
                      <a:pt x="968" y="-1"/>
                    </a:cubicBezTo>
                    <a:lnTo>
                      <a:pt x="14570" y="1678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25" name="Line 408">
                <a:extLst>
                  <a:ext uri="{FF2B5EF4-FFF2-40B4-BE49-F238E27FC236}">
                    <a16:creationId xmlns:a16="http://schemas.microsoft.com/office/drawing/2014/main" id="{A70A9893-5B5F-1722-F1F9-A84141B896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946" y="1870"/>
                <a:ext cx="101" cy="10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26" name="Rectangle 409">
                <a:extLst>
                  <a:ext uri="{FF2B5EF4-FFF2-40B4-BE49-F238E27FC236}">
                    <a16:creationId xmlns:a16="http://schemas.microsoft.com/office/drawing/2014/main" id="{32935742-DA8F-89CC-9DBE-B1DD475D2A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3240000">
                <a:off x="627" y="1409"/>
                <a:ext cx="402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effectLst/>
                    <a:latin typeface="Arial" panose="020B0604020202020204" pitchFamily="34" charset="0"/>
                  </a:rPr>
                  <a:t>Lju682C9G10</a:t>
                </a:r>
              </a:p>
            </p:txBody>
          </p:sp>
          <p:sp>
            <p:nvSpPr>
              <p:cNvPr id="27" name="Line 410">
                <a:extLst>
                  <a:ext uri="{FF2B5EF4-FFF2-40B4-BE49-F238E27FC236}">
                    <a16:creationId xmlns:a16="http://schemas.microsoft.com/office/drawing/2014/main" id="{030BCF26-B17F-5E2B-CAAA-78113F5A55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933" y="1595"/>
                <a:ext cx="173" cy="24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28" name="Rectangle 411">
                <a:extLst>
                  <a:ext uri="{FF2B5EF4-FFF2-40B4-BE49-F238E27FC236}">
                    <a16:creationId xmlns:a16="http://schemas.microsoft.com/office/drawing/2014/main" id="{2C939486-0D92-ABC7-D58E-2ECEB4653F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3480000">
                <a:off x="763" y="1367"/>
                <a:ext cx="32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effectLst/>
                    <a:latin typeface="Arial" panose="020B0604020202020204" pitchFamily="34" charset="0"/>
                  </a:rPr>
                  <a:t>Lj1C518G2</a:t>
                </a:r>
              </a:p>
            </p:txBody>
          </p:sp>
          <p:sp>
            <p:nvSpPr>
              <p:cNvPr id="29" name="Line 412">
                <a:extLst>
                  <a:ext uri="{FF2B5EF4-FFF2-40B4-BE49-F238E27FC236}">
                    <a16:creationId xmlns:a16="http://schemas.microsoft.com/office/drawing/2014/main" id="{85CF2807-5550-1B5D-CF13-6F3D26E574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006" y="1545"/>
                <a:ext cx="119" cy="19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30" name="Rectangle 413">
                <a:extLst>
                  <a:ext uri="{FF2B5EF4-FFF2-40B4-BE49-F238E27FC236}">
                    <a16:creationId xmlns:a16="http://schemas.microsoft.com/office/drawing/2014/main" id="{E2FD8324-AE13-FB3F-E8B4-EE3878AC3D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3720000">
                <a:off x="856" y="1325"/>
                <a:ext cx="32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effectLst/>
                    <a:latin typeface="Arial" panose="020B0604020202020204" pitchFamily="34" charset="0"/>
                  </a:rPr>
                  <a:t>Lj1A498G7</a:t>
                </a:r>
              </a:p>
            </p:txBody>
          </p:sp>
          <p:sp>
            <p:nvSpPr>
              <p:cNvPr id="31" name="Line 414">
                <a:extLst>
                  <a:ext uri="{FF2B5EF4-FFF2-40B4-BE49-F238E27FC236}">
                    <a16:creationId xmlns:a16="http://schemas.microsoft.com/office/drawing/2014/main" id="{A888ED70-9533-9F8E-AFFF-7A6DD2B384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088" y="1499"/>
                <a:ext cx="69" cy="13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32" name="Rectangle 415">
                <a:extLst>
                  <a:ext uri="{FF2B5EF4-FFF2-40B4-BE49-F238E27FC236}">
                    <a16:creationId xmlns:a16="http://schemas.microsoft.com/office/drawing/2014/main" id="{FA727AA2-EFDB-038F-DFB1-FFA3128F76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3960000">
                <a:off x="946" y="1286"/>
                <a:ext cx="32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effectLst/>
                    <a:latin typeface="Arial" panose="020B0604020202020204" pitchFamily="34" charset="0"/>
                  </a:rPr>
                  <a:t>Lj1C499G0</a:t>
                </a:r>
              </a:p>
            </p:txBody>
          </p:sp>
          <p:sp>
            <p:nvSpPr>
              <p:cNvPr id="33" name="Line 416">
                <a:extLst>
                  <a:ext uri="{FF2B5EF4-FFF2-40B4-BE49-F238E27FC236}">
                    <a16:creationId xmlns:a16="http://schemas.microsoft.com/office/drawing/2014/main" id="{970805B3-4F8F-2C68-AC5A-42FF3F9F6A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170" y="1463"/>
                <a:ext cx="28" cy="6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34" name="Rectangle 417">
                <a:extLst>
                  <a:ext uri="{FF2B5EF4-FFF2-40B4-BE49-F238E27FC236}">
                    <a16:creationId xmlns:a16="http://schemas.microsoft.com/office/drawing/2014/main" id="{E0CC9E9D-85F2-2FC2-3DB9-6AF6D0D76F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4200000">
                <a:off x="1042" y="1241"/>
                <a:ext cx="329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>
                    <a:ln>
                      <a:noFill/>
                    </a:ln>
                    <a:effectLst/>
                    <a:latin typeface="Arial" panose="020B0604020202020204" pitchFamily="34" charset="0"/>
                  </a:rPr>
                  <a:t>Lj1C519G0</a:t>
                </a:r>
              </a:p>
            </p:txBody>
          </p:sp>
          <p:sp>
            <p:nvSpPr>
              <p:cNvPr id="35" name="Line 418">
                <a:extLst>
                  <a:ext uri="{FF2B5EF4-FFF2-40B4-BE49-F238E27FC236}">
                    <a16:creationId xmlns:a16="http://schemas.microsoft.com/office/drawing/2014/main" id="{26170BBA-8E0B-5452-24FA-08C2C72B29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253" y="1426"/>
                <a:ext cx="22" cy="6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36" name="Arc 419">
                <a:extLst>
                  <a:ext uri="{FF2B5EF4-FFF2-40B4-BE49-F238E27FC236}">
                    <a16:creationId xmlns:a16="http://schemas.microsoft.com/office/drawing/2014/main" id="{285FE142-26C2-6413-483C-6601D3E7A64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9" y="1512"/>
                <a:ext cx="525" cy="1204"/>
              </a:xfrm>
              <a:custGeom>
                <a:avLst/>
                <a:gdLst>
                  <a:gd name="G0" fmla="+- 8739 0 0"/>
                  <a:gd name="G1" fmla="+- 20033 0 0"/>
                  <a:gd name="G2" fmla="+- 21600 0 0"/>
                  <a:gd name="T0" fmla="*/ 0 w 8739"/>
                  <a:gd name="T1" fmla="*/ 280 h 20033"/>
                  <a:gd name="T2" fmla="*/ 662 w 8739"/>
                  <a:gd name="T3" fmla="*/ 0 h 20033"/>
                  <a:gd name="T4" fmla="*/ 8739 w 8739"/>
                  <a:gd name="T5" fmla="*/ 20033 h 200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39" h="20033" fill="none" extrusionOk="0">
                    <a:moveTo>
                      <a:pt x="-1" y="279"/>
                    </a:moveTo>
                    <a:cubicBezTo>
                      <a:pt x="219" y="182"/>
                      <a:pt x="439" y="89"/>
                      <a:pt x="661" y="-1"/>
                    </a:cubicBezTo>
                  </a:path>
                  <a:path w="8739" h="20033" stroke="0" extrusionOk="0">
                    <a:moveTo>
                      <a:pt x="-1" y="279"/>
                    </a:moveTo>
                    <a:cubicBezTo>
                      <a:pt x="219" y="182"/>
                      <a:pt x="439" y="89"/>
                      <a:pt x="661" y="-1"/>
                    </a:cubicBezTo>
                    <a:lnTo>
                      <a:pt x="8739" y="20033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37" name="Arc 420">
                <a:extLst>
                  <a:ext uri="{FF2B5EF4-FFF2-40B4-BE49-F238E27FC236}">
                    <a16:creationId xmlns:a16="http://schemas.microsoft.com/office/drawing/2014/main" id="{3CCB25EF-A52D-AAD6-3F50-BDEA2C8F591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38" y="1496"/>
                <a:ext cx="486" cy="1220"/>
              </a:xfrm>
              <a:custGeom>
                <a:avLst/>
                <a:gdLst>
                  <a:gd name="G0" fmla="+- 8077 0 0"/>
                  <a:gd name="G1" fmla="+- 20300 0 0"/>
                  <a:gd name="G2" fmla="+- 21600 0 0"/>
                  <a:gd name="T0" fmla="*/ 0 w 8077"/>
                  <a:gd name="T1" fmla="*/ 267 h 20300"/>
                  <a:gd name="T2" fmla="*/ 695 w 8077"/>
                  <a:gd name="T3" fmla="*/ 0 h 20300"/>
                  <a:gd name="T4" fmla="*/ 8077 w 8077"/>
                  <a:gd name="T5" fmla="*/ 20300 h 203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077" h="20300" fill="none" extrusionOk="0">
                    <a:moveTo>
                      <a:pt x="-1" y="266"/>
                    </a:moveTo>
                    <a:cubicBezTo>
                      <a:pt x="230" y="174"/>
                      <a:pt x="461" y="85"/>
                      <a:pt x="695" y="0"/>
                    </a:cubicBezTo>
                  </a:path>
                  <a:path w="8077" h="20300" stroke="0" extrusionOk="0">
                    <a:moveTo>
                      <a:pt x="-1" y="266"/>
                    </a:moveTo>
                    <a:cubicBezTo>
                      <a:pt x="230" y="174"/>
                      <a:pt x="461" y="85"/>
                      <a:pt x="695" y="0"/>
                    </a:cubicBezTo>
                    <a:lnTo>
                      <a:pt x="8077" y="2030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38" name="Line 421">
                <a:extLst>
                  <a:ext uri="{FF2B5EF4-FFF2-40B4-BE49-F238E27FC236}">
                    <a16:creationId xmlns:a16="http://schemas.microsoft.com/office/drawing/2014/main" id="{95C0C3A7-F490-FFCA-A425-1A562105A3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239" y="1513"/>
                <a:ext cx="27" cy="6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39" name="Arc 422">
                <a:extLst>
                  <a:ext uri="{FF2B5EF4-FFF2-40B4-BE49-F238E27FC236}">
                    <a16:creationId xmlns:a16="http://schemas.microsoft.com/office/drawing/2014/main" id="{ABDC9CD7-41CC-4BB0-30B8-3589D0F62A1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58" y="1609"/>
                <a:ext cx="566" cy="1107"/>
              </a:xfrm>
              <a:custGeom>
                <a:avLst/>
                <a:gdLst>
                  <a:gd name="G0" fmla="+- 10011 0 0"/>
                  <a:gd name="G1" fmla="+- 19598 0 0"/>
                  <a:gd name="G2" fmla="+- 21600 0 0"/>
                  <a:gd name="T0" fmla="*/ 0 w 10011"/>
                  <a:gd name="T1" fmla="*/ 458 h 19598"/>
                  <a:gd name="T2" fmla="*/ 929 w 10011"/>
                  <a:gd name="T3" fmla="*/ 0 h 19598"/>
                  <a:gd name="T4" fmla="*/ 10011 w 10011"/>
                  <a:gd name="T5" fmla="*/ 19598 h 195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011" h="19598" fill="none" extrusionOk="0">
                    <a:moveTo>
                      <a:pt x="-1" y="457"/>
                    </a:moveTo>
                    <a:cubicBezTo>
                      <a:pt x="305" y="297"/>
                      <a:pt x="615" y="145"/>
                      <a:pt x="929" y="0"/>
                    </a:cubicBezTo>
                  </a:path>
                  <a:path w="10011" h="19598" stroke="0" extrusionOk="0">
                    <a:moveTo>
                      <a:pt x="-1" y="457"/>
                    </a:moveTo>
                    <a:cubicBezTo>
                      <a:pt x="305" y="297"/>
                      <a:pt x="615" y="145"/>
                      <a:pt x="929" y="0"/>
                    </a:cubicBezTo>
                    <a:lnTo>
                      <a:pt x="10011" y="19598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40" name="Arc 423">
                <a:extLst>
                  <a:ext uri="{FF2B5EF4-FFF2-40B4-BE49-F238E27FC236}">
                    <a16:creationId xmlns:a16="http://schemas.microsoft.com/office/drawing/2014/main" id="{8D493E9D-DE85-7474-D5ED-7B66AA617AA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1" y="1584"/>
                <a:ext cx="513" cy="1132"/>
              </a:xfrm>
              <a:custGeom>
                <a:avLst/>
                <a:gdLst>
                  <a:gd name="G0" fmla="+- 9082 0 0"/>
                  <a:gd name="G1" fmla="+- 20028 0 0"/>
                  <a:gd name="G2" fmla="+- 21600 0 0"/>
                  <a:gd name="T0" fmla="*/ 0 w 9082"/>
                  <a:gd name="T1" fmla="*/ 430 h 20028"/>
                  <a:gd name="T2" fmla="*/ 993 w 9082"/>
                  <a:gd name="T3" fmla="*/ 0 h 20028"/>
                  <a:gd name="T4" fmla="*/ 9082 w 9082"/>
                  <a:gd name="T5" fmla="*/ 20028 h 200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82" h="20028" fill="none" extrusionOk="0">
                    <a:moveTo>
                      <a:pt x="0" y="430"/>
                    </a:moveTo>
                    <a:cubicBezTo>
                      <a:pt x="327" y="278"/>
                      <a:pt x="658" y="134"/>
                      <a:pt x="992" y="-1"/>
                    </a:cubicBezTo>
                  </a:path>
                  <a:path w="9082" h="20028" stroke="0" extrusionOk="0">
                    <a:moveTo>
                      <a:pt x="0" y="430"/>
                    </a:moveTo>
                    <a:cubicBezTo>
                      <a:pt x="327" y="278"/>
                      <a:pt x="658" y="134"/>
                      <a:pt x="992" y="-1"/>
                    </a:cubicBezTo>
                    <a:lnTo>
                      <a:pt x="9082" y="20028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41" name="Line 424">
                <a:extLst>
                  <a:ext uri="{FF2B5EF4-FFF2-40B4-BE49-F238E27FC236}">
                    <a16:creationId xmlns:a16="http://schemas.microsoft.com/office/drawing/2014/main" id="{46246CD7-4AAF-DA37-0F6B-FF3670F3F1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211" y="1604"/>
                <a:ext cx="28" cy="6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42" name="Arc 425">
                <a:extLst>
                  <a:ext uri="{FF2B5EF4-FFF2-40B4-BE49-F238E27FC236}">
                    <a16:creationId xmlns:a16="http://schemas.microsoft.com/office/drawing/2014/main" id="{57C75952-5DEC-A773-7C94-6B66B9A47B2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26" y="1704"/>
                <a:ext cx="598" cy="1012"/>
              </a:xfrm>
              <a:custGeom>
                <a:avLst/>
                <a:gdLst>
                  <a:gd name="G0" fmla="+- 11260 0 0"/>
                  <a:gd name="G1" fmla="+- 19053 0 0"/>
                  <a:gd name="G2" fmla="+- 21600 0 0"/>
                  <a:gd name="T0" fmla="*/ 0 w 11260"/>
                  <a:gd name="T1" fmla="*/ 620 h 19053"/>
                  <a:gd name="T2" fmla="*/ 1084 w 11260"/>
                  <a:gd name="T3" fmla="*/ 0 h 19053"/>
                  <a:gd name="T4" fmla="*/ 11260 w 11260"/>
                  <a:gd name="T5" fmla="*/ 19053 h 190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260" h="19053" fill="none" extrusionOk="0">
                    <a:moveTo>
                      <a:pt x="0" y="620"/>
                    </a:moveTo>
                    <a:cubicBezTo>
                      <a:pt x="355" y="403"/>
                      <a:pt x="716" y="196"/>
                      <a:pt x="1084" y="0"/>
                    </a:cubicBezTo>
                  </a:path>
                  <a:path w="11260" h="19053" stroke="0" extrusionOk="0">
                    <a:moveTo>
                      <a:pt x="0" y="620"/>
                    </a:moveTo>
                    <a:cubicBezTo>
                      <a:pt x="355" y="403"/>
                      <a:pt x="716" y="196"/>
                      <a:pt x="1084" y="0"/>
                    </a:cubicBezTo>
                    <a:lnTo>
                      <a:pt x="11260" y="19053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43" name="Arc 426">
                <a:extLst>
                  <a:ext uri="{FF2B5EF4-FFF2-40B4-BE49-F238E27FC236}">
                    <a16:creationId xmlns:a16="http://schemas.microsoft.com/office/drawing/2014/main" id="{331C618A-7D73-E260-28F2-FC8864D8627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83" y="1674"/>
                <a:ext cx="541" cy="1042"/>
              </a:xfrm>
              <a:custGeom>
                <a:avLst/>
                <a:gdLst>
                  <a:gd name="G0" fmla="+- 10176 0 0"/>
                  <a:gd name="G1" fmla="+- 19615 0 0"/>
                  <a:gd name="G2" fmla="+- 21600 0 0"/>
                  <a:gd name="T0" fmla="*/ 0 w 10176"/>
                  <a:gd name="T1" fmla="*/ 562 h 19615"/>
                  <a:gd name="T2" fmla="*/ 1130 w 10176"/>
                  <a:gd name="T3" fmla="*/ 0 h 19615"/>
                  <a:gd name="T4" fmla="*/ 10176 w 10176"/>
                  <a:gd name="T5" fmla="*/ 19615 h 196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176" h="19615" fill="none" extrusionOk="0">
                    <a:moveTo>
                      <a:pt x="0" y="562"/>
                    </a:moveTo>
                    <a:cubicBezTo>
                      <a:pt x="371" y="363"/>
                      <a:pt x="748" y="176"/>
                      <a:pt x="1130" y="0"/>
                    </a:cubicBezTo>
                  </a:path>
                  <a:path w="10176" h="19615" stroke="0" extrusionOk="0">
                    <a:moveTo>
                      <a:pt x="0" y="562"/>
                    </a:moveTo>
                    <a:cubicBezTo>
                      <a:pt x="371" y="363"/>
                      <a:pt x="748" y="176"/>
                      <a:pt x="1130" y="0"/>
                    </a:cubicBezTo>
                    <a:lnTo>
                      <a:pt x="10176" y="19615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44" name="Line 427">
                <a:extLst>
                  <a:ext uri="{FF2B5EF4-FFF2-40B4-BE49-F238E27FC236}">
                    <a16:creationId xmlns:a16="http://schemas.microsoft.com/office/drawing/2014/main" id="{B61766D7-0550-4D6E-E6CF-A266152FC0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184" y="1700"/>
                <a:ext cx="32" cy="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45" name="Arc 428">
                <a:extLst>
                  <a:ext uri="{FF2B5EF4-FFF2-40B4-BE49-F238E27FC236}">
                    <a16:creationId xmlns:a16="http://schemas.microsoft.com/office/drawing/2014/main" id="{41A19DAE-20F4-DA97-D3D6-330A85E8D7D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03" y="1801"/>
                <a:ext cx="621" cy="915"/>
              </a:xfrm>
              <a:custGeom>
                <a:avLst/>
                <a:gdLst>
                  <a:gd name="G0" fmla="+- 12486 0 0"/>
                  <a:gd name="G1" fmla="+- 18397 0 0"/>
                  <a:gd name="G2" fmla="+- 21600 0 0"/>
                  <a:gd name="T0" fmla="*/ 0 w 12486"/>
                  <a:gd name="T1" fmla="*/ 772 h 18397"/>
                  <a:gd name="T2" fmla="*/ 1167 w 12486"/>
                  <a:gd name="T3" fmla="*/ 0 h 18397"/>
                  <a:gd name="T4" fmla="*/ 12486 w 12486"/>
                  <a:gd name="T5" fmla="*/ 18397 h 183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486" h="18397" fill="none" extrusionOk="0">
                    <a:moveTo>
                      <a:pt x="-1" y="771"/>
                    </a:moveTo>
                    <a:cubicBezTo>
                      <a:pt x="380" y="501"/>
                      <a:pt x="769" y="244"/>
                      <a:pt x="1167" y="0"/>
                    </a:cubicBezTo>
                  </a:path>
                  <a:path w="12486" h="18397" stroke="0" extrusionOk="0">
                    <a:moveTo>
                      <a:pt x="-1" y="771"/>
                    </a:moveTo>
                    <a:cubicBezTo>
                      <a:pt x="380" y="501"/>
                      <a:pt x="769" y="244"/>
                      <a:pt x="1167" y="0"/>
                    </a:cubicBezTo>
                    <a:lnTo>
                      <a:pt x="12486" y="18397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46" name="Arc 429">
                <a:extLst>
                  <a:ext uri="{FF2B5EF4-FFF2-40B4-BE49-F238E27FC236}">
                    <a16:creationId xmlns:a16="http://schemas.microsoft.com/office/drawing/2014/main" id="{2B7A7DF8-3712-C6BA-9438-EA51174AA7E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61" y="1769"/>
                <a:ext cx="563" cy="947"/>
              </a:xfrm>
              <a:custGeom>
                <a:avLst/>
                <a:gdLst>
                  <a:gd name="G0" fmla="+- 11319 0 0"/>
                  <a:gd name="G1" fmla="+- 19034 0 0"/>
                  <a:gd name="G2" fmla="+- 21600 0 0"/>
                  <a:gd name="T0" fmla="*/ 0 w 11319"/>
                  <a:gd name="T1" fmla="*/ 637 h 19034"/>
                  <a:gd name="T2" fmla="*/ 1108 w 11319"/>
                  <a:gd name="T3" fmla="*/ 0 h 19034"/>
                  <a:gd name="T4" fmla="*/ 11319 w 11319"/>
                  <a:gd name="T5" fmla="*/ 19034 h 190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319" h="19034" fill="none" extrusionOk="0">
                    <a:moveTo>
                      <a:pt x="0" y="637"/>
                    </a:moveTo>
                    <a:cubicBezTo>
                      <a:pt x="363" y="413"/>
                      <a:pt x="732" y="201"/>
                      <a:pt x="1107" y="-1"/>
                    </a:cubicBezTo>
                  </a:path>
                  <a:path w="11319" h="19034" stroke="0" extrusionOk="0">
                    <a:moveTo>
                      <a:pt x="0" y="637"/>
                    </a:moveTo>
                    <a:cubicBezTo>
                      <a:pt x="363" y="413"/>
                      <a:pt x="732" y="201"/>
                      <a:pt x="1107" y="-1"/>
                    </a:cubicBezTo>
                    <a:lnTo>
                      <a:pt x="11319" y="19034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47" name="Line 430">
                <a:extLst>
                  <a:ext uri="{FF2B5EF4-FFF2-40B4-BE49-F238E27FC236}">
                    <a16:creationId xmlns:a16="http://schemas.microsoft.com/office/drawing/2014/main" id="{76B35AB9-FB7E-BE3C-E9B1-F9B9FAFA29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161" y="1801"/>
                <a:ext cx="41" cy="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48" name="Arc 431">
                <a:extLst>
                  <a:ext uri="{FF2B5EF4-FFF2-40B4-BE49-F238E27FC236}">
                    <a16:creationId xmlns:a16="http://schemas.microsoft.com/office/drawing/2014/main" id="{A046CEB1-EC9B-0B8C-58BD-9CDAECE4061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49" y="1916"/>
                <a:ext cx="675" cy="800"/>
              </a:xfrm>
              <a:custGeom>
                <a:avLst/>
                <a:gdLst>
                  <a:gd name="G0" fmla="+- 14565 0 0"/>
                  <a:gd name="G1" fmla="+- 17246 0 0"/>
                  <a:gd name="G2" fmla="+- 21600 0 0"/>
                  <a:gd name="T0" fmla="*/ 0 w 14565"/>
                  <a:gd name="T1" fmla="*/ 1296 h 17246"/>
                  <a:gd name="T2" fmla="*/ 1560 w 14565"/>
                  <a:gd name="T3" fmla="*/ 0 h 17246"/>
                  <a:gd name="T4" fmla="*/ 14565 w 14565"/>
                  <a:gd name="T5" fmla="*/ 17246 h 172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565" h="17246" fill="none" extrusionOk="0">
                    <a:moveTo>
                      <a:pt x="-1" y="1295"/>
                    </a:moveTo>
                    <a:cubicBezTo>
                      <a:pt x="499" y="839"/>
                      <a:pt x="1019" y="407"/>
                      <a:pt x="1559" y="-1"/>
                    </a:cubicBezTo>
                  </a:path>
                  <a:path w="14565" h="17246" stroke="0" extrusionOk="0">
                    <a:moveTo>
                      <a:pt x="-1" y="1295"/>
                    </a:moveTo>
                    <a:cubicBezTo>
                      <a:pt x="499" y="839"/>
                      <a:pt x="1019" y="407"/>
                      <a:pt x="1559" y="-1"/>
                    </a:cubicBezTo>
                    <a:lnTo>
                      <a:pt x="14565" y="17246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49" name="Arc 432">
                <a:extLst>
                  <a:ext uri="{FF2B5EF4-FFF2-40B4-BE49-F238E27FC236}">
                    <a16:creationId xmlns:a16="http://schemas.microsoft.com/office/drawing/2014/main" id="{0354F3EE-B403-F0A0-3D79-E24DF57038B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21" y="1864"/>
                <a:ext cx="603" cy="852"/>
              </a:xfrm>
              <a:custGeom>
                <a:avLst/>
                <a:gdLst>
                  <a:gd name="G0" fmla="+- 13005 0 0"/>
                  <a:gd name="G1" fmla="+- 18374 0 0"/>
                  <a:gd name="G2" fmla="+- 21600 0 0"/>
                  <a:gd name="T0" fmla="*/ 0 w 13005"/>
                  <a:gd name="T1" fmla="*/ 1128 h 18374"/>
                  <a:gd name="T2" fmla="*/ 1648 w 13005"/>
                  <a:gd name="T3" fmla="*/ 0 h 18374"/>
                  <a:gd name="T4" fmla="*/ 13005 w 13005"/>
                  <a:gd name="T5" fmla="*/ 18374 h 183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005" h="18374" fill="none" extrusionOk="0">
                    <a:moveTo>
                      <a:pt x="-1" y="1127"/>
                    </a:moveTo>
                    <a:cubicBezTo>
                      <a:pt x="531" y="726"/>
                      <a:pt x="1081" y="350"/>
                      <a:pt x="1648" y="0"/>
                    </a:cubicBezTo>
                  </a:path>
                  <a:path w="13005" h="18374" stroke="0" extrusionOk="0">
                    <a:moveTo>
                      <a:pt x="-1" y="1127"/>
                    </a:moveTo>
                    <a:cubicBezTo>
                      <a:pt x="531" y="726"/>
                      <a:pt x="1081" y="350"/>
                      <a:pt x="1648" y="0"/>
                    </a:cubicBezTo>
                    <a:lnTo>
                      <a:pt x="13005" y="18374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50" name="Line 433">
                <a:extLst>
                  <a:ext uri="{FF2B5EF4-FFF2-40B4-BE49-F238E27FC236}">
                    <a16:creationId xmlns:a16="http://schemas.microsoft.com/office/drawing/2014/main" id="{6BD081A1-5DA8-4E9B-5CCC-BB3FA943EC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120" y="1920"/>
                <a:ext cx="46" cy="5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51" name="Arc 434">
                <a:extLst>
                  <a:ext uri="{FF2B5EF4-FFF2-40B4-BE49-F238E27FC236}">
                    <a16:creationId xmlns:a16="http://schemas.microsoft.com/office/drawing/2014/main" id="{38A8EC66-84FC-EF17-DDD2-61C6191510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14" y="2113"/>
                <a:ext cx="810" cy="603"/>
              </a:xfrm>
              <a:custGeom>
                <a:avLst/>
                <a:gdLst>
                  <a:gd name="G0" fmla="+- 18941 0 0"/>
                  <a:gd name="G1" fmla="+- 14111 0 0"/>
                  <a:gd name="G2" fmla="+- 21600 0 0"/>
                  <a:gd name="T0" fmla="*/ 0 w 18941"/>
                  <a:gd name="T1" fmla="*/ 3728 h 14111"/>
                  <a:gd name="T2" fmla="*/ 2587 w 18941"/>
                  <a:gd name="T3" fmla="*/ 0 h 14111"/>
                  <a:gd name="T4" fmla="*/ 18941 w 18941"/>
                  <a:gd name="T5" fmla="*/ 14111 h 14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941" h="14111" fill="none" extrusionOk="0">
                    <a:moveTo>
                      <a:pt x="0" y="3728"/>
                    </a:moveTo>
                    <a:cubicBezTo>
                      <a:pt x="729" y="2398"/>
                      <a:pt x="1596" y="1148"/>
                      <a:pt x="2587" y="0"/>
                    </a:cubicBezTo>
                  </a:path>
                  <a:path w="18941" h="14111" stroke="0" extrusionOk="0">
                    <a:moveTo>
                      <a:pt x="0" y="3728"/>
                    </a:moveTo>
                    <a:cubicBezTo>
                      <a:pt x="729" y="2398"/>
                      <a:pt x="1596" y="1148"/>
                      <a:pt x="2587" y="0"/>
                    </a:cubicBezTo>
                    <a:lnTo>
                      <a:pt x="18941" y="14111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52" name="Arc 435">
                <a:extLst>
                  <a:ext uri="{FF2B5EF4-FFF2-40B4-BE49-F238E27FC236}">
                    <a16:creationId xmlns:a16="http://schemas.microsoft.com/office/drawing/2014/main" id="{FF6483DD-0AA5-3708-5096-F3A7811977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25" y="1980"/>
                <a:ext cx="699" cy="736"/>
              </a:xfrm>
              <a:custGeom>
                <a:avLst/>
                <a:gdLst>
                  <a:gd name="G0" fmla="+- 16354 0 0"/>
                  <a:gd name="G1" fmla="+- 17221 0 0"/>
                  <a:gd name="G2" fmla="+- 21600 0 0"/>
                  <a:gd name="T0" fmla="*/ 0 w 16354"/>
                  <a:gd name="T1" fmla="*/ 3110 h 17221"/>
                  <a:gd name="T2" fmla="*/ 3316 w 16354"/>
                  <a:gd name="T3" fmla="*/ 0 h 17221"/>
                  <a:gd name="T4" fmla="*/ 16354 w 16354"/>
                  <a:gd name="T5" fmla="*/ 17221 h 172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354" h="17221" fill="none" extrusionOk="0">
                    <a:moveTo>
                      <a:pt x="0" y="3110"/>
                    </a:moveTo>
                    <a:cubicBezTo>
                      <a:pt x="992" y="1959"/>
                      <a:pt x="2104" y="917"/>
                      <a:pt x="3315" y="-1"/>
                    </a:cubicBezTo>
                  </a:path>
                  <a:path w="16354" h="17221" stroke="0" extrusionOk="0">
                    <a:moveTo>
                      <a:pt x="0" y="3110"/>
                    </a:moveTo>
                    <a:cubicBezTo>
                      <a:pt x="992" y="1959"/>
                      <a:pt x="2104" y="917"/>
                      <a:pt x="3315" y="-1"/>
                    </a:cubicBezTo>
                    <a:lnTo>
                      <a:pt x="16354" y="17221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53" name="Line 436">
                <a:extLst>
                  <a:ext uri="{FF2B5EF4-FFF2-40B4-BE49-F238E27FC236}">
                    <a16:creationId xmlns:a16="http://schemas.microsoft.com/office/drawing/2014/main" id="{48D97E55-5D52-C3B4-A9E2-9316C238BA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1024" y="2112"/>
                <a:ext cx="59" cy="5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54" name="Arc 437">
                <a:extLst>
                  <a:ext uri="{FF2B5EF4-FFF2-40B4-BE49-F238E27FC236}">
                    <a16:creationId xmlns:a16="http://schemas.microsoft.com/office/drawing/2014/main" id="{B7EE7C35-7A0C-0ACD-710C-CD8743AC30F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5" y="2395"/>
                <a:ext cx="849" cy="321"/>
              </a:xfrm>
              <a:custGeom>
                <a:avLst/>
                <a:gdLst>
                  <a:gd name="G0" fmla="+- 21569 0 0"/>
                  <a:gd name="G1" fmla="+- 8158 0 0"/>
                  <a:gd name="G2" fmla="+- 21600 0 0"/>
                  <a:gd name="T0" fmla="*/ 0 w 21569"/>
                  <a:gd name="T1" fmla="*/ 6992 h 8158"/>
                  <a:gd name="T2" fmla="*/ 1569 w 21569"/>
                  <a:gd name="T3" fmla="*/ 0 h 8158"/>
                  <a:gd name="T4" fmla="*/ 21569 w 21569"/>
                  <a:gd name="T5" fmla="*/ 8158 h 81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569" h="8158" fill="none" extrusionOk="0">
                    <a:moveTo>
                      <a:pt x="0" y="6992"/>
                    </a:moveTo>
                    <a:cubicBezTo>
                      <a:pt x="130" y="4590"/>
                      <a:pt x="660" y="2227"/>
                      <a:pt x="1568" y="-1"/>
                    </a:cubicBezTo>
                  </a:path>
                  <a:path w="21569" h="8158" stroke="0" extrusionOk="0">
                    <a:moveTo>
                      <a:pt x="0" y="6992"/>
                    </a:moveTo>
                    <a:cubicBezTo>
                      <a:pt x="130" y="4590"/>
                      <a:pt x="660" y="2227"/>
                      <a:pt x="1568" y="-1"/>
                    </a:cubicBezTo>
                    <a:lnTo>
                      <a:pt x="21569" y="8158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55" name="Arc 438">
                <a:extLst>
                  <a:ext uri="{FF2B5EF4-FFF2-40B4-BE49-F238E27FC236}">
                    <a16:creationId xmlns:a16="http://schemas.microsoft.com/office/drawing/2014/main" id="{9F94B215-A57C-47BF-83D1-2A3E627C15D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36" y="2160"/>
                <a:ext cx="788" cy="556"/>
              </a:xfrm>
              <a:custGeom>
                <a:avLst/>
                <a:gdLst>
                  <a:gd name="G0" fmla="+- 20000 0 0"/>
                  <a:gd name="G1" fmla="+- 14124 0 0"/>
                  <a:gd name="G2" fmla="+- 21600 0 0"/>
                  <a:gd name="T0" fmla="*/ 0 w 20000"/>
                  <a:gd name="T1" fmla="*/ 5966 h 14124"/>
                  <a:gd name="T2" fmla="*/ 3658 w 20000"/>
                  <a:gd name="T3" fmla="*/ 0 h 14124"/>
                  <a:gd name="T4" fmla="*/ 20000 w 20000"/>
                  <a:gd name="T5" fmla="*/ 14124 h 141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000" h="14124" fill="none" extrusionOk="0">
                    <a:moveTo>
                      <a:pt x="-1" y="5965"/>
                    </a:moveTo>
                    <a:cubicBezTo>
                      <a:pt x="886" y="3791"/>
                      <a:pt x="2122" y="1776"/>
                      <a:pt x="3657" y="-1"/>
                    </a:cubicBezTo>
                  </a:path>
                  <a:path w="20000" h="14124" stroke="0" extrusionOk="0">
                    <a:moveTo>
                      <a:pt x="-1" y="5965"/>
                    </a:moveTo>
                    <a:cubicBezTo>
                      <a:pt x="886" y="3791"/>
                      <a:pt x="2122" y="1776"/>
                      <a:pt x="3657" y="-1"/>
                    </a:cubicBezTo>
                    <a:lnTo>
                      <a:pt x="20000" y="14124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56" name="Line 439">
                <a:extLst>
                  <a:ext uri="{FF2B5EF4-FFF2-40B4-BE49-F238E27FC236}">
                    <a16:creationId xmlns:a16="http://schemas.microsoft.com/office/drawing/2014/main" id="{B7B87716-6678-A64D-2172-0CB3D8C5C6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933" y="2395"/>
                <a:ext cx="68" cy="2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57" name="Arc 440">
                <a:extLst>
                  <a:ext uri="{FF2B5EF4-FFF2-40B4-BE49-F238E27FC236}">
                    <a16:creationId xmlns:a16="http://schemas.microsoft.com/office/drawing/2014/main" id="{CEF25588-10A9-E38B-F7C9-AC301377752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46" y="2606"/>
                <a:ext cx="778" cy="183"/>
              </a:xfrm>
              <a:custGeom>
                <a:avLst/>
                <a:gdLst>
                  <a:gd name="G0" fmla="+- 21600 0 0"/>
                  <a:gd name="G1" fmla="+- 3059 0 0"/>
                  <a:gd name="G2" fmla="+- 21600 0 0"/>
                  <a:gd name="T0" fmla="*/ 96 w 21600"/>
                  <a:gd name="T1" fmla="*/ 5090 h 5090"/>
                  <a:gd name="T2" fmla="*/ 218 w 21600"/>
                  <a:gd name="T3" fmla="*/ 0 h 5090"/>
                  <a:gd name="T4" fmla="*/ 21600 w 21600"/>
                  <a:gd name="T5" fmla="*/ 3059 h 50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600" h="5090" fill="none" extrusionOk="0">
                    <a:moveTo>
                      <a:pt x="95" y="5090"/>
                    </a:moveTo>
                    <a:cubicBezTo>
                      <a:pt x="31" y="4414"/>
                      <a:pt x="0" y="3737"/>
                      <a:pt x="0" y="3059"/>
                    </a:cubicBezTo>
                    <a:cubicBezTo>
                      <a:pt x="0" y="2035"/>
                      <a:pt x="72" y="1013"/>
                      <a:pt x="217" y="-1"/>
                    </a:cubicBezTo>
                  </a:path>
                  <a:path w="21600" h="5090" stroke="0" extrusionOk="0">
                    <a:moveTo>
                      <a:pt x="95" y="5090"/>
                    </a:moveTo>
                    <a:cubicBezTo>
                      <a:pt x="31" y="4414"/>
                      <a:pt x="0" y="3737"/>
                      <a:pt x="0" y="3059"/>
                    </a:cubicBezTo>
                    <a:cubicBezTo>
                      <a:pt x="0" y="2035"/>
                      <a:pt x="72" y="1013"/>
                      <a:pt x="217" y="-1"/>
                    </a:cubicBezTo>
                    <a:lnTo>
                      <a:pt x="21600" y="3059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58" name="Arc 441">
                <a:extLst>
                  <a:ext uri="{FF2B5EF4-FFF2-40B4-BE49-F238E27FC236}">
                    <a16:creationId xmlns:a16="http://schemas.microsoft.com/office/drawing/2014/main" id="{1A5DEB71-E3D2-DF3F-22FD-C1901AC4FFA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54" y="2424"/>
                <a:ext cx="770" cy="292"/>
              </a:xfrm>
              <a:custGeom>
                <a:avLst/>
                <a:gdLst>
                  <a:gd name="G0" fmla="+- 21382 0 0"/>
                  <a:gd name="G1" fmla="+- 8113 0 0"/>
                  <a:gd name="G2" fmla="+- 21600 0 0"/>
                  <a:gd name="T0" fmla="*/ 0 w 21382"/>
                  <a:gd name="T1" fmla="*/ 5054 h 8113"/>
                  <a:gd name="T2" fmla="*/ 1363 w 21382"/>
                  <a:gd name="T3" fmla="*/ 0 h 8113"/>
                  <a:gd name="T4" fmla="*/ 21382 w 21382"/>
                  <a:gd name="T5" fmla="*/ 8113 h 81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382" h="8113" fill="none" extrusionOk="0">
                    <a:moveTo>
                      <a:pt x="-1" y="5053"/>
                    </a:moveTo>
                    <a:cubicBezTo>
                      <a:pt x="247" y="3320"/>
                      <a:pt x="705" y="1623"/>
                      <a:pt x="1363" y="0"/>
                    </a:cubicBezTo>
                  </a:path>
                  <a:path w="21382" h="8113" stroke="0" extrusionOk="0">
                    <a:moveTo>
                      <a:pt x="-1" y="5053"/>
                    </a:moveTo>
                    <a:cubicBezTo>
                      <a:pt x="247" y="3320"/>
                      <a:pt x="705" y="1623"/>
                      <a:pt x="1363" y="0"/>
                    </a:cubicBezTo>
                    <a:lnTo>
                      <a:pt x="21382" y="8113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59" name="Line 442">
                <a:extLst>
                  <a:ext uri="{FF2B5EF4-FFF2-40B4-BE49-F238E27FC236}">
                    <a16:creationId xmlns:a16="http://schemas.microsoft.com/office/drawing/2014/main" id="{FA812DDD-1535-0CF1-E4DC-B0AF9AF21A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 flipV="1">
                <a:off x="955" y="2606"/>
                <a:ext cx="74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60" name="Arc 443">
                <a:extLst>
                  <a:ext uri="{FF2B5EF4-FFF2-40B4-BE49-F238E27FC236}">
                    <a16:creationId xmlns:a16="http://schemas.microsoft.com/office/drawing/2014/main" id="{F23864F0-4EB3-6B51-B91E-D3E0EE70298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22" y="2715"/>
                <a:ext cx="702" cy="211"/>
              </a:xfrm>
              <a:custGeom>
                <a:avLst/>
                <a:gdLst>
                  <a:gd name="G0" fmla="+- 21534 0 0"/>
                  <a:gd name="G1" fmla="+- 0 0 0"/>
                  <a:gd name="G2" fmla="+- 21600 0 0"/>
                  <a:gd name="T0" fmla="*/ 925 w 21534"/>
                  <a:gd name="T1" fmla="*/ 6466 h 6466"/>
                  <a:gd name="T2" fmla="*/ 0 w 21534"/>
                  <a:gd name="T3" fmla="*/ 1681 h 6466"/>
                  <a:gd name="T4" fmla="*/ 21534 w 21534"/>
                  <a:gd name="T5" fmla="*/ 0 h 64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534" h="6466" fill="none" extrusionOk="0">
                    <a:moveTo>
                      <a:pt x="924" y="6466"/>
                    </a:moveTo>
                    <a:cubicBezTo>
                      <a:pt x="436" y="4911"/>
                      <a:pt x="126" y="3305"/>
                      <a:pt x="-1" y="1681"/>
                    </a:cubicBezTo>
                  </a:path>
                  <a:path w="21534" h="6466" stroke="0" extrusionOk="0">
                    <a:moveTo>
                      <a:pt x="924" y="6466"/>
                    </a:moveTo>
                    <a:cubicBezTo>
                      <a:pt x="436" y="4911"/>
                      <a:pt x="126" y="3305"/>
                      <a:pt x="-1" y="1681"/>
                    </a:cubicBezTo>
                    <a:lnTo>
                      <a:pt x="21534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61" name="Arc 444">
                <a:extLst>
                  <a:ext uri="{FF2B5EF4-FFF2-40B4-BE49-F238E27FC236}">
                    <a16:creationId xmlns:a16="http://schemas.microsoft.com/office/drawing/2014/main" id="{DFB00868-273A-55D7-59F9-9C38327E077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19" y="2615"/>
                <a:ext cx="705" cy="155"/>
              </a:xfrm>
              <a:custGeom>
                <a:avLst/>
                <a:gdLst>
                  <a:gd name="G0" fmla="+- 21600 0 0"/>
                  <a:gd name="G1" fmla="+- 3078 0 0"/>
                  <a:gd name="G2" fmla="+- 21600 0 0"/>
                  <a:gd name="T0" fmla="*/ 66 w 21600"/>
                  <a:gd name="T1" fmla="*/ 4759 h 4759"/>
                  <a:gd name="T2" fmla="*/ 220 w 21600"/>
                  <a:gd name="T3" fmla="*/ 0 h 4759"/>
                  <a:gd name="T4" fmla="*/ 21600 w 21600"/>
                  <a:gd name="T5" fmla="*/ 3078 h 47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600" h="4759" fill="none" extrusionOk="0">
                    <a:moveTo>
                      <a:pt x="65" y="4759"/>
                    </a:moveTo>
                    <a:cubicBezTo>
                      <a:pt x="21" y="4199"/>
                      <a:pt x="0" y="3638"/>
                      <a:pt x="0" y="3078"/>
                    </a:cubicBezTo>
                    <a:cubicBezTo>
                      <a:pt x="0" y="2048"/>
                      <a:pt x="73" y="1019"/>
                      <a:pt x="220" y="0"/>
                    </a:cubicBezTo>
                  </a:path>
                  <a:path w="21600" h="4759" stroke="0" extrusionOk="0">
                    <a:moveTo>
                      <a:pt x="65" y="4759"/>
                    </a:moveTo>
                    <a:cubicBezTo>
                      <a:pt x="21" y="4199"/>
                      <a:pt x="0" y="3638"/>
                      <a:pt x="0" y="3078"/>
                    </a:cubicBezTo>
                    <a:cubicBezTo>
                      <a:pt x="0" y="2048"/>
                      <a:pt x="73" y="1019"/>
                      <a:pt x="220" y="0"/>
                    </a:cubicBezTo>
                    <a:lnTo>
                      <a:pt x="21600" y="3078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62" name="Line 445">
                <a:extLst>
                  <a:ext uri="{FF2B5EF4-FFF2-40B4-BE49-F238E27FC236}">
                    <a16:creationId xmlns:a16="http://schemas.microsoft.com/office/drawing/2014/main" id="{42EE22B7-48C6-EE97-C12C-008E7CF4F4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024" y="2766"/>
                <a:ext cx="73" cy="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63" name="Arc 446">
                <a:extLst>
                  <a:ext uri="{FF2B5EF4-FFF2-40B4-BE49-F238E27FC236}">
                    <a16:creationId xmlns:a16="http://schemas.microsoft.com/office/drawing/2014/main" id="{9C72E973-2396-C9DA-6A01-09ED55DD69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30" y="2716"/>
                <a:ext cx="594" cy="342"/>
              </a:xfrm>
              <a:custGeom>
                <a:avLst/>
                <a:gdLst>
                  <a:gd name="G0" fmla="+- 20464 0 0"/>
                  <a:gd name="G1" fmla="+- 0 0 0"/>
                  <a:gd name="G2" fmla="+- 21600 0 0"/>
                  <a:gd name="T0" fmla="*/ 2355 w 20464"/>
                  <a:gd name="T1" fmla="*/ 11774 h 11774"/>
                  <a:gd name="T2" fmla="*/ 0 w 20464"/>
                  <a:gd name="T3" fmla="*/ 6913 h 11774"/>
                  <a:gd name="T4" fmla="*/ 20464 w 20464"/>
                  <a:gd name="T5" fmla="*/ 0 h 117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464" h="11774" fill="none" extrusionOk="0">
                    <a:moveTo>
                      <a:pt x="2355" y="11773"/>
                    </a:moveTo>
                    <a:cubicBezTo>
                      <a:pt x="1369" y="10258"/>
                      <a:pt x="578" y="8625"/>
                      <a:pt x="0" y="6912"/>
                    </a:cubicBezTo>
                  </a:path>
                  <a:path w="20464" h="11774" stroke="0" extrusionOk="0">
                    <a:moveTo>
                      <a:pt x="2355" y="11773"/>
                    </a:moveTo>
                    <a:cubicBezTo>
                      <a:pt x="1369" y="10258"/>
                      <a:pt x="578" y="8625"/>
                      <a:pt x="0" y="6912"/>
                    </a:cubicBezTo>
                    <a:lnTo>
                      <a:pt x="20464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64" name="Arc 447">
                <a:extLst>
                  <a:ext uri="{FF2B5EF4-FFF2-40B4-BE49-F238E27FC236}">
                    <a16:creationId xmlns:a16="http://schemas.microsoft.com/office/drawing/2014/main" id="{85DC0459-548C-64B6-74A5-CC22174EA90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99" y="2716"/>
                <a:ext cx="625" cy="201"/>
              </a:xfrm>
              <a:custGeom>
                <a:avLst/>
                <a:gdLst>
                  <a:gd name="G0" fmla="+- 21532 0 0"/>
                  <a:gd name="G1" fmla="+- 0 0 0"/>
                  <a:gd name="G2" fmla="+- 21600 0 0"/>
                  <a:gd name="T0" fmla="*/ 1068 w 21532"/>
                  <a:gd name="T1" fmla="*/ 6913 h 6913"/>
                  <a:gd name="T2" fmla="*/ 0 w 21532"/>
                  <a:gd name="T3" fmla="*/ 1717 h 6913"/>
                  <a:gd name="T4" fmla="*/ 21532 w 21532"/>
                  <a:gd name="T5" fmla="*/ 0 h 69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532" h="6913" fill="none" extrusionOk="0">
                    <a:moveTo>
                      <a:pt x="1068" y="6912"/>
                    </a:moveTo>
                    <a:cubicBezTo>
                      <a:pt x="500" y="5231"/>
                      <a:pt x="141" y="3486"/>
                      <a:pt x="0" y="1716"/>
                    </a:cubicBezTo>
                  </a:path>
                  <a:path w="21532" h="6913" stroke="0" extrusionOk="0">
                    <a:moveTo>
                      <a:pt x="1068" y="6912"/>
                    </a:moveTo>
                    <a:cubicBezTo>
                      <a:pt x="500" y="5231"/>
                      <a:pt x="141" y="3486"/>
                      <a:pt x="0" y="1716"/>
                    </a:cubicBezTo>
                    <a:lnTo>
                      <a:pt x="21532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65" name="Line 448">
                <a:extLst>
                  <a:ext uri="{FF2B5EF4-FFF2-40B4-BE49-F238E27FC236}">
                    <a16:creationId xmlns:a16="http://schemas.microsoft.com/office/drawing/2014/main" id="{370A3BBB-5AE5-82B4-6FF5-30E4DD3F5E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129" y="2894"/>
                <a:ext cx="69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66" name="Arc 449">
                <a:extLst>
                  <a:ext uri="{FF2B5EF4-FFF2-40B4-BE49-F238E27FC236}">
                    <a16:creationId xmlns:a16="http://schemas.microsoft.com/office/drawing/2014/main" id="{B0003E1C-2332-1C80-18E9-3C08F8FA079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5" y="2716"/>
                <a:ext cx="429" cy="479"/>
              </a:xfrm>
              <a:custGeom>
                <a:avLst/>
                <a:gdLst>
                  <a:gd name="G0" fmla="+- 16733 0 0"/>
                  <a:gd name="G1" fmla="+- 0 0 0"/>
                  <a:gd name="G2" fmla="+- 21600 0 0"/>
                  <a:gd name="T0" fmla="*/ 5911 w 16733"/>
                  <a:gd name="T1" fmla="*/ 18693 h 18693"/>
                  <a:gd name="T2" fmla="*/ 0 w 16733"/>
                  <a:gd name="T3" fmla="*/ 13659 h 18693"/>
                  <a:gd name="T4" fmla="*/ 16733 w 16733"/>
                  <a:gd name="T5" fmla="*/ 0 h 186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733" h="18693" fill="none" extrusionOk="0">
                    <a:moveTo>
                      <a:pt x="5910" y="18693"/>
                    </a:moveTo>
                    <a:cubicBezTo>
                      <a:pt x="3652" y="17385"/>
                      <a:pt x="1650" y="15680"/>
                      <a:pt x="0" y="13658"/>
                    </a:cubicBezTo>
                  </a:path>
                  <a:path w="16733" h="18693" stroke="0" extrusionOk="0">
                    <a:moveTo>
                      <a:pt x="5910" y="18693"/>
                    </a:moveTo>
                    <a:cubicBezTo>
                      <a:pt x="3652" y="17385"/>
                      <a:pt x="1650" y="15680"/>
                      <a:pt x="0" y="13658"/>
                    </a:cubicBezTo>
                    <a:lnTo>
                      <a:pt x="16733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67" name="Arc 450">
                <a:extLst>
                  <a:ext uri="{FF2B5EF4-FFF2-40B4-BE49-F238E27FC236}">
                    <a16:creationId xmlns:a16="http://schemas.microsoft.com/office/drawing/2014/main" id="{64355EEE-8ACE-61FA-509A-367823A0A2B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00" y="2716"/>
                <a:ext cx="524" cy="350"/>
              </a:xfrm>
              <a:custGeom>
                <a:avLst/>
                <a:gdLst>
                  <a:gd name="G0" fmla="+- 20460 0 0"/>
                  <a:gd name="G1" fmla="+- 0 0 0"/>
                  <a:gd name="G2" fmla="+- 21600 0 0"/>
                  <a:gd name="T0" fmla="*/ 3727 w 20460"/>
                  <a:gd name="T1" fmla="*/ 13659 h 13659"/>
                  <a:gd name="T2" fmla="*/ 0 w 20460"/>
                  <a:gd name="T3" fmla="*/ 6924 h 13659"/>
                  <a:gd name="T4" fmla="*/ 20460 w 20460"/>
                  <a:gd name="T5" fmla="*/ 0 h 136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460" h="13659" fill="none" extrusionOk="0">
                    <a:moveTo>
                      <a:pt x="3727" y="13658"/>
                    </a:moveTo>
                    <a:cubicBezTo>
                      <a:pt x="2091" y="11655"/>
                      <a:pt x="828" y="9374"/>
                      <a:pt x="-1" y="6924"/>
                    </a:cubicBezTo>
                  </a:path>
                  <a:path w="20460" h="13659" stroke="0" extrusionOk="0">
                    <a:moveTo>
                      <a:pt x="3727" y="13658"/>
                    </a:moveTo>
                    <a:cubicBezTo>
                      <a:pt x="2091" y="11655"/>
                      <a:pt x="828" y="9374"/>
                      <a:pt x="-1" y="6924"/>
                    </a:cubicBezTo>
                    <a:lnTo>
                      <a:pt x="20460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68" name="Line 451">
                <a:extLst>
                  <a:ext uri="{FF2B5EF4-FFF2-40B4-BE49-F238E27FC236}">
                    <a16:creationId xmlns:a16="http://schemas.microsoft.com/office/drawing/2014/main" id="{D65EBFE3-3527-803C-14C6-53FBC79281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294" y="2889"/>
                <a:ext cx="215" cy="17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69" name="Arc 452">
                <a:extLst>
                  <a:ext uri="{FF2B5EF4-FFF2-40B4-BE49-F238E27FC236}">
                    <a16:creationId xmlns:a16="http://schemas.microsoft.com/office/drawing/2014/main" id="{6AAD6EB6-D141-43E0-0DE9-FDB4EB9480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32" y="2716"/>
                <a:ext cx="146" cy="275"/>
              </a:xfrm>
              <a:custGeom>
                <a:avLst/>
                <a:gdLst>
                  <a:gd name="G0" fmla="+- 7205 0 0"/>
                  <a:gd name="G1" fmla="+- 0 0 0"/>
                  <a:gd name="G2" fmla="+- 21600 0 0"/>
                  <a:gd name="T0" fmla="*/ 11456 w 11456"/>
                  <a:gd name="T1" fmla="*/ 21178 h 21600"/>
                  <a:gd name="T2" fmla="*/ 0 w 11456"/>
                  <a:gd name="T3" fmla="*/ 20363 h 21600"/>
                  <a:gd name="T4" fmla="*/ 7205 w 11456"/>
                  <a:gd name="T5" fmla="*/ 0 h 216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456" h="21600" fill="none" extrusionOk="0">
                    <a:moveTo>
                      <a:pt x="11455" y="21177"/>
                    </a:moveTo>
                    <a:cubicBezTo>
                      <a:pt x="10056" y="21458"/>
                      <a:pt x="8632" y="21599"/>
                      <a:pt x="7205" y="21599"/>
                    </a:cubicBezTo>
                    <a:cubicBezTo>
                      <a:pt x="4750" y="21599"/>
                      <a:pt x="2313" y="21181"/>
                      <a:pt x="0" y="20362"/>
                    </a:cubicBezTo>
                  </a:path>
                  <a:path w="11456" h="21600" stroke="0" extrusionOk="0">
                    <a:moveTo>
                      <a:pt x="11455" y="21177"/>
                    </a:moveTo>
                    <a:cubicBezTo>
                      <a:pt x="10056" y="21458"/>
                      <a:pt x="8632" y="21599"/>
                      <a:pt x="7205" y="21599"/>
                    </a:cubicBezTo>
                    <a:cubicBezTo>
                      <a:pt x="4750" y="21599"/>
                      <a:pt x="2313" y="21181"/>
                      <a:pt x="0" y="20362"/>
                    </a:cubicBezTo>
                    <a:lnTo>
                      <a:pt x="7205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  <p:sp>
            <p:nvSpPr>
              <p:cNvPr id="70" name="Arc 453">
                <a:extLst>
                  <a:ext uri="{FF2B5EF4-FFF2-40B4-BE49-F238E27FC236}">
                    <a16:creationId xmlns:a16="http://schemas.microsoft.com/office/drawing/2014/main" id="{269E70F4-A756-41F0-F636-58A31373828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10" y="2716"/>
                <a:ext cx="214" cy="259"/>
              </a:xfrm>
              <a:custGeom>
                <a:avLst/>
                <a:gdLst>
                  <a:gd name="G0" fmla="+- 16859 0 0"/>
                  <a:gd name="G1" fmla="+- 0 0 0"/>
                  <a:gd name="G2" fmla="+- 21600 0 0"/>
                  <a:gd name="T0" fmla="*/ 9654 w 16859"/>
                  <a:gd name="T1" fmla="*/ 20363 h 20363"/>
                  <a:gd name="T2" fmla="*/ 0 w 16859"/>
                  <a:gd name="T3" fmla="*/ 13503 h 20363"/>
                  <a:gd name="T4" fmla="*/ 16859 w 16859"/>
                  <a:gd name="T5" fmla="*/ 0 h 203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859" h="20363" fill="none" extrusionOk="0">
                    <a:moveTo>
                      <a:pt x="9654" y="20362"/>
                    </a:moveTo>
                    <a:cubicBezTo>
                      <a:pt x="5859" y="19020"/>
                      <a:pt x="2516" y="16644"/>
                      <a:pt x="-1" y="13503"/>
                    </a:cubicBezTo>
                  </a:path>
                  <a:path w="16859" h="20363" stroke="0" extrusionOk="0">
                    <a:moveTo>
                      <a:pt x="9654" y="20362"/>
                    </a:moveTo>
                    <a:cubicBezTo>
                      <a:pt x="5859" y="19020"/>
                      <a:pt x="2516" y="16644"/>
                      <a:pt x="-1" y="13503"/>
                    </a:cubicBezTo>
                    <a:lnTo>
                      <a:pt x="16859" y="0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/>
              </a:p>
            </p:txBody>
          </p:sp>
        </p:grpSp>
        <p:sp>
          <p:nvSpPr>
            <p:cNvPr id="6" name="椭圆 5">
              <a:extLst>
                <a:ext uri="{FF2B5EF4-FFF2-40B4-BE49-F238E27FC236}">
                  <a16:creationId xmlns:a16="http://schemas.microsoft.com/office/drawing/2014/main" id="{55435833-6B98-EE86-113B-06B196562DA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92379" y="1408817"/>
              <a:ext cx="5580000" cy="5580000"/>
            </a:xfrm>
            <a:prstGeom prst="ellipse">
              <a:avLst/>
            </a:prstGeom>
            <a:noFill/>
            <a:ln w="19050"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n>
                  <a:solidFill>
                    <a:srgbClr val="00B0F0"/>
                  </a:solidFill>
                </a:ln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3922370C-C4D1-49EB-AF7E-89BBB2A7D24D}"/>
                </a:ext>
              </a:extLst>
            </p:cNvPr>
            <p:cNvSpPr/>
            <p:nvPr/>
          </p:nvSpPr>
          <p:spPr>
            <a:xfrm rot="21010692">
              <a:off x="2370969" y="1339193"/>
              <a:ext cx="877286" cy="2018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36C1296B-EE8B-C6D6-5B30-13C79CD4E170}"/>
                </a:ext>
              </a:extLst>
            </p:cNvPr>
            <p:cNvSpPr/>
            <p:nvPr/>
          </p:nvSpPr>
          <p:spPr>
            <a:xfrm rot="20124679">
              <a:off x="5736442" y="2950302"/>
              <a:ext cx="155598" cy="1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F57F7507-BAFA-3DCA-CB70-ACB35E468EF8}"/>
                </a:ext>
              </a:extLst>
            </p:cNvPr>
            <p:cNvSpPr txBox="1"/>
            <p:nvPr/>
          </p:nvSpPr>
          <p:spPr>
            <a:xfrm>
              <a:off x="5161492" y="1937505"/>
              <a:ext cx="440842" cy="15846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PS-b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B49C862D-414D-200A-E805-DE2A84D93D3C}"/>
                </a:ext>
              </a:extLst>
            </p:cNvPr>
            <p:cNvSpPr/>
            <p:nvPr/>
          </p:nvSpPr>
          <p:spPr>
            <a:xfrm rot="21424402">
              <a:off x="6015557" y="4008902"/>
              <a:ext cx="155598" cy="1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A698A96A-E217-FB74-AA63-49F940C2BE12}"/>
                </a:ext>
              </a:extLst>
            </p:cNvPr>
            <p:cNvSpPr/>
            <p:nvPr/>
          </p:nvSpPr>
          <p:spPr>
            <a:xfrm rot="4794006">
              <a:off x="3703363" y="6909078"/>
              <a:ext cx="155598" cy="1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3B0BEAA9-D664-276B-A6C1-6BE67EBC7916}"/>
                </a:ext>
              </a:extLst>
            </p:cNvPr>
            <p:cNvSpPr/>
            <p:nvPr/>
          </p:nvSpPr>
          <p:spPr>
            <a:xfrm rot="18132270">
              <a:off x="1780330" y="6563182"/>
              <a:ext cx="155598" cy="1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7D3A6ABD-E454-FBD2-B89D-FEA403786D95}"/>
                </a:ext>
              </a:extLst>
            </p:cNvPr>
            <p:cNvSpPr/>
            <p:nvPr/>
          </p:nvSpPr>
          <p:spPr>
            <a:xfrm rot="19951758">
              <a:off x="763622" y="5483980"/>
              <a:ext cx="155598" cy="1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FD252032-01E2-0271-0FC4-14E5A27C0F16}"/>
                </a:ext>
              </a:extLst>
            </p:cNvPr>
            <p:cNvSpPr/>
            <p:nvPr/>
          </p:nvSpPr>
          <p:spPr>
            <a:xfrm rot="20697931">
              <a:off x="511339" y="4801634"/>
              <a:ext cx="155598" cy="1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B5BB6E89-CCD3-0E55-3C79-F29308EE437A}"/>
                </a:ext>
              </a:extLst>
            </p:cNvPr>
            <p:cNvSpPr txBox="1"/>
            <p:nvPr/>
          </p:nvSpPr>
          <p:spPr>
            <a:xfrm>
              <a:off x="6018983" y="3385105"/>
              <a:ext cx="440842" cy="15846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PS-g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D8616F85-D575-AEBA-0DC7-4C4A92A9971F}"/>
                </a:ext>
              </a:extLst>
            </p:cNvPr>
            <p:cNvSpPr txBox="1"/>
            <p:nvPr/>
          </p:nvSpPr>
          <p:spPr>
            <a:xfrm>
              <a:off x="5604094" y="5787786"/>
              <a:ext cx="440842" cy="15846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PS-a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88660F4B-E7F9-2C15-95B4-B0AA661DA29C}"/>
                </a:ext>
              </a:extLst>
            </p:cNvPr>
            <p:cNvSpPr txBox="1"/>
            <p:nvPr/>
          </p:nvSpPr>
          <p:spPr>
            <a:xfrm>
              <a:off x="2413530" y="6968468"/>
              <a:ext cx="440842" cy="15846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PS-d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4E11366C-72BB-9B0F-5E17-09E5B4830465}"/>
                </a:ext>
              </a:extLst>
            </p:cNvPr>
            <p:cNvSpPr txBox="1"/>
            <p:nvPr/>
          </p:nvSpPr>
          <p:spPr>
            <a:xfrm>
              <a:off x="870707" y="6152973"/>
              <a:ext cx="440842" cy="15846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PS-h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83670B4E-46D8-46E6-B0F2-615078037D8A}"/>
                </a:ext>
              </a:extLst>
            </p:cNvPr>
            <p:cNvSpPr txBox="1"/>
            <p:nvPr/>
          </p:nvSpPr>
          <p:spPr>
            <a:xfrm>
              <a:off x="297186" y="5272976"/>
              <a:ext cx="440842" cy="15846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PS-c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F1D8CF51-AB5E-C3ED-8355-1E8FD837A77C}"/>
                </a:ext>
              </a:extLst>
            </p:cNvPr>
            <p:cNvSpPr txBox="1"/>
            <p:nvPr/>
          </p:nvSpPr>
          <p:spPr>
            <a:xfrm>
              <a:off x="370303" y="2649513"/>
              <a:ext cx="580542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PS-e/f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76645BD4-7EBF-AD66-E5CB-1080166E79E5}"/>
              </a:ext>
            </a:extLst>
          </p:cNvPr>
          <p:cNvSpPr txBox="1"/>
          <p:nvPr/>
        </p:nvSpPr>
        <p:spPr>
          <a:xfrm>
            <a:off x="550364" y="6525677"/>
            <a:ext cx="57600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zh-CN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hylogenetic analysis of terpene synthase (TPS) 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in </a:t>
            </a:r>
            <a:r>
              <a:rPr lang="en-US" altLang="zh-CN" sz="1100" i="1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L. japonica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and representative plant species. Amino acid sequences from </a:t>
            </a:r>
            <a:r>
              <a:rPr lang="en-US" altLang="zh-CN" sz="1100" i="1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L. japonica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, the model flowering plant </a:t>
            </a:r>
            <a:r>
              <a:rPr lang="en-US" altLang="zh-CN" sz="1100" i="1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Arabidopsis thaliana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, gymnosperm (</a:t>
            </a:r>
            <a:r>
              <a:rPr lang="en-GB" altLang="zh-CN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ies grandis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), and fern (</a:t>
            </a:r>
            <a:r>
              <a:rPr lang="en-GB" altLang="zh-CN" sz="11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laginella </a:t>
            </a:r>
            <a:r>
              <a:rPr lang="en-GB" altLang="zh-CN" sz="11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ellendorffii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) were used for the 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hylogenetic analysis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. The TPS family was divided into seven subfamilies a-g as previously reported.</a:t>
            </a:r>
            <a:endParaRPr lang="zh-CN" altLang="zh-CN" sz="1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4773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388</Words>
  <Application>Microsoft Office PowerPoint</Application>
  <PresentationFormat>A4 纸张(210x297 毫米)</PresentationFormat>
  <Paragraphs>9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禹 新杰</dc:creator>
  <cp:lastModifiedBy>YuJJ</cp:lastModifiedBy>
  <cp:revision>7</cp:revision>
  <dcterms:created xsi:type="dcterms:W3CDTF">2022-08-18T00:29:09Z</dcterms:created>
  <dcterms:modified xsi:type="dcterms:W3CDTF">2022-08-18T07:16:58Z</dcterms:modified>
</cp:coreProperties>
</file>